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427" r:id="rId2"/>
  </p:sldIdLst>
  <p:sldSz cx="6858000" cy="9144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993" userDrawn="1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beckr" initials="b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FF"/>
    <a:srgbClr val="4472C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9D7B26C5-4107-4FEC-AEDC-1716B250A1EF}" styleName="スタイル (淡色)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85963" autoAdjust="0"/>
  </p:normalViewPr>
  <p:slideViewPr>
    <p:cSldViewPr snapToGrid="0">
      <p:cViewPr varScale="1">
        <p:scale>
          <a:sx n="80" d="100"/>
          <a:sy n="80" d="100"/>
        </p:scale>
        <p:origin x="3006" y="72"/>
      </p:cViewPr>
      <p:guideLst>
        <p:guide orient="horz" pos="2993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khoi ho" userId="c93cb340-cf97-4d7c-9739-bad0ee582323" providerId="ADAL" clId="{FEA2351C-EBF4-4837-ABA7-1BF784C3A80A}"/>
    <pc:docChg chg="modSld">
      <pc:chgData name="khoi ho" userId="c93cb340-cf97-4d7c-9739-bad0ee582323" providerId="ADAL" clId="{FEA2351C-EBF4-4837-ABA7-1BF784C3A80A}" dt="2021-07-29T08:26:06.086" v="123" actId="207"/>
      <pc:docMkLst>
        <pc:docMk/>
      </pc:docMkLst>
      <pc:sldChg chg="modSp mod">
        <pc:chgData name="khoi ho" userId="c93cb340-cf97-4d7c-9739-bad0ee582323" providerId="ADAL" clId="{FEA2351C-EBF4-4837-ABA7-1BF784C3A80A}" dt="2021-07-29T08:26:06.086" v="123" actId="207"/>
        <pc:sldMkLst>
          <pc:docMk/>
          <pc:sldMk cId="2275032014" sldId="427"/>
        </pc:sldMkLst>
        <pc:spChg chg="mod">
          <ac:chgData name="khoi ho" userId="c93cb340-cf97-4d7c-9739-bad0ee582323" providerId="ADAL" clId="{FEA2351C-EBF4-4837-ABA7-1BF784C3A80A}" dt="2021-07-29T08:26:06.086" v="123" actId="207"/>
          <ac:spMkLst>
            <pc:docMk/>
            <pc:sldMk cId="2275032014" sldId="427"/>
            <ac:spMk id="17" creationId="{B85962D4-3D62-4068-95BA-774506E50767}"/>
          </ac:spMkLst>
        </pc:spChg>
      </pc:sldChg>
    </pc:docChg>
  </pc:docChgLst>
  <pc:docChgLst>
    <pc:chgData name="khoi ho" userId="c93cb340-cf97-4d7c-9739-bad0ee582323" providerId="ADAL" clId="{D4CD4F77-BBAC-456B-94C2-5A86893A17E4}"/>
    <pc:docChg chg="undo custSel modSld">
      <pc:chgData name="khoi ho" userId="c93cb340-cf97-4d7c-9739-bad0ee582323" providerId="ADAL" clId="{D4CD4F77-BBAC-456B-94C2-5A86893A17E4}" dt="2021-03-24T07:52:15.623" v="156" actId="1076"/>
      <pc:docMkLst>
        <pc:docMk/>
      </pc:docMkLst>
      <pc:sldChg chg="addSp modSp mod">
        <pc:chgData name="khoi ho" userId="c93cb340-cf97-4d7c-9739-bad0ee582323" providerId="ADAL" clId="{D4CD4F77-BBAC-456B-94C2-5A86893A17E4}" dt="2021-03-24T07:52:15.623" v="156" actId="1076"/>
        <pc:sldMkLst>
          <pc:docMk/>
          <pc:sldMk cId="492678732" sldId="426"/>
        </pc:sldMkLst>
        <pc:spChg chg="mod">
          <ac:chgData name="khoi ho" userId="c93cb340-cf97-4d7c-9739-bad0ee582323" providerId="ADAL" clId="{D4CD4F77-BBAC-456B-94C2-5A86893A17E4}" dt="2021-03-24T07:41:16.433" v="2" actId="1076"/>
          <ac:spMkLst>
            <pc:docMk/>
            <pc:sldMk cId="492678732" sldId="426"/>
            <ac:spMk id="22" creationId="{E27A54E4-56F5-4B9B-BEED-2C75E4670006}"/>
          </ac:spMkLst>
        </pc:spChg>
        <pc:spChg chg="add mod">
          <ac:chgData name="khoi ho" userId="c93cb340-cf97-4d7c-9739-bad0ee582323" providerId="ADAL" clId="{D4CD4F77-BBAC-456B-94C2-5A86893A17E4}" dt="2021-03-24T07:41:31.776" v="18" actId="14100"/>
          <ac:spMkLst>
            <pc:docMk/>
            <pc:sldMk cId="492678732" sldId="426"/>
            <ac:spMk id="23" creationId="{BC78A6B0-C2D9-4BB1-B007-F94BDAFB2273}"/>
          </ac:spMkLst>
        </pc:spChg>
        <pc:spChg chg="add mod">
          <ac:chgData name="khoi ho" userId="c93cb340-cf97-4d7c-9739-bad0ee582323" providerId="ADAL" clId="{D4CD4F77-BBAC-456B-94C2-5A86893A17E4}" dt="2021-03-24T07:52:01.999" v="155" actId="1076"/>
          <ac:spMkLst>
            <pc:docMk/>
            <pc:sldMk cId="492678732" sldId="426"/>
            <ac:spMk id="25" creationId="{5DE550F3-5891-4EA8-9D72-110BD7212EB6}"/>
          </ac:spMkLst>
        </pc:spChg>
        <pc:spChg chg="mod">
          <ac:chgData name="khoi ho" userId="c93cb340-cf97-4d7c-9739-bad0ee582323" providerId="ADAL" clId="{D4CD4F77-BBAC-456B-94C2-5A86893A17E4}" dt="2021-03-24T07:41:16.433" v="2" actId="1076"/>
          <ac:spMkLst>
            <pc:docMk/>
            <pc:sldMk cId="492678732" sldId="426"/>
            <ac:spMk id="27" creationId="{2BA3AA9C-88F0-4980-8077-083B26B4A490}"/>
          </ac:spMkLst>
        </pc:spChg>
        <pc:spChg chg="mod">
          <ac:chgData name="khoi ho" userId="c93cb340-cf97-4d7c-9739-bad0ee582323" providerId="ADAL" clId="{D4CD4F77-BBAC-456B-94C2-5A86893A17E4}" dt="2021-03-24T07:41:16.433" v="2" actId="1076"/>
          <ac:spMkLst>
            <pc:docMk/>
            <pc:sldMk cId="492678732" sldId="426"/>
            <ac:spMk id="28" creationId="{296C9DBE-F180-4CD6-979C-26BC676D8362}"/>
          </ac:spMkLst>
        </pc:spChg>
        <pc:spChg chg="mod">
          <ac:chgData name="khoi ho" userId="c93cb340-cf97-4d7c-9739-bad0ee582323" providerId="ADAL" clId="{D4CD4F77-BBAC-456B-94C2-5A86893A17E4}" dt="2021-03-24T07:41:16.433" v="2" actId="1076"/>
          <ac:spMkLst>
            <pc:docMk/>
            <pc:sldMk cId="492678732" sldId="426"/>
            <ac:spMk id="33" creationId="{F1720C31-19DF-479D-9B5A-675F3BD35DD1}"/>
          </ac:spMkLst>
        </pc:spChg>
        <pc:spChg chg="mod">
          <ac:chgData name="khoi ho" userId="c93cb340-cf97-4d7c-9739-bad0ee582323" providerId="ADAL" clId="{D4CD4F77-BBAC-456B-94C2-5A86893A17E4}" dt="2021-03-24T07:41:16.433" v="2" actId="1076"/>
          <ac:spMkLst>
            <pc:docMk/>
            <pc:sldMk cId="492678732" sldId="426"/>
            <ac:spMk id="34" creationId="{49305999-9936-454E-9DB5-DB630FD9EED3}"/>
          </ac:spMkLst>
        </pc:spChg>
        <pc:spChg chg="mod">
          <ac:chgData name="khoi ho" userId="c93cb340-cf97-4d7c-9739-bad0ee582323" providerId="ADAL" clId="{D4CD4F77-BBAC-456B-94C2-5A86893A17E4}" dt="2021-03-24T07:41:16.433" v="2" actId="1076"/>
          <ac:spMkLst>
            <pc:docMk/>
            <pc:sldMk cId="492678732" sldId="426"/>
            <ac:spMk id="37" creationId="{62C7C64A-D3EB-41F0-A05D-0E30EBA6EAC2}"/>
          </ac:spMkLst>
        </pc:spChg>
        <pc:spChg chg="mod">
          <ac:chgData name="khoi ho" userId="c93cb340-cf97-4d7c-9739-bad0ee582323" providerId="ADAL" clId="{D4CD4F77-BBAC-456B-94C2-5A86893A17E4}" dt="2021-03-24T07:41:16.433" v="2" actId="1076"/>
          <ac:spMkLst>
            <pc:docMk/>
            <pc:sldMk cId="492678732" sldId="426"/>
            <ac:spMk id="38" creationId="{EF10B90E-6CF4-40FD-8070-DEFEC7588DB8}"/>
          </ac:spMkLst>
        </pc:spChg>
        <pc:spChg chg="mod">
          <ac:chgData name="khoi ho" userId="c93cb340-cf97-4d7c-9739-bad0ee582323" providerId="ADAL" clId="{D4CD4F77-BBAC-456B-94C2-5A86893A17E4}" dt="2021-03-24T07:41:16.433" v="2" actId="1076"/>
          <ac:spMkLst>
            <pc:docMk/>
            <pc:sldMk cId="492678732" sldId="426"/>
            <ac:spMk id="43" creationId="{90CBF72A-5A87-4CF6-983D-2A2C1B284A44}"/>
          </ac:spMkLst>
        </pc:spChg>
        <pc:spChg chg="mod">
          <ac:chgData name="khoi ho" userId="c93cb340-cf97-4d7c-9739-bad0ee582323" providerId="ADAL" clId="{D4CD4F77-BBAC-456B-94C2-5A86893A17E4}" dt="2021-03-24T07:52:15.623" v="156" actId="1076"/>
          <ac:spMkLst>
            <pc:docMk/>
            <pc:sldMk cId="492678732" sldId="426"/>
            <ac:spMk id="46" creationId="{4F772BC8-12FC-43F3-B384-63E021DBB1AA}"/>
          </ac:spMkLst>
        </pc:spChg>
        <pc:spChg chg="mod">
          <ac:chgData name="khoi ho" userId="c93cb340-cf97-4d7c-9739-bad0ee582323" providerId="ADAL" clId="{D4CD4F77-BBAC-456B-94C2-5A86893A17E4}" dt="2021-03-24T07:52:15.623" v="156" actId="1076"/>
          <ac:spMkLst>
            <pc:docMk/>
            <pc:sldMk cId="492678732" sldId="426"/>
            <ac:spMk id="47" creationId="{1843AD5C-97B0-4958-9D34-3994CADBEF33}"/>
          </ac:spMkLst>
        </pc:spChg>
        <pc:spChg chg="mod">
          <ac:chgData name="khoi ho" userId="c93cb340-cf97-4d7c-9739-bad0ee582323" providerId="ADAL" clId="{D4CD4F77-BBAC-456B-94C2-5A86893A17E4}" dt="2021-03-24T07:52:15.623" v="156" actId="1076"/>
          <ac:spMkLst>
            <pc:docMk/>
            <pc:sldMk cId="492678732" sldId="426"/>
            <ac:spMk id="48" creationId="{168CB7A1-CE87-447C-914D-53992EFA0381}"/>
          </ac:spMkLst>
        </pc:spChg>
        <pc:spChg chg="mod">
          <ac:chgData name="khoi ho" userId="c93cb340-cf97-4d7c-9739-bad0ee582323" providerId="ADAL" clId="{D4CD4F77-BBAC-456B-94C2-5A86893A17E4}" dt="2021-03-24T07:52:15.623" v="156" actId="1076"/>
          <ac:spMkLst>
            <pc:docMk/>
            <pc:sldMk cId="492678732" sldId="426"/>
            <ac:spMk id="49" creationId="{EB8E42C7-D68E-4AA3-841B-BE9367D5DBEF}"/>
          </ac:spMkLst>
        </pc:spChg>
        <pc:graphicFrameChg chg="mod">
          <ac:chgData name="khoi ho" userId="c93cb340-cf97-4d7c-9739-bad0ee582323" providerId="ADAL" clId="{D4CD4F77-BBAC-456B-94C2-5A86893A17E4}" dt="2021-03-24T07:52:15.623" v="156" actId="1076"/>
          <ac:graphicFrameMkLst>
            <pc:docMk/>
            <pc:sldMk cId="492678732" sldId="426"/>
            <ac:graphicFrameMk id="35" creationId="{F56B6F4F-6F1F-4B88-98BD-5FFA1340A943}"/>
          </ac:graphicFrameMkLst>
        </pc:graphicFrameChg>
        <pc:picChg chg="mod">
          <ac:chgData name="khoi ho" userId="c93cb340-cf97-4d7c-9739-bad0ee582323" providerId="ADAL" clId="{D4CD4F77-BBAC-456B-94C2-5A86893A17E4}" dt="2021-03-24T07:41:16.433" v="2" actId="1076"/>
          <ac:picMkLst>
            <pc:docMk/>
            <pc:sldMk cId="492678732" sldId="426"/>
            <ac:picMk id="3" creationId="{7E737D68-68EB-4628-BA00-3335C4A96285}"/>
          </ac:picMkLst>
        </pc:picChg>
        <pc:picChg chg="mod">
          <ac:chgData name="khoi ho" userId="c93cb340-cf97-4d7c-9739-bad0ee582323" providerId="ADAL" clId="{D4CD4F77-BBAC-456B-94C2-5A86893A17E4}" dt="2021-03-24T07:41:16.433" v="2" actId="1076"/>
          <ac:picMkLst>
            <pc:docMk/>
            <pc:sldMk cId="492678732" sldId="426"/>
            <ac:picMk id="6" creationId="{DCF72E67-29A0-409C-AB2A-BB225FF7E0ED}"/>
          </ac:picMkLst>
        </pc:picChg>
        <pc:picChg chg="mod">
          <ac:chgData name="khoi ho" userId="c93cb340-cf97-4d7c-9739-bad0ee582323" providerId="ADAL" clId="{D4CD4F77-BBAC-456B-94C2-5A86893A17E4}" dt="2021-03-24T07:41:16.433" v="2" actId="1076"/>
          <ac:picMkLst>
            <pc:docMk/>
            <pc:sldMk cId="492678732" sldId="426"/>
            <ac:picMk id="10" creationId="{E92B23F5-583F-42AE-9D02-44010DFD3C48}"/>
          </ac:picMkLst>
        </pc:picChg>
        <pc:picChg chg="mod">
          <ac:chgData name="khoi ho" userId="c93cb340-cf97-4d7c-9739-bad0ee582323" providerId="ADAL" clId="{D4CD4F77-BBAC-456B-94C2-5A86893A17E4}" dt="2021-03-24T07:41:16.433" v="2" actId="1076"/>
          <ac:picMkLst>
            <pc:docMk/>
            <pc:sldMk cId="492678732" sldId="426"/>
            <ac:picMk id="14" creationId="{9A79F9B6-10C7-4E95-BDC2-92EE6D05FF56}"/>
          </ac:picMkLst>
        </pc:picChg>
        <pc:picChg chg="mod">
          <ac:chgData name="khoi ho" userId="c93cb340-cf97-4d7c-9739-bad0ee582323" providerId="ADAL" clId="{D4CD4F77-BBAC-456B-94C2-5A86893A17E4}" dt="2021-03-24T07:41:16.433" v="2" actId="1076"/>
          <ac:picMkLst>
            <pc:docMk/>
            <pc:sldMk cId="492678732" sldId="426"/>
            <ac:picMk id="18" creationId="{A291F610-F077-41B5-A607-785843AF72A0}"/>
          </ac:picMkLst>
        </pc:picChg>
        <pc:picChg chg="mod">
          <ac:chgData name="khoi ho" userId="c93cb340-cf97-4d7c-9739-bad0ee582323" providerId="ADAL" clId="{D4CD4F77-BBAC-456B-94C2-5A86893A17E4}" dt="2021-03-24T07:41:16.433" v="2" actId="1076"/>
          <ac:picMkLst>
            <pc:docMk/>
            <pc:sldMk cId="492678732" sldId="426"/>
            <ac:picMk id="21" creationId="{34A0D976-4884-45AA-80D9-F9399D3339B9}"/>
          </ac:picMkLst>
        </pc:picChg>
        <pc:picChg chg="mod">
          <ac:chgData name="khoi ho" userId="c93cb340-cf97-4d7c-9739-bad0ee582323" providerId="ADAL" clId="{D4CD4F77-BBAC-456B-94C2-5A86893A17E4}" dt="2021-03-24T07:41:16.433" v="2" actId="1076"/>
          <ac:picMkLst>
            <pc:docMk/>
            <pc:sldMk cId="492678732" sldId="426"/>
            <ac:picMk id="24" creationId="{5FE38B0D-09BD-4DEF-B740-A45BE9D4517E}"/>
          </ac:picMkLst>
        </pc:picChg>
        <pc:picChg chg="mod">
          <ac:chgData name="khoi ho" userId="c93cb340-cf97-4d7c-9739-bad0ee582323" providerId="ADAL" clId="{D4CD4F77-BBAC-456B-94C2-5A86893A17E4}" dt="2021-03-24T07:41:16.433" v="2" actId="1076"/>
          <ac:picMkLst>
            <pc:docMk/>
            <pc:sldMk cId="492678732" sldId="426"/>
            <ac:picMk id="26" creationId="{A5CA2A6C-5755-4916-98F4-3F41468BB32B}"/>
          </ac:picMkLst>
        </pc:picChg>
      </pc:sldChg>
    </pc:docChg>
  </pc:docChgLst>
  <pc:docChgLst>
    <pc:chgData name="khoi ho" userId="c93cb340-cf97-4d7c-9739-bad0ee582323" providerId="ADAL" clId="{C2BB2C1E-DF47-4B6A-976C-433CC21C1951}"/>
    <pc:docChg chg="undo custSel modSld">
      <pc:chgData name="khoi ho" userId="c93cb340-cf97-4d7c-9739-bad0ee582323" providerId="ADAL" clId="{C2BB2C1E-DF47-4B6A-976C-433CC21C1951}" dt="2020-10-13T03:55:24.460" v="407" actId="1037"/>
      <pc:docMkLst>
        <pc:docMk/>
      </pc:docMkLst>
      <pc:sldChg chg="modSp">
        <pc:chgData name="khoi ho" userId="c93cb340-cf97-4d7c-9739-bad0ee582323" providerId="ADAL" clId="{C2BB2C1E-DF47-4B6A-976C-433CC21C1951}" dt="2020-09-29T12:10:00.643" v="126" actId="1037"/>
        <pc:sldMkLst>
          <pc:docMk/>
          <pc:sldMk cId="1654466452" sldId="398"/>
        </pc:sldMkLst>
        <pc:spChg chg="mod">
          <ac:chgData name="khoi ho" userId="c93cb340-cf97-4d7c-9739-bad0ee582323" providerId="ADAL" clId="{C2BB2C1E-DF47-4B6A-976C-433CC21C1951}" dt="2020-09-29T12:10:00.643" v="126" actId="1037"/>
          <ac:spMkLst>
            <pc:docMk/>
            <pc:sldMk cId="1654466452" sldId="398"/>
            <ac:spMk id="30" creationId="{6AE5A766-EF87-4AE7-AC17-E341674A2FE1}"/>
          </ac:spMkLst>
        </pc:spChg>
      </pc:sldChg>
      <pc:sldChg chg="modSp">
        <pc:chgData name="khoi ho" userId="c93cb340-cf97-4d7c-9739-bad0ee582323" providerId="ADAL" clId="{C2BB2C1E-DF47-4B6A-976C-433CC21C1951}" dt="2020-09-29T11:58:50.589" v="97" actId="1037"/>
        <pc:sldMkLst>
          <pc:docMk/>
          <pc:sldMk cId="1212021925" sldId="399"/>
        </pc:sldMkLst>
        <pc:spChg chg="mod">
          <ac:chgData name="khoi ho" userId="c93cb340-cf97-4d7c-9739-bad0ee582323" providerId="ADAL" clId="{C2BB2C1E-DF47-4B6A-976C-433CC21C1951}" dt="2020-09-29T11:58:41.061" v="93" actId="1037"/>
          <ac:spMkLst>
            <pc:docMk/>
            <pc:sldMk cId="1212021925" sldId="399"/>
            <ac:spMk id="35" creationId="{395930F6-77E4-4936-88DE-ECA674F60E79}"/>
          </ac:spMkLst>
        </pc:spChg>
        <pc:spChg chg="mod">
          <ac:chgData name="khoi ho" userId="c93cb340-cf97-4d7c-9739-bad0ee582323" providerId="ADAL" clId="{C2BB2C1E-DF47-4B6A-976C-433CC21C1951}" dt="2020-09-29T11:58:31.884" v="85" actId="122"/>
          <ac:spMkLst>
            <pc:docMk/>
            <pc:sldMk cId="1212021925" sldId="399"/>
            <ac:spMk id="36" creationId="{B4B2B7CA-6309-4693-B023-6A1F08088A58}"/>
          </ac:spMkLst>
        </pc:spChg>
        <pc:spChg chg="mod">
          <ac:chgData name="khoi ho" userId="c93cb340-cf97-4d7c-9739-bad0ee582323" providerId="ADAL" clId="{C2BB2C1E-DF47-4B6A-976C-433CC21C1951}" dt="2020-09-29T11:58:50.589" v="97" actId="1037"/>
          <ac:spMkLst>
            <pc:docMk/>
            <pc:sldMk cId="1212021925" sldId="399"/>
            <ac:spMk id="39" creationId="{BA52E51B-1FAD-4953-A42A-FD489145AF59}"/>
          </ac:spMkLst>
        </pc:spChg>
        <pc:spChg chg="mod">
          <ac:chgData name="khoi ho" userId="c93cb340-cf97-4d7c-9739-bad0ee582323" providerId="ADAL" clId="{C2BB2C1E-DF47-4B6A-976C-433CC21C1951}" dt="2020-09-29T11:58:46.221" v="95" actId="1037"/>
          <ac:spMkLst>
            <pc:docMk/>
            <pc:sldMk cId="1212021925" sldId="399"/>
            <ac:spMk id="40" creationId="{51DC3C3A-B161-49D1-8934-40C6412F36D4}"/>
          </ac:spMkLst>
        </pc:spChg>
      </pc:sldChg>
      <pc:sldChg chg="addSp delSp modSp mod">
        <pc:chgData name="khoi ho" userId="c93cb340-cf97-4d7c-9739-bad0ee582323" providerId="ADAL" clId="{C2BB2C1E-DF47-4B6A-976C-433CC21C1951}" dt="2020-10-13T03:54:26.430" v="397" actId="1038"/>
        <pc:sldMkLst>
          <pc:docMk/>
          <pc:sldMk cId="4107458222" sldId="400"/>
        </pc:sldMkLst>
        <pc:spChg chg="del">
          <ac:chgData name="khoi ho" userId="c93cb340-cf97-4d7c-9739-bad0ee582323" providerId="ADAL" clId="{C2BB2C1E-DF47-4B6A-976C-433CC21C1951}" dt="2020-09-29T11:30:02.723" v="0" actId="478"/>
          <ac:spMkLst>
            <pc:docMk/>
            <pc:sldMk cId="4107458222" sldId="400"/>
            <ac:spMk id="2" creationId="{88DD778E-552E-420E-9491-0BB4449B47F0}"/>
          </ac:spMkLst>
        </pc:spChg>
        <pc:spChg chg="del mod">
          <ac:chgData name="khoi ho" userId="c93cb340-cf97-4d7c-9739-bad0ee582323" providerId="ADAL" clId="{C2BB2C1E-DF47-4B6A-976C-433CC21C1951}" dt="2020-10-12T01:22:03.418" v="341"/>
          <ac:spMkLst>
            <pc:docMk/>
            <pc:sldMk cId="4107458222" sldId="400"/>
            <ac:spMk id="25" creationId="{60B24278-7561-48BA-9060-D8DD10F9500F}"/>
          </ac:spMkLst>
        </pc:spChg>
        <pc:spChg chg="del mod">
          <ac:chgData name="khoi ho" userId="c93cb340-cf97-4d7c-9739-bad0ee582323" providerId="ADAL" clId="{C2BB2C1E-DF47-4B6A-976C-433CC21C1951}" dt="2020-10-12T01:22:03.418" v="341"/>
          <ac:spMkLst>
            <pc:docMk/>
            <pc:sldMk cId="4107458222" sldId="400"/>
            <ac:spMk id="26" creationId="{3F314890-660C-440C-B308-E3D1A08024A5}"/>
          </ac:spMkLst>
        </pc:spChg>
        <pc:spChg chg="mod">
          <ac:chgData name="khoi ho" userId="c93cb340-cf97-4d7c-9739-bad0ee582323" providerId="ADAL" clId="{C2BB2C1E-DF47-4B6A-976C-433CC21C1951}" dt="2020-09-29T11:46:09.038" v="58" actId="408"/>
          <ac:spMkLst>
            <pc:docMk/>
            <pc:sldMk cId="4107458222" sldId="400"/>
            <ac:spMk id="27" creationId="{2BA3AA9C-88F0-4980-8077-083B26B4A490}"/>
          </ac:spMkLst>
        </pc:spChg>
        <pc:spChg chg="mod">
          <ac:chgData name="khoi ho" userId="c93cb340-cf97-4d7c-9739-bad0ee582323" providerId="ADAL" clId="{C2BB2C1E-DF47-4B6A-976C-433CC21C1951}" dt="2020-09-29T11:46:01.786" v="57" actId="408"/>
          <ac:spMkLst>
            <pc:docMk/>
            <pc:sldMk cId="4107458222" sldId="400"/>
            <ac:spMk id="28" creationId="{296C9DBE-F180-4CD6-979C-26BC676D8362}"/>
          </ac:spMkLst>
        </pc:spChg>
        <pc:spChg chg="add mod">
          <ac:chgData name="khoi ho" userId="c93cb340-cf97-4d7c-9739-bad0ee582323" providerId="ADAL" clId="{C2BB2C1E-DF47-4B6A-976C-433CC21C1951}" dt="2020-10-12T01:22:43.757" v="360" actId="1038"/>
          <ac:spMkLst>
            <pc:docMk/>
            <pc:sldMk cId="4107458222" sldId="400"/>
            <ac:spMk id="30" creationId="{8F9A49DC-BEEB-49B9-98DE-8104DA8CFB7E}"/>
          </ac:spMkLst>
        </pc:spChg>
        <pc:spChg chg="add mod">
          <ac:chgData name="khoi ho" userId="c93cb340-cf97-4d7c-9739-bad0ee582323" providerId="ADAL" clId="{C2BB2C1E-DF47-4B6A-976C-433CC21C1951}" dt="2020-10-12T01:22:47.693" v="361" actId="1037"/>
          <ac:spMkLst>
            <pc:docMk/>
            <pc:sldMk cId="4107458222" sldId="400"/>
            <ac:spMk id="31" creationId="{F6976E57-1EB7-41A0-B748-3B0E28FCEE0C}"/>
          </ac:spMkLst>
        </pc:spChg>
        <pc:spChg chg="add mod">
          <ac:chgData name="khoi ho" userId="c93cb340-cf97-4d7c-9739-bad0ee582323" providerId="ADAL" clId="{C2BB2C1E-DF47-4B6A-976C-433CC21C1951}" dt="2020-10-13T03:54:26.430" v="397" actId="1038"/>
          <ac:spMkLst>
            <pc:docMk/>
            <pc:sldMk cId="4107458222" sldId="400"/>
            <ac:spMk id="32" creationId="{FEAAE993-EF8B-482A-B845-B63A5845FFAB}"/>
          </ac:spMkLst>
        </pc:spChg>
        <pc:spChg chg="mod">
          <ac:chgData name="khoi ho" userId="c93cb340-cf97-4d7c-9739-bad0ee582323" providerId="ADAL" clId="{C2BB2C1E-DF47-4B6A-976C-433CC21C1951}" dt="2020-09-29T11:47:44.430" v="69" actId="1076"/>
          <ac:spMkLst>
            <pc:docMk/>
            <pc:sldMk cId="4107458222" sldId="400"/>
            <ac:spMk id="33" creationId="{F1720C31-19DF-479D-9B5A-675F3BD35DD1}"/>
          </ac:spMkLst>
        </pc:spChg>
        <pc:spChg chg="mod">
          <ac:chgData name="khoi ho" userId="c93cb340-cf97-4d7c-9739-bad0ee582323" providerId="ADAL" clId="{C2BB2C1E-DF47-4B6A-976C-433CC21C1951}" dt="2020-09-29T11:46:21.271" v="60" actId="465"/>
          <ac:spMkLst>
            <pc:docMk/>
            <pc:sldMk cId="4107458222" sldId="400"/>
            <ac:spMk id="34" creationId="{49305999-9936-454E-9DB5-DB630FD9EED3}"/>
          </ac:spMkLst>
        </pc:spChg>
        <pc:spChg chg="add mod">
          <ac:chgData name="khoi ho" userId="c93cb340-cf97-4d7c-9739-bad0ee582323" providerId="ADAL" clId="{C2BB2C1E-DF47-4B6A-976C-433CC21C1951}" dt="2020-10-12T01:22:30.097" v="352" actId="1076"/>
          <ac:spMkLst>
            <pc:docMk/>
            <pc:sldMk cId="4107458222" sldId="400"/>
            <ac:spMk id="35" creationId="{B2B46B93-6AC7-426D-BEAD-0ED16CB71E4D}"/>
          </ac:spMkLst>
        </pc:spChg>
        <pc:spChg chg="del mod">
          <ac:chgData name="khoi ho" userId="c93cb340-cf97-4d7c-9739-bad0ee582323" providerId="ADAL" clId="{C2BB2C1E-DF47-4B6A-976C-433CC21C1951}" dt="2020-10-12T01:22:03.418" v="341"/>
          <ac:spMkLst>
            <pc:docMk/>
            <pc:sldMk cId="4107458222" sldId="400"/>
            <ac:spMk id="36" creationId="{E1BDE290-777E-4175-A04D-9CC679275C1A}"/>
          </ac:spMkLst>
        </pc:spChg>
        <pc:spChg chg="mod">
          <ac:chgData name="khoi ho" userId="c93cb340-cf97-4d7c-9739-bad0ee582323" providerId="ADAL" clId="{C2BB2C1E-DF47-4B6A-976C-433CC21C1951}" dt="2020-09-29T11:46:32.048" v="62" actId="465"/>
          <ac:spMkLst>
            <pc:docMk/>
            <pc:sldMk cId="4107458222" sldId="400"/>
            <ac:spMk id="37" creationId="{62C7C64A-D3EB-41F0-A05D-0E30EBA6EAC2}"/>
          </ac:spMkLst>
        </pc:spChg>
        <pc:spChg chg="mod">
          <ac:chgData name="khoi ho" userId="c93cb340-cf97-4d7c-9739-bad0ee582323" providerId="ADAL" clId="{C2BB2C1E-DF47-4B6A-976C-433CC21C1951}" dt="2020-09-29T11:47:48.356" v="70" actId="1076"/>
          <ac:spMkLst>
            <pc:docMk/>
            <pc:sldMk cId="4107458222" sldId="400"/>
            <ac:spMk id="38" creationId="{EF10B90E-6CF4-40FD-8070-DEFEC7588DB8}"/>
          </ac:spMkLst>
        </pc:spChg>
        <pc:spChg chg="del mod">
          <ac:chgData name="khoi ho" userId="c93cb340-cf97-4d7c-9739-bad0ee582323" providerId="ADAL" clId="{C2BB2C1E-DF47-4B6A-976C-433CC21C1951}" dt="2020-10-12T01:22:03.418" v="341"/>
          <ac:spMkLst>
            <pc:docMk/>
            <pc:sldMk cId="4107458222" sldId="400"/>
            <ac:spMk id="39" creationId="{73BAE5B5-4115-48A7-B60C-F4B872C85FE4}"/>
          </ac:spMkLst>
        </pc:spChg>
        <pc:graphicFrameChg chg="del">
          <ac:chgData name="khoi ho" userId="c93cb340-cf97-4d7c-9739-bad0ee582323" providerId="ADAL" clId="{C2BB2C1E-DF47-4B6A-976C-433CC21C1951}" dt="2020-10-12T01:20:26.140" v="333" actId="478"/>
          <ac:graphicFrameMkLst>
            <pc:docMk/>
            <pc:sldMk cId="4107458222" sldId="400"/>
            <ac:graphicFrameMk id="24" creationId="{068814A4-5893-4593-AF60-E993A6875328}"/>
          </ac:graphicFrameMkLst>
        </pc:graphicFrameChg>
        <pc:graphicFrameChg chg="add mod">
          <ac:chgData name="khoi ho" userId="c93cb340-cf97-4d7c-9739-bad0ee582323" providerId="ADAL" clId="{C2BB2C1E-DF47-4B6A-976C-433CC21C1951}" dt="2020-10-12T01:21:50.995" v="340" actId="1076"/>
          <ac:graphicFrameMkLst>
            <pc:docMk/>
            <pc:sldMk cId="4107458222" sldId="400"/>
            <ac:graphicFrameMk id="29" creationId="{90D516EE-FF2A-4C06-8C8D-438CDFBBCDFF}"/>
          </ac:graphicFrameMkLst>
        </pc:graphicFrameChg>
        <pc:picChg chg="add mod">
          <ac:chgData name="khoi ho" userId="c93cb340-cf97-4d7c-9739-bad0ee582323" providerId="ADAL" clId="{C2BB2C1E-DF47-4B6A-976C-433CC21C1951}" dt="2020-09-29T11:47:17.747" v="66" actId="1076"/>
          <ac:picMkLst>
            <pc:docMk/>
            <pc:sldMk cId="4107458222" sldId="400"/>
            <ac:picMk id="4" creationId="{0972CE7D-3E4D-4B29-8284-26F7632BED95}"/>
          </ac:picMkLst>
        </pc:picChg>
        <pc:picChg chg="add mod">
          <ac:chgData name="khoi ho" userId="c93cb340-cf97-4d7c-9739-bad0ee582323" providerId="ADAL" clId="{C2BB2C1E-DF47-4B6A-976C-433CC21C1951}" dt="2020-09-30T00:58:53.084" v="174"/>
          <ac:picMkLst>
            <pc:docMk/>
            <pc:sldMk cId="4107458222" sldId="400"/>
            <ac:picMk id="6" creationId="{E494C7DA-4F0D-408E-9225-7B793E6347D0}"/>
          </ac:picMkLst>
        </pc:picChg>
        <pc:picChg chg="del">
          <ac:chgData name="khoi ho" userId="c93cb340-cf97-4d7c-9739-bad0ee582323" providerId="ADAL" clId="{C2BB2C1E-DF47-4B6A-976C-433CC21C1951}" dt="2020-09-29T11:34:49.044" v="1" actId="478"/>
          <ac:picMkLst>
            <pc:docMk/>
            <pc:sldMk cId="4107458222" sldId="400"/>
            <ac:picMk id="7" creationId="{C88A2E18-150B-48C1-82A0-BC44B52FBD96}"/>
          </ac:picMkLst>
        </pc:picChg>
        <pc:picChg chg="add mod">
          <ac:chgData name="khoi ho" userId="c93cb340-cf97-4d7c-9739-bad0ee582323" providerId="ADAL" clId="{C2BB2C1E-DF47-4B6A-976C-433CC21C1951}" dt="2020-09-29T11:47:17.747" v="66" actId="1076"/>
          <ac:picMkLst>
            <pc:docMk/>
            <pc:sldMk cId="4107458222" sldId="400"/>
            <ac:picMk id="9" creationId="{1DDDF4D1-19AC-4AED-98B4-679483BC963F}"/>
          </ac:picMkLst>
        </pc:picChg>
        <pc:picChg chg="del">
          <ac:chgData name="khoi ho" userId="c93cb340-cf97-4d7c-9739-bad0ee582323" providerId="ADAL" clId="{C2BB2C1E-DF47-4B6A-976C-433CC21C1951}" dt="2020-09-29T11:34:50.117" v="2" actId="478"/>
          <ac:picMkLst>
            <pc:docMk/>
            <pc:sldMk cId="4107458222" sldId="400"/>
            <ac:picMk id="10" creationId="{DC0AFB79-7000-4201-A0F9-DFB265A93051}"/>
          </ac:picMkLst>
        </pc:picChg>
        <pc:picChg chg="add mod">
          <ac:chgData name="khoi ho" userId="c93cb340-cf97-4d7c-9739-bad0ee582323" providerId="ADAL" clId="{C2BB2C1E-DF47-4B6A-976C-433CC21C1951}" dt="2020-09-30T00:58:44.147" v="171"/>
          <ac:picMkLst>
            <pc:docMk/>
            <pc:sldMk cId="4107458222" sldId="400"/>
            <ac:picMk id="12" creationId="{6A396BCB-DC01-4BC7-97A6-6D79B3EC3815}"/>
          </ac:picMkLst>
        </pc:picChg>
        <pc:picChg chg="del">
          <ac:chgData name="khoi ho" userId="c93cb340-cf97-4d7c-9739-bad0ee582323" providerId="ADAL" clId="{C2BB2C1E-DF47-4B6A-976C-433CC21C1951}" dt="2020-09-29T11:38:01.444" v="14" actId="478"/>
          <ac:picMkLst>
            <pc:docMk/>
            <pc:sldMk cId="4107458222" sldId="400"/>
            <ac:picMk id="14" creationId="{54B5D06C-6D39-4901-8AF7-B3E0335C3193}"/>
          </ac:picMkLst>
        </pc:picChg>
        <pc:picChg chg="add mod">
          <ac:chgData name="khoi ho" userId="c93cb340-cf97-4d7c-9739-bad0ee582323" providerId="ADAL" clId="{C2BB2C1E-DF47-4B6A-976C-433CC21C1951}" dt="2020-09-30T00:58:39.621" v="170"/>
          <ac:picMkLst>
            <pc:docMk/>
            <pc:sldMk cId="4107458222" sldId="400"/>
            <ac:picMk id="15" creationId="{059C1DE3-6E20-4C89-AD75-CB802D5DFE09}"/>
          </ac:picMkLst>
        </pc:picChg>
        <pc:picChg chg="del">
          <ac:chgData name="khoi ho" userId="c93cb340-cf97-4d7c-9739-bad0ee582323" providerId="ADAL" clId="{C2BB2C1E-DF47-4B6A-976C-433CC21C1951}" dt="2020-09-29T11:38:01.444" v="14" actId="478"/>
          <ac:picMkLst>
            <pc:docMk/>
            <pc:sldMk cId="4107458222" sldId="400"/>
            <ac:picMk id="17" creationId="{3ED1B430-E813-40E3-80B9-8A2FF9404A82}"/>
          </ac:picMkLst>
        </pc:picChg>
        <pc:picChg chg="add mod">
          <ac:chgData name="khoi ho" userId="c93cb340-cf97-4d7c-9739-bad0ee582323" providerId="ADAL" clId="{C2BB2C1E-DF47-4B6A-976C-433CC21C1951}" dt="2020-09-29T11:47:17.747" v="66" actId="1076"/>
          <ac:picMkLst>
            <pc:docMk/>
            <pc:sldMk cId="4107458222" sldId="400"/>
            <ac:picMk id="18" creationId="{1B41D453-95C9-45E9-A93A-222D1DE9DD20}"/>
          </ac:picMkLst>
        </pc:picChg>
        <pc:picChg chg="del">
          <ac:chgData name="khoi ho" userId="c93cb340-cf97-4d7c-9739-bad0ee582323" providerId="ADAL" clId="{C2BB2C1E-DF47-4B6A-976C-433CC21C1951}" dt="2020-09-29T11:39:21.981" v="26" actId="478"/>
          <ac:picMkLst>
            <pc:docMk/>
            <pc:sldMk cId="4107458222" sldId="400"/>
            <ac:picMk id="20" creationId="{68FBD0C8-DACE-4D5E-B399-A4F38F1896A1}"/>
          </ac:picMkLst>
        </pc:picChg>
        <pc:picChg chg="add mod">
          <ac:chgData name="khoi ho" userId="c93cb340-cf97-4d7c-9739-bad0ee582323" providerId="ADAL" clId="{C2BB2C1E-DF47-4B6A-976C-433CC21C1951}" dt="2020-09-30T00:58:32.030" v="169"/>
          <ac:picMkLst>
            <pc:docMk/>
            <pc:sldMk cId="4107458222" sldId="400"/>
            <ac:picMk id="21" creationId="{1CF79B11-A75E-463D-8F31-CF4BCC06C0CA}"/>
          </ac:picMkLst>
        </pc:picChg>
        <pc:picChg chg="add mod">
          <ac:chgData name="khoi ho" userId="c93cb340-cf97-4d7c-9739-bad0ee582323" providerId="ADAL" clId="{C2BB2C1E-DF47-4B6A-976C-433CC21C1951}" dt="2020-09-29T11:47:36.659" v="68" actId="1076"/>
          <ac:picMkLst>
            <pc:docMk/>
            <pc:sldMk cId="4107458222" sldId="400"/>
            <ac:picMk id="23" creationId="{322B4D96-4F0C-4FF3-A351-B122B12FE9D4}"/>
          </ac:picMkLst>
        </pc:picChg>
        <pc:picChg chg="del">
          <ac:chgData name="khoi ho" userId="c93cb340-cf97-4d7c-9739-bad0ee582323" providerId="ADAL" clId="{C2BB2C1E-DF47-4B6A-976C-433CC21C1951}" dt="2020-09-29T11:39:21.981" v="26" actId="478"/>
          <ac:picMkLst>
            <pc:docMk/>
            <pc:sldMk cId="4107458222" sldId="400"/>
            <ac:picMk id="40" creationId="{82C9C63E-6A6C-42C0-98F6-877CAA776A39}"/>
          </ac:picMkLst>
        </pc:picChg>
        <pc:picChg chg="del">
          <ac:chgData name="khoi ho" userId="c93cb340-cf97-4d7c-9739-bad0ee582323" providerId="ADAL" clId="{C2BB2C1E-DF47-4B6A-976C-433CC21C1951}" dt="2020-09-29T11:40:44.092" v="41" actId="478"/>
          <ac:picMkLst>
            <pc:docMk/>
            <pc:sldMk cId="4107458222" sldId="400"/>
            <ac:picMk id="42" creationId="{59CD5D4D-C334-4B5B-A2BB-7F9C630BB3BC}"/>
          </ac:picMkLst>
        </pc:picChg>
        <pc:picChg chg="del">
          <ac:chgData name="khoi ho" userId="c93cb340-cf97-4d7c-9739-bad0ee582323" providerId="ADAL" clId="{C2BB2C1E-DF47-4B6A-976C-433CC21C1951}" dt="2020-09-29T11:40:44.092" v="41" actId="478"/>
          <ac:picMkLst>
            <pc:docMk/>
            <pc:sldMk cId="4107458222" sldId="400"/>
            <ac:picMk id="45" creationId="{4C30288B-5208-407E-B030-0A57C967F426}"/>
          </ac:picMkLst>
        </pc:picChg>
      </pc:sldChg>
      <pc:sldChg chg="modSp">
        <pc:chgData name="khoi ho" userId="c93cb340-cf97-4d7c-9739-bad0ee582323" providerId="ADAL" clId="{C2BB2C1E-DF47-4B6A-976C-433CC21C1951}" dt="2020-09-29T11:59:10.908" v="104" actId="1037"/>
        <pc:sldMkLst>
          <pc:docMk/>
          <pc:sldMk cId="3434091264" sldId="401"/>
        </pc:sldMkLst>
        <pc:spChg chg="mod">
          <ac:chgData name="khoi ho" userId="c93cb340-cf97-4d7c-9739-bad0ee582323" providerId="ADAL" clId="{C2BB2C1E-DF47-4B6A-976C-433CC21C1951}" dt="2020-09-29T11:59:04.940" v="100" actId="1037"/>
          <ac:spMkLst>
            <pc:docMk/>
            <pc:sldMk cId="3434091264" sldId="401"/>
            <ac:spMk id="26" creationId="{E6B6FC73-6F92-43C2-A72E-2BCDECA051F2}"/>
          </ac:spMkLst>
        </pc:spChg>
        <pc:spChg chg="mod">
          <ac:chgData name="khoi ho" userId="c93cb340-cf97-4d7c-9739-bad0ee582323" providerId="ADAL" clId="{C2BB2C1E-DF47-4B6A-976C-433CC21C1951}" dt="2020-09-29T11:59:10.908" v="104" actId="1037"/>
          <ac:spMkLst>
            <pc:docMk/>
            <pc:sldMk cId="3434091264" sldId="401"/>
            <ac:spMk id="27" creationId="{97C29430-C691-44AC-BF98-C9FD555436A0}"/>
          </ac:spMkLst>
        </pc:spChg>
        <pc:spChg chg="mod">
          <ac:chgData name="khoi ho" userId="c93cb340-cf97-4d7c-9739-bad0ee582323" providerId="ADAL" clId="{C2BB2C1E-DF47-4B6A-976C-433CC21C1951}" dt="2020-09-29T11:58:59.716" v="98" actId="122"/>
          <ac:spMkLst>
            <pc:docMk/>
            <pc:sldMk cId="3434091264" sldId="401"/>
            <ac:spMk id="28" creationId="{5F4E63FE-AB9F-4C67-A4CE-5DDB69121619}"/>
          </ac:spMkLst>
        </pc:spChg>
      </pc:sldChg>
      <pc:sldChg chg="addSp delSp modSp mod">
        <pc:chgData name="khoi ho" userId="c93cb340-cf97-4d7c-9739-bad0ee582323" providerId="ADAL" clId="{C2BB2C1E-DF47-4B6A-976C-433CC21C1951}" dt="2020-10-02T09:33:04.518" v="257" actId="27918"/>
        <pc:sldMkLst>
          <pc:docMk/>
          <pc:sldMk cId="2621352214" sldId="407"/>
        </pc:sldMkLst>
        <pc:spChg chg="del">
          <ac:chgData name="khoi ho" userId="c93cb340-cf97-4d7c-9739-bad0ee582323" providerId="ADAL" clId="{C2BB2C1E-DF47-4B6A-976C-433CC21C1951}" dt="2020-09-29T12:35:19.659" v="128" actId="478"/>
          <ac:spMkLst>
            <pc:docMk/>
            <pc:sldMk cId="2621352214" sldId="407"/>
            <ac:spMk id="20" creationId="{6C65CCFD-2F3E-47A3-AD63-A0660EA1AF66}"/>
          </ac:spMkLst>
        </pc:spChg>
        <pc:spChg chg="del">
          <ac:chgData name="khoi ho" userId="c93cb340-cf97-4d7c-9739-bad0ee582323" providerId="ADAL" clId="{C2BB2C1E-DF47-4B6A-976C-433CC21C1951}" dt="2020-09-30T06:25:55.938" v="177" actId="478"/>
          <ac:spMkLst>
            <pc:docMk/>
            <pc:sldMk cId="2621352214" sldId="407"/>
            <ac:spMk id="29" creationId="{AD4CF90F-18EB-444F-BBAA-EB43D9DD73C5}"/>
          </ac:spMkLst>
        </pc:spChg>
        <pc:spChg chg="del">
          <ac:chgData name="khoi ho" userId="c93cb340-cf97-4d7c-9739-bad0ee582323" providerId="ADAL" clId="{C2BB2C1E-DF47-4B6A-976C-433CC21C1951}" dt="2020-09-30T06:25:54.619" v="176" actId="478"/>
          <ac:spMkLst>
            <pc:docMk/>
            <pc:sldMk cId="2621352214" sldId="407"/>
            <ac:spMk id="30" creationId="{6A1A4C8E-93BD-4D2E-87C6-16115805B742}"/>
          </ac:spMkLst>
        </pc:spChg>
        <pc:spChg chg="del">
          <ac:chgData name="khoi ho" userId="c93cb340-cf97-4d7c-9739-bad0ee582323" providerId="ADAL" clId="{C2BB2C1E-DF47-4B6A-976C-433CC21C1951}" dt="2020-09-30T06:25:57.186" v="178" actId="478"/>
          <ac:spMkLst>
            <pc:docMk/>
            <pc:sldMk cId="2621352214" sldId="407"/>
            <ac:spMk id="31" creationId="{2B6037CB-87DA-4BA5-BD8D-C19DBA60B773}"/>
          </ac:spMkLst>
        </pc:spChg>
        <pc:spChg chg="add">
          <ac:chgData name="khoi ho" userId="c93cb340-cf97-4d7c-9739-bad0ee582323" providerId="ADAL" clId="{C2BB2C1E-DF47-4B6A-976C-433CC21C1951}" dt="2020-09-30T06:25:59.457" v="180"/>
          <ac:spMkLst>
            <pc:docMk/>
            <pc:sldMk cId="2621352214" sldId="407"/>
            <ac:spMk id="36" creationId="{E335D200-80F0-4EA7-9EA3-5CE9B78295FC}"/>
          </ac:spMkLst>
        </pc:spChg>
        <pc:spChg chg="add">
          <ac:chgData name="khoi ho" userId="c93cb340-cf97-4d7c-9739-bad0ee582323" providerId="ADAL" clId="{C2BB2C1E-DF47-4B6A-976C-433CC21C1951}" dt="2020-09-30T06:25:59.457" v="180"/>
          <ac:spMkLst>
            <pc:docMk/>
            <pc:sldMk cId="2621352214" sldId="407"/>
            <ac:spMk id="37" creationId="{C27C5879-F79D-4F75-BEFC-B284F81830C9}"/>
          </ac:spMkLst>
        </pc:spChg>
        <pc:spChg chg="add">
          <ac:chgData name="khoi ho" userId="c93cb340-cf97-4d7c-9739-bad0ee582323" providerId="ADAL" clId="{C2BB2C1E-DF47-4B6A-976C-433CC21C1951}" dt="2020-09-30T06:25:59.457" v="180"/>
          <ac:spMkLst>
            <pc:docMk/>
            <pc:sldMk cId="2621352214" sldId="407"/>
            <ac:spMk id="39" creationId="{86AE1EE9-FA74-4EBB-AE1B-0779C7359DBE}"/>
          </ac:spMkLst>
        </pc:spChg>
        <pc:graphicFrameChg chg="del">
          <ac:chgData name="khoi ho" userId="c93cb340-cf97-4d7c-9739-bad0ee582323" providerId="ADAL" clId="{C2BB2C1E-DF47-4B6A-976C-433CC21C1951}" dt="2020-09-30T06:25:51.954" v="175" actId="478"/>
          <ac:graphicFrameMkLst>
            <pc:docMk/>
            <pc:sldMk cId="2621352214" sldId="407"/>
            <ac:graphicFrameMk id="26" creationId="{A7D1480D-B75C-4C78-9986-3AB48EA40BE2}"/>
          </ac:graphicFrameMkLst>
        </pc:graphicFrameChg>
        <pc:graphicFrameChg chg="add">
          <ac:chgData name="khoi ho" userId="c93cb340-cf97-4d7c-9739-bad0ee582323" providerId="ADAL" clId="{C2BB2C1E-DF47-4B6A-976C-433CC21C1951}" dt="2020-09-30T06:25:59.457" v="180"/>
          <ac:graphicFrameMkLst>
            <pc:docMk/>
            <pc:sldMk cId="2621352214" sldId="407"/>
            <ac:graphicFrameMk id="35" creationId="{6AAB4EC3-88B1-473E-910F-3EC09AB590E1}"/>
          </ac:graphicFrameMkLst>
        </pc:graphicFrameChg>
        <pc:picChg chg="del">
          <ac:chgData name="khoi ho" userId="c93cb340-cf97-4d7c-9739-bad0ee582323" providerId="ADAL" clId="{C2BB2C1E-DF47-4B6A-976C-433CC21C1951}" dt="2020-09-29T12:35:16.442" v="127" actId="478"/>
          <ac:picMkLst>
            <pc:docMk/>
            <pc:sldMk cId="2621352214" sldId="407"/>
            <ac:picMk id="3" creationId="{6F1BA26F-B4C8-499C-8724-778A6A9A0D6F}"/>
          </ac:picMkLst>
        </pc:picChg>
        <pc:picChg chg="del">
          <ac:chgData name="khoi ho" userId="c93cb340-cf97-4d7c-9739-bad0ee582323" providerId="ADAL" clId="{C2BB2C1E-DF47-4B6A-976C-433CC21C1951}" dt="2020-09-29T12:35:16.442" v="127" actId="478"/>
          <ac:picMkLst>
            <pc:docMk/>
            <pc:sldMk cId="2621352214" sldId="407"/>
            <ac:picMk id="4" creationId="{CC3A5948-7567-47BB-9ED8-27F73E0BBF4B}"/>
          </ac:picMkLst>
        </pc:picChg>
        <pc:picChg chg="add mod">
          <ac:chgData name="khoi ho" userId="c93cb340-cf97-4d7c-9739-bad0ee582323" providerId="ADAL" clId="{C2BB2C1E-DF47-4B6A-976C-433CC21C1951}" dt="2020-09-29T12:36:12.325" v="140" actId="1076"/>
          <ac:picMkLst>
            <pc:docMk/>
            <pc:sldMk cId="2621352214" sldId="407"/>
            <ac:picMk id="5" creationId="{2DE9615E-F841-461E-B360-7D89465CC7C1}"/>
          </ac:picMkLst>
        </pc:picChg>
        <pc:picChg chg="del">
          <ac:chgData name="khoi ho" userId="c93cb340-cf97-4d7c-9739-bad0ee582323" providerId="ADAL" clId="{C2BB2C1E-DF47-4B6A-976C-433CC21C1951}" dt="2020-09-29T12:36:17.035" v="142" actId="478"/>
          <ac:picMkLst>
            <pc:docMk/>
            <pc:sldMk cId="2621352214" sldId="407"/>
            <ac:picMk id="6" creationId="{897AD71C-83D8-423A-B495-E22BCCE657E7}"/>
          </ac:picMkLst>
        </pc:picChg>
        <pc:picChg chg="add mod">
          <ac:chgData name="khoi ho" userId="c93cb340-cf97-4d7c-9739-bad0ee582323" providerId="ADAL" clId="{C2BB2C1E-DF47-4B6A-976C-433CC21C1951}" dt="2020-09-29T12:35:59.670" v="139" actId="1076"/>
          <ac:picMkLst>
            <pc:docMk/>
            <pc:sldMk cId="2621352214" sldId="407"/>
            <ac:picMk id="8" creationId="{E8EADA22-BBA2-47DF-9B79-BA4C02956362}"/>
          </ac:picMkLst>
        </pc:picChg>
        <pc:picChg chg="del">
          <ac:chgData name="khoi ho" userId="c93cb340-cf97-4d7c-9739-bad0ee582323" providerId="ADAL" clId="{C2BB2C1E-DF47-4B6A-976C-433CC21C1951}" dt="2020-09-29T12:37:41.297" v="156" actId="478"/>
          <ac:picMkLst>
            <pc:docMk/>
            <pc:sldMk cId="2621352214" sldId="407"/>
            <ac:picMk id="9" creationId="{30489410-302D-4E31-96F1-9F7A3A4981C8}"/>
          </ac:picMkLst>
        </pc:picChg>
        <pc:picChg chg="del">
          <ac:chgData name="khoi ho" userId="c93cb340-cf97-4d7c-9739-bad0ee582323" providerId="ADAL" clId="{C2BB2C1E-DF47-4B6A-976C-433CC21C1951}" dt="2020-09-29T12:36:15.171" v="141" actId="478"/>
          <ac:picMkLst>
            <pc:docMk/>
            <pc:sldMk cId="2621352214" sldId="407"/>
            <ac:picMk id="10" creationId="{26D8C3A6-558E-43E2-8C58-A0AEE5E6CA80}"/>
          </ac:picMkLst>
        </pc:picChg>
        <pc:picChg chg="add mod">
          <ac:chgData name="khoi ho" userId="c93cb340-cf97-4d7c-9739-bad0ee582323" providerId="ADAL" clId="{C2BB2C1E-DF47-4B6A-976C-433CC21C1951}" dt="2020-09-29T12:37:58.434" v="157"/>
          <ac:picMkLst>
            <pc:docMk/>
            <pc:sldMk cId="2621352214" sldId="407"/>
            <ac:picMk id="12" creationId="{44C17D9C-109A-4610-B3A3-96835394EE47}"/>
          </ac:picMkLst>
        </pc:picChg>
        <pc:picChg chg="add mod">
          <ac:chgData name="khoi ho" userId="c93cb340-cf97-4d7c-9739-bad0ee582323" providerId="ADAL" clId="{C2BB2C1E-DF47-4B6A-976C-433CC21C1951}" dt="2020-09-29T12:37:01.650" v="151" actId="1076"/>
          <ac:picMkLst>
            <pc:docMk/>
            <pc:sldMk cId="2621352214" sldId="407"/>
            <ac:picMk id="14" creationId="{510ED31E-F95F-4CDE-B11F-E3191F791D44}"/>
          </ac:picMkLst>
        </pc:picChg>
        <pc:picChg chg="del">
          <ac:chgData name="khoi ho" userId="c93cb340-cf97-4d7c-9739-bad0ee582323" providerId="ADAL" clId="{C2BB2C1E-DF47-4B6A-976C-433CC21C1951}" dt="2020-09-29T12:37:40.658" v="155" actId="478"/>
          <ac:picMkLst>
            <pc:docMk/>
            <pc:sldMk cId="2621352214" sldId="407"/>
            <ac:picMk id="16" creationId="{5298AA35-0999-4B8C-ACE2-7612A9859ACB}"/>
          </ac:picMkLst>
        </pc:picChg>
        <pc:picChg chg="add mod">
          <ac:chgData name="khoi ho" userId="c93cb340-cf97-4d7c-9739-bad0ee582323" providerId="ADAL" clId="{C2BB2C1E-DF47-4B6A-976C-433CC21C1951}" dt="2020-09-29T12:38:52.725" v="168" actId="1076"/>
          <ac:picMkLst>
            <pc:docMk/>
            <pc:sldMk cId="2621352214" sldId="407"/>
            <ac:picMk id="17" creationId="{60954C8C-2DE0-498B-A6EC-D0ACFF996DE8}"/>
          </ac:picMkLst>
        </pc:picChg>
        <pc:picChg chg="add mod">
          <ac:chgData name="khoi ho" userId="c93cb340-cf97-4d7c-9739-bad0ee582323" providerId="ADAL" clId="{C2BB2C1E-DF47-4B6A-976C-433CC21C1951}" dt="2020-09-29T12:38:42.161" v="167" actId="1076"/>
          <ac:picMkLst>
            <pc:docMk/>
            <pc:sldMk cId="2621352214" sldId="407"/>
            <ac:picMk id="19" creationId="{8B78A97F-7380-415D-9E84-D50D7FBFF461}"/>
          </ac:picMkLst>
        </pc:picChg>
      </pc:sldChg>
      <pc:sldChg chg="modSp">
        <pc:chgData name="khoi ho" userId="c93cb340-cf97-4d7c-9739-bad0ee582323" providerId="ADAL" clId="{C2BB2C1E-DF47-4B6A-976C-433CC21C1951}" dt="2020-09-30T06:30:42.456" v="202" actId="1038"/>
        <pc:sldMkLst>
          <pc:docMk/>
          <pc:sldMk cId="3173550047" sldId="408"/>
        </pc:sldMkLst>
        <pc:spChg chg="mod">
          <ac:chgData name="khoi ho" userId="c93cb340-cf97-4d7c-9739-bad0ee582323" providerId="ADAL" clId="{C2BB2C1E-DF47-4B6A-976C-433CC21C1951}" dt="2020-09-30T06:30:22.939" v="188" actId="1037"/>
          <ac:spMkLst>
            <pc:docMk/>
            <pc:sldMk cId="3173550047" sldId="408"/>
            <ac:spMk id="29" creationId="{92EBDBB4-2B6A-4FE6-A5F8-E388CAAB2AA8}"/>
          </ac:spMkLst>
        </pc:spChg>
        <pc:spChg chg="mod">
          <ac:chgData name="khoi ho" userId="c93cb340-cf97-4d7c-9739-bad0ee582323" providerId="ADAL" clId="{C2BB2C1E-DF47-4B6A-976C-433CC21C1951}" dt="2020-09-30T06:30:30.379" v="193" actId="1037"/>
          <ac:spMkLst>
            <pc:docMk/>
            <pc:sldMk cId="3173550047" sldId="408"/>
            <ac:spMk id="30" creationId="{7CB9A980-ACC9-453A-AC70-9007A77D5170}"/>
          </ac:spMkLst>
        </pc:spChg>
        <pc:spChg chg="mod">
          <ac:chgData name="khoi ho" userId="c93cb340-cf97-4d7c-9739-bad0ee582323" providerId="ADAL" clId="{C2BB2C1E-DF47-4B6A-976C-433CC21C1951}" dt="2020-09-30T06:30:42.456" v="202" actId="1038"/>
          <ac:spMkLst>
            <pc:docMk/>
            <pc:sldMk cId="3173550047" sldId="408"/>
            <ac:spMk id="31" creationId="{E143031A-B689-4997-B3D0-5287FE5340AC}"/>
          </ac:spMkLst>
        </pc:spChg>
      </pc:sldChg>
      <pc:sldChg chg="modSp">
        <pc:chgData name="khoi ho" userId="c93cb340-cf97-4d7c-9739-bad0ee582323" providerId="ADAL" clId="{C2BB2C1E-DF47-4B6A-976C-433CC21C1951}" dt="2020-09-29T11:59:47.688" v="124" actId="122"/>
        <pc:sldMkLst>
          <pc:docMk/>
          <pc:sldMk cId="3664975801" sldId="410"/>
        </pc:sldMkLst>
        <pc:spChg chg="mod">
          <ac:chgData name="khoi ho" userId="c93cb340-cf97-4d7c-9739-bad0ee582323" providerId="ADAL" clId="{C2BB2C1E-DF47-4B6A-976C-433CC21C1951}" dt="2020-09-29T11:59:28.267" v="108" actId="1038"/>
          <ac:spMkLst>
            <pc:docMk/>
            <pc:sldMk cId="3664975801" sldId="410"/>
            <ac:spMk id="35" creationId="{7084EE3E-EFC2-4B87-A2FB-AEE7F3BA28AD}"/>
          </ac:spMkLst>
        </pc:spChg>
        <pc:spChg chg="mod">
          <ac:chgData name="khoi ho" userId="c93cb340-cf97-4d7c-9739-bad0ee582323" providerId="ADAL" clId="{C2BB2C1E-DF47-4B6A-976C-433CC21C1951}" dt="2020-09-29T11:59:41.319" v="120" actId="122"/>
          <ac:spMkLst>
            <pc:docMk/>
            <pc:sldMk cId="3664975801" sldId="410"/>
            <ac:spMk id="36" creationId="{58E2D0D4-DB8B-4407-A3FB-C232F0BCA718}"/>
          </ac:spMkLst>
        </pc:spChg>
        <pc:spChg chg="mod">
          <ac:chgData name="khoi ho" userId="c93cb340-cf97-4d7c-9739-bad0ee582323" providerId="ADAL" clId="{C2BB2C1E-DF47-4B6A-976C-433CC21C1951}" dt="2020-09-29T11:59:34.333" v="116" actId="1037"/>
          <ac:spMkLst>
            <pc:docMk/>
            <pc:sldMk cId="3664975801" sldId="410"/>
            <ac:spMk id="39" creationId="{D7AE6B2A-C1C1-4162-A29A-4971FBD2C114}"/>
          </ac:spMkLst>
        </pc:spChg>
        <pc:spChg chg="mod">
          <ac:chgData name="khoi ho" userId="c93cb340-cf97-4d7c-9739-bad0ee582323" providerId="ADAL" clId="{C2BB2C1E-DF47-4B6A-976C-433CC21C1951}" dt="2020-09-29T11:59:47.688" v="124" actId="122"/>
          <ac:spMkLst>
            <pc:docMk/>
            <pc:sldMk cId="3664975801" sldId="410"/>
            <ac:spMk id="40" creationId="{E967DEB5-2FCC-4426-BF6A-D580F0648323}"/>
          </ac:spMkLst>
        </pc:spChg>
      </pc:sldChg>
      <pc:sldChg chg="addSp delSp modSp">
        <pc:chgData name="khoi ho" userId="c93cb340-cf97-4d7c-9739-bad0ee582323" providerId="ADAL" clId="{C2BB2C1E-DF47-4B6A-976C-433CC21C1951}" dt="2020-10-12T01:25:50.920" v="373" actId="14100"/>
        <pc:sldMkLst>
          <pc:docMk/>
          <pc:sldMk cId="3022863545" sldId="411"/>
        </pc:sldMkLst>
        <pc:spChg chg="mod">
          <ac:chgData name="khoi ho" userId="c93cb340-cf97-4d7c-9739-bad0ee582323" providerId="ADAL" clId="{C2BB2C1E-DF47-4B6A-976C-433CC21C1951}" dt="2020-09-30T06:59:50.315" v="206" actId="1076"/>
          <ac:spMkLst>
            <pc:docMk/>
            <pc:sldMk cId="3022863545" sldId="411"/>
            <ac:spMk id="28" creationId="{A85EF9F2-D5DF-422B-AFAA-D2CCBB8EC503}"/>
          </ac:spMkLst>
        </pc:spChg>
        <pc:spChg chg="mod">
          <ac:chgData name="khoi ho" userId="c93cb340-cf97-4d7c-9739-bad0ee582323" providerId="ADAL" clId="{C2BB2C1E-DF47-4B6A-976C-433CC21C1951}" dt="2020-09-30T07:01:57.990" v="223" actId="1076"/>
          <ac:spMkLst>
            <pc:docMk/>
            <pc:sldMk cId="3022863545" sldId="411"/>
            <ac:spMk id="157" creationId="{E9486576-9624-43BF-A72E-20766A2DD813}"/>
          </ac:spMkLst>
        </pc:spChg>
        <pc:spChg chg="mod">
          <ac:chgData name="khoi ho" userId="c93cb340-cf97-4d7c-9739-bad0ee582323" providerId="ADAL" clId="{C2BB2C1E-DF47-4B6A-976C-433CC21C1951}" dt="2020-09-30T07:01:52.990" v="221" actId="1076"/>
          <ac:spMkLst>
            <pc:docMk/>
            <pc:sldMk cId="3022863545" sldId="411"/>
            <ac:spMk id="158" creationId="{6AA123D1-22C4-42DD-8451-1A6EBDD95E1E}"/>
          </ac:spMkLst>
        </pc:spChg>
        <pc:spChg chg="del">
          <ac:chgData name="khoi ho" userId="c93cb340-cf97-4d7c-9739-bad0ee582323" providerId="ADAL" clId="{C2BB2C1E-DF47-4B6A-976C-433CC21C1951}" dt="2020-10-12T01:24:26.397" v="367" actId="478"/>
          <ac:spMkLst>
            <pc:docMk/>
            <pc:sldMk cId="3022863545" sldId="411"/>
            <ac:spMk id="169" creationId="{88F494D2-6841-4408-AF1C-5F24BCE245B7}"/>
          </ac:spMkLst>
        </pc:spChg>
        <pc:spChg chg="del">
          <ac:chgData name="khoi ho" userId="c93cb340-cf97-4d7c-9739-bad0ee582323" providerId="ADAL" clId="{C2BB2C1E-DF47-4B6A-976C-433CC21C1951}" dt="2020-09-30T07:06:31.249" v="248" actId="478"/>
          <ac:spMkLst>
            <pc:docMk/>
            <pc:sldMk cId="3022863545" sldId="411"/>
            <ac:spMk id="170" creationId="{CD239789-E2B6-4DED-87C5-755491A6D1F3}"/>
          </ac:spMkLst>
        </pc:spChg>
        <pc:spChg chg="mod">
          <ac:chgData name="khoi ho" userId="c93cb340-cf97-4d7c-9739-bad0ee582323" providerId="ADAL" clId="{C2BB2C1E-DF47-4B6A-976C-433CC21C1951}" dt="2020-09-30T07:07:06.763" v="256" actId="1076"/>
          <ac:spMkLst>
            <pc:docMk/>
            <pc:sldMk cId="3022863545" sldId="411"/>
            <ac:spMk id="171" creationId="{C78414DC-5A09-426E-AEE9-D2FA3AD3BD1F}"/>
          </ac:spMkLst>
        </pc:spChg>
        <pc:spChg chg="add mod">
          <ac:chgData name="khoi ho" userId="c93cb340-cf97-4d7c-9739-bad0ee582323" providerId="ADAL" clId="{C2BB2C1E-DF47-4B6A-976C-433CC21C1951}" dt="2020-09-30T07:05:51.462" v="241" actId="1076"/>
          <ac:spMkLst>
            <pc:docMk/>
            <pc:sldMk cId="3022863545" sldId="411"/>
            <ac:spMk id="176" creationId="{633AFB04-D691-4B88-9D85-6EB6529E7D15}"/>
          </ac:spMkLst>
        </pc:spChg>
        <pc:spChg chg="add mod">
          <ac:chgData name="khoi ho" userId="c93cb340-cf97-4d7c-9739-bad0ee582323" providerId="ADAL" clId="{C2BB2C1E-DF47-4B6A-976C-433CC21C1951}" dt="2020-09-30T07:05:51.462" v="241" actId="1076"/>
          <ac:spMkLst>
            <pc:docMk/>
            <pc:sldMk cId="3022863545" sldId="411"/>
            <ac:spMk id="179" creationId="{05B270C8-DB45-4156-9FEB-DAC4EE2677AA}"/>
          </ac:spMkLst>
        </pc:spChg>
        <pc:spChg chg="add mod">
          <ac:chgData name="khoi ho" userId="c93cb340-cf97-4d7c-9739-bad0ee582323" providerId="ADAL" clId="{C2BB2C1E-DF47-4B6A-976C-433CC21C1951}" dt="2020-09-30T07:07:06.763" v="256" actId="1076"/>
          <ac:spMkLst>
            <pc:docMk/>
            <pc:sldMk cId="3022863545" sldId="411"/>
            <ac:spMk id="196" creationId="{151ADA77-29B6-4424-891A-10713803F9F2}"/>
          </ac:spMkLst>
        </pc:spChg>
        <pc:spChg chg="add del mod">
          <ac:chgData name="khoi ho" userId="c93cb340-cf97-4d7c-9739-bad0ee582323" providerId="ADAL" clId="{C2BB2C1E-DF47-4B6A-976C-433CC21C1951}" dt="2020-10-03T07:08:29.786" v="330" actId="478"/>
          <ac:spMkLst>
            <pc:docMk/>
            <pc:sldMk cId="3022863545" sldId="411"/>
            <ac:spMk id="221" creationId="{AEEE1555-3B95-458B-9AA2-3A9C3FBC274B}"/>
          </ac:spMkLst>
        </pc:spChg>
        <pc:spChg chg="add del mod">
          <ac:chgData name="khoi ho" userId="c93cb340-cf97-4d7c-9739-bad0ee582323" providerId="ADAL" clId="{C2BB2C1E-DF47-4B6A-976C-433CC21C1951}" dt="2020-10-03T07:08:29.786" v="330" actId="478"/>
          <ac:spMkLst>
            <pc:docMk/>
            <pc:sldMk cId="3022863545" sldId="411"/>
            <ac:spMk id="222" creationId="{E155088C-A85D-4900-917A-E272EE72E74F}"/>
          </ac:spMkLst>
        </pc:spChg>
        <pc:spChg chg="mod">
          <ac:chgData name="khoi ho" userId="c93cb340-cf97-4d7c-9739-bad0ee582323" providerId="ADAL" clId="{C2BB2C1E-DF47-4B6A-976C-433CC21C1951}" dt="2020-10-02T10:42:52.359" v="294" actId="1076"/>
          <ac:spMkLst>
            <pc:docMk/>
            <pc:sldMk cId="3022863545" sldId="411"/>
            <ac:spMk id="442" creationId="{9DA83F5F-CCC5-4052-85E6-FD1A34AE7935}"/>
          </ac:spMkLst>
        </pc:spChg>
        <pc:spChg chg="mod">
          <ac:chgData name="khoi ho" userId="c93cb340-cf97-4d7c-9739-bad0ee582323" providerId="ADAL" clId="{C2BB2C1E-DF47-4B6A-976C-433CC21C1951}" dt="2020-10-02T10:46:22.993" v="323" actId="20577"/>
          <ac:spMkLst>
            <pc:docMk/>
            <pc:sldMk cId="3022863545" sldId="411"/>
            <ac:spMk id="448" creationId="{8CC366E0-95A8-42FC-87F1-095000584BBD}"/>
          </ac:spMkLst>
        </pc:spChg>
        <pc:spChg chg="mod">
          <ac:chgData name="khoi ho" userId="c93cb340-cf97-4d7c-9739-bad0ee582323" providerId="ADAL" clId="{C2BB2C1E-DF47-4B6A-976C-433CC21C1951}" dt="2020-10-02T10:46:08.931" v="320" actId="1076"/>
          <ac:spMkLst>
            <pc:docMk/>
            <pc:sldMk cId="3022863545" sldId="411"/>
            <ac:spMk id="687" creationId="{FFD52A56-253A-428D-AB18-F8A3C2E622CB}"/>
          </ac:spMkLst>
        </pc:spChg>
        <pc:spChg chg="mod">
          <ac:chgData name="khoi ho" userId="c93cb340-cf97-4d7c-9739-bad0ee582323" providerId="ADAL" clId="{C2BB2C1E-DF47-4B6A-976C-433CC21C1951}" dt="2020-10-02T10:46:08.931" v="320" actId="1076"/>
          <ac:spMkLst>
            <pc:docMk/>
            <pc:sldMk cId="3022863545" sldId="411"/>
            <ac:spMk id="688" creationId="{3CC0C569-4BE3-4BDB-9C84-D14029A12799}"/>
          </ac:spMkLst>
        </pc:spChg>
        <pc:spChg chg="del">
          <ac:chgData name="khoi ho" userId="c93cb340-cf97-4d7c-9739-bad0ee582323" providerId="ADAL" clId="{C2BB2C1E-DF47-4B6A-976C-433CC21C1951}" dt="2020-10-02T10:41:13.738" v="285" actId="478"/>
          <ac:spMkLst>
            <pc:docMk/>
            <pc:sldMk cId="3022863545" sldId="411"/>
            <ac:spMk id="715" creationId="{44D3A3FF-9FD8-4431-88FB-184F57F52A6D}"/>
          </ac:spMkLst>
        </pc:spChg>
        <pc:spChg chg="del">
          <ac:chgData name="khoi ho" userId="c93cb340-cf97-4d7c-9739-bad0ee582323" providerId="ADAL" clId="{C2BB2C1E-DF47-4B6A-976C-433CC21C1951}" dt="2020-10-02T10:41:16.768" v="287" actId="478"/>
          <ac:spMkLst>
            <pc:docMk/>
            <pc:sldMk cId="3022863545" sldId="411"/>
            <ac:spMk id="716" creationId="{D75B2FF1-700B-46F5-8293-756E5007F66E}"/>
          </ac:spMkLst>
        </pc:spChg>
        <pc:spChg chg="mod">
          <ac:chgData name="khoi ho" userId="c93cb340-cf97-4d7c-9739-bad0ee582323" providerId="ADAL" clId="{C2BB2C1E-DF47-4B6A-976C-433CC21C1951}" dt="2020-10-02T10:27:34.088" v="274" actId="1076"/>
          <ac:spMkLst>
            <pc:docMk/>
            <pc:sldMk cId="3022863545" sldId="411"/>
            <ac:spMk id="741" creationId="{C1D508DC-4275-482D-9F25-301813A15E89}"/>
          </ac:spMkLst>
        </pc:spChg>
        <pc:spChg chg="mod">
          <ac:chgData name="khoi ho" userId="c93cb340-cf97-4d7c-9739-bad0ee582323" providerId="ADAL" clId="{C2BB2C1E-DF47-4B6A-976C-433CC21C1951}" dt="2020-09-30T06:59:50.315" v="206" actId="1076"/>
          <ac:spMkLst>
            <pc:docMk/>
            <pc:sldMk cId="3022863545" sldId="411"/>
            <ac:spMk id="744" creationId="{5F5A82EC-1321-4554-90B4-1B3988DB25C9}"/>
          </ac:spMkLst>
        </pc:spChg>
        <pc:spChg chg="del">
          <ac:chgData name="khoi ho" userId="c93cb340-cf97-4d7c-9739-bad0ee582323" providerId="ADAL" clId="{C2BB2C1E-DF47-4B6A-976C-433CC21C1951}" dt="2020-10-12T01:24:24.114" v="366" actId="478"/>
          <ac:spMkLst>
            <pc:docMk/>
            <pc:sldMk cId="3022863545" sldId="411"/>
            <ac:spMk id="757" creationId="{47C655C7-FC6C-4E50-9BE0-8F8378D9D8FA}"/>
          </ac:spMkLst>
        </pc:spChg>
        <pc:spChg chg="del">
          <ac:chgData name="khoi ho" userId="c93cb340-cf97-4d7c-9739-bad0ee582323" providerId="ADAL" clId="{C2BB2C1E-DF47-4B6A-976C-433CC21C1951}" dt="2020-10-12T01:24:24.114" v="366" actId="478"/>
          <ac:spMkLst>
            <pc:docMk/>
            <pc:sldMk cId="3022863545" sldId="411"/>
            <ac:spMk id="758" creationId="{54229105-9C02-4C88-A774-38B88A063D19}"/>
          </ac:spMkLst>
        </pc:spChg>
        <pc:spChg chg="del">
          <ac:chgData name="khoi ho" userId="c93cb340-cf97-4d7c-9739-bad0ee582323" providerId="ADAL" clId="{C2BB2C1E-DF47-4B6A-976C-433CC21C1951}" dt="2020-10-12T01:24:24.114" v="366" actId="478"/>
          <ac:spMkLst>
            <pc:docMk/>
            <pc:sldMk cId="3022863545" sldId="411"/>
            <ac:spMk id="759" creationId="{1033B231-7A56-44FC-97C2-A72DE77D52BC}"/>
          </ac:spMkLst>
        </pc:spChg>
        <pc:spChg chg="del">
          <ac:chgData name="khoi ho" userId="c93cb340-cf97-4d7c-9739-bad0ee582323" providerId="ADAL" clId="{C2BB2C1E-DF47-4B6A-976C-433CC21C1951}" dt="2020-10-12T01:24:24.114" v="366" actId="478"/>
          <ac:spMkLst>
            <pc:docMk/>
            <pc:sldMk cId="3022863545" sldId="411"/>
            <ac:spMk id="769" creationId="{0B54BB71-A382-4940-A014-36D3725D5B47}"/>
          </ac:spMkLst>
        </pc:spChg>
        <pc:spChg chg="del">
          <ac:chgData name="khoi ho" userId="c93cb340-cf97-4d7c-9739-bad0ee582323" providerId="ADAL" clId="{C2BB2C1E-DF47-4B6A-976C-433CC21C1951}" dt="2020-10-12T01:24:24.114" v="366" actId="478"/>
          <ac:spMkLst>
            <pc:docMk/>
            <pc:sldMk cId="3022863545" sldId="411"/>
            <ac:spMk id="774" creationId="{8E10E6D0-71A6-4728-9B3F-810F0C00F6AE}"/>
          </ac:spMkLst>
        </pc:spChg>
        <pc:spChg chg="del">
          <ac:chgData name="khoi ho" userId="c93cb340-cf97-4d7c-9739-bad0ee582323" providerId="ADAL" clId="{C2BB2C1E-DF47-4B6A-976C-433CC21C1951}" dt="2020-10-12T01:24:24.114" v="366" actId="478"/>
          <ac:spMkLst>
            <pc:docMk/>
            <pc:sldMk cId="3022863545" sldId="411"/>
            <ac:spMk id="775" creationId="{F9066B54-474C-486F-9B78-2D43C6C51F6D}"/>
          </ac:spMkLst>
        </pc:spChg>
        <pc:spChg chg="del">
          <ac:chgData name="khoi ho" userId="c93cb340-cf97-4d7c-9739-bad0ee582323" providerId="ADAL" clId="{C2BB2C1E-DF47-4B6A-976C-433CC21C1951}" dt="2020-10-12T01:24:24.114" v="366" actId="478"/>
          <ac:spMkLst>
            <pc:docMk/>
            <pc:sldMk cId="3022863545" sldId="411"/>
            <ac:spMk id="776" creationId="{97375D51-A6DE-4CF5-A7AF-410548E3223C}"/>
          </ac:spMkLst>
        </pc:spChg>
        <pc:spChg chg="del">
          <ac:chgData name="khoi ho" userId="c93cb340-cf97-4d7c-9739-bad0ee582323" providerId="ADAL" clId="{C2BB2C1E-DF47-4B6A-976C-433CC21C1951}" dt="2020-10-12T01:24:24.114" v="366" actId="478"/>
          <ac:spMkLst>
            <pc:docMk/>
            <pc:sldMk cId="3022863545" sldId="411"/>
            <ac:spMk id="777" creationId="{85C2D2BA-D6B1-4673-9B78-666F241829EF}"/>
          </ac:spMkLst>
        </pc:spChg>
        <pc:spChg chg="del">
          <ac:chgData name="khoi ho" userId="c93cb340-cf97-4d7c-9739-bad0ee582323" providerId="ADAL" clId="{C2BB2C1E-DF47-4B6A-976C-433CC21C1951}" dt="2020-10-12T01:24:24.114" v="366" actId="478"/>
          <ac:spMkLst>
            <pc:docMk/>
            <pc:sldMk cId="3022863545" sldId="411"/>
            <ac:spMk id="778" creationId="{2B826850-7166-4C96-8BC8-0B3088B9126A}"/>
          </ac:spMkLst>
        </pc:spChg>
        <pc:spChg chg="del">
          <ac:chgData name="khoi ho" userId="c93cb340-cf97-4d7c-9739-bad0ee582323" providerId="ADAL" clId="{C2BB2C1E-DF47-4B6A-976C-433CC21C1951}" dt="2020-10-12T01:24:24.114" v="366" actId="478"/>
          <ac:spMkLst>
            <pc:docMk/>
            <pc:sldMk cId="3022863545" sldId="411"/>
            <ac:spMk id="779" creationId="{796BFE48-4618-410C-85F9-1104581B9CF5}"/>
          </ac:spMkLst>
        </pc:spChg>
        <pc:spChg chg="del">
          <ac:chgData name="khoi ho" userId="c93cb340-cf97-4d7c-9739-bad0ee582323" providerId="ADAL" clId="{C2BB2C1E-DF47-4B6A-976C-433CC21C1951}" dt="2020-10-12T01:24:24.114" v="366" actId="478"/>
          <ac:spMkLst>
            <pc:docMk/>
            <pc:sldMk cId="3022863545" sldId="411"/>
            <ac:spMk id="780" creationId="{5521D00B-67ED-4CD5-9330-CC275B0382DB}"/>
          </ac:spMkLst>
        </pc:spChg>
        <pc:spChg chg="del">
          <ac:chgData name="khoi ho" userId="c93cb340-cf97-4d7c-9739-bad0ee582323" providerId="ADAL" clId="{C2BB2C1E-DF47-4B6A-976C-433CC21C1951}" dt="2020-10-12T01:24:24.114" v="366" actId="478"/>
          <ac:spMkLst>
            <pc:docMk/>
            <pc:sldMk cId="3022863545" sldId="411"/>
            <ac:spMk id="781" creationId="{2EA16F88-A052-4AE5-8FA0-DC385F6C733C}"/>
          </ac:spMkLst>
        </pc:spChg>
        <pc:spChg chg="del">
          <ac:chgData name="khoi ho" userId="c93cb340-cf97-4d7c-9739-bad0ee582323" providerId="ADAL" clId="{C2BB2C1E-DF47-4B6A-976C-433CC21C1951}" dt="2020-10-12T01:24:24.114" v="366" actId="478"/>
          <ac:spMkLst>
            <pc:docMk/>
            <pc:sldMk cId="3022863545" sldId="411"/>
            <ac:spMk id="782" creationId="{A1BB110D-C7B0-4113-895A-BEDD2447E9B8}"/>
          </ac:spMkLst>
        </pc:spChg>
        <pc:spChg chg="del">
          <ac:chgData name="khoi ho" userId="c93cb340-cf97-4d7c-9739-bad0ee582323" providerId="ADAL" clId="{C2BB2C1E-DF47-4B6A-976C-433CC21C1951}" dt="2020-10-12T01:24:24.114" v="366" actId="478"/>
          <ac:spMkLst>
            <pc:docMk/>
            <pc:sldMk cId="3022863545" sldId="411"/>
            <ac:spMk id="799" creationId="{5FEA845B-4D44-4CB4-BF16-BBA25DC66B76}"/>
          </ac:spMkLst>
        </pc:spChg>
        <pc:spChg chg="del">
          <ac:chgData name="khoi ho" userId="c93cb340-cf97-4d7c-9739-bad0ee582323" providerId="ADAL" clId="{C2BB2C1E-DF47-4B6A-976C-433CC21C1951}" dt="2020-10-12T01:24:24.114" v="366" actId="478"/>
          <ac:spMkLst>
            <pc:docMk/>
            <pc:sldMk cId="3022863545" sldId="411"/>
            <ac:spMk id="803" creationId="{8380DC41-7507-45D1-B68D-F0BEF56246FF}"/>
          </ac:spMkLst>
        </pc:spChg>
        <pc:spChg chg="del">
          <ac:chgData name="khoi ho" userId="c93cb340-cf97-4d7c-9739-bad0ee582323" providerId="ADAL" clId="{C2BB2C1E-DF47-4B6A-976C-433CC21C1951}" dt="2020-10-12T01:24:24.114" v="366" actId="478"/>
          <ac:spMkLst>
            <pc:docMk/>
            <pc:sldMk cId="3022863545" sldId="411"/>
            <ac:spMk id="805" creationId="{B8D39206-92E6-41A0-8E41-B3153C69BF0B}"/>
          </ac:spMkLst>
        </pc:spChg>
        <pc:spChg chg="del">
          <ac:chgData name="khoi ho" userId="c93cb340-cf97-4d7c-9739-bad0ee582323" providerId="ADAL" clId="{C2BB2C1E-DF47-4B6A-976C-433CC21C1951}" dt="2020-10-12T01:24:24.114" v="366" actId="478"/>
          <ac:spMkLst>
            <pc:docMk/>
            <pc:sldMk cId="3022863545" sldId="411"/>
            <ac:spMk id="806" creationId="{0EDFC95F-761E-457E-AB72-2E5981C71BFE}"/>
          </ac:spMkLst>
        </pc:spChg>
        <pc:spChg chg="del">
          <ac:chgData name="khoi ho" userId="c93cb340-cf97-4d7c-9739-bad0ee582323" providerId="ADAL" clId="{C2BB2C1E-DF47-4B6A-976C-433CC21C1951}" dt="2020-10-12T01:24:24.114" v="366" actId="478"/>
          <ac:spMkLst>
            <pc:docMk/>
            <pc:sldMk cId="3022863545" sldId="411"/>
            <ac:spMk id="807" creationId="{F75A5EDA-7C29-487A-9682-38CAD450CA75}"/>
          </ac:spMkLst>
        </pc:spChg>
        <pc:spChg chg="del">
          <ac:chgData name="khoi ho" userId="c93cb340-cf97-4d7c-9739-bad0ee582323" providerId="ADAL" clId="{C2BB2C1E-DF47-4B6A-976C-433CC21C1951}" dt="2020-10-12T01:24:24.114" v="366" actId="478"/>
          <ac:spMkLst>
            <pc:docMk/>
            <pc:sldMk cId="3022863545" sldId="411"/>
            <ac:spMk id="808" creationId="{73C3C30E-F65E-41A3-8005-3CB5DFEFBFF8}"/>
          </ac:spMkLst>
        </pc:spChg>
        <pc:spChg chg="del">
          <ac:chgData name="khoi ho" userId="c93cb340-cf97-4d7c-9739-bad0ee582323" providerId="ADAL" clId="{C2BB2C1E-DF47-4B6A-976C-433CC21C1951}" dt="2020-10-12T01:24:24.114" v="366" actId="478"/>
          <ac:spMkLst>
            <pc:docMk/>
            <pc:sldMk cId="3022863545" sldId="411"/>
            <ac:spMk id="809" creationId="{C86AA124-5336-4C35-BC48-FEC4285B664E}"/>
          </ac:spMkLst>
        </pc:spChg>
        <pc:spChg chg="del">
          <ac:chgData name="khoi ho" userId="c93cb340-cf97-4d7c-9739-bad0ee582323" providerId="ADAL" clId="{C2BB2C1E-DF47-4B6A-976C-433CC21C1951}" dt="2020-10-12T01:24:24.114" v="366" actId="478"/>
          <ac:spMkLst>
            <pc:docMk/>
            <pc:sldMk cId="3022863545" sldId="411"/>
            <ac:spMk id="810" creationId="{48A91177-CEC4-46F7-9E52-5C1F4631D186}"/>
          </ac:spMkLst>
        </pc:spChg>
        <pc:spChg chg="del">
          <ac:chgData name="khoi ho" userId="c93cb340-cf97-4d7c-9739-bad0ee582323" providerId="ADAL" clId="{C2BB2C1E-DF47-4B6A-976C-433CC21C1951}" dt="2020-10-12T01:24:24.114" v="366" actId="478"/>
          <ac:spMkLst>
            <pc:docMk/>
            <pc:sldMk cId="3022863545" sldId="411"/>
            <ac:spMk id="811" creationId="{A7B9AF16-3E77-46F1-8224-1076B5053E59}"/>
          </ac:spMkLst>
        </pc:spChg>
        <pc:spChg chg="del">
          <ac:chgData name="khoi ho" userId="c93cb340-cf97-4d7c-9739-bad0ee582323" providerId="ADAL" clId="{C2BB2C1E-DF47-4B6A-976C-433CC21C1951}" dt="2020-10-12T01:24:24.114" v="366" actId="478"/>
          <ac:spMkLst>
            <pc:docMk/>
            <pc:sldMk cId="3022863545" sldId="411"/>
            <ac:spMk id="813" creationId="{4EE70EBC-9836-4FFA-9B2C-4A5A6B9C5001}"/>
          </ac:spMkLst>
        </pc:spChg>
        <pc:spChg chg="del">
          <ac:chgData name="khoi ho" userId="c93cb340-cf97-4d7c-9739-bad0ee582323" providerId="ADAL" clId="{C2BB2C1E-DF47-4B6A-976C-433CC21C1951}" dt="2020-10-12T01:24:24.114" v="366" actId="478"/>
          <ac:spMkLst>
            <pc:docMk/>
            <pc:sldMk cId="3022863545" sldId="411"/>
            <ac:spMk id="814" creationId="{4A337181-3F25-483A-A8BD-0CA88ADC7075}"/>
          </ac:spMkLst>
        </pc:spChg>
        <pc:spChg chg="del">
          <ac:chgData name="khoi ho" userId="c93cb340-cf97-4d7c-9739-bad0ee582323" providerId="ADAL" clId="{C2BB2C1E-DF47-4B6A-976C-433CC21C1951}" dt="2020-10-12T01:24:24.114" v="366" actId="478"/>
          <ac:spMkLst>
            <pc:docMk/>
            <pc:sldMk cId="3022863545" sldId="411"/>
            <ac:spMk id="815" creationId="{6B11EC0A-CEAD-472F-9D31-DEB5B9028BFA}"/>
          </ac:spMkLst>
        </pc:spChg>
        <pc:spChg chg="del">
          <ac:chgData name="khoi ho" userId="c93cb340-cf97-4d7c-9739-bad0ee582323" providerId="ADAL" clId="{C2BB2C1E-DF47-4B6A-976C-433CC21C1951}" dt="2020-10-12T01:24:24.114" v="366" actId="478"/>
          <ac:spMkLst>
            <pc:docMk/>
            <pc:sldMk cId="3022863545" sldId="411"/>
            <ac:spMk id="816" creationId="{3545F5F7-4BD5-43F9-BED6-45120460EFA8}"/>
          </ac:spMkLst>
        </pc:spChg>
        <pc:spChg chg="del">
          <ac:chgData name="khoi ho" userId="c93cb340-cf97-4d7c-9739-bad0ee582323" providerId="ADAL" clId="{C2BB2C1E-DF47-4B6A-976C-433CC21C1951}" dt="2020-10-12T01:24:24.114" v="366" actId="478"/>
          <ac:spMkLst>
            <pc:docMk/>
            <pc:sldMk cId="3022863545" sldId="411"/>
            <ac:spMk id="817" creationId="{06EF61E9-F9BA-4234-8B39-E9994857BAC1}"/>
          </ac:spMkLst>
        </pc:spChg>
        <pc:spChg chg="del">
          <ac:chgData name="khoi ho" userId="c93cb340-cf97-4d7c-9739-bad0ee582323" providerId="ADAL" clId="{C2BB2C1E-DF47-4B6A-976C-433CC21C1951}" dt="2020-10-12T01:24:24.114" v="366" actId="478"/>
          <ac:spMkLst>
            <pc:docMk/>
            <pc:sldMk cId="3022863545" sldId="411"/>
            <ac:spMk id="818" creationId="{CF8F44C1-5EBF-4A7C-9000-58E9C17C42F7}"/>
          </ac:spMkLst>
        </pc:spChg>
        <pc:spChg chg="del">
          <ac:chgData name="khoi ho" userId="c93cb340-cf97-4d7c-9739-bad0ee582323" providerId="ADAL" clId="{C2BB2C1E-DF47-4B6A-976C-433CC21C1951}" dt="2020-10-12T01:24:24.114" v="366" actId="478"/>
          <ac:spMkLst>
            <pc:docMk/>
            <pc:sldMk cId="3022863545" sldId="411"/>
            <ac:spMk id="819" creationId="{18F34D2B-ED28-4F3D-B2F9-97347C62FA4D}"/>
          </ac:spMkLst>
        </pc:spChg>
        <pc:spChg chg="del">
          <ac:chgData name="khoi ho" userId="c93cb340-cf97-4d7c-9739-bad0ee582323" providerId="ADAL" clId="{C2BB2C1E-DF47-4B6A-976C-433CC21C1951}" dt="2020-10-12T01:24:24.114" v="366" actId="478"/>
          <ac:spMkLst>
            <pc:docMk/>
            <pc:sldMk cId="3022863545" sldId="411"/>
            <ac:spMk id="820" creationId="{F98BA031-3DE6-4392-A95B-B281390BE457}"/>
          </ac:spMkLst>
        </pc:spChg>
        <pc:spChg chg="del">
          <ac:chgData name="khoi ho" userId="c93cb340-cf97-4d7c-9739-bad0ee582323" providerId="ADAL" clId="{C2BB2C1E-DF47-4B6A-976C-433CC21C1951}" dt="2020-10-12T01:24:21.029" v="365" actId="478"/>
          <ac:spMkLst>
            <pc:docMk/>
            <pc:sldMk cId="3022863545" sldId="411"/>
            <ac:spMk id="821" creationId="{946BA0AF-BBB7-4D12-9EC9-330842C051FA}"/>
          </ac:spMkLst>
        </pc:spChg>
        <pc:grpChg chg="mod">
          <ac:chgData name="khoi ho" userId="c93cb340-cf97-4d7c-9739-bad0ee582323" providerId="ADAL" clId="{C2BB2C1E-DF47-4B6A-976C-433CC21C1951}" dt="2020-10-02T09:46:38.379" v="271" actId="1076"/>
          <ac:grpSpMkLst>
            <pc:docMk/>
            <pc:sldMk cId="3022863545" sldId="411"/>
            <ac:grpSpMk id="132" creationId="{E113D0B3-B956-4F7F-AD7A-6B5C577F4E64}"/>
          </ac:grpSpMkLst>
        </pc:grpChg>
        <pc:grpChg chg="del">
          <ac:chgData name="khoi ho" userId="c93cb340-cf97-4d7c-9739-bad0ee582323" providerId="ADAL" clId="{C2BB2C1E-DF47-4B6A-976C-433CC21C1951}" dt="2020-10-12T01:24:24.114" v="366" actId="478"/>
          <ac:grpSpMkLst>
            <pc:docMk/>
            <pc:sldMk cId="3022863545" sldId="411"/>
            <ac:grpSpMk id="760" creationId="{8E466DD6-F1E2-4D07-BB6E-C65037AB546D}"/>
          </ac:grpSpMkLst>
        </pc:grpChg>
        <pc:grpChg chg="del">
          <ac:chgData name="khoi ho" userId="c93cb340-cf97-4d7c-9739-bad0ee582323" providerId="ADAL" clId="{C2BB2C1E-DF47-4B6A-976C-433CC21C1951}" dt="2020-10-12T01:24:24.114" v="366" actId="478"/>
          <ac:grpSpMkLst>
            <pc:docMk/>
            <pc:sldMk cId="3022863545" sldId="411"/>
            <ac:grpSpMk id="763" creationId="{A5579B01-9EDE-4579-8987-D930D3602AA8}"/>
          </ac:grpSpMkLst>
        </pc:grpChg>
        <pc:grpChg chg="del">
          <ac:chgData name="khoi ho" userId="c93cb340-cf97-4d7c-9739-bad0ee582323" providerId="ADAL" clId="{C2BB2C1E-DF47-4B6A-976C-433CC21C1951}" dt="2020-10-12T01:24:24.114" v="366" actId="478"/>
          <ac:grpSpMkLst>
            <pc:docMk/>
            <pc:sldMk cId="3022863545" sldId="411"/>
            <ac:grpSpMk id="766" creationId="{D33F27E1-F5C6-4DC2-845A-155C92CE951A}"/>
          </ac:grpSpMkLst>
        </pc:grpChg>
        <pc:grpChg chg="del">
          <ac:chgData name="khoi ho" userId="c93cb340-cf97-4d7c-9739-bad0ee582323" providerId="ADAL" clId="{C2BB2C1E-DF47-4B6A-976C-433CC21C1951}" dt="2020-10-12T01:24:24.114" v="366" actId="478"/>
          <ac:grpSpMkLst>
            <pc:docMk/>
            <pc:sldMk cId="3022863545" sldId="411"/>
            <ac:grpSpMk id="770" creationId="{9CDADAD2-7B35-47EA-A451-E96A029F8A90}"/>
          </ac:grpSpMkLst>
        </pc:grpChg>
        <pc:grpChg chg="del">
          <ac:chgData name="khoi ho" userId="c93cb340-cf97-4d7c-9739-bad0ee582323" providerId="ADAL" clId="{C2BB2C1E-DF47-4B6A-976C-433CC21C1951}" dt="2020-10-12T01:24:24.114" v="366" actId="478"/>
          <ac:grpSpMkLst>
            <pc:docMk/>
            <pc:sldMk cId="3022863545" sldId="411"/>
            <ac:grpSpMk id="788" creationId="{73C1531D-09CB-49FA-B0E6-77EED6644E74}"/>
          </ac:grpSpMkLst>
        </pc:grpChg>
        <pc:cxnChg chg="del mod">
          <ac:chgData name="khoi ho" userId="c93cb340-cf97-4d7c-9739-bad0ee582323" providerId="ADAL" clId="{C2BB2C1E-DF47-4B6A-976C-433CC21C1951}" dt="2020-09-30T07:01:18.791" v="210" actId="478"/>
          <ac:cxnSpMkLst>
            <pc:docMk/>
            <pc:sldMk cId="3022863545" sldId="411"/>
            <ac:cxnSpMk id="41" creationId="{CA6EAF19-3E5A-49CC-9480-DB696B25753C}"/>
          </ac:cxnSpMkLst>
        </pc:cxnChg>
        <pc:cxnChg chg="add mod">
          <ac:chgData name="khoi ho" userId="c93cb340-cf97-4d7c-9739-bad0ee582323" providerId="ADAL" clId="{C2BB2C1E-DF47-4B6A-976C-433CC21C1951}" dt="2020-09-30T07:05:51.462" v="241" actId="1076"/>
          <ac:cxnSpMkLst>
            <pc:docMk/>
            <pc:sldMk cId="3022863545" sldId="411"/>
            <ac:cxnSpMk id="180" creationId="{DA7BEDED-1F77-4A1C-A289-5CE847EB640E}"/>
          </ac:cxnSpMkLst>
        </pc:cxnChg>
        <pc:cxnChg chg="add del mod">
          <ac:chgData name="khoi ho" userId="c93cb340-cf97-4d7c-9739-bad0ee582323" providerId="ADAL" clId="{C2BB2C1E-DF47-4B6A-976C-433CC21C1951}" dt="2020-09-30T07:02:56.989" v="237" actId="478"/>
          <ac:cxnSpMkLst>
            <pc:docMk/>
            <pc:sldMk cId="3022863545" sldId="411"/>
            <ac:cxnSpMk id="184" creationId="{E799F526-2D4F-459F-9722-6EBBD9ED574F}"/>
          </ac:cxnSpMkLst>
        </pc:cxnChg>
        <pc:cxnChg chg="add del mod">
          <ac:chgData name="khoi ho" userId="c93cb340-cf97-4d7c-9739-bad0ee582323" providerId="ADAL" clId="{C2BB2C1E-DF47-4B6A-976C-433CC21C1951}" dt="2020-09-30T07:06:54.871" v="255" actId="478"/>
          <ac:cxnSpMkLst>
            <pc:docMk/>
            <pc:sldMk cId="3022863545" sldId="411"/>
            <ac:cxnSpMk id="187" creationId="{4AC26610-7CAD-4B3F-9758-E996322AD411}"/>
          </ac:cxnSpMkLst>
        </pc:cxnChg>
        <pc:cxnChg chg="add mod">
          <ac:chgData name="khoi ho" userId="c93cb340-cf97-4d7c-9739-bad0ee582323" providerId="ADAL" clId="{C2BB2C1E-DF47-4B6A-976C-433CC21C1951}" dt="2020-09-30T07:07:06.763" v="256" actId="1076"/>
          <ac:cxnSpMkLst>
            <pc:docMk/>
            <pc:sldMk cId="3022863545" sldId="411"/>
            <ac:cxnSpMk id="199" creationId="{35F9733B-8576-4F59-9B41-E7A702D3E76D}"/>
          </ac:cxnSpMkLst>
        </pc:cxnChg>
        <pc:cxnChg chg="add mod">
          <ac:chgData name="khoi ho" userId="c93cb340-cf97-4d7c-9739-bad0ee582323" providerId="ADAL" clId="{C2BB2C1E-DF47-4B6A-976C-433CC21C1951}" dt="2020-09-30T07:06:10.215" v="247" actId="14100"/>
          <ac:cxnSpMkLst>
            <pc:docMk/>
            <pc:sldMk cId="3022863545" sldId="411"/>
            <ac:cxnSpMk id="204" creationId="{29D6543F-B6FB-4A92-92B8-9F2DAE0BE792}"/>
          </ac:cxnSpMkLst>
        </pc:cxnChg>
        <pc:cxnChg chg="add mod">
          <ac:chgData name="khoi ho" userId="c93cb340-cf97-4d7c-9739-bad0ee582323" providerId="ADAL" clId="{C2BB2C1E-DF47-4B6A-976C-433CC21C1951}" dt="2020-09-30T07:07:06.763" v="256" actId="1076"/>
          <ac:cxnSpMkLst>
            <pc:docMk/>
            <pc:sldMk cId="3022863545" sldId="411"/>
            <ac:cxnSpMk id="206" creationId="{6CA56205-7D41-4E8E-988F-A42DA119FAAC}"/>
          </ac:cxnSpMkLst>
        </pc:cxnChg>
        <pc:cxnChg chg="mod">
          <ac:chgData name="khoi ho" userId="c93cb340-cf97-4d7c-9739-bad0ee582323" providerId="ADAL" clId="{C2BB2C1E-DF47-4B6A-976C-433CC21C1951}" dt="2020-10-02T09:46:38.379" v="271" actId="1076"/>
          <ac:cxnSpMkLst>
            <pc:docMk/>
            <pc:sldMk cId="3022863545" sldId="411"/>
            <ac:cxnSpMk id="213" creationId="{66F508C7-3A8F-4EDF-B9EC-F92FCB743C46}"/>
          </ac:cxnSpMkLst>
        </pc:cxnChg>
        <pc:cxnChg chg="mod">
          <ac:chgData name="khoi ho" userId="c93cb340-cf97-4d7c-9739-bad0ee582323" providerId="ADAL" clId="{C2BB2C1E-DF47-4B6A-976C-433CC21C1951}" dt="2020-10-02T09:46:38.379" v="271" actId="1076"/>
          <ac:cxnSpMkLst>
            <pc:docMk/>
            <pc:sldMk cId="3022863545" sldId="411"/>
            <ac:cxnSpMk id="218" creationId="{CAF2C90B-7F13-4944-851C-39189CF0BB6F}"/>
          </ac:cxnSpMkLst>
        </pc:cxnChg>
        <pc:cxnChg chg="add del mod">
          <ac:chgData name="khoi ho" userId="c93cb340-cf97-4d7c-9739-bad0ee582323" providerId="ADAL" clId="{C2BB2C1E-DF47-4B6A-976C-433CC21C1951}" dt="2020-10-02T10:42:17.023" v="291" actId="478"/>
          <ac:cxnSpMkLst>
            <pc:docMk/>
            <pc:sldMk cId="3022863545" sldId="411"/>
            <ac:cxnSpMk id="232" creationId="{320C9A90-AF60-4471-B11F-48917875FFDD}"/>
          </ac:cxnSpMkLst>
        </pc:cxnChg>
        <pc:cxnChg chg="add mod">
          <ac:chgData name="khoi ho" userId="c93cb340-cf97-4d7c-9739-bad0ee582323" providerId="ADAL" clId="{C2BB2C1E-DF47-4B6A-976C-433CC21C1951}" dt="2020-10-02T10:46:22.816" v="322" actId="20577"/>
          <ac:cxnSpMkLst>
            <pc:docMk/>
            <pc:sldMk cId="3022863545" sldId="411"/>
            <ac:cxnSpMk id="238" creationId="{201A8FF1-4527-443A-9079-9423AE27DC18}"/>
          </ac:cxnSpMkLst>
        </pc:cxnChg>
        <pc:cxnChg chg="add mod">
          <ac:chgData name="khoi ho" userId="c93cb340-cf97-4d7c-9739-bad0ee582323" providerId="ADAL" clId="{C2BB2C1E-DF47-4B6A-976C-433CC21C1951}" dt="2020-10-02T10:43:44.525" v="307" actId="571"/>
          <ac:cxnSpMkLst>
            <pc:docMk/>
            <pc:sldMk cId="3022863545" sldId="411"/>
            <ac:cxnSpMk id="243" creationId="{DB855FFE-BA5C-46AB-80C0-439E7FF5125B}"/>
          </ac:cxnSpMkLst>
        </pc:cxnChg>
        <pc:cxnChg chg="add mod">
          <ac:chgData name="khoi ho" userId="c93cb340-cf97-4d7c-9739-bad0ee582323" providerId="ADAL" clId="{C2BB2C1E-DF47-4B6A-976C-433CC21C1951}" dt="2020-10-02T10:46:08.931" v="320" actId="1076"/>
          <ac:cxnSpMkLst>
            <pc:docMk/>
            <pc:sldMk cId="3022863545" sldId="411"/>
            <ac:cxnSpMk id="248" creationId="{10841333-57A8-4DD8-A7E3-BF039F541A00}"/>
          </ac:cxnSpMkLst>
        </pc:cxnChg>
        <pc:cxnChg chg="add mod">
          <ac:chgData name="khoi ho" userId="c93cb340-cf97-4d7c-9739-bad0ee582323" providerId="ADAL" clId="{C2BB2C1E-DF47-4B6A-976C-433CC21C1951}" dt="2020-10-02T10:46:08.931" v="320" actId="1076"/>
          <ac:cxnSpMkLst>
            <pc:docMk/>
            <pc:sldMk cId="3022863545" sldId="411"/>
            <ac:cxnSpMk id="253" creationId="{CCF2708F-91DE-4645-8109-48F4A6B39E66}"/>
          </ac:cxnSpMkLst>
        </pc:cxnChg>
        <pc:cxnChg chg="mod">
          <ac:chgData name="khoi ho" userId="c93cb340-cf97-4d7c-9739-bad0ee582323" providerId="ADAL" clId="{C2BB2C1E-DF47-4B6A-976C-433CC21C1951}" dt="2020-10-02T10:46:22.816" v="322" actId="20577"/>
          <ac:cxnSpMkLst>
            <pc:docMk/>
            <pc:sldMk cId="3022863545" sldId="411"/>
            <ac:cxnSpMk id="462" creationId="{D156288E-F936-46AC-A39D-CBAE6F9403C6}"/>
          </ac:cxnSpMkLst>
        </pc:cxnChg>
        <pc:cxnChg chg="mod">
          <ac:chgData name="khoi ho" userId="c93cb340-cf97-4d7c-9739-bad0ee582323" providerId="ADAL" clId="{C2BB2C1E-DF47-4B6A-976C-433CC21C1951}" dt="2020-10-12T01:25:11.860" v="372" actId="14100"/>
          <ac:cxnSpMkLst>
            <pc:docMk/>
            <pc:sldMk cId="3022863545" sldId="411"/>
            <ac:cxnSpMk id="559" creationId="{39B91BBB-24D7-4A26-AB25-A860A51C604E}"/>
          </ac:cxnSpMkLst>
        </pc:cxnChg>
        <pc:cxnChg chg="mod">
          <ac:chgData name="khoi ho" userId="c93cb340-cf97-4d7c-9739-bad0ee582323" providerId="ADAL" clId="{C2BB2C1E-DF47-4B6A-976C-433CC21C1951}" dt="2020-10-03T07:08:15.029" v="326" actId="14100"/>
          <ac:cxnSpMkLst>
            <pc:docMk/>
            <pc:sldMk cId="3022863545" sldId="411"/>
            <ac:cxnSpMk id="565" creationId="{BEF6439A-5491-49EA-BF83-7E45B1024183}"/>
          </ac:cxnSpMkLst>
        </pc:cxnChg>
        <pc:cxnChg chg="mod">
          <ac:chgData name="khoi ho" userId="c93cb340-cf97-4d7c-9739-bad0ee582323" providerId="ADAL" clId="{C2BB2C1E-DF47-4B6A-976C-433CC21C1951}" dt="2020-10-12T01:25:50.920" v="373" actId="14100"/>
          <ac:cxnSpMkLst>
            <pc:docMk/>
            <pc:sldMk cId="3022863545" sldId="411"/>
            <ac:cxnSpMk id="570" creationId="{C9336884-13DE-4FED-9A9D-FD0740C8839A}"/>
          </ac:cxnSpMkLst>
        </pc:cxnChg>
        <pc:cxnChg chg="mod">
          <ac:chgData name="khoi ho" userId="c93cb340-cf97-4d7c-9739-bad0ee582323" providerId="ADAL" clId="{C2BB2C1E-DF47-4B6A-976C-433CC21C1951}" dt="2020-10-12T01:25:08.553" v="371" actId="1076"/>
          <ac:cxnSpMkLst>
            <pc:docMk/>
            <pc:sldMk cId="3022863545" sldId="411"/>
            <ac:cxnSpMk id="623" creationId="{1696CC9A-D0AE-4E62-9554-EEACAA46BDFA}"/>
          </ac:cxnSpMkLst>
        </pc:cxnChg>
        <pc:cxnChg chg="mod">
          <ac:chgData name="khoi ho" userId="c93cb340-cf97-4d7c-9739-bad0ee582323" providerId="ADAL" clId="{C2BB2C1E-DF47-4B6A-976C-433CC21C1951}" dt="2020-09-30T06:59:50.315" v="206" actId="1076"/>
          <ac:cxnSpMkLst>
            <pc:docMk/>
            <pc:sldMk cId="3022863545" sldId="411"/>
            <ac:cxnSpMk id="648" creationId="{D0B3D9C2-3E90-41F9-BD52-D73E5144504D}"/>
          </ac:cxnSpMkLst>
        </pc:cxnChg>
        <pc:cxnChg chg="del mod">
          <ac:chgData name="khoi ho" userId="c93cb340-cf97-4d7c-9739-bad0ee582323" providerId="ADAL" clId="{C2BB2C1E-DF47-4B6A-976C-433CC21C1951}" dt="2020-10-02T10:42:15.903" v="290" actId="478"/>
          <ac:cxnSpMkLst>
            <pc:docMk/>
            <pc:sldMk cId="3022863545" sldId="411"/>
            <ac:cxnSpMk id="710" creationId="{D8615967-3A0E-4F9D-8F70-91ED3076DE5E}"/>
          </ac:cxnSpMkLst>
        </pc:cxnChg>
        <pc:cxnChg chg="del mod">
          <ac:chgData name="khoi ho" userId="c93cb340-cf97-4d7c-9739-bad0ee582323" providerId="ADAL" clId="{C2BB2C1E-DF47-4B6A-976C-433CC21C1951}" dt="2020-10-02T10:42:17.887" v="292" actId="478"/>
          <ac:cxnSpMkLst>
            <pc:docMk/>
            <pc:sldMk cId="3022863545" sldId="411"/>
            <ac:cxnSpMk id="712" creationId="{3066D02C-F261-46AE-8823-CE21CC46B693}"/>
          </ac:cxnSpMkLst>
        </pc:cxnChg>
        <pc:cxnChg chg="del mod">
          <ac:chgData name="khoi ho" userId="c93cb340-cf97-4d7c-9739-bad0ee582323" providerId="ADAL" clId="{C2BB2C1E-DF47-4B6A-976C-433CC21C1951}" dt="2020-10-02T10:41:14.894" v="286" actId="478"/>
          <ac:cxnSpMkLst>
            <pc:docMk/>
            <pc:sldMk cId="3022863545" sldId="411"/>
            <ac:cxnSpMk id="718" creationId="{5EA34DE3-5F00-4139-A3F6-B2E5D8D4AE74}"/>
          </ac:cxnSpMkLst>
        </pc:cxnChg>
        <pc:cxnChg chg="del">
          <ac:chgData name="khoi ho" userId="c93cb340-cf97-4d7c-9739-bad0ee582323" providerId="ADAL" clId="{C2BB2C1E-DF47-4B6A-976C-433CC21C1951}" dt="2020-10-03T07:12:19.625" v="331" actId="478"/>
          <ac:cxnSpMkLst>
            <pc:docMk/>
            <pc:sldMk cId="3022863545" sldId="411"/>
            <ac:cxnSpMk id="722" creationId="{2A56187E-AF99-4432-AD3F-E99FAB04F60C}"/>
          </ac:cxnSpMkLst>
        </pc:cxnChg>
        <pc:cxnChg chg="del">
          <ac:chgData name="khoi ho" userId="c93cb340-cf97-4d7c-9739-bad0ee582323" providerId="ADAL" clId="{C2BB2C1E-DF47-4B6A-976C-433CC21C1951}" dt="2020-10-03T07:12:21.105" v="332" actId="478"/>
          <ac:cxnSpMkLst>
            <pc:docMk/>
            <pc:sldMk cId="3022863545" sldId="411"/>
            <ac:cxnSpMk id="724" creationId="{D25D5806-28CF-4EF4-8297-E5D58E5C609D}"/>
          </ac:cxnSpMkLst>
        </pc:cxnChg>
        <pc:cxnChg chg="del">
          <ac:chgData name="khoi ho" userId="c93cb340-cf97-4d7c-9739-bad0ee582323" providerId="ADAL" clId="{C2BB2C1E-DF47-4B6A-976C-433CC21C1951}" dt="2020-10-02T10:41:19.502" v="288" actId="478"/>
          <ac:cxnSpMkLst>
            <pc:docMk/>
            <pc:sldMk cId="3022863545" sldId="411"/>
            <ac:cxnSpMk id="729" creationId="{A36226AD-7521-44CC-97F5-F193E26AAEB4}"/>
          </ac:cxnSpMkLst>
        </pc:cxnChg>
        <pc:cxnChg chg="del mod">
          <ac:chgData name="khoi ho" userId="c93cb340-cf97-4d7c-9739-bad0ee582323" providerId="ADAL" clId="{C2BB2C1E-DF47-4B6A-976C-433CC21C1951}" dt="2020-10-12T01:24:24.114" v="366" actId="478"/>
          <ac:cxnSpMkLst>
            <pc:docMk/>
            <pc:sldMk cId="3022863545" sldId="411"/>
            <ac:cxnSpMk id="773" creationId="{B32D0BBA-0AF7-4D45-8521-8862C1CCE06A}"/>
          </ac:cxnSpMkLst>
        </pc:cxnChg>
        <pc:cxnChg chg="del mod">
          <ac:chgData name="khoi ho" userId="c93cb340-cf97-4d7c-9739-bad0ee582323" providerId="ADAL" clId="{C2BB2C1E-DF47-4B6A-976C-433CC21C1951}" dt="2020-10-12T01:24:24.114" v="366" actId="478"/>
          <ac:cxnSpMkLst>
            <pc:docMk/>
            <pc:sldMk cId="3022863545" sldId="411"/>
            <ac:cxnSpMk id="783" creationId="{6823F064-E05F-407E-9DE2-6D4DA8EE0CC4}"/>
          </ac:cxnSpMkLst>
        </pc:cxnChg>
        <pc:cxnChg chg="del mod">
          <ac:chgData name="khoi ho" userId="c93cb340-cf97-4d7c-9739-bad0ee582323" providerId="ADAL" clId="{C2BB2C1E-DF47-4B6A-976C-433CC21C1951}" dt="2020-10-12T01:24:24.114" v="366" actId="478"/>
          <ac:cxnSpMkLst>
            <pc:docMk/>
            <pc:sldMk cId="3022863545" sldId="411"/>
            <ac:cxnSpMk id="784" creationId="{8BDA8F7D-FAD8-426E-B86C-7F0369969DBF}"/>
          </ac:cxnSpMkLst>
        </pc:cxnChg>
        <pc:cxnChg chg="del mod">
          <ac:chgData name="khoi ho" userId="c93cb340-cf97-4d7c-9739-bad0ee582323" providerId="ADAL" clId="{C2BB2C1E-DF47-4B6A-976C-433CC21C1951}" dt="2020-10-12T01:24:24.114" v="366" actId="478"/>
          <ac:cxnSpMkLst>
            <pc:docMk/>
            <pc:sldMk cId="3022863545" sldId="411"/>
            <ac:cxnSpMk id="785" creationId="{F0337767-9F54-4B48-A714-86B51759DDE0}"/>
          </ac:cxnSpMkLst>
        </pc:cxnChg>
        <pc:cxnChg chg="del mod">
          <ac:chgData name="khoi ho" userId="c93cb340-cf97-4d7c-9739-bad0ee582323" providerId="ADAL" clId="{C2BB2C1E-DF47-4B6A-976C-433CC21C1951}" dt="2020-10-12T01:24:24.114" v="366" actId="478"/>
          <ac:cxnSpMkLst>
            <pc:docMk/>
            <pc:sldMk cId="3022863545" sldId="411"/>
            <ac:cxnSpMk id="786" creationId="{2110AFEC-60E9-4D0D-96D2-BC8445029977}"/>
          </ac:cxnSpMkLst>
        </pc:cxnChg>
        <pc:cxnChg chg="del mod">
          <ac:chgData name="khoi ho" userId="c93cb340-cf97-4d7c-9739-bad0ee582323" providerId="ADAL" clId="{C2BB2C1E-DF47-4B6A-976C-433CC21C1951}" dt="2020-10-12T01:24:24.114" v="366" actId="478"/>
          <ac:cxnSpMkLst>
            <pc:docMk/>
            <pc:sldMk cId="3022863545" sldId="411"/>
            <ac:cxnSpMk id="787" creationId="{8C7EB3F6-7B6C-4926-ABCA-B1D5632CD18B}"/>
          </ac:cxnSpMkLst>
        </pc:cxnChg>
        <pc:cxnChg chg="del mod">
          <ac:chgData name="khoi ho" userId="c93cb340-cf97-4d7c-9739-bad0ee582323" providerId="ADAL" clId="{C2BB2C1E-DF47-4B6A-976C-433CC21C1951}" dt="2020-10-12T01:24:24.114" v="366" actId="478"/>
          <ac:cxnSpMkLst>
            <pc:docMk/>
            <pc:sldMk cId="3022863545" sldId="411"/>
            <ac:cxnSpMk id="793" creationId="{58E05583-66A6-44B3-B438-4B6A825ACAFA}"/>
          </ac:cxnSpMkLst>
        </pc:cxnChg>
        <pc:cxnChg chg="del mod">
          <ac:chgData name="khoi ho" userId="c93cb340-cf97-4d7c-9739-bad0ee582323" providerId="ADAL" clId="{C2BB2C1E-DF47-4B6A-976C-433CC21C1951}" dt="2020-10-12T01:24:24.114" v="366" actId="478"/>
          <ac:cxnSpMkLst>
            <pc:docMk/>
            <pc:sldMk cId="3022863545" sldId="411"/>
            <ac:cxnSpMk id="794" creationId="{D2020777-4F19-4FD0-A121-DB9F71245548}"/>
          </ac:cxnSpMkLst>
        </pc:cxnChg>
        <pc:cxnChg chg="del mod">
          <ac:chgData name="khoi ho" userId="c93cb340-cf97-4d7c-9739-bad0ee582323" providerId="ADAL" clId="{C2BB2C1E-DF47-4B6A-976C-433CC21C1951}" dt="2020-10-12T01:24:24.114" v="366" actId="478"/>
          <ac:cxnSpMkLst>
            <pc:docMk/>
            <pc:sldMk cId="3022863545" sldId="411"/>
            <ac:cxnSpMk id="795" creationId="{E7C2DF12-87FF-41A2-941F-17DD6150324A}"/>
          </ac:cxnSpMkLst>
        </pc:cxnChg>
        <pc:cxnChg chg="del mod">
          <ac:chgData name="khoi ho" userId="c93cb340-cf97-4d7c-9739-bad0ee582323" providerId="ADAL" clId="{C2BB2C1E-DF47-4B6A-976C-433CC21C1951}" dt="2020-10-12T01:24:24.114" v="366" actId="478"/>
          <ac:cxnSpMkLst>
            <pc:docMk/>
            <pc:sldMk cId="3022863545" sldId="411"/>
            <ac:cxnSpMk id="796" creationId="{A318E8F5-2C91-49E3-8EF9-0E6AEC8C7EF2}"/>
          </ac:cxnSpMkLst>
        </pc:cxnChg>
        <pc:cxnChg chg="del mod">
          <ac:chgData name="khoi ho" userId="c93cb340-cf97-4d7c-9739-bad0ee582323" providerId="ADAL" clId="{C2BB2C1E-DF47-4B6A-976C-433CC21C1951}" dt="2020-10-12T01:24:24.114" v="366" actId="478"/>
          <ac:cxnSpMkLst>
            <pc:docMk/>
            <pc:sldMk cId="3022863545" sldId="411"/>
            <ac:cxnSpMk id="797" creationId="{4E3B7EF4-6A7A-4558-BA4C-94A4EE85D840}"/>
          </ac:cxnSpMkLst>
        </pc:cxnChg>
        <pc:cxnChg chg="del mod">
          <ac:chgData name="khoi ho" userId="c93cb340-cf97-4d7c-9739-bad0ee582323" providerId="ADAL" clId="{C2BB2C1E-DF47-4B6A-976C-433CC21C1951}" dt="2020-10-12T01:24:24.114" v="366" actId="478"/>
          <ac:cxnSpMkLst>
            <pc:docMk/>
            <pc:sldMk cId="3022863545" sldId="411"/>
            <ac:cxnSpMk id="798" creationId="{C5DA2D72-E420-4C22-B9A7-A157CAE7A3E7}"/>
          </ac:cxnSpMkLst>
        </pc:cxnChg>
        <pc:cxnChg chg="del mod">
          <ac:chgData name="khoi ho" userId="c93cb340-cf97-4d7c-9739-bad0ee582323" providerId="ADAL" clId="{C2BB2C1E-DF47-4B6A-976C-433CC21C1951}" dt="2020-10-12T01:24:24.114" v="366" actId="478"/>
          <ac:cxnSpMkLst>
            <pc:docMk/>
            <pc:sldMk cId="3022863545" sldId="411"/>
            <ac:cxnSpMk id="800" creationId="{3EE5E09A-5725-43BB-B25A-9C2C12FD1254}"/>
          </ac:cxnSpMkLst>
        </pc:cxnChg>
        <pc:cxnChg chg="del mod">
          <ac:chgData name="khoi ho" userId="c93cb340-cf97-4d7c-9739-bad0ee582323" providerId="ADAL" clId="{C2BB2C1E-DF47-4B6A-976C-433CC21C1951}" dt="2020-10-12T01:24:24.114" v="366" actId="478"/>
          <ac:cxnSpMkLst>
            <pc:docMk/>
            <pc:sldMk cId="3022863545" sldId="411"/>
            <ac:cxnSpMk id="801" creationId="{8D4D47AC-96AA-4E86-A626-D7BC352B0F03}"/>
          </ac:cxnSpMkLst>
        </pc:cxnChg>
        <pc:cxnChg chg="del">
          <ac:chgData name="khoi ho" userId="c93cb340-cf97-4d7c-9739-bad0ee582323" providerId="ADAL" clId="{C2BB2C1E-DF47-4B6A-976C-433CC21C1951}" dt="2020-10-12T01:24:24.114" v="366" actId="478"/>
          <ac:cxnSpMkLst>
            <pc:docMk/>
            <pc:sldMk cId="3022863545" sldId="411"/>
            <ac:cxnSpMk id="802" creationId="{37F41C7B-9143-4FB8-BFCE-A792C1AEB43B}"/>
          </ac:cxnSpMkLst>
        </pc:cxnChg>
        <pc:cxnChg chg="del mod">
          <ac:chgData name="khoi ho" userId="c93cb340-cf97-4d7c-9739-bad0ee582323" providerId="ADAL" clId="{C2BB2C1E-DF47-4B6A-976C-433CC21C1951}" dt="2020-10-12T01:24:24.114" v="366" actId="478"/>
          <ac:cxnSpMkLst>
            <pc:docMk/>
            <pc:sldMk cId="3022863545" sldId="411"/>
            <ac:cxnSpMk id="804" creationId="{D35FC6D3-C3DB-468A-BCE6-8CBB599A6128}"/>
          </ac:cxnSpMkLst>
        </pc:cxnChg>
        <pc:cxnChg chg="del mod">
          <ac:chgData name="khoi ho" userId="c93cb340-cf97-4d7c-9739-bad0ee582323" providerId="ADAL" clId="{C2BB2C1E-DF47-4B6A-976C-433CC21C1951}" dt="2020-10-12T01:24:24.114" v="366" actId="478"/>
          <ac:cxnSpMkLst>
            <pc:docMk/>
            <pc:sldMk cId="3022863545" sldId="411"/>
            <ac:cxnSpMk id="812" creationId="{89B497E0-CB49-4E51-AD64-B66B8F66DA98}"/>
          </ac:cxnSpMkLst>
        </pc:cxnChg>
      </pc:sldChg>
      <pc:sldChg chg="modSp">
        <pc:chgData name="khoi ho" userId="c93cb340-cf97-4d7c-9739-bad0ee582323" providerId="ADAL" clId="{C2BB2C1E-DF47-4B6A-976C-433CC21C1951}" dt="2020-10-13T03:55:24.460" v="407" actId="1037"/>
        <pc:sldMkLst>
          <pc:docMk/>
          <pc:sldMk cId="1956460582" sldId="415"/>
        </pc:sldMkLst>
        <pc:spChg chg="mod">
          <ac:chgData name="khoi ho" userId="c93cb340-cf97-4d7c-9739-bad0ee582323" providerId="ADAL" clId="{C2BB2C1E-DF47-4B6A-976C-433CC21C1951}" dt="2020-10-13T03:55:13.900" v="404" actId="1038"/>
          <ac:spMkLst>
            <pc:docMk/>
            <pc:sldMk cId="1956460582" sldId="415"/>
            <ac:spMk id="14" creationId="{CD949400-FE0B-416E-B382-6987AE0CA188}"/>
          </ac:spMkLst>
        </pc:spChg>
        <pc:spChg chg="mod">
          <ac:chgData name="khoi ho" userId="c93cb340-cf97-4d7c-9739-bad0ee582323" providerId="ADAL" clId="{C2BB2C1E-DF47-4B6A-976C-433CC21C1951}" dt="2020-10-13T03:55:04.580" v="402" actId="1037"/>
          <ac:spMkLst>
            <pc:docMk/>
            <pc:sldMk cId="1956460582" sldId="415"/>
            <ac:spMk id="15" creationId="{9DFE3474-C396-4AAE-97A5-34374B2EF55B}"/>
          </ac:spMkLst>
        </pc:spChg>
        <pc:spChg chg="mod">
          <ac:chgData name="khoi ho" userId="c93cb340-cf97-4d7c-9739-bad0ee582323" providerId="ADAL" clId="{C2BB2C1E-DF47-4B6A-976C-433CC21C1951}" dt="2020-10-13T03:55:24.460" v="407" actId="1037"/>
          <ac:spMkLst>
            <pc:docMk/>
            <pc:sldMk cId="1956460582" sldId="415"/>
            <ac:spMk id="16" creationId="{A2225B13-E5CF-4480-9111-14742318B2E1}"/>
          </ac:spMkLst>
        </pc:spChg>
      </pc:sldChg>
      <pc:sldChg chg="addSp delSp modSp">
        <pc:chgData name="khoi ho" userId="c93cb340-cf97-4d7c-9739-bad0ee582323" providerId="ADAL" clId="{C2BB2C1E-DF47-4B6A-976C-433CC21C1951}" dt="2020-10-12T01:57:25.935" v="395" actId="1076"/>
        <pc:sldMkLst>
          <pc:docMk/>
          <pc:sldMk cId="1134663030" sldId="416"/>
        </pc:sldMkLst>
        <pc:spChg chg="del">
          <ac:chgData name="khoi ho" userId="c93cb340-cf97-4d7c-9739-bad0ee582323" providerId="ADAL" clId="{C2BB2C1E-DF47-4B6A-976C-433CC21C1951}" dt="2020-10-12T01:23:31.534" v="364" actId="478"/>
          <ac:spMkLst>
            <pc:docMk/>
            <pc:sldMk cId="1134663030" sldId="416"/>
            <ac:spMk id="44" creationId="{4A31AC70-E048-4ECA-A054-685E8A4AEEB1}"/>
          </ac:spMkLst>
        </pc:spChg>
        <pc:spChg chg="add mod">
          <ac:chgData name="khoi ho" userId="c93cb340-cf97-4d7c-9739-bad0ee582323" providerId="ADAL" clId="{C2BB2C1E-DF47-4B6A-976C-433CC21C1951}" dt="2020-10-12T01:56:05.255" v="376" actId="1076"/>
          <ac:spMkLst>
            <pc:docMk/>
            <pc:sldMk cId="1134663030" sldId="416"/>
            <ac:spMk id="45" creationId="{B0F90D63-CA74-45C4-8A01-015DA7996711}"/>
          </ac:spMkLst>
        </pc:spChg>
        <pc:spChg chg="add mod">
          <ac:chgData name="khoi ho" userId="c93cb340-cf97-4d7c-9739-bad0ee582323" providerId="ADAL" clId="{C2BB2C1E-DF47-4B6A-976C-433CC21C1951}" dt="2020-10-12T01:56:54.662" v="382" actId="20577"/>
          <ac:spMkLst>
            <pc:docMk/>
            <pc:sldMk cId="1134663030" sldId="416"/>
            <ac:spMk id="46" creationId="{B803DC08-456E-48D0-9D8F-315F84C6CF3D}"/>
          </ac:spMkLst>
        </pc:spChg>
        <pc:spChg chg="add mod">
          <ac:chgData name="khoi ho" userId="c93cb340-cf97-4d7c-9739-bad0ee582323" providerId="ADAL" clId="{C2BB2C1E-DF47-4B6A-976C-433CC21C1951}" dt="2020-10-12T01:56:59.078" v="384" actId="20577"/>
          <ac:spMkLst>
            <pc:docMk/>
            <pc:sldMk cId="1134663030" sldId="416"/>
            <ac:spMk id="47" creationId="{4A42FB62-E779-4D57-8AE1-CB03E0C807FE}"/>
          </ac:spMkLst>
        </pc:spChg>
        <pc:spChg chg="add mod">
          <ac:chgData name="khoi ho" userId="c93cb340-cf97-4d7c-9739-bad0ee582323" providerId="ADAL" clId="{C2BB2C1E-DF47-4B6A-976C-433CC21C1951}" dt="2020-10-12T01:57:02.941" v="386" actId="20577"/>
          <ac:spMkLst>
            <pc:docMk/>
            <pc:sldMk cId="1134663030" sldId="416"/>
            <ac:spMk id="48" creationId="{C1B55BDE-C2FF-4D45-BA0D-7BE1381BC0B8}"/>
          </ac:spMkLst>
        </pc:spChg>
        <pc:spChg chg="add mod">
          <ac:chgData name="khoi ho" userId="c93cb340-cf97-4d7c-9739-bad0ee582323" providerId="ADAL" clId="{C2BB2C1E-DF47-4B6A-976C-433CC21C1951}" dt="2020-10-12T01:57:07.253" v="388" actId="20577"/>
          <ac:spMkLst>
            <pc:docMk/>
            <pc:sldMk cId="1134663030" sldId="416"/>
            <ac:spMk id="85" creationId="{251D14E9-B633-4A65-A51F-211B0D27FB63}"/>
          </ac:spMkLst>
        </pc:spChg>
        <pc:spChg chg="add mod">
          <ac:chgData name="khoi ho" userId="c93cb340-cf97-4d7c-9739-bad0ee582323" providerId="ADAL" clId="{C2BB2C1E-DF47-4B6A-976C-433CC21C1951}" dt="2020-10-12T01:57:10.337" v="390" actId="20577"/>
          <ac:spMkLst>
            <pc:docMk/>
            <pc:sldMk cId="1134663030" sldId="416"/>
            <ac:spMk id="86" creationId="{7BBD49EE-24B6-445A-91E7-8BBFF5E1A39A}"/>
          </ac:spMkLst>
        </pc:spChg>
        <pc:spChg chg="add mod">
          <ac:chgData name="khoi ho" userId="c93cb340-cf97-4d7c-9739-bad0ee582323" providerId="ADAL" clId="{C2BB2C1E-DF47-4B6A-976C-433CC21C1951}" dt="2020-10-12T01:57:25.935" v="395" actId="1076"/>
          <ac:spMkLst>
            <pc:docMk/>
            <pc:sldMk cId="1134663030" sldId="416"/>
            <ac:spMk id="87" creationId="{20BB6567-887E-4690-879C-5BA1388AA54E}"/>
          </ac:spMkLst>
        </pc:spChg>
        <pc:spChg chg="add mod">
          <ac:chgData name="khoi ho" userId="c93cb340-cf97-4d7c-9739-bad0ee582323" providerId="ADAL" clId="{C2BB2C1E-DF47-4B6A-976C-433CC21C1951}" dt="2020-10-12T01:57:20.518" v="394" actId="20577"/>
          <ac:spMkLst>
            <pc:docMk/>
            <pc:sldMk cId="1134663030" sldId="416"/>
            <ac:spMk id="88" creationId="{CDC425C4-4F2A-4BC1-BE32-7817A1DF60A2}"/>
          </ac:spMkLst>
        </pc:spChg>
      </pc:sldChg>
    </pc:docChg>
  </pc:docChgLst>
  <pc:docChgLst>
    <pc:chgData name="khoi ho" userId="c93cb340-cf97-4d7c-9739-bad0ee582323" providerId="ADAL" clId="{365471B3-2CEF-4916-A41E-7336EB602685}"/>
    <pc:docChg chg="undo custSel addSld delSld modSld">
      <pc:chgData name="khoi ho" userId="c93cb340-cf97-4d7c-9739-bad0ee582323" providerId="ADAL" clId="{365471B3-2CEF-4916-A41E-7336EB602685}" dt="2020-11-06T11:11:16.946" v="435"/>
      <pc:docMkLst>
        <pc:docMk/>
      </pc:docMkLst>
      <pc:sldChg chg="modSp">
        <pc:chgData name="khoi ho" userId="c93cb340-cf97-4d7c-9739-bad0ee582323" providerId="ADAL" clId="{365471B3-2CEF-4916-A41E-7336EB602685}" dt="2020-11-02T02:55:08.118" v="389" actId="20577"/>
        <pc:sldMkLst>
          <pc:docMk/>
          <pc:sldMk cId="1654466452" sldId="398"/>
        </pc:sldMkLst>
        <pc:spChg chg="mod">
          <ac:chgData name="khoi ho" userId="c93cb340-cf97-4d7c-9739-bad0ee582323" providerId="ADAL" clId="{365471B3-2CEF-4916-A41E-7336EB602685}" dt="2020-11-02T02:55:08.118" v="389" actId="20577"/>
          <ac:spMkLst>
            <pc:docMk/>
            <pc:sldMk cId="1654466452" sldId="398"/>
            <ac:spMk id="82" creationId="{42AAC5BF-A8E2-42EF-95CC-9AD1021554E6}"/>
          </ac:spMkLst>
        </pc:spChg>
      </pc:sldChg>
      <pc:sldChg chg="modSp">
        <pc:chgData name="khoi ho" userId="c93cb340-cf97-4d7c-9739-bad0ee582323" providerId="ADAL" clId="{365471B3-2CEF-4916-A41E-7336EB602685}" dt="2020-11-02T02:54:54.133" v="385" actId="20577"/>
        <pc:sldMkLst>
          <pc:docMk/>
          <pc:sldMk cId="1212021925" sldId="399"/>
        </pc:sldMkLst>
        <pc:spChg chg="mod">
          <ac:chgData name="khoi ho" userId="c93cb340-cf97-4d7c-9739-bad0ee582323" providerId="ADAL" clId="{365471B3-2CEF-4916-A41E-7336EB602685}" dt="2020-11-02T02:54:54.133" v="385" actId="20577"/>
          <ac:spMkLst>
            <pc:docMk/>
            <pc:sldMk cId="1212021925" sldId="399"/>
            <ac:spMk id="82" creationId="{42AAC5BF-A8E2-42EF-95CC-9AD1021554E6}"/>
          </ac:spMkLst>
        </pc:spChg>
      </pc:sldChg>
      <pc:sldChg chg="delSp modSp">
        <pc:chgData name="khoi ho" userId="c93cb340-cf97-4d7c-9739-bad0ee582323" providerId="ADAL" clId="{365471B3-2CEF-4916-A41E-7336EB602685}" dt="2020-11-02T02:55:03.984" v="387" actId="20577"/>
        <pc:sldMkLst>
          <pc:docMk/>
          <pc:sldMk cId="4107458222" sldId="400"/>
        </pc:sldMkLst>
        <pc:spChg chg="del">
          <ac:chgData name="khoi ho" userId="c93cb340-cf97-4d7c-9739-bad0ee582323" providerId="ADAL" clId="{365471B3-2CEF-4916-A41E-7336EB602685}" dt="2020-10-13T11:00:40.827" v="2" actId="478"/>
          <ac:spMkLst>
            <pc:docMk/>
            <pc:sldMk cId="4107458222" sldId="400"/>
            <ac:spMk id="2" creationId="{723D5DB9-7564-47B9-98A4-4D533D1EC2E7}"/>
          </ac:spMkLst>
        </pc:spChg>
        <pc:spChg chg="del">
          <ac:chgData name="khoi ho" userId="c93cb340-cf97-4d7c-9739-bad0ee582323" providerId="ADAL" clId="{365471B3-2CEF-4916-A41E-7336EB602685}" dt="2020-10-13T11:00:43.038" v="4" actId="478"/>
          <ac:spMkLst>
            <pc:docMk/>
            <pc:sldMk cId="4107458222" sldId="400"/>
            <ac:spMk id="36" creationId="{F2460463-FE42-435B-ABD3-10D0C27643CF}"/>
          </ac:spMkLst>
        </pc:spChg>
        <pc:spChg chg="mod">
          <ac:chgData name="khoi ho" userId="c93cb340-cf97-4d7c-9739-bad0ee582323" providerId="ADAL" clId="{365471B3-2CEF-4916-A41E-7336EB602685}" dt="2020-11-02T02:55:03.984" v="387" actId="20577"/>
          <ac:spMkLst>
            <pc:docMk/>
            <pc:sldMk cId="4107458222" sldId="400"/>
            <ac:spMk id="82" creationId="{42AAC5BF-A8E2-42EF-95CC-9AD1021554E6}"/>
          </ac:spMkLst>
        </pc:spChg>
        <pc:graphicFrameChg chg="mod">
          <ac:chgData name="khoi ho" userId="c93cb340-cf97-4d7c-9739-bad0ee582323" providerId="ADAL" clId="{365471B3-2CEF-4916-A41E-7336EB602685}" dt="2020-10-13T11:00:37.204" v="1" actId="20577"/>
          <ac:graphicFrameMkLst>
            <pc:docMk/>
            <pc:sldMk cId="4107458222" sldId="400"/>
            <ac:graphicFrameMk id="29" creationId="{90D516EE-FF2A-4C06-8C8D-438CDFBBCDFF}"/>
          </ac:graphicFrameMkLst>
        </pc:graphicFrameChg>
        <pc:cxnChg chg="del">
          <ac:chgData name="khoi ho" userId="c93cb340-cf97-4d7c-9739-bad0ee582323" providerId="ADAL" clId="{365471B3-2CEF-4916-A41E-7336EB602685}" dt="2020-10-13T11:00:41.806" v="3" actId="478"/>
          <ac:cxnSpMkLst>
            <pc:docMk/>
            <pc:sldMk cId="4107458222" sldId="400"/>
            <ac:cxnSpMk id="5" creationId="{9CF7CFCB-BBD1-49D3-BF60-EDDBD13B9248}"/>
          </ac:cxnSpMkLst>
        </pc:cxnChg>
        <pc:cxnChg chg="del">
          <ac:chgData name="khoi ho" userId="c93cb340-cf97-4d7c-9739-bad0ee582323" providerId="ADAL" clId="{365471B3-2CEF-4916-A41E-7336EB602685}" dt="2020-10-13T11:00:44.179" v="5" actId="478"/>
          <ac:cxnSpMkLst>
            <pc:docMk/>
            <pc:sldMk cId="4107458222" sldId="400"/>
            <ac:cxnSpMk id="10" creationId="{DC848B04-6109-4AAB-866B-EB70E1582B93}"/>
          </ac:cxnSpMkLst>
        </pc:cxnChg>
      </pc:sldChg>
      <pc:sldChg chg="modSp">
        <pc:chgData name="khoi ho" userId="c93cb340-cf97-4d7c-9739-bad0ee582323" providerId="ADAL" clId="{365471B3-2CEF-4916-A41E-7336EB602685}" dt="2020-11-02T02:54:49.878" v="383" actId="20577"/>
        <pc:sldMkLst>
          <pc:docMk/>
          <pc:sldMk cId="3434091264" sldId="401"/>
        </pc:sldMkLst>
        <pc:spChg chg="mod">
          <ac:chgData name="khoi ho" userId="c93cb340-cf97-4d7c-9739-bad0ee582323" providerId="ADAL" clId="{365471B3-2CEF-4916-A41E-7336EB602685}" dt="2020-11-02T02:54:49.878" v="383" actId="20577"/>
          <ac:spMkLst>
            <pc:docMk/>
            <pc:sldMk cId="3434091264" sldId="401"/>
            <ac:spMk id="82" creationId="{42AAC5BF-A8E2-42EF-95CC-9AD1021554E6}"/>
          </ac:spMkLst>
        </pc:spChg>
      </pc:sldChg>
      <pc:sldChg chg="delSp modSp">
        <pc:chgData name="khoi ho" userId="c93cb340-cf97-4d7c-9739-bad0ee582323" providerId="ADAL" clId="{365471B3-2CEF-4916-A41E-7336EB602685}" dt="2020-11-02T02:55:22.095" v="394" actId="20577"/>
        <pc:sldMkLst>
          <pc:docMk/>
          <pc:sldMk cId="2621352214" sldId="407"/>
        </pc:sldMkLst>
        <pc:spChg chg="del">
          <ac:chgData name="khoi ho" userId="c93cb340-cf97-4d7c-9739-bad0ee582323" providerId="ADAL" clId="{365471B3-2CEF-4916-A41E-7336EB602685}" dt="2020-10-13T11:01:16.038" v="6" actId="478"/>
          <ac:spMkLst>
            <pc:docMk/>
            <pc:sldMk cId="2621352214" sldId="407"/>
            <ac:spMk id="20" creationId="{3232E53D-F51E-4E93-9C22-4759AB51CA26}"/>
          </ac:spMkLst>
        </pc:spChg>
        <pc:spChg chg="del">
          <ac:chgData name="khoi ho" userId="c93cb340-cf97-4d7c-9739-bad0ee582323" providerId="ADAL" clId="{365471B3-2CEF-4916-A41E-7336EB602685}" dt="2020-10-13T11:01:17.998" v="8" actId="478"/>
          <ac:spMkLst>
            <pc:docMk/>
            <pc:sldMk cId="2621352214" sldId="407"/>
            <ac:spMk id="22" creationId="{EFA9FCFC-BCE0-4FFC-930D-8422C7CBDEEB}"/>
          </ac:spMkLst>
        </pc:spChg>
        <pc:spChg chg="mod">
          <ac:chgData name="khoi ho" userId="c93cb340-cf97-4d7c-9739-bad0ee582323" providerId="ADAL" clId="{365471B3-2CEF-4916-A41E-7336EB602685}" dt="2020-11-02T02:55:22.095" v="394" actId="20577"/>
          <ac:spMkLst>
            <pc:docMk/>
            <pc:sldMk cId="2621352214" sldId="407"/>
            <ac:spMk id="82" creationId="{42AAC5BF-A8E2-42EF-95CC-9AD1021554E6}"/>
          </ac:spMkLst>
        </pc:spChg>
        <pc:graphicFrameChg chg="mod">
          <ac:chgData name="khoi ho" userId="c93cb340-cf97-4d7c-9739-bad0ee582323" providerId="ADAL" clId="{365471B3-2CEF-4916-A41E-7336EB602685}" dt="2020-10-13T11:01:22.315" v="10" actId="20577"/>
          <ac:graphicFrameMkLst>
            <pc:docMk/>
            <pc:sldMk cId="2621352214" sldId="407"/>
            <ac:graphicFrameMk id="35" creationId="{6AAB4EC3-88B1-473E-910F-3EC09AB590E1}"/>
          </ac:graphicFrameMkLst>
        </pc:graphicFrameChg>
        <pc:cxnChg chg="del">
          <ac:chgData name="khoi ho" userId="c93cb340-cf97-4d7c-9739-bad0ee582323" providerId="ADAL" clId="{365471B3-2CEF-4916-A41E-7336EB602685}" dt="2020-10-13T11:01:16.677" v="7" actId="478"/>
          <ac:cxnSpMkLst>
            <pc:docMk/>
            <pc:sldMk cId="2621352214" sldId="407"/>
            <ac:cxnSpMk id="21" creationId="{30426344-AF23-4F60-B626-1342DF869623}"/>
          </ac:cxnSpMkLst>
        </pc:cxnChg>
        <pc:cxnChg chg="del">
          <ac:chgData name="khoi ho" userId="c93cb340-cf97-4d7c-9739-bad0ee582323" providerId="ADAL" clId="{365471B3-2CEF-4916-A41E-7336EB602685}" dt="2020-10-13T11:01:25.229" v="11" actId="478"/>
          <ac:cxnSpMkLst>
            <pc:docMk/>
            <pc:sldMk cId="2621352214" sldId="407"/>
            <ac:cxnSpMk id="23" creationId="{B9C0961F-D15A-4869-AFFE-F766A861A4C4}"/>
          </ac:cxnSpMkLst>
        </pc:cxnChg>
      </pc:sldChg>
      <pc:sldChg chg="modSp">
        <pc:chgData name="khoi ho" userId="c93cb340-cf97-4d7c-9739-bad0ee582323" providerId="ADAL" clId="{365471B3-2CEF-4916-A41E-7336EB602685}" dt="2020-11-02T02:55:27.237" v="396" actId="20577"/>
        <pc:sldMkLst>
          <pc:docMk/>
          <pc:sldMk cId="3173550047" sldId="408"/>
        </pc:sldMkLst>
        <pc:spChg chg="mod">
          <ac:chgData name="khoi ho" userId="c93cb340-cf97-4d7c-9739-bad0ee582323" providerId="ADAL" clId="{365471B3-2CEF-4916-A41E-7336EB602685}" dt="2020-11-02T02:55:27.237" v="396" actId="20577"/>
          <ac:spMkLst>
            <pc:docMk/>
            <pc:sldMk cId="3173550047" sldId="408"/>
            <ac:spMk id="82" creationId="{42AAC5BF-A8E2-42EF-95CC-9AD1021554E6}"/>
          </ac:spMkLst>
        </pc:spChg>
      </pc:sldChg>
      <pc:sldChg chg="modSp">
        <pc:chgData name="khoi ho" userId="c93cb340-cf97-4d7c-9739-bad0ee582323" providerId="ADAL" clId="{365471B3-2CEF-4916-A41E-7336EB602685}" dt="2020-11-02T02:54:45.097" v="381" actId="20577"/>
        <pc:sldMkLst>
          <pc:docMk/>
          <pc:sldMk cId="3664975801" sldId="410"/>
        </pc:sldMkLst>
        <pc:spChg chg="mod">
          <ac:chgData name="khoi ho" userId="c93cb340-cf97-4d7c-9739-bad0ee582323" providerId="ADAL" clId="{365471B3-2CEF-4916-A41E-7336EB602685}" dt="2020-11-02T02:54:45.097" v="381" actId="20577"/>
          <ac:spMkLst>
            <pc:docMk/>
            <pc:sldMk cId="3664975801" sldId="410"/>
            <ac:spMk id="82" creationId="{42AAC5BF-A8E2-42EF-95CC-9AD1021554E6}"/>
          </ac:spMkLst>
        </pc:spChg>
      </pc:sldChg>
      <pc:sldChg chg="addSp delSp">
        <pc:chgData name="khoi ho" userId="c93cb340-cf97-4d7c-9739-bad0ee582323" providerId="ADAL" clId="{365471B3-2CEF-4916-A41E-7336EB602685}" dt="2020-10-15T05:03:05.444" v="13"/>
        <pc:sldMkLst>
          <pc:docMk/>
          <pc:sldMk cId="3022863545" sldId="411"/>
        </pc:sldMkLst>
        <pc:spChg chg="add del">
          <ac:chgData name="khoi ho" userId="c93cb340-cf97-4d7c-9739-bad0ee582323" providerId="ADAL" clId="{365471B3-2CEF-4916-A41E-7336EB602685}" dt="2020-10-15T05:03:05.444" v="13"/>
          <ac:spMkLst>
            <pc:docMk/>
            <pc:sldMk cId="3022863545" sldId="411"/>
            <ac:spMk id="5" creationId="{7B645C12-4436-47BA-A35A-B55F7A987DE0}"/>
          </ac:spMkLst>
        </pc:spChg>
      </pc:sldChg>
      <pc:sldChg chg="modSp">
        <pc:chgData name="khoi ho" userId="c93cb340-cf97-4d7c-9739-bad0ee582323" providerId="ADAL" clId="{365471B3-2CEF-4916-A41E-7336EB602685}" dt="2020-11-02T02:55:33.873" v="398" actId="20577"/>
        <pc:sldMkLst>
          <pc:docMk/>
          <pc:sldMk cId="1956460582" sldId="415"/>
        </pc:sldMkLst>
        <pc:spChg chg="mod">
          <ac:chgData name="khoi ho" userId="c93cb340-cf97-4d7c-9739-bad0ee582323" providerId="ADAL" clId="{365471B3-2CEF-4916-A41E-7336EB602685}" dt="2020-11-02T02:55:33.873" v="398" actId="20577"/>
          <ac:spMkLst>
            <pc:docMk/>
            <pc:sldMk cId="1956460582" sldId="415"/>
            <ac:spMk id="82" creationId="{42AAC5BF-A8E2-42EF-95CC-9AD1021554E6}"/>
          </ac:spMkLst>
        </pc:spChg>
      </pc:sldChg>
      <pc:sldChg chg="modSp">
        <pc:chgData name="khoi ho" userId="c93cb340-cf97-4d7c-9739-bad0ee582323" providerId="ADAL" clId="{365471B3-2CEF-4916-A41E-7336EB602685}" dt="2020-11-02T02:55:16.433" v="391" actId="20577"/>
        <pc:sldMkLst>
          <pc:docMk/>
          <pc:sldMk cId="1134663030" sldId="416"/>
        </pc:sldMkLst>
        <pc:spChg chg="mod">
          <ac:chgData name="khoi ho" userId="c93cb340-cf97-4d7c-9739-bad0ee582323" providerId="ADAL" clId="{365471B3-2CEF-4916-A41E-7336EB602685}" dt="2020-11-02T02:55:16.433" v="391" actId="20577"/>
          <ac:spMkLst>
            <pc:docMk/>
            <pc:sldMk cId="1134663030" sldId="416"/>
            <ac:spMk id="82" creationId="{42AAC5BF-A8E2-42EF-95CC-9AD1021554E6}"/>
          </ac:spMkLst>
        </pc:spChg>
      </pc:sldChg>
      <pc:sldChg chg="addSp delSp modSp add">
        <pc:chgData name="khoi ho" userId="c93cb340-cf97-4d7c-9739-bad0ee582323" providerId="ADAL" clId="{365471B3-2CEF-4916-A41E-7336EB602685}" dt="2020-10-16T06:56:10.120" v="172" actId="1076"/>
        <pc:sldMkLst>
          <pc:docMk/>
          <pc:sldMk cId="1836038841" sldId="417"/>
        </pc:sldMkLst>
        <pc:spChg chg="del">
          <ac:chgData name="khoi ho" userId="c93cb340-cf97-4d7c-9739-bad0ee582323" providerId="ADAL" clId="{365471B3-2CEF-4916-A41E-7336EB602685}" dt="2020-10-15T05:03:30.899" v="20" actId="478"/>
          <ac:spMkLst>
            <pc:docMk/>
            <pc:sldMk cId="1836038841" sldId="417"/>
            <ac:spMk id="2" creationId="{06FB6171-EA90-4D89-81E5-501EC0F97142}"/>
          </ac:spMkLst>
        </pc:spChg>
        <pc:spChg chg="del">
          <ac:chgData name="khoi ho" userId="c93cb340-cf97-4d7c-9739-bad0ee582323" providerId="ADAL" clId="{365471B3-2CEF-4916-A41E-7336EB602685}" dt="2020-10-15T05:03:18.809" v="15" actId="478"/>
          <ac:spMkLst>
            <pc:docMk/>
            <pc:sldMk cId="1836038841" sldId="417"/>
            <ac:spMk id="4" creationId="{2D708B0A-ACC1-4A5E-A3E8-A58360FF1FC1}"/>
          </ac:spMkLst>
        </pc:spChg>
        <pc:spChg chg="mod">
          <ac:chgData name="khoi ho" userId="c93cb340-cf97-4d7c-9739-bad0ee582323" providerId="ADAL" clId="{365471B3-2CEF-4916-A41E-7336EB602685}" dt="2020-10-16T06:55:34.306" v="169" actId="1076"/>
          <ac:spMkLst>
            <pc:docMk/>
            <pc:sldMk cId="1836038841" sldId="417"/>
            <ac:spMk id="7" creationId="{DA7344AA-3B28-4507-AD97-239AACB929A7}"/>
          </ac:spMkLst>
        </pc:spChg>
        <pc:spChg chg="mod">
          <ac:chgData name="khoi ho" userId="c93cb340-cf97-4d7c-9739-bad0ee582323" providerId="ADAL" clId="{365471B3-2CEF-4916-A41E-7336EB602685}" dt="2020-10-16T06:55:34.306" v="169" actId="1076"/>
          <ac:spMkLst>
            <pc:docMk/>
            <pc:sldMk cId="1836038841" sldId="417"/>
            <ac:spMk id="21" creationId="{B17D8AF8-4209-4174-A410-0B09449FABE3}"/>
          </ac:spMkLst>
        </pc:spChg>
        <pc:spChg chg="mod">
          <ac:chgData name="khoi ho" userId="c93cb340-cf97-4d7c-9739-bad0ee582323" providerId="ADAL" clId="{365471B3-2CEF-4916-A41E-7336EB602685}" dt="2020-10-16T06:55:34.306" v="169" actId="1076"/>
          <ac:spMkLst>
            <pc:docMk/>
            <pc:sldMk cId="1836038841" sldId="417"/>
            <ac:spMk id="28" creationId="{A85EF9F2-D5DF-422B-AFAA-D2CCBB8EC503}"/>
          </ac:spMkLst>
        </pc:spChg>
        <pc:spChg chg="mod">
          <ac:chgData name="khoi ho" userId="c93cb340-cf97-4d7c-9739-bad0ee582323" providerId="ADAL" clId="{365471B3-2CEF-4916-A41E-7336EB602685}" dt="2020-10-16T06:55:34.306" v="169" actId="1076"/>
          <ac:spMkLst>
            <pc:docMk/>
            <pc:sldMk cId="1836038841" sldId="417"/>
            <ac:spMk id="85" creationId="{0DFE3949-931F-4023-9F0C-5C26A775B2A4}"/>
          </ac:spMkLst>
        </pc:spChg>
        <pc:spChg chg="mod">
          <ac:chgData name="khoi ho" userId="c93cb340-cf97-4d7c-9739-bad0ee582323" providerId="ADAL" clId="{365471B3-2CEF-4916-A41E-7336EB602685}" dt="2020-10-16T06:55:34.306" v="169" actId="1076"/>
          <ac:spMkLst>
            <pc:docMk/>
            <pc:sldMk cId="1836038841" sldId="417"/>
            <ac:spMk id="102" creationId="{3048F7EF-CD87-432B-8532-861A1AA4E4A5}"/>
          </ac:spMkLst>
        </pc:spChg>
        <pc:spChg chg="mod">
          <ac:chgData name="khoi ho" userId="c93cb340-cf97-4d7c-9739-bad0ee582323" providerId="ADAL" clId="{365471B3-2CEF-4916-A41E-7336EB602685}" dt="2020-10-16T06:55:34.306" v="169" actId="1076"/>
          <ac:spMkLst>
            <pc:docMk/>
            <pc:sldMk cId="1836038841" sldId="417"/>
            <ac:spMk id="106" creationId="{355C4C1E-5635-4670-B04D-49106C24E336}"/>
          </ac:spMkLst>
        </pc:spChg>
        <pc:spChg chg="mod">
          <ac:chgData name="khoi ho" userId="c93cb340-cf97-4d7c-9739-bad0ee582323" providerId="ADAL" clId="{365471B3-2CEF-4916-A41E-7336EB602685}" dt="2020-10-16T06:55:34.306" v="169" actId="1076"/>
          <ac:spMkLst>
            <pc:docMk/>
            <pc:sldMk cId="1836038841" sldId="417"/>
            <ac:spMk id="110" creationId="{9843D9A7-46F5-4560-B09B-BFB67A8934AC}"/>
          </ac:spMkLst>
        </pc:spChg>
        <pc:spChg chg="mod">
          <ac:chgData name="khoi ho" userId="c93cb340-cf97-4d7c-9739-bad0ee582323" providerId="ADAL" clId="{365471B3-2CEF-4916-A41E-7336EB602685}" dt="2020-10-16T06:55:34.306" v="169" actId="1076"/>
          <ac:spMkLst>
            <pc:docMk/>
            <pc:sldMk cId="1836038841" sldId="417"/>
            <ac:spMk id="111" creationId="{A9913ECB-DD20-4534-B9D6-5E235C619088}"/>
          </ac:spMkLst>
        </pc:spChg>
        <pc:spChg chg="mod">
          <ac:chgData name="khoi ho" userId="c93cb340-cf97-4d7c-9739-bad0ee582323" providerId="ADAL" clId="{365471B3-2CEF-4916-A41E-7336EB602685}" dt="2020-10-16T06:55:34.306" v="169" actId="1076"/>
          <ac:spMkLst>
            <pc:docMk/>
            <pc:sldMk cId="1836038841" sldId="417"/>
            <ac:spMk id="112" creationId="{8D58650E-2B7F-4F9A-92FE-297DA2395DD7}"/>
          </ac:spMkLst>
        </pc:spChg>
        <pc:spChg chg="mod">
          <ac:chgData name="khoi ho" userId="c93cb340-cf97-4d7c-9739-bad0ee582323" providerId="ADAL" clId="{365471B3-2CEF-4916-A41E-7336EB602685}" dt="2020-10-16T06:55:34.306" v="169" actId="1076"/>
          <ac:spMkLst>
            <pc:docMk/>
            <pc:sldMk cId="1836038841" sldId="417"/>
            <ac:spMk id="113" creationId="{067E4792-521C-4B52-9FE8-5FE7F3C8AD4E}"/>
          </ac:spMkLst>
        </pc:spChg>
        <pc:spChg chg="del">
          <ac:chgData name="khoi ho" userId="c93cb340-cf97-4d7c-9739-bad0ee582323" providerId="ADAL" clId="{365471B3-2CEF-4916-A41E-7336EB602685}" dt="2020-10-15T05:03:22.618" v="17" actId="478"/>
          <ac:spMkLst>
            <pc:docMk/>
            <pc:sldMk cId="1836038841" sldId="417"/>
            <ac:spMk id="115" creationId="{97B6FC23-106B-40C5-A53A-71F6EF95A731}"/>
          </ac:spMkLst>
        </pc:spChg>
        <pc:spChg chg="add mod">
          <ac:chgData name="khoi ho" userId="c93cb340-cf97-4d7c-9739-bad0ee582323" providerId="ADAL" clId="{365471B3-2CEF-4916-A41E-7336EB602685}" dt="2020-10-16T06:56:10.120" v="172" actId="1076"/>
          <ac:spMkLst>
            <pc:docMk/>
            <pc:sldMk cId="1836038841" sldId="417"/>
            <ac:spMk id="116" creationId="{E31232EE-C77B-438D-8C6A-A79B008D5205}"/>
          </ac:spMkLst>
        </pc:spChg>
        <pc:spChg chg="add mod">
          <ac:chgData name="khoi ho" userId="c93cb340-cf97-4d7c-9739-bad0ee582323" providerId="ADAL" clId="{365471B3-2CEF-4916-A41E-7336EB602685}" dt="2020-10-16T06:56:10.120" v="172" actId="1076"/>
          <ac:spMkLst>
            <pc:docMk/>
            <pc:sldMk cId="1836038841" sldId="417"/>
            <ac:spMk id="117" creationId="{2D70A360-8C25-4176-BA14-6BCC2D8AC562}"/>
          </ac:spMkLst>
        </pc:spChg>
        <pc:spChg chg="add del mod">
          <ac:chgData name="khoi ho" userId="c93cb340-cf97-4d7c-9739-bad0ee582323" providerId="ADAL" clId="{365471B3-2CEF-4916-A41E-7336EB602685}" dt="2020-10-15T05:38:21.547" v="95" actId="478"/>
          <ac:spMkLst>
            <pc:docMk/>
            <pc:sldMk cId="1836038841" sldId="417"/>
            <ac:spMk id="120" creationId="{95D68C0E-8E23-478E-94B6-36EE7C862AF0}"/>
          </ac:spMkLst>
        </pc:spChg>
        <pc:spChg chg="add del mod">
          <ac:chgData name="khoi ho" userId="c93cb340-cf97-4d7c-9739-bad0ee582323" providerId="ADAL" clId="{365471B3-2CEF-4916-A41E-7336EB602685}" dt="2020-10-15T06:34:35.684" v="117" actId="478"/>
          <ac:spMkLst>
            <pc:docMk/>
            <pc:sldMk cId="1836038841" sldId="417"/>
            <ac:spMk id="123" creationId="{E7428FB1-66B0-49A1-B0C8-334F28202FCA}"/>
          </ac:spMkLst>
        </pc:spChg>
        <pc:spChg chg="add del mod">
          <ac:chgData name="khoi ho" userId="c93cb340-cf97-4d7c-9739-bad0ee582323" providerId="ADAL" clId="{365471B3-2CEF-4916-A41E-7336EB602685}" dt="2020-10-15T05:55:12.292" v="109" actId="478"/>
          <ac:spMkLst>
            <pc:docMk/>
            <pc:sldMk cId="1836038841" sldId="417"/>
            <ac:spMk id="124" creationId="{98F869AB-EA7C-44CB-8B6E-079EB0970EE1}"/>
          </ac:spMkLst>
        </pc:spChg>
        <pc:spChg chg="add mod">
          <ac:chgData name="khoi ho" userId="c93cb340-cf97-4d7c-9739-bad0ee582323" providerId="ADAL" clId="{365471B3-2CEF-4916-A41E-7336EB602685}" dt="2020-10-16T06:56:10.120" v="172" actId="1076"/>
          <ac:spMkLst>
            <pc:docMk/>
            <pc:sldMk cId="1836038841" sldId="417"/>
            <ac:spMk id="138" creationId="{D9F1F254-DCAB-43DE-A874-A95AE2789976}"/>
          </ac:spMkLst>
        </pc:spChg>
        <pc:spChg chg="add mod">
          <ac:chgData name="khoi ho" userId="c93cb340-cf97-4d7c-9739-bad0ee582323" providerId="ADAL" clId="{365471B3-2CEF-4916-A41E-7336EB602685}" dt="2020-10-16T06:56:10.120" v="172" actId="1076"/>
          <ac:spMkLst>
            <pc:docMk/>
            <pc:sldMk cId="1836038841" sldId="417"/>
            <ac:spMk id="139" creationId="{3D724460-3ECC-455C-AE84-773B39AB186C}"/>
          </ac:spMkLst>
        </pc:spChg>
        <pc:spChg chg="add mod">
          <ac:chgData name="khoi ho" userId="c93cb340-cf97-4d7c-9739-bad0ee582323" providerId="ADAL" clId="{365471B3-2CEF-4916-A41E-7336EB602685}" dt="2020-10-16T06:56:10.120" v="172" actId="1076"/>
          <ac:spMkLst>
            <pc:docMk/>
            <pc:sldMk cId="1836038841" sldId="417"/>
            <ac:spMk id="140" creationId="{F615A804-0DF9-4DC7-8395-43A095005ADD}"/>
          </ac:spMkLst>
        </pc:spChg>
        <pc:spChg chg="add mod">
          <ac:chgData name="khoi ho" userId="c93cb340-cf97-4d7c-9739-bad0ee582323" providerId="ADAL" clId="{365471B3-2CEF-4916-A41E-7336EB602685}" dt="2020-10-16T06:56:10.120" v="172" actId="1076"/>
          <ac:spMkLst>
            <pc:docMk/>
            <pc:sldMk cId="1836038841" sldId="417"/>
            <ac:spMk id="141" creationId="{E54476C0-562C-4FBD-A053-C5AF647C0463}"/>
          </ac:spMkLst>
        </pc:spChg>
        <pc:spChg chg="add mod">
          <ac:chgData name="khoi ho" userId="c93cb340-cf97-4d7c-9739-bad0ee582323" providerId="ADAL" clId="{365471B3-2CEF-4916-A41E-7336EB602685}" dt="2020-10-16T06:56:10.120" v="172" actId="1076"/>
          <ac:spMkLst>
            <pc:docMk/>
            <pc:sldMk cId="1836038841" sldId="417"/>
            <ac:spMk id="142" creationId="{E32422EE-1D22-47E9-9A08-989AE6952C42}"/>
          </ac:spMkLst>
        </pc:spChg>
        <pc:spChg chg="add mod">
          <ac:chgData name="khoi ho" userId="c93cb340-cf97-4d7c-9739-bad0ee582323" providerId="ADAL" clId="{365471B3-2CEF-4916-A41E-7336EB602685}" dt="2020-10-16T06:56:10.120" v="172" actId="1076"/>
          <ac:spMkLst>
            <pc:docMk/>
            <pc:sldMk cId="1836038841" sldId="417"/>
            <ac:spMk id="143" creationId="{181C25B8-8BC1-4EBF-8B11-C481062589C3}"/>
          </ac:spMkLst>
        </pc:spChg>
        <pc:spChg chg="add mod">
          <ac:chgData name="khoi ho" userId="c93cb340-cf97-4d7c-9739-bad0ee582323" providerId="ADAL" clId="{365471B3-2CEF-4916-A41E-7336EB602685}" dt="2020-10-16T06:56:10.120" v="172" actId="1076"/>
          <ac:spMkLst>
            <pc:docMk/>
            <pc:sldMk cId="1836038841" sldId="417"/>
            <ac:spMk id="144" creationId="{71D1355C-844A-4090-9FE6-050FD40C9770}"/>
          </ac:spMkLst>
        </pc:spChg>
        <pc:spChg chg="mod">
          <ac:chgData name="khoi ho" userId="c93cb340-cf97-4d7c-9739-bad0ee582323" providerId="ADAL" clId="{365471B3-2CEF-4916-A41E-7336EB602685}" dt="2020-10-16T06:55:34.306" v="169" actId="1076"/>
          <ac:spMkLst>
            <pc:docMk/>
            <pc:sldMk cId="1836038841" sldId="417"/>
            <ac:spMk id="145" creationId="{E0AB78C5-0396-4C53-B967-49409492016B}"/>
          </ac:spMkLst>
        </pc:spChg>
        <pc:spChg chg="add mod">
          <ac:chgData name="khoi ho" userId="c93cb340-cf97-4d7c-9739-bad0ee582323" providerId="ADAL" clId="{365471B3-2CEF-4916-A41E-7336EB602685}" dt="2020-10-16T06:56:10.120" v="172" actId="1076"/>
          <ac:spMkLst>
            <pc:docMk/>
            <pc:sldMk cId="1836038841" sldId="417"/>
            <ac:spMk id="146" creationId="{E6F16D6C-D127-4800-98E5-BA0FF2C87EA2}"/>
          </ac:spMkLst>
        </pc:spChg>
        <pc:spChg chg="mod">
          <ac:chgData name="khoi ho" userId="c93cb340-cf97-4d7c-9739-bad0ee582323" providerId="ADAL" clId="{365471B3-2CEF-4916-A41E-7336EB602685}" dt="2020-10-16T06:55:34.306" v="169" actId="1076"/>
          <ac:spMkLst>
            <pc:docMk/>
            <pc:sldMk cId="1836038841" sldId="417"/>
            <ac:spMk id="147" creationId="{8D2036E0-EE91-4DD4-8984-123E02E99A90}"/>
          </ac:spMkLst>
        </pc:spChg>
        <pc:spChg chg="mod">
          <ac:chgData name="khoi ho" userId="c93cb340-cf97-4d7c-9739-bad0ee582323" providerId="ADAL" clId="{365471B3-2CEF-4916-A41E-7336EB602685}" dt="2020-10-16T06:55:34.306" v="169" actId="1076"/>
          <ac:spMkLst>
            <pc:docMk/>
            <pc:sldMk cId="1836038841" sldId="417"/>
            <ac:spMk id="148" creationId="{35FE86E7-C5EB-4F10-802D-AD86DAAD43EA}"/>
          </ac:spMkLst>
        </pc:spChg>
        <pc:spChg chg="add del mod">
          <ac:chgData name="khoi ho" userId="c93cb340-cf97-4d7c-9739-bad0ee582323" providerId="ADAL" clId="{365471B3-2CEF-4916-A41E-7336EB602685}" dt="2020-10-15T05:29:23.492" v="62" actId="478"/>
          <ac:spMkLst>
            <pc:docMk/>
            <pc:sldMk cId="1836038841" sldId="417"/>
            <ac:spMk id="150" creationId="{EE73A355-563D-467F-A6D7-59A51EBF8F83}"/>
          </ac:spMkLst>
        </pc:spChg>
        <pc:spChg chg="add mod">
          <ac:chgData name="khoi ho" userId="c93cb340-cf97-4d7c-9739-bad0ee582323" providerId="ADAL" clId="{365471B3-2CEF-4916-A41E-7336EB602685}" dt="2020-10-16T06:56:10.120" v="172" actId="1076"/>
          <ac:spMkLst>
            <pc:docMk/>
            <pc:sldMk cId="1836038841" sldId="417"/>
            <ac:spMk id="151" creationId="{4EA05EF3-976B-47D3-B84B-665435550E43}"/>
          </ac:spMkLst>
        </pc:spChg>
        <pc:spChg chg="mod">
          <ac:chgData name="khoi ho" userId="c93cb340-cf97-4d7c-9739-bad0ee582323" providerId="ADAL" clId="{365471B3-2CEF-4916-A41E-7336EB602685}" dt="2020-10-16T06:55:34.306" v="169" actId="1076"/>
          <ac:spMkLst>
            <pc:docMk/>
            <pc:sldMk cId="1836038841" sldId="417"/>
            <ac:spMk id="157" creationId="{E9486576-9624-43BF-A72E-20766A2DD813}"/>
          </ac:spMkLst>
        </pc:spChg>
        <pc:spChg chg="mod">
          <ac:chgData name="khoi ho" userId="c93cb340-cf97-4d7c-9739-bad0ee582323" providerId="ADAL" clId="{365471B3-2CEF-4916-A41E-7336EB602685}" dt="2020-10-16T06:55:34.306" v="169" actId="1076"/>
          <ac:spMkLst>
            <pc:docMk/>
            <pc:sldMk cId="1836038841" sldId="417"/>
            <ac:spMk id="158" creationId="{6AA123D1-22C4-42DD-8451-1A6EBDD95E1E}"/>
          </ac:spMkLst>
        </pc:spChg>
        <pc:spChg chg="mod">
          <ac:chgData name="khoi ho" userId="c93cb340-cf97-4d7c-9739-bad0ee582323" providerId="ADAL" clId="{365471B3-2CEF-4916-A41E-7336EB602685}" dt="2020-10-16T06:55:34.306" v="169" actId="1076"/>
          <ac:spMkLst>
            <pc:docMk/>
            <pc:sldMk cId="1836038841" sldId="417"/>
            <ac:spMk id="160" creationId="{5CA69FB2-D9BF-48F8-82B6-C63FAD3B64FB}"/>
          </ac:spMkLst>
        </pc:spChg>
        <pc:spChg chg="add del mod">
          <ac:chgData name="khoi ho" userId="c93cb340-cf97-4d7c-9739-bad0ee582323" providerId="ADAL" clId="{365471B3-2CEF-4916-A41E-7336EB602685}" dt="2020-10-15T05:29:32.355" v="64" actId="478"/>
          <ac:spMkLst>
            <pc:docMk/>
            <pc:sldMk cId="1836038841" sldId="417"/>
            <ac:spMk id="164" creationId="{AF3C59DD-3A99-41E8-99C9-E85184C15D92}"/>
          </ac:spMkLst>
        </pc:spChg>
        <pc:spChg chg="add del mod">
          <ac:chgData name="khoi ho" userId="c93cb340-cf97-4d7c-9739-bad0ee582323" providerId="ADAL" clId="{365471B3-2CEF-4916-A41E-7336EB602685}" dt="2020-10-15T05:32:13.627" v="75" actId="478"/>
          <ac:spMkLst>
            <pc:docMk/>
            <pc:sldMk cId="1836038841" sldId="417"/>
            <ac:spMk id="165" creationId="{0E7E3DFB-85FE-4E5A-94E7-B45609E056D8}"/>
          </ac:spMkLst>
        </pc:spChg>
        <pc:spChg chg="add mod">
          <ac:chgData name="khoi ho" userId="c93cb340-cf97-4d7c-9739-bad0ee582323" providerId="ADAL" clId="{365471B3-2CEF-4916-A41E-7336EB602685}" dt="2020-10-16T06:56:10.120" v="172" actId="1076"/>
          <ac:spMkLst>
            <pc:docMk/>
            <pc:sldMk cId="1836038841" sldId="417"/>
            <ac:spMk id="166" creationId="{2AE1542C-FEE7-4C29-B160-F271B65CC86C}"/>
          </ac:spMkLst>
        </pc:spChg>
        <pc:spChg chg="add mod">
          <ac:chgData name="khoi ho" userId="c93cb340-cf97-4d7c-9739-bad0ee582323" providerId="ADAL" clId="{365471B3-2CEF-4916-A41E-7336EB602685}" dt="2020-10-16T06:56:10.120" v="172" actId="1076"/>
          <ac:spMkLst>
            <pc:docMk/>
            <pc:sldMk cId="1836038841" sldId="417"/>
            <ac:spMk id="167" creationId="{0C4609BE-C051-4E40-BA53-A5963B576159}"/>
          </ac:spMkLst>
        </pc:spChg>
        <pc:spChg chg="add mod">
          <ac:chgData name="khoi ho" userId="c93cb340-cf97-4d7c-9739-bad0ee582323" providerId="ADAL" clId="{365471B3-2CEF-4916-A41E-7336EB602685}" dt="2020-10-16T06:56:10.120" v="172" actId="1076"/>
          <ac:spMkLst>
            <pc:docMk/>
            <pc:sldMk cId="1836038841" sldId="417"/>
            <ac:spMk id="169" creationId="{48F8A3AE-0574-4B3F-9997-63D1442C0ED5}"/>
          </ac:spMkLst>
        </pc:spChg>
        <pc:spChg chg="add mod">
          <ac:chgData name="khoi ho" userId="c93cb340-cf97-4d7c-9739-bad0ee582323" providerId="ADAL" clId="{365471B3-2CEF-4916-A41E-7336EB602685}" dt="2020-10-16T06:56:10.120" v="172" actId="1076"/>
          <ac:spMkLst>
            <pc:docMk/>
            <pc:sldMk cId="1836038841" sldId="417"/>
            <ac:spMk id="170" creationId="{CA496CCD-2DF7-4ACB-8D59-0CE269DDC3DC}"/>
          </ac:spMkLst>
        </pc:spChg>
        <pc:spChg chg="mod">
          <ac:chgData name="khoi ho" userId="c93cb340-cf97-4d7c-9739-bad0ee582323" providerId="ADAL" clId="{365471B3-2CEF-4916-A41E-7336EB602685}" dt="2020-10-16T06:55:34.306" v="169" actId="1076"/>
          <ac:spMkLst>
            <pc:docMk/>
            <pc:sldMk cId="1836038841" sldId="417"/>
            <ac:spMk id="171" creationId="{C78414DC-5A09-426E-AEE9-D2FA3AD3BD1F}"/>
          </ac:spMkLst>
        </pc:spChg>
        <pc:spChg chg="add mod">
          <ac:chgData name="khoi ho" userId="c93cb340-cf97-4d7c-9739-bad0ee582323" providerId="ADAL" clId="{365471B3-2CEF-4916-A41E-7336EB602685}" dt="2020-10-16T06:56:10.120" v="172" actId="1076"/>
          <ac:spMkLst>
            <pc:docMk/>
            <pc:sldMk cId="1836038841" sldId="417"/>
            <ac:spMk id="172" creationId="{6A1FD1E6-DC46-4D4F-9FED-B46C1F2E5EF5}"/>
          </ac:spMkLst>
        </pc:spChg>
        <pc:spChg chg="mod">
          <ac:chgData name="khoi ho" userId="c93cb340-cf97-4d7c-9739-bad0ee582323" providerId="ADAL" clId="{365471B3-2CEF-4916-A41E-7336EB602685}" dt="2020-10-16T06:55:34.306" v="169" actId="1076"/>
          <ac:spMkLst>
            <pc:docMk/>
            <pc:sldMk cId="1836038841" sldId="417"/>
            <ac:spMk id="176" creationId="{633AFB04-D691-4B88-9D85-6EB6529E7D15}"/>
          </ac:spMkLst>
        </pc:spChg>
        <pc:spChg chg="mod">
          <ac:chgData name="khoi ho" userId="c93cb340-cf97-4d7c-9739-bad0ee582323" providerId="ADAL" clId="{365471B3-2CEF-4916-A41E-7336EB602685}" dt="2020-10-16T06:55:34.306" v="169" actId="1076"/>
          <ac:spMkLst>
            <pc:docMk/>
            <pc:sldMk cId="1836038841" sldId="417"/>
            <ac:spMk id="177" creationId="{D6163A66-7F3C-49E3-A780-F69391485055}"/>
          </ac:spMkLst>
        </pc:spChg>
        <pc:spChg chg="mod">
          <ac:chgData name="khoi ho" userId="c93cb340-cf97-4d7c-9739-bad0ee582323" providerId="ADAL" clId="{365471B3-2CEF-4916-A41E-7336EB602685}" dt="2020-10-16T06:55:34.306" v="169" actId="1076"/>
          <ac:spMkLst>
            <pc:docMk/>
            <pc:sldMk cId="1836038841" sldId="417"/>
            <ac:spMk id="178" creationId="{3D1862F5-25F8-46F3-A2DD-2452A20EC5C0}"/>
          </ac:spMkLst>
        </pc:spChg>
        <pc:spChg chg="mod">
          <ac:chgData name="khoi ho" userId="c93cb340-cf97-4d7c-9739-bad0ee582323" providerId="ADAL" clId="{365471B3-2CEF-4916-A41E-7336EB602685}" dt="2020-10-16T06:55:34.306" v="169" actId="1076"/>
          <ac:spMkLst>
            <pc:docMk/>
            <pc:sldMk cId="1836038841" sldId="417"/>
            <ac:spMk id="179" creationId="{05B270C8-DB45-4156-9FEB-DAC4EE2677AA}"/>
          </ac:spMkLst>
        </pc:spChg>
        <pc:spChg chg="add mod">
          <ac:chgData name="khoi ho" userId="c93cb340-cf97-4d7c-9739-bad0ee582323" providerId="ADAL" clId="{365471B3-2CEF-4916-A41E-7336EB602685}" dt="2020-10-16T06:56:10.120" v="172" actId="1076"/>
          <ac:spMkLst>
            <pc:docMk/>
            <pc:sldMk cId="1836038841" sldId="417"/>
            <ac:spMk id="181" creationId="{B93DBC7F-DA6F-4C81-9206-C7D1F6494783}"/>
          </ac:spMkLst>
        </pc:spChg>
        <pc:spChg chg="add del mod">
          <ac:chgData name="khoi ho" userId="c93cb340-cf97-4d7c-9739-bad0ee582323" providerId="ADAL" clId="{365471B3-2CEF-4916-A41E-7336EB602685}" dt="2020-10-15T06:34:43.589" v="121" actId="478"/>
          <ac:spMkLst>
            <pc:docMk/>
            <pc:sldMk cId="1836038841" sldId="417"/>
            <ac:spMk id="183" creationId="{4DD0763D-B034-4C83-B27A-6B2DFAAAC9E9}"/>
          </ac:spMkLst>
        </pc:spChg>
        <pc:spChg chg="add del mod">
          <ac:chgData name="khoi ho" userId="c93cb340-cf97-4d7c-9739-bad0ee582323" providerId="ADAL" clId="{365471B3-2CEF-4916-A41E-7336EB602685}" dt="2020-10-15T06:34:44.252" v="122" actId="478"/>
          <ac:spMkLst>
            <pc:docMk/>
            <pc:sldMk cId="1836038841" sldId="417"/>
            <ac:spMk id="184" creationId="{DB120063-6A25-4543-BAAE-31367F9EB89A}"/>
          </ac:spMkLst>
        </pc:spChg>
        <pc:spChg chg="add mod">
          <ac:chgData name="khoi ho" userId="c93cb340-cf97-4d7c-9739-bad0ee582323" providerId="ADAL" clId="{365471B3-2CEF-4916-A41E-7336EB602685}" dt="2020-10-16T06:56:10.120" v="172" actId="1076"/>
          <ac:spMkLst>
            <pc:docMk/>
            <pc:sldMk cId="1836038841" sldId="417"/>
            <ac:spMk id="185" creationId="{C7DF5245-D421-44AF-8705-D3223F817AA0}"/>
          </ac:spMkLst>
        </pc:spChg>
        <pc:spChg chg="add del mod">
          <ac:chgData name="khoi ho" userId="c93cb340-cf97-4d7c-9739-bad0ee582323" providerId="ADAL" clId="{365471B3-2CEF-4916-A41E-7336EB602685}" dt="2020-10-15T06:34:33.221" v="114" actId="478"/>
          <ac:spMkLst>
            <pc:docMk/>
            <pc:sldMk cId="1836038841" sldId="417"/>
            <ac:spMk id="186" creationId="{C0867619-5F42-4CF6-9D3B-A14DD6B51D06}"/>
          </ac:spMkLst>
        </pc:spChg>
        <pc:spChg chg="add del mod">
          <ac:chgData name="khoi ho" userId="c93cb340-cf97-4d7c-9739-bad0ee582323" providerId="ADAL" clId="{365471B3-2CEF-4916-A41E-7336EB602685}" dt="2020-10-15T06:34:33.899" v="115" actId="478"/>
          <ac:spMkLst>
            <pc:docMk/>
            <pc:sldMk cId="1836038841" sldId="417"/>
            <ac:spMk id="187" creationId="{7A29EE6B-F55C-4CB8-A013-BD0AC6824E8D}"/>
          </ac:spMkLst>
        </pc:spChg>
        <pc:spChg chg="add mod">
          <ac:chgData name="khoi ho" userId="c93cb340-cf97-4d7c-9739-bad0ee582323" providerId="ADAL" clId="{365471B3-2CEF-4916-A41E-7336EB602685}" dt="2020-10-16T06:56:10.120" v="172" actId="1076"/>
          <ac:spMkLst>
            <pc:docMk/>
            <pc:sldMk cId="1836038841" sldId="417"/>
            <ac:spMk id="188" creationId="{419B3240-7264-4C14-95E1-A3F5861EA1C9}"/>
          </ac:spMkLst>
        </pc:spChg>
        <pc:spChg chg="add del mod">
          <ac:chgData name="khoi ho" userId="c93cb340-cf97-4d7c-9739-bad0ee582323" providerId="ADAL" clId="{365471B3-2CEF-4916-A41E-7336EB602685}" dt="2020-10-15T05:55:13.923" v="111" actId="478"/>
          <ac:spMkLst>
            <pc:docMk/>
            <pc:sldMk cId="1836038841" sldId="417"/>
            <ac:spMk id="190" creationId="{2E7907A3-8AD8-494E-AC3C-80D8D8228198}"/>
          </ac:spMkLst>
        </pc:spChg>
        <pc:spChg chg="add del mod">
          <ac:chgData name="khoi ho" userId="c93cb340-cf97-4d7c-9739-bad0ee582323" providerId="ADAL" clId="{365471B3-2CEF-4916-A41E-7336EB602685}" dt="2020-10-15T05:55:14.924" v="112" actId="478"/>
          <ac:spMkLst>
            <pc:docMk/>
            <pc:sldMk cId="1836038841" sldId="417"/>
            <ac:spMk id="191" creationId="{2F6ACF3D-A81C-4E38-A9C9-D3EF2D8E56A0}"/>
          </ac:spMkLst>
        </pc:spChg>
        <pc:spChg chg="add mod">
          <ac:chgData name="khoi ho" userId="c93cb340-cf97-4d7c-9739-bad0ee582323" providerId="ADAL" clId="{365471B3-2CEF-4916-A41E-7336EB602685}" dt="2020-10-16T06:56:10.120" v="172" actId="1076"/>
          <ac:spMkLst>
            <pc:docMk/>
            <pc:sldMk cId="1836038841" sldId="417"/>
            <ac:spMk id="192" creationId="{937CBA8D-BFF7-4350-9398-11602F1A9E91}"/>
          </ac:spMkLst>
        </pc:spChg>
        <pc:spChg chg="mod">
          <ac:chgData name="khoi ho" userId="c93cb340-cf97-4d7c-9739-bad0ee582323" providerId="ADAL" clId="{365471B3-2CEF-4916-A41E-7336EB602685}" dt="2020-10-16T06:55:34.306" v="169" actId="1076"/>
          <ac:spMkLst>
            <pc:docMk/>
            <pc:sldMk cId="1836038841" sldId="417"/>
            <ac:spMk id="196" creationId="{151ADA77-29B6-4424-891A-10713803F9F2}"/>
          </ac:spMkLst>
        </pc:spChg>
        <pc:spChg chg="mod">
          <ac:chgData name="khoi ho" userId="c93cb340-cf97-4d7c-9739-bad0ee582323" providerId="ADAL" clId="{365471B3-2CEF-4916-A41E-7336EB602685}" dt="2020-10-16T06:55:34.306" v="169" actId="1076"/>
          <ac:spMkLst>
            <pc:docMk/>
            <pc:sldMk cId="1836038841" sldId="417"/>
            <ac:spMk id="203" creationId="{89543DAB-5C53-4A1F-A79B-127CC5466789}"/>
          </ac:spMkLst>
        </pc:spChg>
        <pc:spChg chg="mod">
          <ac:chgData name="khoi ho" userId="c93cb340-cf97-4d7c-9739-bad0ee582323" providerId="ADAL" clId="{365471B3-2CEF-4916-A41E-7336EB602685}" dt="2020-10-16T06:55:34.306" v="169" actId="1076"/>
          <ac:spMkLst>
            <pc:docMk/>
            <pc:sldMk cId="1836038841" sldId="417"/>
            <ac:spMk id="205" creationId="{B7526496-F986-40E8-A0A8-B364512D2FB5}"/>
          </ac:spMkLst>
        </pc:spChg>
        <pc:spChg chg="add mod">
          <ac:chgData name="khoi ho" userId="c93cb340-cf97-4d7c-9739-bad0ee582323" providerId="ADAL" clId="{365471B3-2CEF-4916-A41E-7336EB602685}" dt="2020-10-16T06:56:10.120" v="172" actId="1076"/>
          <ac:spMkLst>
            <pc:docMk/>
            <pc:sldMk cId="1836038841" sldId="417"/>
            <ac:spMk id="207" creationId="{407B8E60-08FA-4275-83F8-6666B262E906}"/>
          </ac:spMkLst>
        </pc:spChg>
        <pc:spChg chg="add mod">
          <ac:chgData name="khoi ho" userId="c93cb340-cf97-4d7c-9739-bad0ee582323" providerId="ADAL" clId="{365471B3-2CEF-4916-A41E-7336EB602685}" dt="2020-10-16T06:56:10.120" v="172" actId="1076"/>
          <ac:spMkLst>
            <pc:docMk/>
            <pc:sldMk cId="1836038841" sldId="417"/>
            <ac:spMk id="208" creationId="{0941BDA5-3382-4380-A081-321C1152E541}"/>
          </ac:spMkLst>
        </pc:spChg>
        <pc:spChg chg="mod">
          <ac:chgData name="khoi ho" userId="c93cb340-cf97-4d7c-9739-bad0ee582323" providerId="ADAL" clId="{365471B3-2CEF-4916-A41E-7336EB602685}" dt="2020-10-16T06:55:34.306" v="169" actId="1076"/>
          <ac:spMkLst>
            <pc:docMk/>
            <pc:sldMk cId="1836038841" sldId="417"/>
            <ac:spMk id="219" creationId="{BFA483F8-2134-4986-B30A-E1A515495413}"/>
          </ac:spMkLst>
        </pc:spChg>
        <pc:spChg chg="mod">
          <ac:chgData name="khoi ho" userId="c93cb340-cf97-4d7c-9739-bad0ee582323" providerId="ADAL" clId="{365471B3-2CEF-4916-A41E-7336EB602685}" dt="2020-10-16T06:55:34.306" v="169" actId="1076"/>
          <ac:spMkLst>
            <pc:docMk/>
            <pc:sldMk cId="1836038841" sldId="417"/>
            <ac:spMk id="220" creationId="{268D14B6-5437-4F28-B13D-B68EE1CF60DC}"/>
          </ac:spMkLst>
        </pc:spChg>
        <pc:spChg chg="add mod">
          <ac:chgData name="khoi ho" userId="c93cb340-cf97-4d7c-9739-bad0ee582323" providerId="ADAL" clId="{365471B3-2CEF-4916-A41E-7336EB602685}" dt="2020-10-16T06:56:10.120" v="172" actId="1076"/>
          <ac:spMkLst>
            <pc:docMk/>
            <pc:sldMk cId="1836038841" sldId="417"/>
            <ac:spMk id="223" creationId="{17B5CF0F-09B1-48F2-BF10-7E749BC18509}"/>
          </ac:spMkLst>
        </pc:spChg>
        <pc:spChg chg="mod">
          <ac:chgData name="khoi ho" userId="c93cb340-cf97-4d7c-9739-bad0ee582323" providerId="ADAL" clId="{365471B3-2CEF-4916-A41E-7336EB602685}" dt="2020-10-16T06:55:34.306" v="169" actId="1076"/>
          <ac:spMkLst>
            <pc:docMk/>
            <pc:sldMk cId="1836038841" sldId="417"/>
            <ac:spMk id="224" creationId="{A0B05114-E159-49E1-BCF5-D90533430274}"/>
          </ac:spMkLst>
        </pc:spChg>
        <pc:spChg chg="add mod">
          <ac:chgData name="khoi ho" userId="c93cb340-cf97-4d7c-9739-bad0ee582323" providerId="ADAL" clId="{365471B3-2CEF-4916-A41E-7336EB602685}" dt="2020-10-16T06:56:10.120" v="172" actId="1076"/>
          <ac:spMkLst>
            <pc:docMk/>
            <pc:sldMk cId="1836038841" sldId="417"/>
            <ac:spMk id="225" creationId="{4843C6DA-A88F-4FD2-8922-EA2865B4D255}"/>
          </ac:spMkLst>
        </pc:spChg>
        <pc:spChg chg="add mod">
          <ac:chgData name="khoi ho" userId="c93cb340-cf97-4d7c-9739-bad0ee582323" providerId="ADAL" clId="{365471B3-2CEF-4916-A41E-7336EB602685}" dt="2020-10-16T06:56:10.120" v="172" actId="1076"/>
          <ac:spMkLst>
            <pc:docMk/>
            <pc:sldMk cId="1836038841" sldId="417"/>
            <ac:spMk id="227" creationId="{63A15DE8-8902-4BC9-83A2-027C012CC0A8}"/>
          </ac:spMkLst>
        </pc:spChg>
        <pc:spChg chg="add mod">
          <ac:chgData name="khoi ho" userId="c93cb340-cf97-4d7c-9739-bad0ee582323" providerId="ADAL" clId="{365471B3-2CEF-4916-A41E-7336EB602685}" dt="2020-10-16T06:56:10.120" v="172" actId="1076"/>
          <ac:spMkLst>
            <pc:docMk/>
            <pc:sldMk cId="1836038841" sldId="417"/>
            <ac:spMk id="228" creationId="{51FFD499-CA85-427D-B568-CD8D9F3C5E07}"/>
          </ac:spMkLst>
        </pc:spChg>
        <pc:spChg chg="add mod">
          <ac:chgData name="khoi ho" userId="c93cb340-cf97-4d7c-9739-bad0ee582323" providerId="ADAL" clId="{365471B3-2CEF-4916-A41E-7336EB602685}" dt="2020-10-16T06:56:10.120" v="172" actId="1076"/>
          <ac:spMkLst>
            <pc:docMk/>
            <pc:sldMk cId="1836038841" sldId="417"/>
            <ac:spMk id="229" creationId="{EDCE0083-B641-4418-97D9-EF5C64BF1A16}"/>
          </ac:spMkLst>
        </pc:spChg>
        <pc:spChg chg="add del mod">
          <ac:chgData name="khoi ho" userId="c93cb340-cf97-4d7c-9739-bad0ee582323" providerId="ADAL" clId="{365471B3-2CEF-4916-A41E-7336EB602685}" dt="2020-10-15T05:29:14.491" v="57" actId="478"/>
          <ac:spMkLst>
            <pc:docMk/>
            <pc:sldMk cId="1836038841" sldId="417"/>
            <ac:spMk id="230" creationId="{96295C70-90D6-4240-AC34-2A47AF77F0B0}"/>
          </ac:spMkLst>
        </pc:spChg>
        <pc:spChg chg="add del mod">
          <ac:chgData name="khoi ho" userId="c93cb340-cf97-4d7c-9739-bad0ee582323" providerId="ADAL" clId="{365471B3-2CEF-4916-A41E-7336EB602685}" dt="2020-10-15T05:29:15.124" v="58" actId="478"/>
          <ac:spMkLst>
            <pc:docMk/>
            <pc:sldMk cId="1836038841" sldId="417"/>
            <ac:spMk id="231" creationId="{A0A6695D-A3E2-4E97-8236-F2B3059783E3}"/>
          </ac:spMkLst>
        </pc:spChg>
        <pc:spChg chg="add mod">
          <ac:chgData name="khoi ho" userId="c93cb340-cf97-4d7c-9739-bad0ee582323" providerId="ADAL" clId="{365471B3-2CEF-4916-A41E-7336EB602685}" dt="2020-10-16T06:56:10.120" v="172" actId="1076"/>
          <ac:spMkLst>
            <pc:docMk/>
            <pc:sldMk cId="1836038841" sldId="417"/>
            <ac:spMk id="232" creationId="{F52C334B-CDC4-45DC-BAF9-43B5FE921F57}"/>
          </ac:spMkLst>
        </pc:spChg>
        <pc:spChg chg="add del mod">
          <ac:chgData name="khoi ho" userId="c93cb340-cf97-4d7c-9739-bad0ee582323" providerId="ADAL" clId="{365471B3-2CEF-4916-A41E-7336EB602685}" dt="2020-10-15T05:30:04.419" v="73" actId="478"/>
          <ac:spMkLst>
            <pc:docMk/>
            <pc:sldMk cId="1836038841" sldId="417"/>
            <ac:spMk id="233" creationId="{309DC7BA-DE7C-4850-B60F-B0F9C8179F01}"/>
          </ac:spMkLst>
        </pc:spChg>
        <pc:spChg chg="mod">
          <ac:chgData name="khoi ho" userId="c93cb340-cf97-4d7c-9739-bad0ee582323" providerId="ADAL" clId="{365471B3-2CEF-4916-A41E-7336EB602685}" dt="2020-10-16T06:55:34.306" v="169" actId="1076"/>
          <ac:spMkLst>
            <pc:docMk/>
            <pc:sldMk cId="1836038841" sldId="417"/>
            <ac:spMk id="234" creationId="{52889D10-F584-4C75-9C67-876F0BB42E83}"/>
          </ac:spMkLst>
        </pc:spChg>
        <pc:spChg chg="mod">
          <ac:chgData name="khoi ho" userId="c93cb340-cf97-4d7c-9739-bad0ee582323" providerId="ADAL" clId="{365471B3-2CEF-4916-A41E-7336EB602685}" dt="2020-10-16T06:55:34.306" v="169" actId="1076"/>
          <ac:spMkLst>
            <pc:docMk/>
            <pc:sldMk cId="1836038841" sldId="417"/>
            <ac:spMk id="235" creationId="{9DA7D8E3-4F34-49C1-A03C-0E0B885B6E78}"/>
          </ac:spMkLst>
        </pc:spChg>
        <pc:spChg chg="mod">
          <ac:chgData name="khoi ho" userId="c93cb340-cf97-4d7c-9739-bad0ee582323" providerId="ADAL" clId="{365471B3-2CEF-4916-A41E-7336EB602685}" dt="2020-10-16T06:55:34.306" v="169" actId="1076"/>
          <ac:spMkLst>
            <pc:docMk/>
            <pc:sldMk cId="1836038841" sldId="417"/>
            <ac:spMk id="236" creationId="{1818ED09-2089-4345-966D-263838EC1072}"/>
          </ac:spMkLst>
        </pc:spChg>
        <pc:spChg chg="add del mod">
          <ac:chgData name="khoi ho" userId="c93cb340-cf97-4d7c-9739-bad0ee582323" providerId="ADAL" clId="{365471B3-2CEF-4916-A41E-7336EB602685}" dt="2020-10-15T05:29:50.819" v="70" actId="478"/>
          <ac:spMkLst>
            <pc:docMk/>
            <pc:sldMk cId="1836038841" sldId="417"/>
            <ac:spMk id="237" creationId="{93197CE4-E980-463F-9972-4512C3045F48}"/>
          </ac:spMkLst>
        </pc:spChg>
        <pc:spChg chg="add del mod">
          <ac:chgData name="khoi ho" userId="c93cb340-cf97-4d7c-9739-bad0ee582323" providerId="ADAL" clId="{365471B3-2CEF-4916-A41E-7336EB602685}" dt="2020-10-15T05:38:22.458" v="96" actId="478"/>
          <ac:spMkLst>
            <pc:docMk/>
            <pc:sldMk cId="1836038841" sldId="417"/>
            <ac:spMk id="239" creationId="{CC3A15B1-AB10-43EA-90FE-F7BF06242938}"/>
          </ac:spMkLst>
        </pc:spChg>
        <pc:spChg chg="add mod">
          <ac:chgData name="khoi ho" userId="c93cb340-cf97-4d7c-9739-bad0ee582323" providerId="ADAL" clId="{365471B3-2CEF-4916-A41E-7336EB602685}" dt="2020-10-16T06:56:10.120" v="172" actId="1076"/>
          <ac:spMkLst>
            <pc:docMk/>
            <pc:sldMk cId="1836038841" sldId="417"/>
            <ac:spMk id="240" creationId="{FE4FF16D-DBF1-4769-8690-D439C8A60EFE}"/>
          </ac:spMkLst>
        </pc:spChg>
        <pc:spChg chg="add mod">
          <ac:chgData name="khoi ho" userId="c93cb340-cf97-4d7c-9739-bad0ee582323" providerId="ADAL" clId="{365471B3-2CEF-4916-A41E-7336EB602685}" dt="2020-10-16T06:56:10.120" v="172" actId="1076"/>
          <ac:spMkLst>
            <pc:docMk/>
            <pc:sldMk cId="1836038841" sldId="417"/>
            <ac:spMk id="241" creationId="{09AB5CF2-9A43-4F42-B3CA-7F8E67E2A2A7}"/>
          </ac:spMkLst>
        </pc:spChg>
        <pc:spChg chg="add mod">
          <ac:chgData name="khoi ho" userId="c93cb340-cf97-4d7c-9739-bad0ee582323" providerId="ADAL" clId="{365471B3-2CEF-4916-A41E-7336EB602685}" dt="2020-10-16T06:56:10.120" v="172" actId="1076"/>
          <ac:spMkLst>
            <pc:docMk/>
            <pc:sldMk cId="1836038841" sldId="417"/>
            <ac:spMk id="242" creationId="{35C86FBE-BB6B-4C43-B8B7-30F6E8862129}"/>
          </ac:spMkLst>
        </pc:spChg>
        <pc:spChg chg="add mod">
          <ac:chgData name="khoi ho" userId="c93cb340-cf97-4d7c-9739-bad0ee582323" providerId="ADAL" clId="{365471B3-2CEF-4916-A41E-7336EB602685}" dt="2020-10-16T06:56:10.120" v="172" actId="1076"/>
          <ac:spMkLst>
            <pc:docMk/>
            <pc:sldMk cId="1836038841" sldId="417"/>
            <ac:spMk id="243" creationId="{3E207A93-F101-4BB5-9DE4-8D6E13D0AB7D}"/>
          </ac:spMkLst>
        </pc:spChg>
        <pc:spChg chg="add mod">
          <ac:chgData name="khoi ho" userId="c93cb340-cf97-4d7c-9739-bad0ee582323" providerId="ADAL" clId="{365471B3-2CEF-4916-A41E-7336EB602685}" dt="2020-10-16T06:56:10.120" v="172" actId="1076"/>
          <ac:spMkLst>
            <pc:docMk/>
            <pc:sldMk cId="1836038841" sldId="417"/>
            <ac:spMk id="244" creationId="{2488F43E-8EE0-4C61-8C8C-D0D557097DB9}"/>
          </ac:spMkLst>
        </pc:spChg>
        <pc:spChg chg="add mod">
          <ac:chgData name="khoi ho" userId="c93cb340-cf97-4d7c-9739-bad0ee582323" providerId="ADAL" clId="{365471B3-2CEF-4916-A41E-7336EB602685}" dt="2020-10-16T06:56:10.120" v="172" actId="1076"/>
          <ac:spMkLst>
            <pc:docMk/>
            <pc:sldMk cId="1836038841" sldId="417"/>
            <ac:spMk id="245" creationId="{087FA4D7-D3A5-4A51-AC44-5E22E9E1829B}"/>
          </ac:spMkLst>
        </pc:spChg>
        <pc:spChg chg="add mod">
          <ac:chgData name="khoi ho" userId="c93cb340-cf97-4d7c-9739-bad0ee582323" providerId="ADAL" clId="{365471B3-2CEF-4916-A41E-7336EB602685}" dt="2020-10-16T06:56:10.120" v="172" actId="1076"/>
          <ac:spMkLst>
            <pc:docMk/>
            <pc:sldMk cId="1836038841" sldId="417"/>
            <ac:spMk id="246" creationId="{295D9A31-87DB-43A7-99E9-FE971393E25C}"/>
          </ac:spMkLst>
        </pc:spChg>
        <pc:spChg chg="add del mod">
          <ac:chgData name="khoi ho" userId="c93cb340-cf97-4d7c-9739-bad0ee582323" providerId="ADAL" clId="{365471B3-2CEF-4916-A41E-7336EB602685}" dt="2020-10-15T05:35:31.180" v="81" actId="478"/>
          <ac:spMkLst>
            <pc:docMk/>
            <pc:sldMk cId="1836038841" sldId="417"/>
            <ac:spMk id="247" creationId="{57C7BC25-C045-4F2A-B194-CE21F4038916}"/>
          </ac:spMkLst>
        </pc:spChg>
        <pc:spChg chg="add del mod">
          <ac:chgData name="khoi ho" userId="c93cb340-cf97-4d7c-9739-bad0ee582323" providerId="ADAL" clId="{365471B3-2CEF-4916-A41E-7336EB602685}" dt="2020-10-15T05:38:25.636" v="99" actId="478"/>
          <ac:spMkLst>
            <pc:docMk/>
            <pc:sldMk cId="1836038841" sldId="417"/>
            <ac:spMk id="249" creationId="{0F5CF942-BD5A-42C3-BC72-F33E59E9050C}"/>
          </ac:spMkLst>
        </pc:spChg>
        <pc:spChg chg="add del mod">
          <ac:chgData name="khoi ho" userId="c93cb340-cf97-4d7c-9739-bad0ee582323" providerId="ADAL" clId="{365471B3-2CEF-4916-A41E-7336EB602685}" dt="2020-10-15T05:38:26.358" v="100" actId="478"/>
          <ac:spMkLst>
            <pc:docMk/>
            <pc:sldMk cId="1836038841" sldId="417"/>
            <ac:spMk id="250" creationId="{D6257F0C-9A35-4ED7-BE06-B89096BCA71A}"/>
          </ac:spMkLst>
        </pc:spChg>
        <pc:spChg chg="mod">
          <ac:chgData name="khoi ho" userId="c93cb340-cf97-4d7c-9739-bad0ee582323" providerId="ADAL" clId="{365471B3-2CEF-4916-A41E-7336EB602685}" dt="2020-10-16T06:55:34.306" v="169" actId="1076"/>
          <ac:spMkLst>
            <pc:docMk/>
            <pc:sldMk cId="1836038841" sldId="417"/>
            <ac:spMk id="251" creationId="{012F6FE2-024E-46A8-B98F-B6DEA7D53604}"/>
          </ac:spMkLst>
        </pc:spChg>
        <pc:spChg chg="mod">
          <ac:chgData name="khoi ho" userId="c93cb340-cf97-4d7c-9739-bad0ee582323" providerId="ADAL" clId="{365471B3-2CEF-4916-A41E-7336EB602685}" dt="2020-10-16T06:55:34.306" v="169" actId="1076"/>
          <ac:spMkLst>
            <pc:docMk/>
            <pc:sldMk cId="1836038841" sldId="417"/>
            <ac:spMk id="252" creationId="{C15A3BEA-92DA-4F5C-B308-2C2DD2582177}"/>
          </ac:spMkLst>
        </pc:spChg>
        <pc:spChg chg="mod">
          <ac:chgData name="khoi ho" userId="c93cb340-cf97-4d7c-9739-bad0ee582323" providerId="ADAL" clId="{365471B3-2CEF-4916-A41E-7336EB602685}" dt="2020-10-16T06:55:34.306" v="169" actId="1076"/>
          <ac:spMkLst>
            <pc:docMk/>
            <pc:sldMk cId="1836038841" sldId="417"/>
            <ac:spMk id="254" creationId="{8EE7B6F0-3F5A-40AC-A4D0-9DF61AD30517}"/>
          </ac:spMkLst>
        </pc:spChg>
        <pc:spChg chg="add del mod">
          <ac:chgData name="khoi ho" userId="c93cb340-cf97-4d7c-9739-bad0ee582323" providerId="ADAL" clId="{365471B3-2CEF-4916-A41E-7336EB602685}" dt="2020-10-15T05:35:31.987" v="82" actId="478"/>
          <ac:spMkLst>
            <pc:docMk/>
            <pc:sldMk cId="1836038841" sldId="417"/>
            <ac:spMk id="256" creationId="{2654E617-9BCB-414A-B9FF-8AF1D507A2A6}"/>
          </ac:spMkLst>
        </pc:spChg>
        <pc:spChg chg="add del mod">
          <ac:chgData name="khoi ho" userId="c93cb340-cf97-4d7c-9739-bad0ee582323" providerId="ADAL" clId="{365471B3-2CEF-4916-A41E-7336EB602685}" dt="2020-10-15T05:29:50.178" v="69" actId="478"/>
          <ac:spMkLst>
            <pc:docMk/>
            <pc:sldMk cId="1836038841" sldId="417"/>
            <ac:spMk id="263" creationId="{007A99A1-08DD-4366-B314-2A5D107F0290}"/>
          </ac:spMkLst>
        </pc:spChg>
        <pc:spChg chg="add del mod">
          <ac:chgData name="khoi ho" userId="c93cb340-cf97-4d7c-9739-bad0ee582323" providerId="ADAL" clId="{365471B3-2CEF-4916-A41E-7336EB602685}" dt="2020-10-15T05:29:52.380" v="71" actId="478"/>
          <ac:spMkLst>
            <pc:docMk/>
            <pc:sldMk cId="1836038841" sldId="417"/>
            <ac:spMk id="264" creationId="{EA99C8B7-34A7-43EC-BD61-F74DE689B39D}"/>
          </ac:spMkLst>
        </pc:spChg>
        <pc:spChg chg="add del mod">
          <ac:chgData name="khoi ho" userId="c93cb340-cf97-4d7c-9739-bad0ee582323" providerId="ADAL" clId="{365471B3-2CEF-4916-A41E-7336EB602685}" dt="2020-10-15T05:30:03.819" v="72" actId="478"/>
          <ac:spMkLst>
            <pc:docMk/>
            <pc:sldMk cId="1836038841" sldId="417"/>
            <ac:spMk id="265" creationId="{6B4BB6A6-1C63-43CA-8D27-5BB8A29A9E45}"/>
          </ac:spMkLst>
        </pc:spChg>
        <pc:spChg chg="add del mod">
          <ac:chgData name="khoi ho" userId="c93cb340-cf97-4d7c-9739-bad0ee582323" providerId="ADAL" clId="{365471B3-2CEF-4916-A41E-7336EB602685}" dt="2020-10-15T05:30:11.356" v="74" actId="478"/>
          <ac:spMkLst>
            <pc:docMk/>
            <pc:sldMk cId="1836038841" sldId="417"/>
            <ac:spMk id="266" creationId="{0540BCE8-181E-4223-AAA9-1A669C9A56A5}"/>
          </ac:spMkLst>
        </pc:spChg>
        <pc:spChg chg="add del mod">
          <ac:chgData name="khoi ho" userId="c93cb340-cf97-4d7c-9739-bad0ee582323" providerId="ADAL" clId="{365471B3-2CEF-4916-A41E-7336EB602685}" dt="2020-10-15T05:29:25.395" v="63" actId="478"/>
          <ac:spMkLst>
            <pc:docMk/>
            <pc:sldMk cId="1836038841" sldId="417"/>
            <ac:spMk id="267" creationId="{BC39C787-5D65-4B66-BC16-FDC8D3D36B0F}"/>
          </ac:spMkLst>
        </pc:spChg>
        <pc:spChg chg="add mod">
          <ac:chgData name="khoi ho" userId="c93cb340-cf97-4d7c-9739-bad0ee582323" providerId="ADAL" clId="{365471B3-2CEF-4916-A41E-7336EB602685}" dt="2020-10-16T06:56:10.120" v="172" actId="1076"/>
          <ac:spMkLst>
            <pc:docMk/>
            <pc:sldMk cId="1836038841" sldId="417"/>
            <ac:spMk id="268" creationId="{944FFDD6-0D3E-4A09-89C5-C2A057FCACB6}"/>
          </ac:spMkLst>
        </pc:spChg>
        <pc:spChg chg="mod">
          <ac:chgData name="khoi ho" userId="c93cb340-cf97-4d7c-9739-bad0ee582323" providerId="ADAL" clId="{365471B3-2CEF-4916-A41E-7336EB602685}" dt="2020-10-16T06:55:34.306" v="169" actId="1076"/>
          <ac:spMkLst>
            <pc:docMk/>
            <pc:sldMk cId="1836038841" sldId="417"/>
            <ac:spMk id="398" creationId="{3222BB13-A89C-4A00-A9D5-90FE67AF74F2}"/>
          </ac:spMkLst>
        </pc:spChg>
        <pc:spChg chg="mod">
          <ac:chgData name="khoi ho" userId="c93cb340-cf97-4d7c-9739-bad0ee582323" providerId="ADAL" clId="{365471B3-2CEF-4916-A41E-7336EB602685}" dt="2020-10-16T06:55:34.306" v="169" actId="1076"/>
          <ac:spMkLst>
            <pc:docMk/>
            <pc:sldMk cId="1836038841" sldId="417"/>
            <ac:spMk id="419" creationId="{810A7290-0058-4099-98A6-5A4093A44DBA}"/>
          </ac:spMkLst>
        </pc:spChg>
        <pc:spChg chg="mod">
          <ac:chgData name="khoi ho" userId="c93cb340-cf97-4d7c-9739-bad0ee582323" providerId="ADAL" clId="{365471B3-2CEF-4916-A41E-7336EB602685}" dt="2020-10-16T06:55:34.306" v="169" actId="1076"/>
          <ac:spMkLst>
            <pc:docMk/>
            <pc:sldMk cId="1836038841" sldId="417"/>
            <ac:spMk id="438" creationId="{D85901EA-DC35-4359-AF4D-7CBE6396D6FF}"/>
          </ac:spMkLst>
        </pc:spChg>
        <pc:spChg chg="mod">
          <ac:chgData name="khoi ho" userId="c93cb340-cf97-4d7c-9739-bad0ee582323" providerId="ADAL" clId="{365471B3-2CEF-4916-A41E-7336EB602685}" dt="2020-10-16T06:55:34.306" v="169" actId="1076"/>
          <ac:spMkLst>
            <pc:docMk/>
            <pc:sldMk cId="1836038841" sldId="417"/>
            <ac:spMk id="439" creationId="{5C55DE89-E849-48DA-8C93-A627100ABFB9}"/>
          </ac:spMkLst>
        </pc:spChg>
        <pc:spChg chg="mod">
          <ac:chgData name="khoi ho" userId="c93cb340-cf97-4d7c-9739-bad0ee582323" providerId="ADAL" clId="{365471B3-2CEF-4916-A41E-7336EB602685}" dt="2020-10-16T06:55:34.306" v="169" actId="1076"/>
          <ac:spMkLst>
            <pc:docMk/>
            <pc:sldMk cId="1836038841" sldId="417"/>
            <ac:spMk id="440" creationId="{483F83CB-339B-4470-B0A0-BCEF2DADAD03}"/>
          </ac:spMkLst>
        </pc:spChg>
        <pc:spChg chg="mod">
          <ac:chgData name="khoi ho" userId="c93cb340-cf97-4d7c-9739-bad0ee582323" providerId="ADAL" clId="{365471B3-2CEF-4916-A41E-7336EB602685}" dt="2020-10-16T06:55:34.306" v="169" actId="1076"/>
          <ac:spMkLst>
            <pc:docMk/>
            <pc:sldMk cId="1836038841" sldId="417"/>
            <ac:spMk id="441" creationId="{329D0487-4E65-4439-8C70-EBE6F7AE11E8}"/>
          </ac:spMkLst>
        </pc:spChg>
        <pc:spChg chg="mod">
          <ac:chgData name="khoi ho" userId="c93cb340-cf97-4d7c-9739-bad0ee582323" providerId="ADAL" clId="{365471B3-2CEF-4916-A41E-7336EB602685}" dt="2020-10-16T06:55:34.306" v="169" actId="1076"/>
          <ac:spMkLst>
            <pc:docMk/>
            <pc:sldMk cId="1836038841" sldId="417"/>
            <ac:spMk id="442" creationId="{9DA83F5F-CCC5-4052-85E6-FD1A34AE7935}"/>
          </ac:spMkLst>
        </pc:spChg>
        <pc:spChg chg="mod">
          <ac:chgData name="khoi ho" userId="c93cb340-cf97-4d7c-9739-bad0ee582323" providerId="ADAL" clId="{365471B3-2CEF-4916-A41E-7336EB602685}" dt="2020-10-16T06:55:34.306" v="169" actId="1076"/>
          <ac:spMkLst>
            <pc:docMk/>
            <pc:sldMk cId="1836038841" sldId="417"/>
            <ac:spMk id="448" creationId="{8CC366E0-95A8-42FC-87F1-095000584BBD}"/>
          </ac:spMkLst>
        </pc:spChg>
        <pc:spChg chg="mod">
          <ac:chgData name="khoi ho" userId="c93cb340-cf97-4d7c-9739-bad0ee582323" providerId="ADAL" clId="{365471B3-2CEF-4916-A41E-7336EB602685}" dt="2020-10-16T06:55:34.306" v="169" actId="1076"/>
          <ac:spMkLst>
            <pc:docMk/>
            <pc:sldMk cId="1836038841" sldId="417"/>
            <ac:spMk id="449" creationId="{1E9E4293-7760-45D7-8CB7-4B792EA9DD07}"/>
          </ac:spMkLst>
        </pc:spChg>
        <pc:spChg chg="mod">
          <ac:chgData name="khoi ho" userId="c93cb340-cf97-4d7c-9739-bad0ee582323" providerId="ADAL" clId="{365471B3-2CEF-4916-A41E-7336EB602685}" dt="2020-10-16T06:55:34.306" v="169" actId="1076"/>
          <ac:spMkLst>
            <pc:docMk/>
            <pc:sldMk cId="1836038841" sldId="417"/>
            <ac:spMk id="502" creationId="{51F3EC07-83BF-4EB7-BA15-A2BC2541003D}"/>
          </ac:spMkLst>
        </pc:spChg>
        <pc:spChg chg="mod">
          <ac:chgData name="khoi ho" userId="c93cb340-cf97-4d7c-9739-bad0ee582323" providerId="ADAL" clId="{365471B3-2CEF-4916-A41E-7336EB602685}" dt="2020-10-16T06:55:34.306" v="169" actId="1076"/>
          <ac:spMkLst>
            <pc:docMk/>
            <pc:sldMk cId="1836038841" sldId="417"/>
            <ac:spMk id="687" creationId="{FFD52A56-253A-428D-AB18-F8A3C2E622CB}"/>
          </ac:spMkLst>
        </pc:spChg>
        <pc:spChg chg="mod">
          <ac:chgData name="khoi ho" userId="c93cb340-cf97-4d7c-9739-bad0ee582323" providerId="ADAL" clId="{365471B3-2CEF-4916-A41E-7336EB602685}" dt="2020-10-16T06:55:34.306" v="169" actId="1076"/>
          <ac:spMkLst>
            <pc:docMk/>
            <pc:sldMk cId="1836038841" sldId="417"/>
            <ac:spMk id="688" creationId="{3CC0C569-4BE3-4BDB-9C84-D14029A12799}"/>
          </ac:spMkLst>
        </pc:spChg>
        <pc:spChg chg="mod">
          <ac:chgData name="khoi ho" userId="c93cb340-cf97-4d7c-9739-bad0ee582323" providerId="ADAL" clId="{365471B3-2CEF-4916-A41E-7336EB602685}" dt="2020-10-16T06:55:34.306" v="169" actId="1076"/>
          <ac:spMkLst>
            <pc:docMk/>
            <pc:sldMk cId="1836038841" sldId="417"/>
            <ac:spMk id="730" creationId="{14A05DDF-3BA3-455B-A67B-15018D337C95}"/>
          </ac:spMkLst>
        </pc:spChg>
        <pc:spChg chg="mod">
          <ac:chgData name="khoi ho" userId="c93cb340-cf97-4d7c-9739-bad0ee582323" providerId="ADAL" clId="{365471B3-2CEF-4916-A41E-7336EB602685}" dt="2020-10-16T06:55:34.306" v="169" actId="1076"/>
          <ac:spMkLst>
            <pc:docMk/>
            <pc:sldMk cId="1836038841" sldId="417"/>
            <ac:spMk id="731" creationId="{CB3508E6-85A4-4528-A0EF-E2DE2F4A12A7}"/>
          </ac:spMkLst>
        </pc:spChg>
        <pc:spChg chg="mod">
          <ac:chgData name="khoi ho" userId="c93cb340-cf97-4d7c-9739-bad0ee582323" providerId="ADAL" clId="{365471B3-2CEF-4916-A41E-7336EB602685}" dt="2020-10-16T06:55:34.306" v="169" actId="1076"/>
          <ac:spMkLst>
            <pc:docMk/>
            <pc:sldMk cId="1836038841" sldId="417"/>
            <ac:spMk id="738" creationId="{2F096354-BFD3-4965-90CA-7F9EEFF2E52E}"/>
          </ac:spMkLst>
        </pc:spChg>
        <pc:spChg chg="mod">
          <ac:chgData name="khoi ho" userId="c93cb340-cf97-4d7c-9739-bad0ee582323" providerId="ADAL" clId="{365471B3-2CEF-4916-A41E-7336EB602685}" dt="2020-10-16T06:55:34.306" v="169" actId="1076"/>
          <ac:spMkLst>
            <pc:docMk/>
            <pc:sldMk cId="1836038841" sldId="417"/>
            <ac:spMk id="739" creationId="{D54CDBFA-6B57-4199-BCC6-552C9D36795F}"/>
          </ac:spMkLst>
        </pc:spChg>
        <pc:spChg chg="mod">
          <ac:chgData name="khoi ho" userId="c93cb340-cf97-4d7c-9739-bad0ee582323" providerId="ADAL" clId="{365471B3-2CEF-4916-A41E-7336EB602685}" dt="2020-10-16T06:55:34.306" v="169" actId="1076"/>
          <ac:spMkLst>
            <pc:docMk/>
            <pc:sldMk cId="1836038841" sldId="417"/>
            <ac:spMk id="740" creationId="{BA365201-AD85-4D57-8148-61A8A3231176}"/>
          </ac:spMkLst>
        </pc:spChg>
        <pc:spChg chg="mod">
          <ac:chgData name="khoi ho" userId="c93cb340-cf97-4d7c-9739-bad0ee582323" providerId="ADAL" clId="{365471B3-2CEF-4916-A41E-7336EB602685}" dt="2020-10-16T06:55:34.306" v="169" actId="1076"/>
          <ac:spMkLst>
            <pc:docMk/>
            <pc:sldMk cId="1836038841" sldId="417"/>
            <ac:spMk id="741" creationId="{C1D508DC-4275-482D-9F25-301813A15E89}"/>
          </ac:spMkLst>
        </pc:spChg>
        <pc:spChg chg="mod">
          <ac:chgData name="khoi ho" userId="c93cb340-cf97-4d7c-9739-bad0ee582323" providerId="ADAL" clId="{365471B3-2CEF-4916-A41E-7336EB602685}" dt="2020-10-16T06:55:34.306" v="169" actId="1076"/>
          <ac:spMkLst>
            <pc:docMk/>
            <pc:sldMk cId="1836038841" sldId="417"/>
            <ac:spMk id="742" creationId="{FC11DD2F-15F3-4302-940A-8A73CA373022}"/>
          </ac:spMkLst>
        </pc:spChg>
        <pc:spChg chg="mod">
          <ac:chgData name="khoi ho" userId="c93cb340-cf97-4d7c-9739-bad0ee582323" providerId="ADAL" clId="{365471B3-2CEF-4916-A41E-7336EB602685}" dt="2020-10-16T06:55:34.306" v="169" actId="1076"/>
          <ac:spMkLst>
            <pc:docMk/>
            <pc:sldMk cId="1836038841" sldId="417"/>
            <ac:spMk id="743" creationId="{513EE325-660D-40B6-9508-C79DAF46B11F}"/>
          </ac:spMkLst>
        </pc:spChg>
        <pc:spChg chg="mod">
          <ac:chgData name="khoi ho" userId="c93cb340-cf97-4d7c-9739-bad0ee582323" providerId="ADAL" clId="{365471B3-2CEF-4916-A41E-7336EB602685}" dt="2020-10-16T06:55:34.306" v="169" actId="1076"/>
          <ac:spMkLst>
            <pc:docMk/>
            <pc:sldMk cId="1836038841" sldId="417"/>
            <ac:spMk id="744" creationId="{5F5A82EC-1321-4554-90B4-1B3988DB25C9}"/>
          </ac:spMkLst>
        </pc:spChg>
        <pc:spChg chg="mod">
          <ac:chgData name="khoi ho" userId="c93cb340-cf97-4d7c-9739-bad0ee582323" providerId="ADAL" clId="{365471B3-2CEF-4916-A41E-7336EB602685}" dt="2020-10-16T06:55:34.306" v="169" actId="1076"/>
          <ac:spMkLst>
            <pc:docMk/>
            <pc:sldMk cId="1836038841" sldId="417"/>
            <ac:spMk id="745" creationId="{E13B26F2-17E0-46F0-BD5D-9F6E03278F94}"/>
          </ac:spMkLst>
        </pc:spChg>
        <pc:spChg chg="mod">
          <ac:chgData name="khoi ho" userId="c93cb340-cf97-4d7c-9739-bad0ee582323" providerId="ADAL" clId="{365471B3-2CEF-4916-A41E-7336EB602685}" dt="2020-10-16T06:55:34.306" v="169" actId="1076"/>
          <ac:spMkLst>
            <pc:docMk/>
            <pc:sldMk cId="1836038841" sldId="417"/>
            <ac:spMk id="750" creationId="{F6A5C1F7-0F88-4E75-873E-5D12D7F64056}"/>
          </ac:spMkLst>
        </pc:spChg>
        <pc:spChg chg="mod">
          <ac:chgData name="khoi ho" userId="c93cb340-cf97-4d7c-9739-bad0ee582323" providerId="ADAL" clId="{365471B3-2CEF-4916-A41E-7336EB602685}" dt="2020-10-16T06:55:34.306" v="169" actId="1076"/>
          <ac:spMkLst>
            <pc:docMk/>
            <pc:sldMk cId="1836038841" sldId="417"/>
            <ac:spMk id="752" creationId="{819D58A7-1142-4093-A83E-27F7B4DD66E4}"/>
          </ac:spMkLst>
        </pc:spChg>
        <pc:spChg chg="mod">
          <ac:chgData name="khoi ho" userId="c93cb340-cf97-4d7c-9739-bad0ee582323" providerId="ADAL" clId="{365471B3-2CEF-4916-A41E-7336EB602685}" dt="2020-10-16T06:55:34.306" v="169" actId="1076"/>
          <ac:spMkLst>
            <pc:docMk/>
            <pc:sldMk cId="1836038841" sldId="417"/>
            <ac:spMk id="753" creationId="{236616A7-F9B1-4F7B-8669-62E057AE659E}"/>
          </ac:spMkLst>
        </pc:spChg>
        <pc:spChg chg="mod">
          <ac:chgData name="khoi ho" userId="c93cb340-cf97-4d7c-9739-bad0ee582323" providerId="ADAL" clId="{365471B3-2CEF-4916-A41E-7336EB602685}" dt="2020-10-16T06:55:34.306" v="169" actId="1076"/>
          <ac:spMkLst>
            <pc:docMk/>
            <pc:sldMk cId="1836038841" sldId="417"/>
            <ac:spMk id="754" creationId="{52A0D542-CCD6-4A9C-BC8E-0CD8D213509E}"/>
          </ac:spMkLst>
        </pc:spChg>
        <pc:spChg chg="mod">
          <ac:chgData name="khoi ho" userId="c93cb340-cf97-4d7c-9739-bad0ee582323" providerId="ADAL" clId="{365471B3-2CEF-4916-A41E-7336EB602685}" dt="2020-10-16T06:55:34.306" v="169" actId="1076"/>
          <ac:spMkLst>
            <pc:docMk/>
            <pc:sldMk cId="1836038841" sldId="417"/>
            <ac:spMk id="755" creationId="{5A0A6250-3839-4470-896D-DE16E87D5D37}"/>
          </ac:spMkLst>
        </pc:spChg>
        <pc:spChg chg="mod">
          <ac:chgData name="khoi ho" userId="c93cb340-cf97-4d7c-9739-bad0ee582323" providerId="ADAL" clId="{365471B3-2CEF-4916-A41E-7336EB602685}" dt="2020-10-16T06:55:34.306" v="169" actId="1076"/>
          <ac:spMkLst>
            <pc:docMk/>
            <pc:sldMk cId="1836038841" sldId="417"/>
            <ac:spMk id="756" creationId="{000875D0-FC94-4860-A450-B0EAC0269ADE}"/>
          </ac:spMkLst>
        </pc:spChg>
        <pc:grpChg chg="mod">
          <ac:chgData name="khoi ho" userId="c93cb340-cf97-4d7c-9739-bad0ee582323" providerId="ADAL" clId="{365471B3-2CEF-4916-A41E-7336EB602685}" dt="2020-10-16T06:55:34.306" v="169" actId="1076"/>
          <ac:grpSpMkLst>
            <pc:docMk/>
            <pc:sldMk cId="1836038841" sldId="417"/>
            <ac:grpSpMk id="107" creationId="{E0C45EB9-8DE5-481C-9C09-ADB10CB141C9}"/>
          </ac:grpSpMkLst>
        </pc:grpChg>
        <pc:grpChg chg="add mod">
          <ac:chgData name="khoi ho" userId="c93cb340-cf97-4d7c-9739-bad0ee582323" providerId="ADAL" clId="{365471B3-2CEF-4916-A41E-7336EB602685}" dt="2020-10-16T06:56:10.120" v="172" actId="1076"/>
          <ac:grpSpMkLst>
            <pc:docMk/>
            <pc:sldMk cId="1836038841" sldId="417"/>
            <ac:grpSpMk id="125" creationId="{473DA851-8C04-4B5D-B065-1C07C2F2F08E}"/>
          </ac:grpSpMkLst>
        </pc:grpChg>
        <pc:grpChg chg="add del mod">
          <ac:chgData name="khoi ho" userId="c93cb340-cf97-4d7c-9739-bad0ee582323" providerId="ADAL" clId="{365471B3-2CEF-4916-A41E-7336EB602685}" dt="2020-10-15T05:29:13.005" v="56" actId="478"/>
          <ac:grpSpMkLst>
            <pc:docMk/>
            <pc:sldMk cId="1836038841" sldId="417"/>
            <ac:grpSpMk id="128" creationId="{41519F5D-1654-426C-80D6-D2C48095F0E1}"/>
          </ac:grpSpMkLst>
        </pc:grpChg>
        <pc:grpChg chg="add mod">
          <ac:chgData name="khoi ho" userId="c93cb340-cf97-4d7c-9739-bad0ee582323" providerId="ADAL" clId="{365471B3-2CEF-4916-A41E-7336EB602685}" dt="2020-10-16T06:56:10.120" v="172" actId="1076"/>
          <ac:grpSpMkLst>
            <pc:docMk/>
            <pc:sldMk cId="1836038841" sldId="417"/>
            <ac:grpSpMk id="131" creationId="{074A643C-3A71-4577-912C-AB95F03A0925}"/>
          </ac:grpSpMkLst>
        </pc:grpChg>
        <pc:grpChg chg="mod">
          <ac:chgData name="khoi ho" userId="c93cb340-cf97-4d7c-9739-bad0ee582323" providerId="ADAL" clId="{365471B3-2CEF-4916-A41E-7336EB602685}" dt="2020-10-16T06:55:34.306" v="169" actId="1076"/>
          <ac:grpSpMkLst>
            <pc:docMk/>
            <pc:sldMk cId="1836038841" sldId="417"/>
            <ac:grpSpMk id="132" creationId="{E113D0B3-B956-4F7F-AD7A-6B5C577F4E64}"/>
          </ac:grpSpMkLst>
        </pc:grpChg>
        <pc:grpChg chg="add del mod">
          <ac:chgData name="khoi ho" userId="c93cb340-cf97-4d7c-9739-bad0ee582323" providerId="ADAL" clId="{365471B3-2CEF-4916-A41E-7336EB602685}" dt="2020-10-15T05:29:16.758" v="59" actId="478"/>
          <ac:grpSpMkLst>
            <pc:docMk/>
            <pc:sldMk cId="1836038841" sldId="417"/>
            <ac:grpSpMk id="155" creationId="{7ACC5BFC-F750-4ECC-AD86-10C7F056F265}"/>
          </ac:grpSpMkLst>
        </pc:grpChg>
        <pc:grpChg chg="mod">
          <ac:chgData name="khoi ho" userId="c93cb340-cf97-4d7c-9739-bad0ee582323" providerId="ADAL" clId="{365471B3-2CEF-4916-A41E-7336EB602685}" dt="2020-10-16T06:55:34.306" v="169" actId="1076"/>
          <ac:grpSpMkLst>
            <pc:docMk/>
            <pc:sldMk cId="1836038841" sldId="417"/>
            <ac:grpSpMk id="173" creationId="{E20C0A05-ACBB-4C85-8EE4-6CAB11583C91}"/>
          </ac:grpSpMkLst>
        </pc:grpChg>
        <pc:grpChg chg="mod">
          <ac:chgData name="khoi ho" userId="c93cb340-cf97-4d7c-9739-bad0ee582323" providerId="ADAL" clId="{365471B3-2CEF-4916-A41E-7336EB602685}" dt="2020-10-16T06:55:34.306" v="169" actId="1076"/>
          <ac:grpSpMkLst>
            <pc:docMk/>
            <pc:sldMk cId="1836038841" sldId="417"/>
            <ac:grpSpMk id="200" creationId="{AC934CE0-203B-4E75-85E7-E6A90CEBE761}"/>
          </ac:grpSpMkLst>
        </pc:grpChg>
        <pc:graphicFrameChg chg="del">
          <ac:chgData name="khoi ho" userId="c93cb340-cf97-4d7c-9739-bad0ee582323" providerId="ADAL" clId="{365471B3-2CEF-4916-A41E-7336EB602685}" dt="2020-10-15T05:03:25.033" v="18" actId="478"/>
          <ac:graphicFrameMkLst>
            <pc:docMk/>
            <pc:sldMk cId="1836038841" sldId="417"/>
            <ac:graphicFrameMk id="6" creationId="{3E16D172-9436-4B24-9CE9-CEB2D31EF667}"/>
          </ac:graphicFrameMkLst>
        </pc:graphicFrameChg>
        <pc:graphicFrameChg chg="add del mod">
          <ac:chgData name="khoi ho" userId="c93cb340-cf97-4d7c-9739-bad0ee582323" providerId="ADAL" clId="{365471B3-2CEF-4916-A41E-7336EB602685}" dt="2020-10-16T06:53:44.960" v="158"/>
          <ac:graphicFrameMkLst>
            <pc:docMk/>
            <pc:sldMk cId="1836038841" sldId="417"/>
            <ac:graphicFrameMk id="37" creationId="{183D321B-1FDB-4BC4-AC5B-F62117784859}"/>
          </ac:graphicFrameMkLst>
        </pc:graphicFrameChg>
        <pc:graphicFrameChg chg="add del mod">
          <ac:chgData name="khoi ho" userId="c93cb340-cf97-4d7c-9739-bad0ee582323" providerId="ADAL" clId="{365471B3-2CEF-4916-A41E-7336EB602685}" dt="2020-10-16T06:53:42.856" v="157"/>
          <ac:graphicFrameMkLst>
            <pc:docMk/>
            <pc:sldMk cId="1836038841" sldId="417"/>
            <ac:graphicFrameMk id="38" creationId="{5F8E916E-8987-4A83-8C74-54D3A0510F80}"/>
          </ac:graphicFrameMkLst>
        </pc:graphicFrameChg>
        <pc:graphicFrameChg chg="del">
          <ac:chgData name="khoi ho" userId="c93cb340-cf97-4d7c-9739-bad0ee582323" providerId="ADAL" clId="{365471B3-2CEF-4916-A41E-7336EB602685}" dt="2020-10-15T05:03:27.476" v="19" actId="478"/>
          <ac:graphicFrameMkLst>
            <pc:docMk/>
            <pc:sldMk cId="1836038841" sldId="417"/>
            <ac:graphicFrameMk id="118" creationId="{F28249EA-19CF-47D3-9480-4FCCF22C35BB}"/>
          </ac:graphicFrameMkLst>
        </pc:graphicFrameChg>
        <pc:cxnChg chg="del mod">
          <ac:chgData name="khoi ho" userId="c93cb340-cf97-4d7c-9739-bad0ee582323" providerId="ADAL" clId="{365471B3-2CEF-4916-A41E-7336EB602685}" dt="2020-10-15T05:03:19.956" v="16" actId="478"/>
          <ac:cxnSpMkLst>
            <pc:docMk/>
            <pc:sldMk cId="1836038841" sldId="417"/>
            <ac:cxnSpMk id="3" creationId="{61B83931-B830-479A-9246-F16854B98A5C}"/>
          </ac:cxnSpMkLst>
        </pc:cxnChg>
        <pc:cxnChg chg="mod">
          <ac:chgData name="khoi ho" userId="c93cb340-cf97-4d7c-9739-bad0ee582323" providerId="ADAL" clId="{365471B3-2CEF-4916-A41E-7336EB602685}" dt="2020-10-16T06:55:34.306" v="169" actId="1076"/>
          <ac:cxnSpMkLst>
            <pc:docMk/>
            <pc:sldMk cId="1836038841" sldId="417"/>
            <ac:cxnSpMk id="43" creationId="{1028DBE7-878F-4A34-805F-818A4C62F3C5}"/>
          </ac:cxnSpMkLst>
        </pc:cxnChg>
        <pc:cxnChg chg="mod">
          <ac:chgData name="khoi ho" userId="c93cb340-cf97-4d7c-9739-bad0ee582323" providerId="ADAL" clId="{365471B3-2CEF-4916-A41E-7336EB602685}" dt="2020-10-16T06:55:34.306" v="169" actId="1076"/>
          <ac:cxnSpMkLst>
            <pc:docMk/>
            <pc:sldMk cId="1836038841" sldId="417"/>
            <ac:cxnSpMk id="44" creationId="{7267FA28-12C3-46B4-9600-FA29B870771D}"/>
          </ac:cxnSpMkLst>
        </pc:cxnChg>
        <pc:cxnChg chg="mod">
          <ac:chgData name="khoi ho" userId="c93cb340-cf97-4d7c-9739-bad0ee582323" providerId="ADAL" clId="{365471B3-2CEF-4916-A41E-7336EB602685}" dt="2020-10-16T06:55:34.306" v="169" actId="1076"/>
          <ac:cxnSpMkLst>
            <pc:docMk/>
            <pc:sldMk cId="1836038841" sldId="417"/>
            <ac:cxnSpMk id="48" creationId="{E0ED9E19-E635-4D4C-AE7F-76C14136F571}"/>
          </ac:cxnSpMkLst>
        </pc:cxnChg>
        <pc:cxnChg chg="mod">
          <ac:chgData name="khoi ho" userId="c93cb340-cf97-4d7c-9739-bad0ee582323" providerId="ADAL" clId="{365471B3-2CEF-4916-A41E-7336EB602685}" dt="2020-10-16T06:55:34.306" v="169" actId="1076"/>
          <ac:cxnSpMkLst>
            <pc:docMk/>
            <pc:sldMk cId="1836038841" sldId="417"/>
            <ac:cxnSpMk id="52" creationId="{35B0440D-31E5-47E4-A375-3B49377AFB34}"/>
          </ac:cxnSpMkLst>
        </pc:cxnChg>
        <pc:cxnChg chg="mod">
          <ac:chgData name="khoi ho" userId="c93cb340-cf97-4d7c-9739-bad0ee582323" providerId="ADAL" clId="{365471B3-2CEF-4916-A41E-7336EB602685}" dt="2020-10-16T06:55:34.306" v="169" actId="1076"/>
          <ac:cxnSpMkLst>
            <pc:docMk/>
            <pc:sldMk cId="1836038841" sldId="417"/>
            <ac:cxnSpMk id="92" creationId="{AAE082F4-4F66-49F0-B57D-C1A9C972C046}"/>
          </ac:cxnSpMkLst>
        </pc:cxnChg>
        <pc:cxnChg chg="mod">
          <ac:chgData name="khoi ho" userId="c93cb340-cf97-4d7c-9739-bad0ee582323" providerId="ADAL" clId="{365471B3-2CEF-4916-A41E-7336EB602685}" dt="2020-10-16T06:55:34.306" v="169" actId="1076"/>
          <ac:cxnSpMkLst>
            <pc:docMk/>
            <pc:sldMk cId="1836038841" sldId="417"/>
            <ac:cxnSpMk id="96" creationId="{5E1D4217-69EB-463E-9ABF-4450CE94E4FE}"/>
          </ac:cxnSpMkLst>
        </pc:cxnChg>
        <pc:cxnChg chg="mod">
          <ac:chgData name="khoi ho" userId="c93cb340-cf97-4d7c-9739-bad0ee582323" providerId="ADAL" clId="{365471B3-2CEF-4916-A41E-7336EB602685}" dt="2020-10-16T06:55:34.306" v="169" actId="1076"/>
          <ac:cxnSpMkLst>
            <pc:docMk/>
            <pc:sldMk cId="1836038841" sldId="417"/>
            <ac:cxnSpMk id="119" creationId="{665E9A3D-1D3B-4146-9652-A521B3C008FF}"/>
          </ac:cxnSpMkLst>
        </pc:cxnChg>
        <pc:cxnChg chg="add mod">
          <ac:chgData name="khoi ho" userId="c93cb340-cf97-4d7c-9739-bad0ee582323" providerId="ADAL" clId="{365471B3-2CEF-4916-A41E-7336EB602685}" dt="2020-10-16T06:56:10.120" v="172" actId="1076"/>
          <ac:cxnSpMkLst>
            <pc:docMk/>
            <pc:sldMk cId="1836038841" sldId="417"/>
            <ac:cxnSpMk id="121" creationId="{F6B2DE2B-E7CF-48CC-BDC5-8CF22187F9F3}"/>
          </ac:cxnSpMkLst>
        </pc:cxnChg>
        <pc:cxnChg chg="add mod">
          <ac:chgData name="khoi ho" userId="c93cb340-cf97-4d7c-9739-bad0ee582323" providerId="ADAL" clId="{365471B3-2CEF-4916-A41E-7336EB602685}" dt="2020-10-16T06:56:10.120" v="172" actId="1076"/>
          <ac:cxnSpMkLst>
            <pc:docMk/>
            <pc:sldMk cId="1836038841" sldId="417"/>
            <ac:cxnSpMk id="122" creationId="{5010F7DC-7F09-4305-ADC5-002CF4D2C8B4}"/>
          </ac:cxnSpMkLst>
        </pc:cxnChg>
        <pc:cxnChg chg="mod">
          <ac:chgData name="khoi ho" userId="c93cb340-cf97-4d7c-9739-bad0ee582323" providerId="ADAL" clId="{365471B3-2CEF-4916-A41E-7336EB602685}" dt="2020-10-16T06:55:34.306" v="169" actId="1076"/>
          <ac:cxnSpMkLst>
            <pc:docMk/>
            <pc:sldMk cId="1836038841" sldId="417"/>
            <ac:cxnSpMk id="134" creationId="{D9CD4B9E-B16B-4CEB-9B1E-A13C8511E191}"/>
          </ac:cxnSpMkLst>
        </pc:cxnChg>
        <pc:cxnChg chg="add mod">
          <ac:chgData name="khoi ho" userId="c93cb340-cf97-4d7c-9739-bad0ee582323" providerId="ADAL" clId="{365471B3-2CEF-4916-A41E-7336EB602685}" dt="2020-10-16T06:56:10.120" v="172" actId="1076"/>
          <ac:cxnSpMkLst>
            <pc:docMk/>
            <pc:sldMk cId="1836038841" sldId="417"/>
            <ac:cxnSpMk id="149" creationId="{AC50CD3D-075C-40F5-B87B-806B9A72ECE5}"/>
          </ac:cxnSpMkLst>
        </pc:cxnChg>
        <pc:cxnChg chg="add mod">
          <ac:chgData name="khoi ho" userId="c93cb340-cf97-4d7c-9739-bad0ee582323" providerId="ADAL" clId="{365471B3-2CEF-4916-A41E-7336EB602685}" dt="2020-10-16T06:56:10.120" v="172" actId="1076"/>
          <ac:cxnSpMkLst>
            <pc:docMk/>
            <pc:sldMk cId="1836038841" sldId="417"/>
            <ac:cxnSpMk id="152" creationId="{6B00B2F7-D16B-4F2E-8337-6B55C6D5267A}"/>
          </ac:cxnSpMkLst>
        </pc:cxnChg>
        <pc:cxnChg chg="add mod">
          <ac:chgData name="khoi ho" userId="c93cb340-cf97-4d7c-9739-bad0ee582323" providerId="ADAL" clId="{365471B3-2CEF-4916-A41E-7336EB602685}" dt="2020-10-16T06:56:10.120" v="172" actId="1076"/>
          <ac:cxnSpMkLst>
            <pc:docMk/>
            <pc:sldMk cId="1836038841" sldId="417"/>
            <ac:cxnSpMk id="153" creationId="{AC055919-EDA8-4BFC-8600-CCB314066B26}"/>
          </ac:cxnSpMkLst>
        </pc:cxnChg>
        <pc:cxnChg chg="add mod">
          <ac:chgData name="khoi ho" userId="c93cb340-cf97-4d7c-9739-bad0ee582323" providerId="ADAL" clId="{365471B3-2CEF-4916-A41E-7336EB602685}" dt="2020-10-16T06:56:10.120" v="172" actId="1076"/>
          <ac:cxnSpMkLst>
            <pc:docMk/>
            <pc:sldMk cId="1836038841" sldId="417"/>
            <ac:cxnSpMk id="154" creationId="{3B90480F-F5D1-4A86-9C2B-4B412B6594D7}"/>
          </ac:cxnSpMkLst>
        </pc:cxnChg>
        <pc:cxnChg chg="add mod">
          <ac:chgData name="khoi ho" userId="c93cb340-cf97-4d7c-9739-bad0ee582323" providerId="ADAL" clId="{365471B3-2CEF-4916-A41E-7336EB602685}" dt="2020-10-16T06:56:10.120" v="172" actId="1076"/>
          <ac:cxnSpMkLst>
            <pc:docMk/>
            <pc:sldMk cId="1836038841" sldId="417"/>
            <ac:cxnSpMk id="161" creationId="{91A9EDDC-9E75-4619-BA20-58D4F0C17446}"/>
          </ac:cxnSpMkLst>
        </pc:cxnChg>
        <pc:cxnChg chg="add del mod">
          <ac:chgData name="khoi ho" userId="c93cb340-cf97-4d7c-9739-bad0ee582323" providerId="ADAL" clId="{365471B3-2CEF-4916-A41E-7336EB602685}" dt="2020-10-15T05:29:18.652" v="60" actId="478"/>
          <ac:cxnSpMkLst>
            <pc:docMk/>
            <pc:sldMk cId="1836038841" sldId="417"/>
            <ac:cxnSpMk id="162" creationId="{C5EDF012-70B9-4D7B-949D-91BFD91A3E61}"/>
          </ac:cxnSpMkLst>
        </pc:cxnChg>
        <pc:cxnChg chg="add del mod">
          <ac:chgData name="khoi ho" userId="c93cb340-cf97-4d7c-9739-bad0ee582323" providerId="ADAL" clId="{365471B3-2CEF-4916-A41E-7336EB602685}" dt="2020-10-15T05:29:19.691" v="61" actId="478"/>
          <ac:cxnSpMkLst>
            <pc:docMk/>
            <pc:sldMk cId="1836038841" sldId="417"/>
            <ac:cxnSpMk id="163" creationId="{2E66C648-C087-42D4-8C05-4A08ABF4F051}"/>
          </ac:cxnSpMkLst>
        </pc:cxnChg>
        <pc:cxnChg chg="mod">
          <ac:chgData name="khoi ho" userId="c93cb340-cf97-4d7c-9739-bad0ee582323" providerId="ADAL" clId="{365471B3-2CEF-4916-A41E-7336EB602685}" dt="2020-10-16T06:55:34.306" v="169" actId="1076"/>
          <ac:cxnSpMkLst>
            <pc:docMk/>
            <pc:sldMk cId="1836038841" sldId="417"/>
            <ac:cxnSpMk id="180" creationId="{DA7BEDED-1F77-4A1C-A289-5CE847EB640E}"/>
          </ac:cxnSpMkLst>
        </pc:cxnChg>
        <pc:cxnChg chg="add del mod">
          <ac:chgData name="khoi ho" userId="c93cb340-cf97-4d7c-9739-bad0ee582323" providerId="ADAL" clId="{365471B3-2CEF-4916-A41E-7336EB602685}" dt="2020-10-15T05:55:11.635" v="108" actId="478"/>
          <ac:cxnSpMkLst>
            <pc:docMk/>
            <pc:sldMk cId="1836038841" sldId="417"/>
            <ac:cxnSpMk id="182" creationId="{3F73296B-9506-4A5E-93D8-FE73B9428FBC}"/>
          </ac:cxnSpMkLst>
        </pc:cxnChg>
        <pc:cxnChg chg="add del mod">
          <ac:chgData name="khoi ho" userId="c93cb340-cf97-4d7c-9739-bad0ee582323" providerId="ADAL" clId="{365471B3-2CEF-4916-A41E-7336EB602685}" dt="2020-10-15T06:34:36.636" v="118" actId="478"/>
          <ac:cxnSpMkLst>
            <pc:docMk/>
            <pc:sldMk cId="1836038841" sldId="417"/>
            <ac:cxnSpMk id="189" creationId="{8E8BFC88-8507-44ED-9533-CBAD03F33944}"/>
          </ac:cxnSpMkLst>
        </pc:cxnChg>
        <pc:cxnChg chg="add del mod">
          <ac:chgData name="khoi ho" userId="c93cb340-cf97-4d7c-9739-bad0ee582323" providerId="ADAL" clId="{365471B3-2CEF-4916-A41E-7336EB602685}" dt="2020-10-15T05:55:13.102" v="110" actId="478"/>
          <ac:cxnSpMkLst>
            <pc:docMk/>
            <pc:sldMk cId="1836038841" sldId="417"/>
            <ac:cxnSpMk id="193" creationId="{4CBA9283-2E57-4DA3-93BF-88E6C6E153B0}"/>
          </ac:cxnSpMkLst>
        </pc:cxnChg>
        <pc:cxnChg chg="add del mod">
          <ac:chgData name="khoi ho" userId="c93cb340-cf97-4d7c-9739-bad0ee582323" providerId="ADAL" clId="{365471B3-2CEF-4916-A41E-7336EB602685}" dt="2020-10-15T06:34:34.923" v="116" actId="478"/>
          <ac:cxnSpMkLst>
            <pc:docMk/>
            <pc:sldMk cId="1836038841" sldId="417"/>
            <ac:cxnSpMk id="194" creationId="{3360F515-F1B3-4E9E-B7FC-76F1A2A016ED}"/>
          </ac:cxnSpMkLst>
        </pc:cxnChg>
        <pc:cxnChg chg="add mod">
          <ac:chgData name="khoi ho" userId="c93cb340-cf97-4d7c-9739-bad0ee582323" providerId="ADAL" clId="{365471B3-2CEF-4916-A41E-7336EB602685}" dt="2020-10-16T06:56:10.120" v="172" actId="1076"/>
          <ac:cxnSpMkLst>
            <pc:docMk/>
            <pc:sldMk cId="1836038841" sldId="417"/>
            <ac:cxnSpMk id="195" creationId="{E1548F67-352F-4757-B3C1-1D7B33BDF69A}"/>
          </ac:cxnSpMkLst>
        </pc:cxnChg>
        <pc:cxnChg chg="add del mod">
          <ac:chgData name="khoi ho" userId="c93cb340-cf97-4d7c-9739-bad0ee582323" providerId="ADAL" clId="{365471B3-2CEF-4916-A41E-7336EB602685}" dt="2020-10-15T06:34:32.397" v="113" actId="478"/>
          <ac:cxnSpMkLst>
            <pc:docMk/>
            <pc:sldMk cId="1836038841" sldId="417"/>
            <ac:cxnSpMk id="197" creationId="{F10A2331-1B8C-49EA-9269-56862AFCEFB6}"/>
          </ac:cxnSpMkLst>
        </pc:cxnChg>
        <pc:cxnChg chg="add del mod">
          <ac:chgData name="khoi ho" userId="c93cb340-cf97-4d7c-9739-bad0ee582323" providerId="ADAL" clId="{365471B3-2CEF-4916-A41E-7336EB602685}" dt="2020-10-15T05:35:28.394" v="79" actId="478"/>
          <ac:cxnSpMkLst>
            <pc:docMk/>
            <pc:sldMk cId="1836038841" sldId="417"/>
            <ac:cxnSpMk id="198" creationId="{D360AAD1-2D79-41C0-BDB1-4082E8920FB9}"/>
          </ac:cxnSpMkLst>
        </pc:cxnChg>
        <pc:cxnChg chg="mod">
          <ac:chgData name="khoi ho" userId="c93cb340-cf97-4d7c-9739-bad0ee582323" providerId="ADAL" clId="{365471B3-2CEF-4916-A41E-7336EB602685}" dt="2020-10-16T06:55:34.306" v="169" actId="1076"/>
          <ac:cxnSpMkLst>
            <pc:docMk/>
            <pc:sldMk cId="1836038841" sldId="417"/>
            <ac:cxnSpMk id="199" creationId="{35F9733B-8576-4F59-9B41-E7A702D3E76D}"/>
          </ac:cxnSpMkLst>
        </pc:cxnChg>
        <pc:cxnChg chg="mod">
          <ac:chgData name="khoi ho" userId="c93cb340-cf97-4d7c-9739-bad0ee582323" providerId="ADAL" clId="{365471B3-2CEF-4916-A41E-7336EB602685}" dt="2020-10-16T06:55:34.306" v="169" actId="1076"/>
          <ac:cxnSpMkLst>
            <pc:docMk/>
            <pc:sldMk cId="1836038841" sldId="417"/>
            <ac:cxnSpMk id="204" creationId="{29D6543F-B6FB-4A92-92B8-9F2DAE0BE792}"/>
          </ac:cxnSpMkLst>
        </pc:cxnChg>
        <pc:cxnChg chg="mod">
          <ac:chgData name="khoi ho" userId="c93cb340-cf97-4d7c-9739-bad0ee582323" providerId="ADAL" clId="{365471B3-2CEF-4916-A41E-7336EB602685}" dt="2020-10-16T06:55:34.306" v="169" actId="1076"/>
          <ac:cxnSpMkLst>
            <pc:docMk/>
            <pc:sldMk cId="1836038841" sldId="417"/>
            <ac:cxnSpMk id="206" creationId="{6CA56205-7D41-4E8E-988F-A42DA119FAAC}"/>
          </ac:cxnSpMkLst>
        </pc:cxnChg>
        <pc:cxnChg chg="add mod">
          <ac:chgData name="khoi ho" userId="c93cb340-cf97-4d7c-9739-bad0ee582323" providerId="ADAL" clId="{365471B3-2CEF-4916-A41E-7336EB602685}" dt="2020-10-16T06:56:10.120" v="172" actId="1076"/>
          <ac:cxnSpMkLst>
            <pc:docMk/>
            <pc:sldMk cId="1836038841" sldId="417"/>
            <ac:cxnSpMk id="209" creationId="{B06BC5D1-35E6-4152-B336-7F92F3EA57AD}"/>
          </ac:cxnSpMkLst>
        </pc:cxnChg>
        <pc:cxnChg chg="add mod">
          <ac:chgData name="khoi ho" userId="c93cb340-cf97-4d7c-9739-bad0ee582323" providerId="ADAL" clId="{365471B3-2CEF-4916-A41E-7336EB602685}" dt="2020-10-16T06:56:10.120" v="172" actId="1076"/>
          <ac:cxnSpMkLst>
            <pc:docMk/>
            <pc:sldMk cId="1836038841" sldId="417"/>
            <ac:cxnSpMk id="210" creationId="{7439F5EB-5076-4ABC-A807-02A3271CC63B}"/>
          </ac:cxnSpMkLst>
        </pc:cxnChg>
        <pc:cxnChg chg="add mod">
          <ac:chgData name="khoi ho" userId="c93cb340-cf97-4d7c-9739-bad0ee582323" providerId="ADAL" clId="{365471B3-2CEF-4916-A41E-7336EB602685}" dt="2020-10-16T06:56:10.120" v="172" actId="1076"/>
          <ac:cxnSpMkLst>
            <pc:docMk/>
            <pc:sldMk cId="1836038841" sldId="417"/>
            <ac:cxnSpMk id="211" creationId="{5DEFA423-0284-42D2-94B5-D361637D66BB}"/>
          </ac:cxnSpMkLst>
        </pc:cxnChg>
        <pc:cxnChg chg="add del mod">
          <ac:chgData name="khoi ho" userId="c93cb340-cf97-4d7c-9739-bad0ee582323" providerId="ADAL" clId="{365471B3-2CEF-4916-A41E-7336EB602685}" dt="2020-10-15T05:29:35.987" v="67" actId="478"/>
          <ac:cxnSpMkLst>
            <pc:docMk/>
            <pc:sldMk cId="1836038841" sldId="417"/>
            <ac:cxnSpMk id="212" creationId="{2038002A-FE22-450C-9090-3F40D291DE00}"/>
          </ac:cxnSpMkLst>
        </pc:cxnChg>
        <pc:cxnChg chg="mod">
          <ac:chgData name="khoi ho" userId="c93cb340-cf97-4d7c-9739-bad0ee582323" providerId="ADAL" clId="{365471B3-2CEF-4916-A41E-7336EB602685}" dt="2020-10-16T06:55:34.306" v="169" actId="1076"/>
          <ac:cxnSpMkLst>
            <pc:docMk/>
            <pc:sldMk cId="1836038841" sldId="417"/>
            <ac:cxnSpMk id="213" creationId="{66F508C7-3A8F-4EDF-B9EC-F92FCB743C46}"/>
          </ac:cxnSpMkLst>
        </pc:cxnChg>
        <pc:cxnChg chg="add del mod">
          <ac:chgData name="khoi ho" userId="c93cb340-cf97-4d7c-9739-bad0ee582323" providerId="ADAL" clId="{365471B3-2CEF-4916-A41E-7336EB602685}" dt="2020-10-15T05:29:36.883" v="68" actId="478"/>
          <ac:cxnSpMkLst>
            <pc:docMk/>
            <pc:sldMk cId="1836038841" sldId="417"/>
            <ac:cxnSpMk id="214" creationId="{F9448A63-D920-446C-8646-BA92B2A97588}"/>
          </ac:cxnSpMkLst>
        </pc:cxnChg>
        <pc:cxnChg chg="add mod">
          <ac:chgData name="khoi ho" userId="c93cb340-cf97-4d7c-9739-bad0ee582323" providerId="ADAL" clId="{365471B3-2CEF-4916-A41E-7336EB602685}" dt="2020-10-16T06:56:10.120" v="172" actId="1076"/>
          <ac:cxnSpMkLst>
            <pc:docMk/>
            <pc:sldMk cId="1836038841" sldId="417"/>
            <ac:cxnSpMk id="215" creationId="{8E64E531-1C26-4E96-9D4D-903E7F75962F}"/>
          </ac:cxnSpMkLst>
        </pc:cxnChg>
        <pc:cxnChg chg="add mod">
          <ac:chgData name="khoi ho" userId="c93cb340-cf97-4d7c-9739-bad0ee582323" providerId="ADAL" clId="{365471B3-2CEF-4916-A41E-7336EB602685}" dt="2020-10-16T06:56:10.120" v="172" actId="1076"/>
          <ac:cxnSpMkLst>
            <pc:docMk/>
            <pc:sldMk cId="1836038841" sldId="417"/>
            <ac:cxnSpMk id="216" creationId="{5F7A850A-AD48-4E72-82B8-51CD038D9D1C}"/>
          </ac:cxnSpMkLst>
        </pc:cxnChg>
        <pc:cxnChg chg="add mod">
          <ac:chgData name="khoi ho" userId="c93cb340-cf97-4d7c-9739-bad0ee582323" providerId="ADAL" clId="{365471B3-2CEF-4916-A41E-7336EB602685}" dt="2020-10-16T06:56:10.120" v="172" actId="1076"/>
          <ac:cxnSpMkLst>
            <pc:docMk/>
            <pc:sldMk cId="1836038841" sldId="417"/>
            <ac:cxnSpMk id="217" creationId="{DA10D005-C0AC-42EE-8B78-B1DE1DBCDB51}"/>
          </ac:cxnSpMkLst>
        </pc:cxnChg>
        <pc:cxnChg chg="mod">
          <ac:chgData name="khoi ho" userId="c93cb340-cf97-4d7c-9739-bad0ee582323" providerId="ADAL" clId="{365471B3-2CEF-4916-A41E-7336EB602685}" dt="2020-10-16T06:55:34.306" v="169" actId="1076"/>
          <ac:cxnSpMkLst>
            <pc:docMk/>
            <pc:sldMk cId="1836038841" sldId="417"/>
            <ac:cxnSpMk id="218" creationId="{CAF2C90B-7F13-4944-851C-39189CF0BB6F}"/>
          </ac:cxnSpMkLst>
        </pc:cxnChg>
        <pc:cxnChg chg="add mod">
          <ac:chgData name="khoi ho" userId="c93cb340-cf97-4d7c-9739-bad0ee582323" providerId="ADAL" clId="{365471B3-2CEF-4916-A41E-7336EB602685}" dt="2020-10-16T06:56:10.120" v="172" actId="1076"/>
          <ac:cxnSpMkLst>
            <pc:docMk/>
            <pc:sldMk cId="1836038841" sldId="417"/>
            <ac:cxnSpMk id="221" creationId="{B4D7BE78-6ABC-49D5-A7FF-70A8920629B3}"/>
          </ac:cxnSpMkLst>
        </pc:cxnChg>
        <pc:cxnChg chg="add del mod">
          <ac:chgData name="khoi ho" userId="c93cb340-cf97-4d7c-9739-bad0ee582323" providerId="ADAL" clId="{365471B3-2CEF-4916-A41E-7336EB602685}" dt="2020-10-15T05:38:23.090" v="97" actId="478"/>
          <ac:cxnSpMkLst>
            <pc:docMk/>
            <pc:sldMk cId="1836038841" sldId="417"/>
            <ac:cxnSpMk id="222" creationId="{97519D09-E4EF-40D2-972B-2E581891F5EA}"/>
          </ac:cxnSpMkLst>
        </pc:cxnChg>
        <pc:cxnChg chg="add mod">
          <ac:chgData name="khoi ho" userId="c93cb340-cf97-4d7c-9739-bad0ee582323" providerId="ADAL" clId="{365471B3-2CEF-4916-A41E-7336EB602685}" dt="2020-10-16T06:56:10.120" v="172" actId="1076"/>
          <ac:cxnSpMkLst>
            <pc:docMk/>
            <pc:sldMk cId="1836038841" sldId="417"/>
            <ac:cxnSpMk id="226" creationId="{E3CEF928-1866-493E-892A-2E85CC5F9630}"/>
          </ac:cxnSpMkLst>
        </pc:cxnChg>
        <pc:cxnChg chg="mod">
          <ac:chgData name="khoi ho" userId="c93cb340-cf97-4d7c-9739-bad0ee582323" providerId="ADAL" clId="{365471B3-2CEF-4916-A41E-7336EB602685}" dt="2020-10-16T06:55:34.306" v="169" actId="1076"/>
          <ac:cxnSpMkLst>
            <pc:docMk/>
            <pc:sldMk cId="1836038841" sldId="417"/>
            <ac:cxnSpMk id="238" creationId="{201A8FF1-4527-443A-9079-9423AE27DC18}"/>
          </ac:cxnSpMkLst>
        </pc:cxnChg>
        <pc:cxnChg chg="mod">
          <ac:chgData name="khoi ho" userId="c93cb340-cf97-4d7c-9739-bad0ee582323" providerId="ADAL" clId="{365471B3-2CEF-4916-A41E-7336EB602685}" dt="2020-10-16T06:55:34.306" v="169" actId="1076"/>
          <ac:cxnSpMkLst>
            <pc:docMk/>
            <pc:sldMk cId="1836038841" sldId="417"/>
            <ac:cxnSpMk id="248" creationId="{10841333-57A8-4DD8-A7E3-BF039F541A00}"/>
          </ac:cxnSpMkLst>
        </pc:cxnChg>
        <pc:cxnChg chg="mod">
          <ac:chgData name="khoi ho" userId="c93cb340-cf97-4d7c-9739-bad0ee582323" providerId="ADAL" clId="{365471B3-2CEF-4916-A41E-7336EB602685}" dt="2020-10-16T06:55:34.306" v="169" actId="1076"/>
          <ac:cxnSpMkLst>
            <pc:docMk/>
            <pc:sldMk cId="1836038841" sldId="417"/>
            <ac:cxnSpMk id="253" creationId="{CCF2708F-91DE-4645-8109-48F4A6B39E66}"/>
          </ac:cxnSpMkLst>
        </pc:cxnChg>
        <pc:cxnChg chg="add del mod">
          <ac:chgData name="khoi ho" userId="c93cb340-cf97-4d7c-9739-bad0ee582323" providerId="ADAL" clId="{365471B3-2CEF-4916-A41E-7336EB602685}" dt="2020-10-15T05:38:27.035" v="101" actId="478"/>
          <ac:cxnSpMkLst>
            <pc:docMk/>
            <pc:sldMk cId="1836038841" sldId="417"/>
            <ac:cxnSpMk id="255" creationId="{A8CCF7C0-47FD-444C-9048-764F4F86F072}"/>
          </ac:cxnSpMkLst>
        </pc:cxnChg>
        <pc:cxnChg chg="add del mod">
          <ac:chgData name="khoi ho" userId="c93cb340-cf97-4d7c-9739-bad0ee582323" providerId="ADAL" clId="{365471B3-2CEF-4916-A41E-7336EB602685}" dt="2020-10-15T05:35:33.050" v="83" actId="478"/>
          <ac:cxnSpMkLst>
            <pc:docMk/>
            <pc:sldMk cId="1836038841" sldId="417"/>
            <ac:cxnSpMk id="257" creationId="{A1F09A08-DF84-4C36-938C-D7FE340E3CE4}"/>
          </ac:cxnSpMkLst>
        </pc:cxnChg>
        <pc:cxnChg chg="add del mod">
          <ac:chgData name="khoi ho" userId="c93cb340-cf97-4d7c-9739-bad0ee582323" providerId="ADAL" clId="{365471B3-2CEF-4916-A41E-7336EB602685}" dt="2020-10-15T05:38:23.883" v="98" actId="478"/>
          <ac:cxnSpMkLst>
            <pc:docMk/>
            <pc:sldMk cId="1836038841" sldId="417"/>
            <ac:cxnSpMk id="258" creationId="{4F489887-DE81-4193-9B58-AB3E78ACBA43}"/>
          </ac:cxnSpMkLst>
        </pc:cxnChg>
        <pc:cxnChg chg="add del mod">
          <ac:chgData name="khoi ho" userId="c93cb340-cf97-4d7c-9739-bad0ee582323" providerId="ADAL" clId="{365471B3-2CEF-4916-A41E-7336EB602685}" dt="2020-10-15T05:35:29.606" v="80" actId="478"/>
          <ac:cxnSpMkLst>
            <pc:docMk/>
            <pc:sldMk cId="1836038841" sldId="417"/>
            <ac:cxnSpMk id="259" creationId="{734D62C4-3F87-478D-AF18-B3987E2F4864}"/>
          </ac:cxnSpMkLst>
        </pc:cxnChg>
        <pc:cxnChg chg="add del mod">
          <ac:chgData name="khoi ho" userId="c93cb340-cf97-4d7c-9739-bad0ee582323" providerId="ADAL" clId="{365471B3-2CEF-4916-A41E-7336EB602685}" dt="2020-10-15T05:29:33.395" v="65" actId="478"/>
          <ac:cxnSpMkLst>
            <pc:docMk/>
            <pc:sldMk cId="1836038841" sldId="417"/>
            <ac:cxnSpMk id="260" creationId="{59AC7BD2-37A4-413B-BC55-E64023208261}"/>
          </ac:cxnSpMkLst>
        </pc:cxnChg>
        <pc:cxnChg chg="add del mod">
          <ac:chgData name="khoi ho" userId="c93cb340-cf97-4d7c-9739-bad0ee582323" providerId="ADAL" clId="{365471B3-2CEF-4916-A41E-7336EB602685}" dt="2020-10-15T05:29:34.186" v="66" actId="478"/>
          <ac:cxnSpMkLst>
            <pc:docMk/>
            <pc:sldMk cId="1836038841" sldId="417"/>
            <ac:cxnSpMk id="261" creationId="{5D8E0CB4-14C0-4E88-A614-C85E0B0E7D86}"/>
          </ac:cxnSpMkLst>
        </pc:cxnChg>
        <pc:cxnChg chg="add mod">
          <ac:chgData name="khoi ho" userId="c93cb340-cf97-4d7c-9739-bad0ee582323" providerId="ADAL" clId="{365471B3-2CEF-4916-A41E-7336EB602685}" dt="2020-10-16T06:56:10.120" v="172" actId="1076"/>
          <ac:cxnSpMkLst>
            <pc:docMk/>
            <pc:sldMk cId="1836038841" sldId="417"/>
            <ac:cxnSpMk id="262" creationId="{01B6AEC6-14F8-4047-BBB9-C0762FD17526}"/>
          </ac:cxnSpMkLst>
        </pc:cxnChg>
        <pc:cxnChg chg="add mod">
          <ac:chgData name="khoi ho" userId="c93cb340-cf97-4d7c-9739-bad0ee582323" providerId="ADAL" clId="{365471B3-2CEF-4916-A41E-7336EB602685}" dt="2020-10-16T06:56:10.120" v="172" actId="1076"/>
          <ac:cxnSpMkLst>
            <pc:docMk/>
            <pc:sldMk cId="1836038841" sldId="417"/>
            <ac:cxnSpMk id="269" creationId="{63607029-5E6B-49EB-9668-5DC22F0B3B40}"/>
          </ac:cxnSpMkLst>
        </pc:cxnChg>
        <pc:cxnChg chg="add del mod">
          <ac:chgData name="khoi ho" userId="c93cb340-cf97-4d7c-9739-bad0ee582323" providerId="ADAL" clId="{365471B3-2CEF-4916-A41E-7336EB602685}" dt="2020-10-15T07:40:53.458" v="133" actId="478"/>
          <ac:cxnSpMkLst>
            <pc:docMk/>
            <pc:sldMk cId="1836038841" sldId="417"/>
            <ac:cxnSpMk id="270" creationId="{10C3F8A1-F700-4CFB-90FE-9B4BE2E851FF}"/>
          </ac:cxnSpMkLst>
        </pc:cxnChg>
        <pc:cxnChg chg="add mod">
          <ac:chgData name="khoi ho" userId="c93cb340-cf97-4d7c-9739-bad0ee582323" providerId="ADAL" clId="{365471B3-2CEF-4916-A41E-7336EB602685}" dt="2020-10-16T06:56:10.120" v="172" actId="1076"/>
          <ac:cxnSpMkLst>
            <pc:docMk/>
            <pc:sldMk cId="1836038841" sldId="417"/>
            <ac:cxnSpMk id="271" creationId="{3E9E4D07-930E-43F7-9851-198C52B8D1D2}"/>
          </ac:cxnSpMkLst>
        </pc:cxnChg>
        <pc:cxnChg chg="mod">
          <ac:chgData name="khoi ho" userId="c93cb340-cf97-4d7c-9739-bad0ee582323" providerId="ADAL" clId="{365471B3-2CEF-4916-A41E-7336EB602685}" dt="2020-10-16T06:55:34.306" v="169" actId="1076"/>
          <ac:cxnSpMkLst>
            <pc:docMk/>
            <pc:sldMk cId="1836038841" sldId="417"/>
            <ac:cxnSpMk id="299" creationId="{BC2CD742-2788-45E9-94CA-C1D5B6EFED60}"/>
          </ac:cxnSpMkLst>
        </pc:cxnChg>
        <pc:cxnChg chg="mod">
          <ac:chgData name="khoi ho" userId="c93cb340-cf97-4d7c-9739-bad0ee582323" providerId="ADAL" clId="{365471B3-2CEF-4916-A41E-7336EB602685}" dt="2020-10-16T06:55:34.306" v="169" actId="1076"/>
          <ac:cxnSpMkLst>
            <pc:docMk/>
            <pc:sldMk cId="1836038841" sldId="417"/>
            <ac:cxnSpMk id="304" creationId="{D1DDC043-4D3A-4E69-BFBA-147AD840DC12}"/>
          </ac:cxnSpMkLst>
        </pc:cxnChg>
        <pc:cxnChg chg="mod">
          <ac:chgData name="khoi ho" userId="c93cb340-cf97-4d7c-9739-bad0ee582323" providerId="ADAL" clId="{365471B3-2CEF-4916-A41E-7336EB602685}" dt="2020-10-16T06:55:34.306" v="169" actId="1076"/>
          <ac:cxnSpMkLst>
            <pc:docMk/>
            <pc:sldMk cId="1836038841" sldId="417"/>
            <ac:cxnSpMk id="443" creationId="{AF9C160C-B361-4F0E-BAAC-03E36622EFB0}"/>
          </ac:cxnSpMkLst>
        </pc:cxnChg>
        <pc:cxnChg chg="mod">
          <ac:chgData name="khoi ho" userId="c93cb340-cf97-4d7c-9739-bad0ee582323" providerId="ADAL" clId="{365471B3-2CEF-4916-A41E-7336EB602685}" dt="2020-10-16T06:55:34.306" v="169" actId="1076"/>
          <ac:cxnSpMkLst>
            <pc:docMk/>
            <pc:sldMk cId="1836038841" sldId="417"/>
            <ac:cxnSpMk id="450" creationId="{06C46360-C34A-4446-9E8B-21F094BAA90F}"/>
          </ac:cxnSpMkLst>
        </pc:cxnChg>
        <pc:cxnChg chg="mod">
          <ac:chgData name="khoi ho" userId="c93cb340-cf97-4d7c-9739-bad0ee582323" providerId="ADAL" clId="{365471B3-2CEF-4916-A41E-7336EB602685}" dt="2020-10-16T06:55:34.306" v="169" actId="1076"/>
          <ac:cxnSpMkLst>
            <pc:docMk/>
            <pc:sldMk cId="1836038841" sldId="417"/>
            <ac:cxnSpMk id="452" creationId="{B82B7D1E-CB8B-4531-8898-3B64CA3FDCD1}"/>
          </ac:cxnSpMkLst>
        </pc:cxnChg>
        <pc:cxnChg chg="mod">
          <ac:chgData name="khoi ho" userId="c93cb340-cf97-4d7c-9739-bad0ee582323" providerId="ADAL" clId="{365471B3-2CEF-4916-A41E-7336EB602685}" dt="2020-10-16T06:55:34.306" v="169" actId="1076"/>
          <ac:cxnSpMkLst>
            <pc:docMk/>
            <pc:sldMk cId="1836038841" sldId="417"/>
            <ac:cxnSpMk id="462" creationId="{D156288E-F936-46AC-A39D-CBAE6F9403C6}"/>
          </ac:cxnSpMkLst>
        </pc:cxnChg>
        <pc:cxnChg chg="mod">
          <ac:chgData name="khoi ho" userId="c93cb340-cf97-4d7c-9739-bad0ee582323" providerId="ADAL" clId="{365471B3-2CEF-4916-A41E-7336EB602685}" dt="2020-10-16T06:55:34.306" v="169" actId="1076"/>
          <ac:cxnSpMkLst>
            <pc:docMk/>
            <pc:sldMk cId="1836038841" sldId="417"/>
            <ac:cxnSpMk id="550" creationId="{115EC2BB-8F23-4920-8BB0-1DA8A3ACBE07}"/>
          </ac:cxnSpMkLst>
        </pc:cxnChg>
        <pc:cxnChg chg="mod">
          <ac:chgData name="khoi ho" userId="c93cb340-cf97-4d7c-9739-bad0ee582323" providerId="ADAL" clId="{365471B3-2CEF-4916-A41E-7336EB602685}" dt="2020-10-16T06:55:34.306" v="169" actId="1076"/>
          <ac:cxnSpMkLst>
            <pc:docMk/>
            <pc:sldMk cId="1836038841" sldId="417"/>
            <ac:cxnSpMk id="552" creationId="{75B8FF58-CCE2-4023-97AF-70D1029DCB88}"/>
          </ac:cxnSpMkLst>
        </pc:cxnChg>
        <pc:cxnChg chg="mod">
          <ac:chgData name="khoi ho" userId="c93cb340-cf97-4d7c-9739-bad0ee582323" providerId="ADAL" clId="{365471B3-2CEF-4916-A41E-7336EB602685}" dt="2020-10-16T06:55:34.306" v="169" actId="1076"/>
          <ac:cxnSpMkLst>
            <pc:docMk/>
            <pc:sldMk cId="1836038841" sldId="417"/>
            <ac:cxnSpMk id="559" creationId="{39B91BBB-24D7-4A26-AB25-A860A51C604E}"/>
          </ac:cxnSpMkLst>
        </pc:cxnChg>
        <pc:cxnChg chg="mod">
          <ac:chgData name="khoi ho" userId="c93cb340-cf97-4d7c-9739-bad0ee582323" providerId="ADAL" clId="{365471B3-2CEF-4916-A41E-7336EB602685}" dt="2020-10-16T06:55:34.306" v="169" actId="1076"/>
          <ac:cxnSpMkLst>
            <pc:docMk/>
            <pc:sldMk cId="1836038841" sldId="417"/>
            <ac:cxnSpMk id="565" creationId="{BEF6439A-5491-49EA-BF83-7E45B1024183}"/>
          </ac:cxnSpMkLst>
        </pc:cxnChg>
        <pc:cxnChg chg="mod">
          <ac:chgData name="khoi ho" userId="c93cb340-cf97-4d7c-9739-bad0ee582323" providerId="ADAL" clId="{365471B3-2CEF-4916-A41E-7336EB602685}" dt="2020-10-16T06:55:34.306" v="169" actId="1076"/>
          <ac:cxnSpMkLst>
            <pc:docMk/>
            <pc:sldMk cId="1836038841" sldId="417"/>
            <ac:cxnSpMk id="570" creationId="{C9336884-13DE-4FED-9A9D-FD0740C8839A}"/>
          </ac:cxnSpMkLst>
        </pc:cxnChg>
        <pc:cxnChg chg="mod">
          <ac:chgData name="khoi ho" userId="c93cb340-cf97-4d7c-9739-bad0ee582323" providerId="ADAL" clId="{365471B3-2CEF-4916-A41E-7336EB602685}" dt="2020-10-16T06:55:34.306" v="169" actId="1076"/>
          <ac:cxnSpMkLst>
            <pc:docMk/>
            <pc:sldMk cId="1836038841" sldId="417"/>
            <ac:cxnSpMk id="593" creationId="{3CEF83F9-AA49-48F9-A0B8-145B334746CD}"/>
          </ac:cxnSpMkLst>
        </pc:cxnChg>
        <pc:cxnChg chg="mod">
          <ac:chgData name="khoi ho" userId="c93cb340-cf97-4d7c-9739-bad0ee582323" providerId="ADAL" clId="{365471B3-2CEF-4916-A41E-7336EB602685}" dt="2020-10-16T06:55:34.306" v="169" actId="1076"/>
          <ac:cxnSpMkLst>
            <pc:docMk/>
            <pc:sldMk cId="1836038841" sldId="417"/>
            <ac:cxnSpMk id="595" creationId="{63A530B9-EC2F-4B3E-A56F-DA616EFA2611}"/>
          </ac:cxnSpMkLst>
        </pc:cxnChg>
        <pc:cxnChg chg="mod">
          <ac:chgData name="khoi ho" userId="c93cb340-cf97-4d7c-9739-bad0ee582323" providerId="ADAL" clId="{365471B3-2CEF-4916-A41E-7336EB602685}" dt="2020-10-16T06:55:34.306" v="169" actId="1076"/>
          <ac:cxnSpMkLst>
            <pc:docMk/>
            <pc:sldMk cId="1836038841" sldId="417"/>
            <ac:cxnSpMk id="597" creationId="{D17488C0-17BF-42DE-92B1-47200EA83F5A}"/>
          </ac:cxnSpMkLst>
        </pc:cxnChg>
        <pc:cxnChg chg="mod">
          <ac:chgData name="khoi ho" userId="c93cb340-cf97-4d7c-9739-bad0ee582323" providerId="ADAL" clId="{365471B3-2CEF-4916-A41E-7336EB602685}" dt="2020-10-16T06:55:34.306" v="169" actId="1076"/>
          <ac:cxnSpMkLst>
            <pc:docMk/>
            <pc:sldMk cId="1836038841" sldId="417"/>
            <ac:cxnSpMk id="623" creationId="{1696CC9A-D0AE-4E62-9554-EEACAA46BDFA}"/>
          </ac:cxnSpMkLst>
        </pc:cxnChg>
        <pc:cxnChg chg="mod">
          <ac:chgData name="khoi ho" userId="c93cb340-cf97-4d7c-9739-bad0ee582323" providerId="ADAL" clId="{365471B3-2CEF-4916-A41E-7336EB602685}" dt="2020-10-16T06:55:34.306" v="169" actId="1076"/>
          <ac:cxnSpMkLst>
            <pc:docMk/>
            <pc:sldMk cId="1836038841" sldId="417"/>
            <ac:cxnSpMk id="648" creationId="{D0B3D9C2-3E90-41F9-BD52-D73E5144504D}"/>
          </ac:cxnSpMkLst>
        </pc:cxnChg>
        <pc:cxnChg chg="mod">
          <ac:chgData name="khoi ho" userId="c93cb340-cf97-4d7c-9739-bad0ee582323" providerId="ADAL" clId="{365471B3-2CEF-4916-A41E-7336EB602685}" dt="2020-10-16T06:55:34.306" v="169" actId="1076"/>
          <ac:cxnSpMkLst>
            <pc:docMk/>
            <pc:sldMk cId="1836038841" sldId="417"/>
            <ac:cxnSpMk id="720" creationId="{4CF69994-1833-4CCB-B5A7-6762B2468AC6}"/>
          </ac:cxnSpMkLst>
        </pc:cxnChg>
      </pc:sldChg>
      <pc:sldChg chg="addSp delSp modSp add mod">
        <pc:chgData name="khoi ho" userId="c93cb340-cf97-4d7c-9739-bad0ee582323" providerId="ADAL" clId="{365471B3-2CEF-4916-A41E-7336EB602685}" dt="2020-11-06T11:11:16.946" v="435"/>
        <pc:sldMkLst>
          <pc:docMk/>
          <pc:sldMk cId="1205680389" sldId="418"/>
        </pc:sldMkLst>
        <pc:spChg chg="del mod">
          <ac:chgData name="khoi ho" userId="c93cb340-cf97-4d7c-9739-bad0ee582323" providerId="ADAL" clId="{365471B3-2CEF-4916-A41E-7336EB602685}" dt="2020-10-29T05:46:49.225" v="193"/>
          <ac:spMkLst>
            <pc:docMk/>
            <pc:sldMk cId="1205680389" sldId="418"/>
            <ac:spMk id="17" creationId="{D8E50B76-F67F-4EFF-8763-43A9038AB50F}"/>
          </ac:spMkLst>
        </pc:spChg>
        <pc:spChg chg="add mod">
          <ac:chgData name="khoi ho" userId="c93cb340-cf97-4d7c-9739-bad0ee582323" providerId="ADAL" clId="{365471B3-2CEF-4916-A41E-7336EB602685}" dt="2020-10-29T06:55:13.706" v="294" actId="1036"/>
          <ac:spMkLst>
            <pc:docMk/>
            <pc:sldMk cId="1205680389" sldId="418"/>
            <ac:spMk id="18" creationId="{AE007BA2-D6AB-4BF3-9C36-54596332492E}"/>
          </ac:spMkLst>
        </pc:spChg>
        <pc:spChg chg="add mod">
          <ac:chgData name="khoi ho" userId="c93cb340-cf97-4d7c-9739-bad0ee582323" providerId="ADAL" clId="{365471B3-2CEF-4916-A41E-7336EB602685}" dt="2020-10-29T06:55:06.604" v="290" actId="1037"/>
          <ac:spMkLst>
            <pc:docMk/>
            <pc:sldMk cId="1205680389" sldId="418"/>
            <ac:spMk id="19" creationId="{DF4C31C8-DA05-4A83-B7E3-E8C9E8894F9A}"/>
          </ac:spMkLst>
        </pc:spChg>
        <pc:spChg chg="add mod">
          <ac:chgData name="khoi ho" userId="c93cb340-cf97-4d7c-9739-bad0ee582323" providerId="ADAL" clId="{365471B3-2CEF-4916-A41E-7336EB602685}" dt="2020-10-29T06:54:57.990" v="286" actId="1076"/>
          <ac:spMkLst>
            <pc:docMk/>
            <pc:sldMk cId="1205680389" sldId="418"/>
            <ac:spMk id="20" creationId="{82C5966E-AAF1-45CA-8CB9-3094BCCC4969}"/>
          </ac:spMkLst>
        </pc:spChg>
        <pc:spChg chg="add mod">
          <ac:chgData name="khoi ho" userId="c93cb340-cf97-4d7c-9739-bad0ee582323" providerId="ADAL" clId="{365471B3-2CEF-4916-A41E-7336EB602685}" dt="2020-10-29T06:47:17.786" v="254" actId="207"/>
          <ac:spMkLst>
            <pc:docMk/>
            <pc:sldMk cId="1205680389" sldId="418"/>
            <ac:spMk id="21" creationId="{68F7489C-8867-4DAF-9BA5-DE6F6036B379}"/>
          </ac:spMkLst>
        </pc:spChg>
        <pc:spChg chg="del mod">
          <ac:chgData name="khoi ho" userId="c93cb340-cf97-4d7c-9739-bad0ee582323" providerId="ADAL" clId="{365471B3-2CEF-4916-A41E-7336EB602685}" dt="2020-10-29T05:46:49.225" v="193"/>
          <ac:spMkLst>
            <pc:docMk/>
            <pc:sldMk cId="1205680389" sldId="418"/>
            <ac:spMk id="22" creationId="{A2E52160-0779-49D2-A8F5-ED1248FE0526}"/>
          </ac:spMkLst>
        </pc:spChg>
        <pc:spChg chg="del mod">
          <ac:chgData name="khoi ho" userId="c93cb340-cf97-4d7c-9739-bad0ee582323" providerId="ADAL" clId="{365471B3-2CEF-4916-A41E-7336EB602685}" dt="2020-10-29T05:46:49.225" v="193"/>
          <ac:spMkLst>
            <pc:docMk/>
            <pc:sldMk cId="1205680389" sldId="418"/>
            <ac:spMk id="23" creationId="{89D8AC35-B5E9-4025-8F70-D6EDFAC2B436}"/>
          </ac:spMkLst>
        </pc:spChg>
        <pc:spChg chg="del mod">
          <ac:chgData name="khoi ho" userId="c93cb340-cf97-4d7c-9739-bad0ee582323" providerId="ADAL" clId="{365471B3-2CEF-4916-A41E-7336EB602685}" dt="2020-10-29T05:46:49.225" v="193"/>
          <ac:spMkLst>
            <pc:docMk/>
            <pc:sldMk cId="1205680389" sldId="418"/>
            <ac:spMk id="24" creationId="{FB569DF3-A47F-478D-8D29-37E9F70FB328}"/>
          </ac:spMkLst>
        </pc:spChg>
        <pc:spChg chg="add mod">
          <ac:chgData name="khoi ho" userId="c93cb340-cf97-4d7c-9739-bad0ee582323" providerId="ADAL" clId="{365471B3-2CEF-4916-A41E-7336EB602685}" dt="2020-10-29T07:43:21.773" v="316" actId="1076"/>
          <ac:spMkLst>
            <pc:docMk/>
            <pc:sldMk cId="1205680389" sldId="418"/>
            <ac:spMk id="27" creationId="{EE8F4303-201C-430E-9397-3C83651632F8}"/>
          </ac:spMkLst>
        </pc:spChg>
        <pc:spChg chg="add mod">
          <ac:chgData name="khoi ho" userId="c93cb340-cf97-4d7c-9739-bad0ee582323" providerId="ADAL" clId="{365471B3-2CEF-4916-A41E-7336EB602685}" dt="2020-10-29T07:43:16.978" v="315" actId="1076"/>
          <ac:spMkLst>
            <pc:docMk/>
            <pc:sldMk cId="1205680389" sldId="418"/>
            <ac:spMk id="28" creationId="{07C8AF5B-3467-4985-9D4E-9580EC0D2317}"/>
          </ac:spMkLst>
        </pc:spChg>
        <pc:spChg chg="add mod">
          <ac:chgData name="khoi ho" userId="c93cb340-cf97-4d7c-9739-bad0ee582323" providerId="ADAL" clId="{365471B3-2CEF-4916-A41E-7336EB602685}" dt="2020-10-29T07:43:10.270" v="314" actId="1038"/>
          <ac:spMkLst>
            <pc:docMk/>
            <pc:sldMk cId="1205680389" sldId="418"/>
            <ac:spMk id="29" creationId="{C5C3714B-E260-4EC1-BA4C-39D631158452}"/>
          </ac:spMkLst>
        </pc:spChg>
        <pc:spChg chg="add mod">
          <ac:chgData name="khoi ho" userId="c93cb340-cf97-4d7c-9739-bad0ee582323" providerId="ADAL" clId="{365471B3-2CEF-4916-A41E-7336EB602685}" dt="2020-10-29T07:43:02.383" v="311" actId="1038"/>
          <ac:spMkLst>
            <pc:docMk/>
            <pc:sldMk cId="1205680389" sldId="418"/>
            <ac:spMk id="30" creationId="{A42D5CD6-D5FC-42B2-ACDE-8D14927F34E2}"/>
          </ac:spMkLst>
        </pc:spChg>
        <pc:spChg chg="mod">
          <ac:chgData name="khoi ho" userId="c93cb340-cf97-4d7c-9739-bad0ee582323" providerId="ADAL" clId="{365471B3-2CEF-4916-A41E-7336EB602685}" dt="2020-10-29T06:52:51.912" v="283" actId="1076"/>
          <ac:spMkLst>
            <pc:docMk/>
            <pc:sldMk cId="1205680389" sldId="418"/>
            <ac:spMk id="43" creationId="{90CBF72A-5A87-4CF6-983D-2A2C1B284A44}"/>
          </ac:spMkLst>
        </pc:spChg>
        <pc:spChg chg="mod">
          <ac:chgData name="khoi ho" userId="c93cb340-cf97-4d7c-9739-bad0ee582323" providerId="ADAL" clId="{365471B3-2CEF-4916-A41E-7336EB602685}" dt="2020-10-29T06:52:56.290" v="284" actId="1076"/>
          <ac:spMkLst>
            <pc:docMk/>
            <pc:sldMk cId="1205680389" sldId="418"/>
            <ac:spMk id="46" creationId="{58B8876F-2A72-424A-85DB-FA82354F3D76}"/>
          </ac:spMkLst>
        </pc:spChg>
        <pc:spChg chg="mod">
          <ac:chgData name="khoi ho" userId="c93cb340-cf97-4d7c-9739-bad0ee582323" providerId="ADAL" clId="{365471B3-2CEF-4916-A41E-7336EB602685}" dt="2020-10-29T06:53:12.632" v="285" actId="1076"/>
          <ac:spMkLst>
            <pc:docMk/>
            <pc:sldMk cId="1205680389" sldId="418"/>
            <ac:spMk id="67" creationId="{653006DD-E2DB-409A-8F77-0047E20B5506}"/>
          </ac:spMkLst>
        </pc:spChg>
        <pc:spChg chg="mod">
          <ac:chgData name="khoi ho" userId="c93cb340-cf97-4d7c-9739-bad0ee582323" providerId="ADAL" clId="{365471B3-2CEF-4916-A41E-7336EB602685}" dt="2020-11-02T02:54:38.599" v="379" actId="20577"/>
          <ac:spMkLst>
            <pc:docMk/>
            <pc:sldMk cId="1205680389" sldId="418"/>
            <ac:spMk id="82" creationId="{42AAC5BF-A8E2-42EF-95CC-9AD1021554E6}"/>
          </ac:spMkLst>
        </pc:spChg>
        <pc:graphicFrameChg chg="add mod">
          <ac:chgData name="khoi ho" userId="c93cb340-cf97-4d7c-9739-bad0ee582323" providerId="ADAL" clId="{365471B3-2CEF-4916-A41E-7336EB602685}" dt="2020-11-06T11:10:04.121" v="420" actId="114"/>
          <ac:graphicFrameMkLst>
            <pc:docMk/>
            <pc:sldMk cId="1205680389" sldId="418"/>
            <ac:graphicFrameMk id="13" creationId="{001DE17C-BF79-44CA-9B0E-196A63366CBD}"/>
          </ac:graphicFrameMkLst>
        </pc:graphicFrameChg>
        <pc:graphicFrameChg chg="del">
          <ac:chgData name="khoi ho" userId="c93cb340-cf97-4d7c-9739-bad0ee582323" providerId="ADAL" clId="{365471B3-2CEF-4916-A41E-7336EB602685}" dt="2020-10-29T05:41:44.813" v="176" actId="478"/>
          <ac:graphicFrameMkLst>
            <pc:docMk/>
            <pc:sldMk cId="1205680389" sldId="418"/>
            <ac:graphicFrameMk id="14" creationId="{5003025A-06B5-4772-B5C8-33928BA5BAA5}"/>
          </ac:graphicFrameMkLst>
        </pc:graphicFrameChg>
        <pc:graphicFrameChg chg="del">
          <ac:chgData name="khoi ho" userId="c93cb340-cf97-4d7c-9739-bad0ee582323" providerId="ADAL" clId="{365471B3-2CEF-4916-A41E-7336EB602685}" dt="2020-10-29T05:41:49.289" v="177" actId="478"/>
          <ac:graphicFrameMkLst>
            <pc:docMk/>
            <pc:sldMk cId="1205680389" sldId="418"/>
            <ac:graphicFrameMk id="15" creationId="{C1F7A5B5-33AC-4B32-8E82-B4543411CDB0}"/>
          </ac:graphicFrameMkLst>
        </pc:graphicFrameChg>
        <pc:graphicFrameChg chg="del">
          <ac:chgData name="khoi ho" userId="c93cb340-cf97-4d7c-9739-bad0ee582323" providerId="ADAL" clId="{365471B3-2CEF-4916-A41E-7336EB602685}" dt="2020-10-29T05:41:42.495" v="175" actId="478"/>
          <ac:graphicFrameMkLst>
            <pc:docMk/>
            <pc:sldMk cId="1205680389" sldId="418"/>
            <ac:graphicFrameMk id="16" creationId="{10FFA77B-17D3-451F-A120-89A6D6B1E914}"/>
          </ac:graphicFrameMkLst>
        </pc:graphicFrameChg>
        <pc:graphicFrameChg chg="add mod">
          <ac:chgData name="khoi ho" userId="c93cb340-cf97-4d7c-9739-bad0ee582323" providerId="ADAL" clId="{365471B3-2CEF-4916-A41E-7336EB602685}" dt="2020-11-06T11:11:10.396" v="434"/>
          <ac:graphicFrameMkLst>
            <pc:docMk/>
            <pc:sldMk cId="1205680389" sldId="418"/>
            <ac:graphicFrameMk id="25" creationId="{F6ACC881-F8E2-4688-803D-577C7C0D5889}"/>
          </ac:graphicFrameMkLst>
        </pc:graphicFrameChg>
        <pc:graphicFrameChg chg="add mod">
          <ac:chgData name="khoi ho" userId="c93cb340-cf97-4d7c-9739-bad0ee582323" providerId="ADAL" clId="{365471B3-2CEF-4916-A41E-7336EB602685}" dt="2020-11-06T11:11:16.946" v="435"/>
          <ac:graphicFrameMkLst>
            <pc:docMk/>
            <pc:sldMk cId="1205680389" sldId="418"/>
            <ac:graphicFrameMk id="26" creationId="{01E72CFC-1963-496D-BE6C-21F73A7C0FB5}"/>
          </ac:graphicFrameMkLst>
        </pc:graphicFrameChg>
      </pc:sldChg>
      <pc:sldChg chg="add del">
        <pc:chgData name="khoi ho" userId="c93cb340-cf97-4d7c-9739-bad0ee582323" providerId="ADAL" clId="{365471B3-2CEF-4916-A41E-7336EB602685}" dt="2020-10-16T07:00:41.327" v="173" actId="2696"/>
        <pc:sldMkLst>
          <pc:docMk/>
          <pc:sldMk cId="3915861897" sldId="418"/>
        </pc:sldMkLst>
      </pc:sldChg>
      <pc:sldChg chg="addSp delSp modSp add mod">
        <pc:chgData name="khoi ho" userId="c93cb340-cf97-4d7c-9739-bad0ee582323" providerId="ADAL" clId="{365471B3-2CEF-4916-A41E-7336EB602685}" dt="2020-11-06T11:00:58.038" v="417" actId="114"/>
        <pc:sldMkLst>
          <pc:docMk/>
          <pc:sldMk cId="412136328" sldId="419"/>
        </pc:sldMkLst>
        <pc:spChg chg="del">
          <ac:chgData name="khoi ho" userId="c93cb340-cf97-4d7c-9739-bad0ee582323" providerId="ADAL" clId="{365471B3-2CEF-4916-A41E-7336EB602685}" dt="2020-11-02T02:41:25.202" v="323" actId="478"/>
          <ac:spMkLst>
            <pc:docMk/>
            <pc:sldMk cId="412136328" sldId="419"/>
            <ac:spMk id="14" creationId="{CD949400-FE0B-416E-B382-6987AE0CA188}"/>
          </ac:spMkLst>
        </pc:spChg>
        <pc:spChg chg="del">
          <ac:chgData name="khoi ho" userId="c93cb340-cf97-4d7c-9739-bad0ee582323" providerId="ADAL" clId="{365471B3-2CEF-4916-A41E-7336EB602685}" dt="2020-11-02T02:41:26.703" v="326" actId="478"/>
          <ac:spMkLst>
            <pc:docMk/>
            <pc:sldMk cId="412136328" sldId="419"/>
            <ac:spMk id="15" creationId="{9DFE3474-C396-4AAE-97A5-34374B2EF55B}"/>
          </ac:spMkLst>
        </pc:spChg>
        <pc:spChg chg="del">
          <ac:chgData name="khoi ho" userId="c93cb340-cf97-4d7c-9739-bad0ee582323" providerId="ADAL" clId="{365471B3-2CEF-4916-A41E-7336EB602685}" dt="2020-11-02T02:41:28.291" v="327" actId="478"/>
          <ac:spMkLst>
            <pc:docMk/>
            <pc:sldMk cId="412136328" sldId="419"/>
            <ac:spMk id="16" creationId="{A2225B13-E5CF-4480-9111-14742318B2E1}"/>
          </ac:spMkLst>
        </pc:spChg>
        <pc:spChg chg="del">
          <ac:chgData name="khoi ho" userId="c93cb340-cf97-4d7c-9739-bad0ee582323" providerId="ADAL" clId="{365471B3-2CEF-4916-A41E-7336EB602685}" dt="2020-11-02T02:41:36.664" v="331" actId="478"/>
          <ac:spMkLst>
            <pc:docMk/>
            <pc:sldMk cId="412136328" sldId="419"/>
            <ac:spMk id="18" creationId="{FFA54BD7-5A38-4E89-AEE5-5D3298A4D755}"/>
          </ac:spMkLst>
        </pc:spChg>
        <pc:spChg chg="del">
          <ac:chgData name="khoi ho" userId="c93cb340-cf97-4d7c-9739-bad0ee582323" providerId="ADAL" clId="{365471B3-2CEF-4916-A41E-7336EB602685}" dt="2020-11-02T02:41:34.346" v="330" actId="478"/>
          <ac:spMkLst>
            <pc:docMk/>
            <pc:sldMk cId="412136328" sldId="419"/>
            <ac:spMk id="19" creationId="{F997CF18-F9BB-4FF2-A466-FDA54936FCDB}"/>
          </ac:spMkLst>
        </pc:spChg>
        <pc:spChg chg="add mod">
          <ac:chgData name="khoi ho" userId="c93cb340-cf97-4d7c-9739-bad0ee582323" providerId="ADAL" clId="{365471B3-2CEF-4916-A41E-7336EB602685}" dt="2020-11-02T02:53:38.761" v="360" actId="1076"/>
          <ac:spMkLst>
            <pc:docMk/>
            <pc:sldMk cId="412136328" sldId="419"/>
            <ac:spMk id="21" creationId="{EDF3F42E-E857-407A-ABB9-92AFC4AB3098}"/>
          </ac:spMkLst>
        </pc:spChg>
        <pc:spChg chg="add mod">
          <ac:chgData name="khoi ho" userId="c93cb340-cf97-4d7c-9739-bad0ee582323" providerId="ADAL" clId="{365471B3-2CEF-4916-A41E-7336EB602685}" dt="2020-11-02T02:53:55.252" v="369" actId="1037"/>
          <ac:spMkLst>
            <pc:docMk/>
            <pc:sldMk cId="412136328" sldId="419"/>
            <ac:spMk id="22" creationId="{58837A0E-7C82-4490-BC4B-015001ED5CDD}"/>
          </ac:spMkLst>
        </pc:spChg>
        <pc:spChg chg="add mod">
          <ac:chgData name="khoi ho" userId="c93cb340-cf97-4d7c-9739-bad0ee582323" providerId="ADAL" clId="{365471B3-2CEF-4916-A41E-7336EB602685}" dt="2020-11-02T02:54:15.401" v="377" actId="122"/>
          <ac:spMkLst>
            <pc:docMk/>
            <pc:sldMk cId="412136328" sldId="419"/>
            <ac:spMk id="23" creationId="{1A7424FD-8DAC-4ABC-8E2D-E6499382963C}"/>
          </ac:spMkLst>
        </pc:spChg>
        <pc:spChg chg="add mod">
          <ac:chgData name="khoi ho" userId="c93cb340-cf97-4d7c-9739-bad0ee582323" providerId="ADAL" clId="{365471B3-2CEF-4916-A41E-7336EB602685}" dt="2020-11-02T02:53:59.974" v="370" actId="1076"/>
          <ac:spMkLst>
            <pc:docMk/>
            <pc:sldMk cId="412136328" sldId="419"/>
            <ac:spMk id="24" creationId="{9ACD8600-C8F2-436C-A96F-CAB220071BBF}"/>
          </ac:spMkLst>
        </pc:spChg>
        <pc:spChg chg="del">
          <ac:chgData name="khoi ho" userId="c93cb340-cf97-4d7c-9739-bad0ee582323" providerId="ADAL" clId="{365471B3-2CEF-4916-A41E-7336EB602685}" dt="2020-11-02T02:41:38.201" v="332" actId="478"/>
          <ac:spMkLst>
            <pc:docMk/>
            <pc:sldMk cId="412136328" sldId="419"/>
            <ac:spMk id="26" creationId="{9DC9C857-6AA3-4497-AE79-5AC90EB29040}"/>
          </ac:spMkLst>
        </pc:spChg>
        <pc:spChg chg="del mod">
          <ac:chgData name="khoi ho" userId="c93cb340-cf97-4d7c-9739-bad0ee582323" providerId="ADAL" clId="{365471B3-2CEF-4916-A41E-7336EB602685}" dt="2020-11-02T02:41:25.202" v="325"/>
          <ac:spMkLst>
            <pc:docMk/>
            <pc:sldMk cId="412136328" sldId="419"/>
            <ac:spMk id="43" creationId="{90CBF72A-5A87-4CF6-983D-2A2C1B284A44}"/>
          </ac:spMkLst>
        </pc:spChg>
        <pc:spChg chg="del">
          <ac:chgData name="khoi ho" userId="c93cb340-cf97-4d7c-9739-bad0ee582323" providerId="ADAL" clId="{365471B3-2CEF-4916-A41E-7336EB602685}" dt="2020-11-02T02:41:32.306" v="328" actId="478"/>
          <ac:spMkLst>
            <pc:docMk/>
            <pc:sldMk cId="412136328" sldId="419"/>
            <ac:spMk id="46" creationId="{58B8876F-2A72-424A-85DB-FA82354F3D76}"/>
          </ac:spMkLst>
        </pc:spChg>
        <pc:spChg chg="mod">
          <ac:chgData name="khoi ho" userId="c93cb340-cf97-4d7c-9739-bad0ee582323" providerId="ADAL" clId="{365471B3-2CEF-4916-A41E-7336EB602685}" dt="2020-11-02T02:55:38.933" v="400" actId="20577"/>
          <ac:spMkLst>
            <pc:docMk/>
            <pc:sldMk cId="412136328" sldId="419"/>
            <ac:spMk id="82" creationId="{42AAC5BF-A8E2-42EF-95CC-9AD1021554E6}"/>
          </ac:spMkLst>
        </pc:spChg>
        <pc:graphicFrameChg chg="del">
          <ac:chgData name="khoi ho" userId="c93cb340-cf97-4d7c-9739-bad0ee582323" providerId="ADAL" clId="{365471B3-2CEF-4916-A41E-7336EB602685}" dt="2020-11-02T02:41:22.573" v="321" actId="478"/>
          <ac:graphicFrameMkLst>
            <pc:docMk/>
            <pc:sldMk cId="412136328" sldId="419"/>
            <ac:graphicFrameMk id="13" creationId="{05DE315D-42A9-492E-9CEF-CD9409AB5A01}"/>
          </ac:graphicFrameMkLst>
        </pc:graphicFrameChg>
        <pc:graphicFrameChg chg="del">
          <ac:chgData name="khoi ho" userId="c93cb340-cf97-4d7c-9739-bad0ee582323" providerId="ADAL" clId="{365471B3-2CEF-4916-A41E-7336EB602685}" dt="2020-11-02T02:41:33.437" v="329" actId="478"/>
          <ac:graphicFrameMkLst>
            <pc:docMk/>
            <pc:sldMk cId="412136328" sldId="419"/>
            <ac:graphicFrameMk id="17" creationId="{3E4CAB8D-2A01-40C9-AA61-DE24D36D3BFB}"/>
          </ac:graphicFrameMkLst>
        </pc:graphicFrameChg>
        <pc:graphicFrameChg chg="add mod">
          <ac:chgData name="khoi ho" userId="c93cb340-cf97-4d7c-9739-bad0ee582323" providerId="ADAL" clId="{365471B3-2CEF-4916-A41E-7336EB602685}" dt="2020-11-06T11:00:58.038" v="417" actId="114"/>
          <ac:graphicFrameMkLst>
            <pc:docMk/>
            <pc:sldMk cId="412136328" sldId="419"/>
            <ac:graphicFrameMk id="20" creationId="{CE2E1E5F-546A-439E-AE0B-5A351FFC78D2}"/>
          </ac:graphicFrameMkLst>
        </pc:graphicFrameChg>
      </pc:sldChg>
    </pc:docChg>
  </pc:docChgLst>
  <pc:docChgLst>
    <pc:chgData name="khoi ho" userId="c93cb340-cf97-4d7c-9739-bad0ee582323" providerId="ADAL" clId="{115D3D2B-CADC-4033-9EA0-43264417C94D}"/>
    <pc:docChg chg="undo redo custSel addSld delSld modSld">
      <pc:chgData name="khoi ho" userId="c93cb340-cf97-4d7c-9739-bad0ee582323" providerId="ADAL" clId="{115D3D2B-CADC-4033-9EA0-43264417C94D}" dt="2021-01-04T03:15:09.540" v="415"/>
      <pc:docMkLst>
        <pc:docMk/>
      </pc:docMkLst>
      <pc:sldChg chg="addSp delSp modSp mod">
        <pc:chgData name="khoi ho" userId="c93cb340-cf97-4d7c-9739-bad0ee582323" providerId="ADAL" clId="{115D3D2B-CADC-4033-9EA0-43264417C94D}" dt="2020-12-30T06:38:02.409" v="285"/>
        <pc:sldMkLst>
          <pc:docMk/>
          <pc:sldMk cId="3007145726" sldId="395"/>
        </pc:sldMkLst>
        <pc:spChg chg="del">
          <ac:chgData name="khoi ho" userId="c93cb340-cf97-4d7c-9739-bad0ee582323" providerId="ADAL" clId="{115D3D2B-CADC-4033-9EA0-43264417C94D}" dt="2020-12-28T06:13:23.794" v="10"/>
          <ac:spMkLst>
            <pc:docMk/>
            <pc:sldMk cId="3007145726" sldId="395"/>
            <ac:spMk id="17" creationId="{D8E50B76-F67F-4EFF-8763-43A9038AB50F}"/>
          </ac:spMkLst>
        </pc:spChg>
        <pc:spChg chg="add del mod">
          <ac:chgData name="khoi ho" userId="c93cb340-cf97-4d7c-9739-bad0ee582323" providerId="ADAL" clId="{115D3D2B-CADC-4033-9EA0-43264417C94D}" dt="2020-12-28T06:23:18.524" v="76"/>
          <ac:spMkLst>
            <pc:docMk/>
            <pc:sldMk cId="3007145726" sldId="395"/>
            <ac:spMk id="18" creationId="{0243F739-3CD5-460D-A813-E810766063D2}"/>
          </ac:spMkLst>
        </pc:spChg>
        <pc:spChg chg="add del mod">
          <ac:chgData name="khoi ho" userId="c93cb340-cf97-4d7c-9739-bad0ee582323" providerId="ADAL" clId="{115D3D2B-CADC-4033-9EA0-43264417C94D}" dt="2020-12-28T06:23:18.524" v="76"/>
          <ac:spMkLst>
            <pc:docMk/>
            <pc:sldMk cId="3007145726" sldId="395"/>
            <ac:spMk id="19" creationId="{85F17A16-D4E4-4697-805B-A404AD148E6B}"/>
          </ac:spMkLst>
        </pc:spChg>
        <pc:spChg chg="add del mod">
          <ac:chgData name="khoi ho" userId="c93cb340-cf97-4d7c-9739-bad0ee582323" providerId="ADAL" clId="{115D3D2B-CADC-4033-9EA0-43264417C94D}" dt="2020-12-28T06:23:18.524" v="76"/>
          <ac:spMkLst>
            <pc:docMk/>
            <pc:sldMk cId="3007145726" sldId="395"/>
            <ac:spMk id="20" creationId="{69F91918-B046-4601-B6ED-0C0B4A9FB081}"/>
          </ac:spMkLst>
        </pc:spChg>
        <pc:spChg chg="add del mod">
          <ac:chgData name="khoi ho" userId="c93cb340-cf97-4d7c-9739-bad0ee582323" providerId="ADAL" clId="{115D3D2B-CADC-4033-9EA0-43264417C94D}" dt="2020-12-28T06:23:18.524" v="76"/>
          <ac:spMkLst>
            <pc:docMk/>
            <pc:sldMk cId="3007145726" sldId="395"/>
            <ac:spMk id="21" creationId="{29EB68DC-764D-40EB-A4CD-AA6CBC732E09}"/>
          </ac:spMkLst>
        </pc:spChg>
        <pc:spChg chg="del">
          <ac:chgData name="khoi ho" userId="c93cb340-cf97-4d7c-9739-bad0ee582323" providerId="ADAL" clId="{115D3D2B-CADC-4033-9EA0-43264417C94D}" dt="2020-12-28T06:13:23.794" v="10"/>
          <ac:spMkLst>
            <pc:docMk/>
            <pc:sldMk cId="3007145726" sldId="395"/>
            <ac:spMk id="22" creationId="{A2E52160-0779-49D2-A8F5-ED1248FE0526}"/>
          </ac:spMkLst>
        </pc:spChg>
        <pc:spChg chg="del">
          <ac:chgData name="khoi ho" userId="c93cb340-cf97-4d7c-9739-bad0ee582323" providerId="ADAL" clId="{115D3D2B-CADC-4033-9EA0-43264417C94D}" dt="2020-12-28T06:13:23.794" v="10"/>
          <ac:spMkLst>
            <pc:docMk/>
            <pc:sldMk cId="3007145726" sldId="395"/>
            <ac:spMk id="23" creationId="{89D8AC35-B5E9-4025-8F70-D6EDFAC2B436}"/>
          </ac:spMkLst>
        </pc:spChg>
        <pc:spChg chg="del">
          <ac:chgData name="khoi ho" userId="c93cb340-cf97-4d7c-9739-bad0ee582323" providerId="ADAL" clId="{115D3D2B-CADC-4033-9EA0-43264417C94D}" dt="2020-12-28T06:13:23.794" v="10"/>
          <ac:spMkLst>
            <pc:docMk/>
            <pc:sldMk cId="3007145726" sldId="395"/>
            <ac:spMk id="24" creationId="{FB569DF3-A47F-478D-8D29-37E9F70FB328}"/>
          </ac:spMkLst>
        </pc:spChg>
        <pc:spChg chg="add mod">
          <ac:chgData name="khoi ho" userId="c93cb340-cf97-4d7c-9739-bad0ee582323" providerId="ADAL" clId="{115D3D2B-CADC-4033-9EA0-43264417C94D}" dt="2020-12-28T06:23:53.733" v="80" actId="1076"/>
          <ac:spMkLst>
            <pc:docMk/>
            <pc:sldMk cId="3007145726" sldId="395"/>
            <ac:spMk id="29" creationId="{E31FE930-6420-46BB-A89A-C6696220D39D}"/>
          </ac:spMkLst>
        </pc:spChg>
        <pc:spChg chg="add mod">
          <ac:chgData name="khoi ho" userId="c93cb340-cf97-4d7c-9739-bad0ee582323" providerId="ADAL" clId="{115D3D2B-CADC-4033-9EA0-43264417C94D}" dt="2020-12-28T06:24:21.129" v="84" actId="1076"/>
          <ac:spMkLst>
            <pc:docMk/>
            <pc:sldMk cId="3007145726" sldId="395"/>
            <ac:spMk id="30" creationId="{1091A399-EF06-419E-BE70-958F768BE667}"/>
          </ac:spMkLst>
        </pc:spChg>
        <pc:spChg chg="add mod">
          <ac:chgData name="khoi ho" userId="c93cb340-cf97-4d7c-9739-bad0ee582323" providerId="ADAL" clId="{115D3D2B-CADC-4033-9EA0-43264417C94D}" dt="2020-12-28T06:24:12.749" v="83" actId="1076"/>
          <ac:spMkLst>
            <pc:docMk/>
            <pc:sldMk cId="3007145726" sldId="395"/>
            <ac:spMk id="31" creationId="{A3E84553-DAC8-4D50-A9F0-CD9DF1A87F10}"/>
          </ac:spMkLst>
        </pc:spChg>
        <pc:spChg chg="add mod">
          <ac:chgData name="khoi ho" userId="c93cb340-cf97-4d7c-9739-bad0ee582323" providerId="ADAL" clId="{115D3D2B-CADC-4033-9EA0-43264417C94D}" dt="2020-12-28T06:25:36.810" v="102" actId="122"/>
          <ac:spMkLst>
            <pc:docMk/>
            <pc:sldMk cId="3007145726" sldId="395"/>
            <ac:spMk id="32" creationId="{6E15D2A1-855D-4043-8C6F-3FB4C84CEDF9}"/>
          </ac:spMkLst>
        </pc:spChg>
        <pc:spChg chg="add mod">
          <ac:chgData name="khoi ho" userId="c93cb340-cf97-4d7c-9739-bad0ee582323" providerId="ADAL" clId="{115D3D2B-CADC-4033-9EA0-43264417C94D}" dt="2020-12-28T06:24:36.533" v="87" actId="1076"/>
          <ac:spMkLst>
            <pc:docMk/>
            <pc:sldMk cId="3007145726" sldId="395"/>
            <ac:spMk id="33" creationId="{C389A768-C417-4F3A-8275-4C49C806E0C2}"/>
          </ac:spMkLst>
        </pc:spChg>
        <pc:spChg chg="add mod">
          <ac:chgData name="khoi ho" userId="c93cb340-cf97-4d7c-9739-bad0ee582323" providerId="ADAL" clId="{115D3D2B-CADC-4033-9EA0-43264417C94D}" dt="2020-12-28T06:25:23.947" v="99" actId="1037"/>
          <ac:spMkLst>
            <pc:docMk/>
            <pc:sldMk cId="3007145726" sldId="395"/>
            <ac:spMk id="34" creationId="{A106FDD0-3DAD-48BD-A498-F9CE0E782527}"/>
          </ac:spMkLst>
        </pc:spChg>
        <pc:spChg chg="add mod">
          <ac:chgData name="khoi ho" userId="c93cb340-cf97-4d7c-9739-bad0ee582323" providerId="ADAL" clId="{115D3D2B-CADC-4033-9EA0-43264417C94D}" dt="2020-12-28T06:25:14.861" v="94" actId="20577"/>
          <ac:spMkLst>
            <pc:docMk/>
            <pc:sldMk cId="3007145726" sldId="395"/>
            <ac:spMk id="35" creationId="{4B3BD413-41F5-4330-BC07-C320373073FD}"/>
          </ac:spMkLst>
        </pc:spChg>
        <pc:spChg chg="add mod">
          <ac:chgData name="khoi ho" userId="c93cb340-cf97-4d7c-9739-bad0ee582323" providerId="ADAL" clId="{115D3D2B-CADC-4033-9EA0-43264417C94D}" dt="2020-12-28T06:25:31.481" v="101" actId="1037"/>
          <ac:spMkLst>
            <pc:docMk/>
            <pc:sldMk cId="3007145726" sldId="395"/>
            <ac:spMk id="36" creationId="{FE899CFF-4783-4454-ABB1-8608C42A494B}"/>
          </ac:spMkLst>
        </pc:spChg>
        <pc:spChg chg="mod">
          <ac:chgData name="khoi ho" userId="c93cb340-cf97-4d7c-9739-bad0ee582323" providerId="ADAL" clId="{115D3D2B-CADC-4033-9EA0-43264417C94D}" dt="2020-12-28T06:14:10.120" v="24" actId="1076"/>
          <ac:spMkLst>
            <pc:docMk/>
            <pc:sldMk cId="3007145726" sldId="395"/>
            <ac:spMk id="46" creationId="{58B8876F-2A72-424A-85DB-FA82354F3D76}"/>
          </ac:spMkLst>
        </pc:spChg>
        <pc:spChg chg="del">
          <ac:chgData name="khoi ho" userId="c93cb340-cf97-4d7c-9739-bad0ee582323" providerId="ADAL" clId="{115D3D2B-CADC-4033-9EA0-43264417C94D}" dt="2020-12-28T06:12:03.601" v="3" actId="478"/>
          <ac:spMkLst>
            <pc:docMk/>
            <pc:sldMk cId="3007145726" sldId="395"/>
            <ac:spMk id="67" creationId="{653006DD-E2DB-409A-8F77-0047E20B5506}"/>
          </ac:spMkLst>
        </pc:spChg>
        <pc:graphicFrameChg chg="add del mod">
          <ac:chgData name="khoi ho" userId="c93cb340-cf97-4d7c-9739-bad0ee582323" providerId="ADAL" clId="{115D3D2B-CADC-4033-9EA0-43264417C94D}" dt="2020-12-28T06:22:47.496" v="70" actId="478"/>
          <ac:graphicFrameMkLst>
            <pc:docMk/>
            <pc:sldMk cId="3007145726" sldId="395"/>
            <ac:graphicFrameMk id="13" creationId="{CE2E1E5F-546A-439E-AE0B-5A351FFC78D2}"/>
          </ac:graphicFrameMkLst>
        </pc:graphicFrameChg>
        <pc:graphicFrameChg chg="del">
          <ac:chgData name="khoi ho" userId="c93cb340-cf97-4d7c-9739-bad0ee582323" providerId="ADAL" clId="{115D3D2B-CADC-4033-9EA0-43264417C94D}" dt="2020-12-28T06:11:58.129" v="1" actId="478"/>
          <ac:graphicFrameMkLst>
            <pc:docMk/>
            <pc:sldMk cId="3007145726" sldId="395"/>
            <ac:graphicFrameMk id="14" creationId="{5003025A-06B5-4772-B5C8-33928BA5BAA5}"/>
          </ac:graphicFrameMkLst>
        </pc:graphicFrameChg>
        <pc:graphicFrameChg chg="del">
          <ac:chgData name="khoi ho" userId="c93cb340-cf97-4d7c-9739-bad0ee582323" providerId="ADAL" clId="{115D3D2B-CADC-4033-9EA0-43264417C94D}" dt="2020-12-28T06:11:59.745" v="2" actId="478"/>
          <ac:graphicFrameMkLst>
            <pc:docMk/>
            <pc:sldMk cId="3007145726" sldId="395"/>
            <ac:graphicFrameMk id="15" creationId="{C1F7A5B5-33AC-4B32-8E82-B4543411CDB0}"/>
          </ac:graphicFrameMkLst>
        </pc:graphicFrameChg>
        <pc:graphicFrameChg chg="del">
          <ac:chgData name="khoi ho" userId="c93cb340-cf97-4d7c-9739-bad0ee582323" providerId="ADAL" clId="{115D3D2B-CADC-4033-9EA0-43264417C94D}" dt="2020-12-28T06:11:56.150" v="0" actId="478"/>
          <ac:graphicFrameMkLst>
            <pc:docMk/>
            <pc:sldMk cId="3007145726" sldId="395"/>
            <ac:graphicFrameMk id="16" creationId="{10FFA77B-17D3-451F-A120-89A6D6B1E914}"/>
          </ac:graphicFrameMkLst>
        </pc:graphicFrameChg>
        <pc:graphicFrameChg chg="add del mod">
          <ac:chgData name="khoi ho" userId="c93cb340-cf97-4d7c-9739-bad0ee582323" providerId="ADAL" clId="{115D3D2B-CADC-4033-9EA0-43264417C94D}" dt="2020-12-28T06:17:35.055" v="49" actId="478"/>
          <ac:graphicFrameMkLst>
            <pc:docMk/>
            <pc:sldMk cId="3007145726" sldId="395"/>
            <ac:graphicFrameMk id="25" creationId="{4566F883-4130-422C-A525-BF11EAE08E97}"/>
          </ac:graphicFrameMkLst>
        </pc:graphicFrameChg>
        <pc:graphicFrameChg chg="add del mod">
          <ac:chgData name="khoi ho" userId="c93cb340-cf97-4d7c-9739-bad0ee582323" providerId="ADAL" clId="{115D3D2B-CADC-4033-9EA0-43264417C94D}" dt="2020-12-28T06:20:19.606" v="59" actId="478"/>
          <ac:graphicFrameMkLst>
            <pc:docMk/>
            <pc:sldMk cId="3007145726" sldId="395"/>
            <ac:graphicFrameMk id="26" creationId="{4566F883-4130-422C-A525-BF11EAE08E97}"/>
          </ac:graphicFrameMkLst>
        </pc:graphicFrameChg>
        <pc:graphicFrameChg chg="add mod">
          <ac:chgData name="khoi ho" userId="c93cb340-cf97-4d7c-9739-bad0ee582323" providerId="ADAL" clId="{115D3D2B-CADC-4033-9EA0-43264417C94D}" dt="2020-12-30T06:38:02.409" v="285"/>
          <ac:graphicFrameMkLst>
            <pc:docMk/>
            <pc:sldMk cId="3007145726" sldId="395"/>
            <ac:graphicFrameMk id="27" creationId="{4566F883-4130-422C-A525-BF11EAE08E97}"/>
          </ac:graphicFrameMkLst>
        </pc:graphicFrameChg>
        <pc:graphicFrameChg chg="add mod">
          <ac:chgData name="khoi ho" userId="c93cb340-cf97-4d7c-9739-bad0ee582323" providerId="ADAL" clId="{115D3D2B-CADC-4033-9EA0-43264417C94D}" dt="2020-12-28T06:54:33.861" v="244" actId="114"/>
          <ac:graphicFrameMkLst>
            <pc:docMk/>
            <pc:sldMk cId="3007145726" sldId="395"/>
            <ac:graphicFrameMk id="28" creationId="{CE2E1E5F-546A-439E-AE0B-5A351FFC78D2}"/>
          </ac:graphicFrameMkLst>
        </pc:graphicFrameChg>
      </pc:sldChg>
      <pc:sldChg chg="del">
        <pc:chgData name="khoi ho" userId="c93cb340-cf97-4d7c-9739-bad0ee582323" providerId="ADAL" clId="{115D3D2B-CADC-4033-9EA0-43264417C94D}" dt="2020-12-28T06:34:21.939" v="158" actId="2696"/>
        <pc:sldMkLst>
          <pc:docMk/>
          <pc:sldMk cId="1654466452" sldId="398"/>
        </pc:sldMkLst>
      </pc:sldChg>
      <pc:sldChg chg="del">
        <pc:chgData name="khoi ho" userId="c93cb340-cf97-4d7c-9739-bad0ee582323" providerId="ADAL" clId="{115D3D2B-CADC-4033-9EA0-43264417C94D}" dt="2020-12-28T06:34:21.772" v="156" actId="2696"/>
        <pc:sldMkLst>
          <pc:docMk/>
          <pc:sldMk cId="1212021925" sldId="399"/>
        </pc:sldMkLst>
      </pc:sldChg>
      <pc:sldChg chg="del">
        <pc:chgData name="khoi ho" userId="c93cb340-cf97-4d7c-9739-bad0ee582323" providerId="ADAL" clId="{115D3D2B-CADC-4033-9EA0-43264417C94D}" dt="2020-12-28T06:34:21.822" v="157" actId="2696"/>
        <pc:sldMkLst>
          <pc:docMk/>
          <pc:sldMk cId="4107458222" sldId="400"/>
        </pc:sldMkLst>
      </pc:sldChg>
      <pc:sldChg chg="del">
        <pc:chgData name="khoi ho" userId="c93cb340-cf97-4d7c-9739-bad0ee582323" providerId="ADAL" clId="{115D3D2B-CADC-4033-9EA0-43264417C94D}" dt="2020-12-28T06:34:21.728" v="155" actId="2696"/>
        <pc:sldMkLst>
          <pc:docMk/>
          <pc:sldMk cId="3434091264" sldId="401"/>
        </pc:sldMkLst>
      </pc:sldChg>
      <pc:sldChg chg="addSp delSp modSp mod">
        <pc:chgData name="khoi ho" userId="c93cb340-cf97-4d7c-9739-bad0ee582323" providerId="ADAL" clId="{115D3D2B-CADC-4033-9EA0-43264417C94D}" dt="2020-12-30T06:37:55.488" v="284"/>
        <pc:sldMkLst>
          <pc:docMk/>
          <pc:sldMk cId="1764524680" sldId="402"/>
        </pc:sldMkLst>
        <pc:spChg chg="del">
          <ac:chgData name="khoi ho" userId="c93cb340-cf97-4d7c-9739-bad0ee582323" providerId="ADAL" clId="{115D3D2B-CADC-4033-9EA0-43264417C94D}" dt="2020-12-28T06:26:26.272" v="103" actId="478"/>
          <ac:spMkLst>
            <pc:docMk/>
            <pc:sldMk cId="1764524680" sldId="402"/>
            <ac:spMk id="15" creationId="{E5F1CAAC-D1CE-45D6-B92D-9500309AFE88}"/>
          </ac:spMkLst>
        </pc:spChg>
        <pc:spChg chg="add">
          <ac:chgData name="khoi ho" userId="c93cb340-cf97-4d7c-9739-bad0ee582323" providerId="ADAL" clId="{115D3D2B-CADC-4033-9EA0-43264417C94D}" dt="2020-12-28T06:26:36.489" v="105"/>
          <ac:spMkLst>
            <pc:docMk/>
            <pc:sldMk cId="1764524680" sldId="402"/>
            <ac:spMk id="16" creationId="{F026DEE3-B371-495D-99CD-3470F3270C93}"/>
          </ac:spMkLst>
        </pc:spChg>
        <pc:spChg chg="add">
          <ac:chgData name="khoi ho" userId="c93cb340-cf97-4d7c-9739-bad0ee582323" providerId="ADAL" clId="{115D3D2B-CADC-4033-9EA0-43264417C94D}" dt="2020-12-28T06:26:36.489" v="105"/>
          <ac:spMkLst>
            <pc:docMk/>
            <pc:sldMk cId="1764524680" sldId="402"/>
            <ac:spMk id="17" creationId="{F0870D45-E441-4337-BFC0-B180E0107054}"/>
          </ac:spMkLst>
        </pc:spChg>
        <pc:spChg chg="add mod">
          <ac:chgData name="khoi ho" userId="c93cb340-cf97-4d7c-9739-bad0ee582323" providerId="ADAL" clId="{115D3D2B-CADC-4033-9EA0-43264417C94D}" dt="2020-12-28T06:29:36.241" v="118" actId="1076"/>
          <ac:spMkLst>
            <pc:docMk/>
            <pc:sldMk cId="1764524680" sldId="402"/>
            <ac:spMk id="20" creationId="{BBDC256B-A0D0-4D8B-8B45-ECBC9B89C1DC}"/>
          </ac:spMkLst>
        </pc:spChg>
        <pc:spChg chg="add mod">
          <ac:chgData name="khoi ho" userId="c93cb340-cf97-4d7c-9739-bad0ee582323" providerId="ADAL" clId="{115D3D2B-CADC-4033-9EA0-43264417C94D}" dt="2020-12-28T06:29:51.852" v="120" actId="1076"/>
          <ac:spMkLst>
            <pc:docMk/>
            <pc:sldMk cId="1764524680" sldId="402"/>
            <ac:spMk id="21" creationId="{4E2C7AF9-67A5-4D4B-97D0-A68A822C4757}"/>
          </ac:spMkLst>
        </pc:spChg>
        <pc:spChg chg="add mod">
          <ac:chgData name="khoi ho" userId="c93cb340-cf97-4d7c-9739-bad0ee582323" providerId="ADAL" clId="{115D3D2B-CADC-4033-9EA0-43264417C94D}" dt="2020-12-28T06:29:44.541" v="119" actId="1076"/>
          <ac:spMkLst>
            <pc:docMk/>
            <pc:sldMk cId="1764524680" sldId="402"/>
            <ac:spMk id="22" creationId="{ABFB1841-CD69-438D-A65E-EFE245F4635E}"/>
          </ac:spMkLst>
        </pc:spChg>
        <pc:spChg chg="add mod">
          <ac:chgData name="khoi ho" userId="c93cb340-cf97-4d7c-9739-bad0ee582323" providerId="ADAL" clId="{115D3D2B-CADC-4033-9EA0-43264417C94D}" dt="2020-12-28T06:29:27.597" v="117" actId="1076"/>
          <ac:spMkLst>
            <pc:docMk/>
            <pc:sldMk cId="1764524680" sldId="402"/>
            <ac:spMk id="23" creationId="{5F6F7E59-1884-4115-AAD8-BA746A20C38C}"/>
          </ac:spMkLst>
        </pc:spChg>
        <pc:grpChg chg="del">
          <ac:chgData name="khoi ho" userId="c93cb340-cf97-4d7c-9739-bad0ee582323" providerId="ADAL" clId="{115D3D2B-CADC-4033-9EA0-43264417C94D}" dt="2020-12-28T06:26:29.160" v="104" actId="478"/>
          <ac:grpSpMkLst>
            <pc:docMk/>
            <pc:sldMk cId="1764524680" sldId="402"/>
            <ac:grpSpMk id="2" creationId="{BAAF8DB2-9E39-4CBB-8DA0-A8176E64B38E}"/>
          </ac:grpSpMkLst>
        </pc:grpChg>
        <pc:graphicFrameChg chg="del">
          <ac:chgData name="khoi ho" userId="c93cb340-cf97-4d7c-9739-bad0ee582323" providerId="ADAL" clId="{115D3D2B-CADC-4033-9EA0-43264417C94D}" dt="2020-12-28T06:26:26.272" v="103" actId="478"/>
          <ac:graphicFrameMkLst>
            <pc:docMk/>
            <pc:sldMk cId="1764524680" sldId="402"/>
            <ac:graphicFrameMk id="14" creationId="{581DD6D6-4380-41E2-A932-DAFECD798ACD}"/>
          </ac:graphicFrameMkLst>
        </pc:graphicFrameChg>
        <pc:graphicFrameChg chg="add mod">
          <ac:chgData name="khoi ho" userId="c93cb340-cf97-4d7c-9739-bad0ee582323" providerId="ADAL" clId="{115D3D2B-CADC-4033-9EA0-43264417C94D}" dt="2020-12-28T06:55:49.887" v="246" actId="114"/>
          <ac:graphicFrameMkLst>
            <pc:docMk/>
            <pc:sldMk cId="1764524680" sldId="402"/>
            <ac:graphicFrameMk id="18" creationId="{AEA57728-B531-4970-B16A-D5CCF39506BA}"/>
          </ac:graphicFrameMkLst>
        </pc:graphicFrameChg>
        <pc:graphicFrameChg chg="add mod">
          <ac:chgData name="khoi ho" userId="c93cb340-cf97-4d7c-9739-bad0ee582323" providerId="ADAL" clId="{115D3D2B-CADC-4033-9EA0-43264417C94D}" dt="2020-12-30T06:37:55.488" v="284"/>
          <ac:graphicFrameMkLst>
            <pc:docMk/>
            <pc:sldMk cId="1764524680" sldId="402"/>
            <ac:graphicFrameMk id="19" creationId="{2B7BCFE6-156D-4F81-8F56-03C8CC4716F3}"/>
          </ac:graphicFrameMkLst>
        </pc:graphicFrameChg>
      </pc:sldChg>
      <pc:sldChg chg="del">
        <pc:chgData name="khoi ho" userId="c93cb340-cf97-4d7c-9739-bad0ee582323" providerId="ADAL" clId="{115D3D2B-CADC-4033-9EA0-43264417C94D}" dt="2020-12-28T06:34:22.054" v="160" actId="2696"/>
        <pc:sldMkLst>
          <pc:docMk/>
          <pc:sldMk cId="2621352214" sldId="407"/>
        </pc:sldMkLst>
      </pc:sldChg>
      <pc:sldChg chg="del">
        <pc:chgData name="khoi ho" userId="c93cb340-cf97-4d7c-9739-bad0ee582323" providerId="ADAL" clId="{115D3D2B-CADC-4033-9EA0-43264417C94D}" dt="2020-12-28T06:34:22.086" v="161" actId="2696"/>
        <pc:sldMkLst>
          <pc:docMk/>
          <pc:sldMk cId="3173550047" sldId="408"/>
        </pc:sldMkLst>
      </pc:sldChg>
      <pc:sldChg chg="del">
        <pc:chgData name="khoi ho" userId="c93cb340-cf97-4d7c-9739-bad0ee582323" providerId="ADAL" clId="{115D3D2B-CADC-4033-9EA0-43264417C94D}" dt="2020-12-28T06:34:21.680" v="154" actId="2696"/>
        <pc:sldMkLst>
          <pc:docMk/>
          <pc:sldMk cId="3664975801" sldId="410"/>
        </pc:sldMkLst>
      </pc:sldChg>
      <pc:sldChg chg="del">
        <pc:chgData name="khoi ho" userId="c93cb340-cf97-4d7c-9739-bad0ee582323" providerId="ADAL" clId="{115D3D2B-CADC-4033-9EA0-43264417C94D}" dt="2020-12-28T06:34:22.550" v="164" actId="2696"/>
        <pc:sldMkLst>
          <pc:docMk/>
          <pc:sldMk cId="3022863545" sldId="411"/>
        </pc:sldMkLst>
      </pc:sldChg>
      <pc:sldChg chg="del">
        <pc:chgData name="khoi ho" userId="c93cb340-cf97-4d7c-9739-bad0ee582323" providerId="ADAL" clId="{115D3D2B-CADC-4033-9EA0-43264417C94D}" dt="2020-12-28T06:34:22.118" v="162" actId="2696"/>
        <pc:sldMkLst>
          <pc:docMk/>
          <pc:sldMk cId="1956460582" sldId="415"/>
        </pc:sldMkLst>
      </pc:sldChg>
      <pc:sldChg chg="del">
        <pc:chgData name="khoi ho" userId="c93cb340-cf97-4d7c-9739-bad0ee582323" providerId="ADAL" clId="{115D3D2B-CADC-4033-9EA0-43264417C94D}" dt="2020-12-28T06:34:22.019" v="159" actId="2696"/>
        <pc:sldMkLst>
          <pc:docMk/>
          <pc:sldMk cId="1134663030" sldId="416"/>
        </pc:sldMkLst>
      </pc:sldChg>
      <pc:sldChg chg="del">
        <pc:chgData name="khoi ho" userId="c93cb340-cf97-4d7c-9739-bad0ee582323" providerId="ADAL" clId="{115D3D2B-CADC-4033-9EA0-43264417C94D}" dt="2020-12-28T06:34:22.582" v="165" actId="2696"/>
        <pc:sldMkLst>
          <pc:docMk/>
          <pc:sldMk cId="1836038841" sldId="417"/>
        </pc:sldMkLst>
      </pc:sldChg>
      <pc:sldChg chg="delSp del">
        <pc:chgData name="khoi ho" userId="c93cb340-cf97-4d7c-9739-bad0ee582323" providerId="ADAL" clId="{115D3D2B-CADC-4033-9EA0-43264417C94D}" dt="2020-12-28T06:30:13.354" v="123" actId="2696"/>
        <pc:sldMkLst>
          <pc:docMk/>
          <pc:sldMk cId="1205680389" sldId="418"/>
        </pc:sldMkLst>
        <pc:graphicFrameChg chg="del">
          <ac:chgData name="khoi ho" userId="c93cb340-cf97-4d7c-9739-bad0ee582323" providerId="ADAL" clId="{115D3D2B-CADC-4033-9EA0-43264417C94D}" dt="2020-12-28T06:30:03.481" v="121" actId="478"/>
          <ac:graphicFrameMkLst>
            <pc:docMk/>
            <pc:sldMk cId="1205680389" sldId="418"/>
            <ac:graphicFrameMk id="13" creationId="{001DE17C-BF79-44CA-9B0E-196A63366CBD}"/>
          </ac:graphicFrameMkLst>
        </pc:graphicFrameChg>
      </pc:sldChg>
      <pc:sldChg chg="del">
        <pc:chgData name="khoi ho" userId="c93cb340-cf97-4d7c-9739-bad0ee582323" providerId="ADAL" clId="{115D3D2B-CADC-4033-9EA0-43264417C94D}" dt="2020-12-28T06:34:22.386" v="163" actId="2696"/>
        <pc:sldMkLst>
          <pc:docMk/>
          <pc:sldMk cId="412136328" sldId="419"/>
        </pc:sldMkLst>
      </pc:sldChg>
      <pc:sldChg chg="addSp delSp modSp add mod">
        <pc:chgData name="khoi ho" userId="c93cb340-cf97-4d7c-9739-bad0ee582323" providerId="ADAL" clId="{115D3D2B-CADC-4033-9EA0-43264417C94D}" dt="2020-12-30T06:37:48.025" v="283"/>
        <pc:sldMkLst>
          <pc:docMk/>
          <pc:sldMk cId="3112093971" sldId="420"/>
        </pc:sldMkLst>
        <pc:spChg chg="mod">
          <ac:chgData name="khoi ho" userId="c93cb340-cf97-4d7c-9739-bad0ee582323" providerId="ADAL" clId="{115D3D2B-CADC-4033-9EA0-43264417C94D}" dt="2020-12-28T06:30:25.676" v="125" actId="20577"/>
          <ac:spMkLst>
            <pc:docMk/>
            <pc:sldMk cId="3112093971" sldId="420"/>
            <ac:spMk id="13" creationId="{54BD93B3-4B19-4239-AE5E-DB087DDB95F6}"/>
          </ac:spMkLst>
        </pc:spChg>
        <pc:spChg chg="del">
          <ac:chgData name="khoi ho" userId="c93cb340-cf97-4d7c-9739-bad0ee582323" providerId="ADAL" clId="{115D3D2B-CADC-4033-9EA0-43264417C94D}" dt="2020-12-28T06:30:38.655" v="130" actId="478"/>
          <ac:spMkLst>
            <pc:docMk/>
            <pc:sldMk cId="3112093971" sldId="420"/>
            <ac:spMk id="20" creationId="{BBDC256B-A0D0-4D8B-8B45-ECBC9B89C1DC}"/>
          </ac:spMkLst>
        </pc:spChg>
        <pc:spChg chg="del">
          <ac:chgData name="khoi ho" userId="c93cb340-cf97-4d7c-9739-bad0ee582323" providerId="ADAL" clId="{115D3D2B-CADC-4033-9EA0-43264417C94D}" dt="2020-12-28T06:30:36.691" v="129" actId="478"/>
          <ac:spMkLst>
            <pc:docMk/>
            <pc:sldMk cId="3112093971" sldId="420"/>
            <ac:spMk id="21" creationId="{4E2C7AF9-67A5-4D4B-97D0-A68A822C4757}"/>
          </ac:spMkLst>
        </pc:spChg>
        <pc:spChg chg="del">
          <ac:chgData name="khoi ho" userId="c93cb340-cf97-4d7c-9739-bad0ee582323" providerId="ADAL" clId="{115D3D2B-CADC-4033-9EA0-43264417C94D}" dt="2020-12-28T06:30:36.691" v="129" actId="478"/>
          <ac:spMkLst>
            <pc:docMk/>
            <pc:sldMk cId="3112093971" sldId="420"/>
            <ac:spMk id="22" creationId="{ABFB1841-CD69-438D-A65E-EFE245F4635E}"/>
          </ac:spMkLst>
        </pc:spChg>
        <pc:spChg chg="del mod">
          <ac:chgData name="khoi ho" userId="c93cb340-cf97-4d7c-9739-bad0ee582323" providerId="ADAL" clId="{115D3D2B-CADC-4033-9EA0-43264417C94D}" dt="2020-12-28T06:30:36.691" v="129" actId="478"/>
          <ac:spMkLst>
            <pc:docMk/>
            <pc:sldMk cId="3112093971" sldId="420"/>
            <ac:spMk id="23" creationId="{5F6F7E59-1884-4115-AAD8-BA746A20C38C}"/>
          </ac:spMkLst>
        </pc:spChg>
        <pc:graphicFrameChg chg="add mod">
          <ac:chgData name="khoi ho" userId="c93cb340-cf97-4d7c-9739-bad0ee582323" providerId="ADAL" clId="{115D3D2B-CADC-4033-9EA0-43264417C94D}" dt="2020-12-28T06:56:28.966" v="250" actId="114"/>
          <ac:graphicFrameMkLst>
            <pc:docMk/>
            <pc:sldMk cId="3112093971" sldId="420"/>
            <ac:graphicFrameMk id="11" creationId="{4CA2742B-D1BE-43D3-BE0C-2AAB06383B4C}"/>
          </ac:graphicFrameMkLst>
        </pc:graphicFrameChg>
        <pc:graphicFrameChg chg="add mod">
          <ac:chgData name="khoi ho" userId="c93cb340-cf97-4d7c-9739-bad0ee582323" providerId="ADAL" clId="{115D3D2B-CADC-4033-9EA0-43264417C94D}" dt="2020-12-30T06:37:48.025" v="283"/>
          <ac:graphicFrameMkLst>
            <pc:docMk/>
            <pc:sldMk cId="3112093971" sldId="420"/>
            <ac:graphicFrameMk id="12" creationId="{DEB8BDA9-980E-4560-B8CD-41FE06FDFE5E}"/>
          </ac:graphicFrameMkLst>
        </pc:graphicFrameChg>
        <pc:graphicFrameChg chg="add">
          <ac:chgData name="khoi ho" userId="c93cb340-cf97-4d7c-9739-bad0ee582323" providerId="ADAL" clId="{115D3D2B-CADC-4033-9EA0-43264417C94D}" dt="2020-12-28T06:38:00.171" v="180"/>
          <ac:graphicFrameMkLst>
            <pc:docMk/>
            <pc:sldMk cId="3112093971" sldId="420"/>
            <ac:graphicFrameMk id="14" creationId="{CBD1D145-2DAD-4212-9CA7-9159ADB77AC0}"/>
          </ac:graphicFrameMkLst>
        </pc:graphicFrameChg>
        <pc:graphicFrameChg chg="add">
          <ac:chgData name="khoi ho" userId="c93cb340-cf97-4d7c-9739-bad0ee582323" providerId="ADAL" clId="{115D3D2B-CADC-4033-9EA0-43264417C94D}" dt="2020-12-28T06:38:05.623" v="182"/>
          <ac:graphicFrameMkLst>
            <pc:docMk/>
            <pc:sldMk cId="3112093971" sldId="420"/>
            <ac:graphicFrameMk id="15" creationId="{CBD1D145-2DAD-4212-9CA7-9159ADB77AC0}"/>
          </ac:graphicFrameMkLst>
        </pc:graphicFrameChg>
        <pc:graphicFrameChg chg="del">
          <ac:chgData name="khoi ho" userId="c93cb340-cf97-4d7c-9739-bad0ee582323" providerId="ADAL" clId="{115D3D2B-CADC-4033-9EA0-43264417C94D}" dt="2020-12-28T06:30:28.520" v="126" actId="478"/>
          <ac:graphicFrameMkLst>
            <pc:docMk/>
            <pc:sldMk cId="3112093971" sldId="420"/>
            <ac:graphicFrameMk id="18" creationId="{AEA57728-B531-4970-B16A-D5CCF39506BA}"/>
          </ac:graphicFrameMkLst>
        </pc:graphicFrameChg>
        <pc:graphicFrameChg chg="del">
          <ac:chgData name="khoi ho" userId="c93cb340-cf97-4d7c-9739-bad0ee582323" providerId="ADAL" clId="{115D3D2B-CADC-4033-9EA0-43264417C94D}" dt="2020-12-28T06:30:31.853" v="127" actId="478"/>
          <ac:graphicFrameMkLst>
            <pc:docMk/>
            <pc:sldMk cId="3112093971" sldId="420"/>
            <ac:graphicFrameMk id="19" creationId="{2B7BCFE6-156D-4F81-8F56-03C8CC4716F3}"/>
          </ac:graphicFrameMkLst>
        </pc:graphicFrameChg>
      </pc:sldChg>
      <pc:sldChg chg="addSp delSp modSp add mod">
        <pc:chgData name="khoi ho" userId="c93cb340-cf97-4d7c-9739-bad0ee582323" providerId="ADAL" clId="{115D3D2B-CADC-4033-9EA0-43264417C94D}" dt="2021-01-04T03:15:09.540" v="415"/>
        <pc:sldMkLst>
          <pc:docMk/>
          <pc:sldMk cId="2214468248" sldId="421"/>
        </pc:sldMkLst>
        <pc:spChg chg="add del mod">
          <ac:chgData name="khoi ho" userId="c93cb340-cf97-4d7c-9739-bad0ee582323" providerId="ADAL" clId="{115D3D2B-CADC-4033-9EA0-43264417C94D}" dt="2021-01-04T03:09:32.375" v="389"/>
          <ac:spMkLst>
            <pc:docMk/>
            <pc:sldMk cId="2214468248" sldId="421"/>
            <ac:spMk id="8" creationId="{3E57020E-FAAA-486F-AE20-10D8EC7A5DAB}"/>
          </ac:spMkLst>
        </pc:spChg>
        <pc:spChg chg="add del mod">
          <ac:chgData name="khoi ho" userId="c93cb340-cf97-4d7c-9739-bad0ee582323" providerId="ADAL" clId="{115D3D2B-CADC-4033-9EA0-43264417C94D}" dt="2021-01-04T03:09:32.375" v="389"/>
          <ac:spMkLst>
            <pc:docMk/>
            <pc:sldMk cId="2214468248" sldId="421"/>
            <ac:spMk id="9" creationId="{003F99DD-B867-4DBB-B171-9422699B4B3A}"/>
          </ac:spMkLst>
        </pc:spChg>
        <pc:spChg chg="add del mod">
          <ac:chgData name="khoi ho" userId="c93cb340-cf97-4d7c-9739-bad0ee582323" providerId="ADAL" clId="{115D3D2B-CADC-4033-9EA0-43264417C94D}" dt="2021-01-04T03:09:32.375" v="389"/>
          <ac:spMkLst>
            <pc:docMk/>
            <pc:sldMk cId="2214468248" sldId="421"/>
            <ac:spMk id="10" creationId="{ED93B4C8-E18B-4914-9FA9-DF1A0870E68D}"/>
          </ac:spMkLst>
        </pc:spChg>
        <pc:spChg chg="mod">
          <ac:chgData name="khoi ho" userId="c93cb340-cf97-4d7c-9739-bad0ee582323" providerId="ADAL" clId="{115D3D2B-CADC-4033-9EA0-43264417C94D}" dt="2021-01-04T01:32:07.078" v="294" actId="20577"/>
          <ac:spMkLst>
            <pc:docMk/>
            <pc:sldMk cId="2214468248" sldId="421"/>
            <ac:spMk id="13" creationId="{54BD93B3-4B19-4239-AE5E-DB087DDB95F6}"/>
          </ac:spMkLst>
        </pc:spChg>
        <pc:spChg chg="add del mod">
          <ac:chgData name="khoi ho" userId="c93cb340-cf97-4d7c-9739-bad0ee582323" providerId="ADAL" clId="{115D3D2B-CADC-4033-9EA0-43264417C94D}" dt="2021-01-04T03:13:32.371" v="398"/>
          <ac:spMkLst>
            <pc:docMk/>
            <pc:sldMk cId="2214468248" sldId="421"/>
            <ac:spMk id="15" creationId="{D0D8766E-2002-4352-9EBA-C6050E1F92AD}"/>
          </ac:spMkLst>
        </pc:spChg>
        <pc:spChg chg="add del mod">
          <ac:chgData name="khoi ho" userId="c93cb340-cf97-4d7c-9739-bad0ee582323" providerId="ADAL" clId="{115D3D2B-CADC-4033-9EA0-43264417C94D}" dt="2021-01-04T03:13:32.371" v="398"/>
          <ac:spMkLst>
            <pc:docMk/>
            <pc:sldMk cId="2214468248" sldId="421"/>
            <ac:spMk id="18" creationId="{C6F8DEFE-B9FD-466C-8F68-C7B86495B4EA}"/>
          </ac:spMkLst>
        </pc:spChg>
        <pc:spChg chg="add del mod">
          <ac:chgData name="khoi ho" userId="c93cb340-cf97-4d7c-9739-bad0ee582323" providerId="ADAL" clId="{115D3D2B-CADC-4033-9EA0-43264417C94D}" dt="2021-01-04T03:13:32.371" v="398"/>
          <ac:spMkLst>
            <pc:docMk/>
            <pc:sldMk cId="2214468248" sldId="421"/>
            <ac:spMk id="19" creationId="{F5A4BB03-96A9-48C7-A954-2B836DB00A3F}"/>
          </ac:spMkLst>
        </pc:spChg>
        <pc:spChg chg="add mod">
          <ac:chgData name="khoi ho" userId="c93cb340-cf97-4d7c-9739-bad0ee582323" providerId="ADAL" clId="{115D3D2B-CADC-4033-9EA0-43264417C94D}" dt="2021-01-04T03:13:38.333" v="400" actId="1076"/>
          <ac:spMkLst>
            <pc:docMk/>
            <pc:sldMk cId="2214468248" sldId="421"/>
            <ac:spMk id="21" creationId="{30019D34-61AB-40EE-B5EB-2AF97D35BEA2}"/>
          </ac:spMkLst>
        </pc:spChg>
        <pc:spChg chg="add mod">
          <ac:chgData name="khoi ho" userId="c93cb340-cf97-4d7c-9739-bad0ee582323" providerId="ADAL" clId="{115D3D2B-CADC-4033-9EA0-43264417C94D}" dt="2021-01-04T03:13:45.612" v="401" actId="1076"/>
          <ac:spMkLst>
            <pc:docMk/>
            <pc:sldMk cId="2214468248" sldId="421"/>
            <ac:spMk id="22" creationId="{ACB4078B-4FBC-44C1-ACFA-2DD6D47B8FBB}"/>
          </ac:spMkLst>
        </pc:spChg>
        <pc:spChg chg="add mod">
          <ac:chgData name="khoi ho" userId="c93cb340-cf97-4d7c-9739-bad0ee582323" providerId="ADAL" clId="{115D3D2B-CADC-4033-9EA0-43264417C94D}" dt="2021-01-04T03:13:55.814" v="407" actId="1038"/>
          <ac:spMkLst>
            <pc:docMk/>
            <pc:sldMk cId="2214468248" sldId="421"/>
            <ac:spMk id="23" creationId="{311B96D7-87F9-46C5-818C-7AEA2ACF7F5C}"/>
          </ac:spMkLst>
        </pc:spChg>
        <pc:graphicFrameChg chg="add del mod">
          <ac:chgData name="khoi ho" userId="c93cb340-cf97-4d7c-9739-bad0ee582323" providerId="ADAL" clId="{115D3D2B-CADC-4033-9EA0-43264417C94D}" dt="2021-01-04T03:09:40.500" v="392" actId="478"/>
          <ac:graphicFrameMkLst>
            <pc:docMk/>
            <pc:sldMk cId="2214468248" sldId="421"/>
            <ac:graphicFrameMk id="6" creationId="{E497D4CC-95F7-4818-BC82-6E2DAC20414D}"/>
          </ac:graphicFrameMkLst>
        </pc:graphicFrameChg>
        <pc:graphicFrameChg chg="add del mod">
          <ac:chgData name="khoi ho" userId="c93cb340-cf97-4d7c-9739-bad0ee582323" providerId="ADAL" clId="{115D3D2B-CADC-4033-9EA0-43264417C94D}" dt="2020-12-30T07:16:13.743" v="286" actId="478"/>
          <ac:graphicFrameMkLst>
            <pc:docMk/>
            <pc:sldMk cId="2214468248" sldId="421"/>
            <ac:graphicFrameMk id="7" creationId="{CBD1D145-2DAD-4212-9CA7-9159ADB77AC0}"/>
          </ac:graphicFrameMkLst>
        </pc:graphicFrameChg>
        <pc:graphicFrameChg chg="del">
          <ac:chgData name="khoi ho" userId="c93cb340-cf97-4d7c-9739-bad0ee582323" providerId="ADAL" clId="{115D3D2B-CADC-4033-9EA0-43264417C94D}" dt="2020-12-28T06:34:12.166" v="152" actId="478"/>
          <ac:graphicFrameMkLst>
            <pc:docMk/>
            <pc:sldMk cId="2214468248" sldId="421"/>
            <ac:graphicFrameMk id="11" creationId="{4CA2742B-D1BE-43D3-BE0C-2AAB06383B4C}"/>
          </ac:graphicFrameMkLst>
        </pc:graphicFrameChg>
        <pc:graphicFrameChg chg="add del mod">
          <ac:chgData name="khoi ho" userId="c93cb340-cf97-4d7c-9739-bad0ee582323" providerId="ADAL" clId="{115D3D2B-CADC-4033-9EA0-43264417C94D}" dt="2021-01-04T03:07:53.894" v="378" actId="478"/>
          <ac:graphicFrameMkLst>
            <pc:docMk/>
            <pc:sldMk cId="2214468248" sldId="421"/>
            <ac:graphicFrameMk id="11" creationId="{CBD1D145-2DAD-4212-9CA7-9159ADB77AC0}"/>
          </ac:graphicFrameMkLst>
        </pc:graphicFrameChg>
        <pc:graphicFrameChg chg="del">
          <ac:chgData name="khoi ho" userId="c93cb340-cf97-4d7c-9739-bad0ee582323" providerId="ADAL" clId="{115D3D2B-CADC-4033-9EA0-43264417C94D}" dt="2020-12-28T06:34:15.153" v="153" actId="478"/>
          <ac:graphicFrameMkLst>
            <pc:docMk/>
            <pc:sldMk cId="2214468248" sldId="421"/>
            <ac:graphicFrameMk id="12" creationId="{DEB8BDA9-980E-4560-B8CD-41FE06FDFE5E}"/>
          </ac:graphicFrameMkLst>
        </pc:graphicFrameChg>
        <pc:graphicFrameChg chg="add del mod">
          <ac:chgData name="khoi ho" userId="c93cb340-cf97-4d7c-9739-bad0ee582323" providerId="ADAL" clId="{115D3D2B-CADC-4033-9EA0-43264417C94D}" dt="2021-01-04T03:08:45.683" v="383" actId="478"/>
          <ac:graphicFrameMkLst>
            <pc:docMk/>
            <pc:sldMk cId="2214468248" sldId="421"/>
            <ac:graphicFrameMk id="12" creationId="{F9088379-4F22-43E2-A09A-8C1EC99C5BAE}"/>
          </ac:graphicFrameMkLst>
        </pc:graphicFrameChg>
        <pc:graphicFrameChg chg="add mod">
          <ac:chgData name="khoi ho" userId="c93cb340-cf97-4d7c-9739-bad0ee582323" providerId="ADAL" clId="{115D3D2B-CADC-4033-9EA0-43264417C94D}" dt="2021-01-04T03:15:09.540" v="415"/>
          <ac:graphicFrameMkLst>
            <pc:docMk/>
            <pc:sldMk cId="2214468248" sldId="421"/>
            <ac:graphicFrameMk id="14" creationId="{F9088379-4F22-43E2-A09A-8C1EC99C5BAE}"/>
          </ac:graphicFrameMkLst>
        </pc:graphicFrameChg>
        <pc:graphicFrameChg chg="add mod">
          <ac:chgData name="khoi ho" userId="c93cb340-cf97-4d7c-9739-bad0ee582323" providerId="ADAL" clId="{115D3D2B-CADC-4033-9EA0-43264417C94D}" dt="2021-01-04T03:14:57.036" v="413" actId="114"/>
          <ac:graphicFrameMkLst>
            <pc:docMk/>
            <pc:sldMk cId="2214468248" sldId="421"/>
            <ac:graphicFrameMk id="20" creationId="{FD377D17-8960-43C1-AE97-E7AC49DC5824}"/>
          </ac:graphicFrameMkLst>
        </pc:graphicFrameChg>
      </pc:sldChg>
      <pc:sldChg chg="addSp delSp modSp add mod">
        <pc:chgData name="khoi ho" userId="c93cb340-cf97-4d7c-9739-bad0ee582323" providerId="ADAL" clId="{115D3D2B-CADC-4033-9EA0-43264417C94D}" dt="2020-12-28T06:52:47.971" v="241" actId="1038"/>
        <pc:sldMkLst>
          <pc:docMk/>
          <pc:sldMk cId="1704004096" sldId="422"/>
        </pc:sldMkLst>
        <pc:spChg chg="add del mod">
          <ac:chgData name="khoi ho" userId="c93cb340-cf97-4d7c-9739-bad0ee582323" providerId="ADAL" clId="{115D3D2B-CADC-4033-9EA0-43264417C94D}" dt="2020-12-28T06:50:22.074" v="222"/>
          <ac:spMkLst>
            <pc:docMk/>
            <pc:sldMk cId="1704004096" sldId="422"/>
            <ac:spMk id="8" creationId="{A37A8CE5-963C-4FAB-B6F4-469DF06C55D6}"/>
          </ac:spMkLst>
        </pc:spChg>
        <pc:spChg chg="add del mod">
          <ac:chgData name="khoi ho" userId="c93cb340-cf97-4d7c-9739-bad0ee582323" providerId="ADAL" clId="{115D3D2B-CADC-4033-9EA0-43264417C94D}" dt="2020-12-28T06:50:22.074" v="222"/>
          <ac:spMkLst>
            <pc:docMk/>
            <pc:sldMk cId="1704004096" sldId="422"/>
            <ac:spMk id="9" creationId="{4173517E-3984-482A-A56E-859A66537AD5}"/>
          </ac:spMkLst>
        </pc:spChg>
        <pc:spChg chg="add del mod">
          <ac:chgData name="khoi ho" userId="c93cb340-cf97-4d7c-9739-bad0ee582323" providerId="ADAL" clId="{115D3D2B-CADC-4033-9EA0-43264417C94D}" dt="2020-12-28T06:50:22.074" v="222"/>
          <ac:spMkLst>
            <pc:docMk/>
            <pc:sldMk cId="1704004096" sldId="422"/>
            <ac:spMk id="10" creationId="{7F0725F5-4685-498D-A324-BD4E5BB7975A}"/>
          </ac:spMkLst>
        </pc:spChg>
        <pc:spChg chg="add del mod">
          <ac:chgData name="khoi ho" userId="c93cb340-cf97-4d7c-9739-bad0ee582323" providerId="ADAL" clId="{115D3D2B-CADC-4033-9EA0-43264417C94D}" dt="2020-12-28T06:50:22.074" v="222"/>
          <ac:spMkLst>
            <pc:docMk/>
            <pc:sldMk cId="1704004096" sldId="422"/>
            <ac:spMk id="11" creationId="{CAE496FC-EB75-4D30-892C-C2F7A8754430}"/>
          </ac:spMkLst>
        </pc:spChg>
        <pc:spChg chg="add">
          <ac:chgData name="khoi ho" userId="c93cb340-cf97-4d7c-9739-bad0ee582323" providerId="ADAL" clId="{115D3D2B-CADC-4033-9EA0-43264417C94D}" dt="2020-12-28T06:50:22.994" v="223"/>
          <ac:spMkLst>
            <pc:docMk/>
            <pc:sldMk cId="1704004096" sldId="422"/>
            <ac:spMk id="14" creationId="{CB7CD8D1-3169-42A1-97DF-AE4CF0C4C58D}"/>
          </ac:spMkLst>
        </pc:spChg>
        <pc:spChg chg="add">
          <ac:chgData name="khoi ho" userId="c93cb340-cf97-4d7c-9739-bad0ee582323" providerId="ADAL" clId="{115D3D2B-CADC-4033-9EA0-43264417C94D}" dt="2020-12-28T06:50:22.994" v="223"/>
          <ac:spMkLst>
            <pc:docMk/>
            <pc:sldMk cId="1704004096" sldId="422"/>
            <ac:spMk id="15" creationId="{93E865F8-92EE-40DA-89D0-11BB2D69CC7A}"/>
          </ac:spMkLst>
        </pc:spChg>
        <pc:spChg chg="add">
          <ac:chgData name="khoi ho" userId="c93cb340-cf97-4d7c-9739-bad0ee582323" providerId="ADAL" clId="{115D3D2B-CADC-4033-9EA0-43264417C94D}" dt="2020-12-28T06:50:22.994" v="223"/>
          <ac:spMkLst>
            <pc:docMk/>
            <pc:sldMk cId="1704004096" sldId="422"/>
            <ac:spMk id="18" creationId="{142411E9-6332-41FD-B9DD-85B8E64BD45F}"/>
          </ac:spMkLst>
        </pc:spChg>
        <pc:spChg chg="add">
          <ac:chgData name="khoi ho" userId="c93cb340-cf97-4d7c-9739-bad0ee582323" providerId="ADAL" clId="{115D3D2B-CADC-4033-9EA0-43264417C94D}" dt="2020-12-28T06:50:22.994" v="223"/>
          <ac:spMkLst>
            <pc:docMk/>
            <pc:sldMk cId="1704004096" sldId="422"/>
            <ac:spMk id="19" creationId="{D27A4561-5C7D-403A-B1E4-DE619FF5981F}"/>
          </ac:spMkLst>
        </pc:spChg>
        <pc:spChg chg="add mod">
          <ac:chgData name="khoi ho" userId="c93cb340-cf97-4d7c-9739-bad0ee582323" providerId="ADAL" clId="{115D3D2B-CADC-4033-9EA0-43264417C94D}" dt="2020-12-28T06:52:47.971" v="241" actId="1038"/>
          <ac:spMkLst>
            <pc:docMk/>
            <pc:sldMk cId="1704004096" sldId="422"/>
            <ac:spMk id="21" creationId="{8582D21F-9D97-4292-BA6F-731979E686AB}"/>
          </ac:spMkLst>
        </pc:spChg>
        <pc:graphicFrameChg chg="add del mod">
          <ac:chgData name="khoi ho" userId="c93cb340-cf97-4d7c-9739-bad0ee582323" providerId="ADAL" clId="{115D3D2B-CADC-4033-9EA0-43264417C94D}" dt="2020-12-28T06:49:45.680" v="213" actId="478"/>
          <ac:graphicFrameMkLst>
            <pc:docMk/>
            <pc:sldMk cId="1704004096" sldId="422"/>
            <ac:graphicFrameMk id="6" creationId="{7C1B1335-C356-471E-B138-4AFBFA3D97BF}"/>
          </ac:graphicFrameMkLst>
        </pc:graphicFrameChg>
        <pc:graphicFrameChg chg="del">
          <ac:chgData name="khoi ho" userId="c93cb340-cf97-4d7c-9739-bad0ee582323" providerId="ADAL" clId="{115D3D2B-CADC-4033-9EA0-43264417C94D}" dt="2020-12-28T06:38:16.762" v="184" actId="478"/>
          <ac:graphicFrameMkLst>
            <pc:docMk/>
            <pc:sldMk cId="1704004096" sldId="422"/>
            <ac:graphicFrameMk id="7" creationId="{CBD1D145-2DAD-4212-9CA7-9159ADB77AC0}"/>
          </ac:graphicFrameMkLst>
        </pc:graphicFrameChg>
        <pc:graphicFrameChg chg="add mod">
          <ac:chgData name="khoi ho" userId="c93cb340-cf97-4d7c-9739-bad0ee582323" providerId="ADAL" clId="{115D3D2B-CADC-4033-9EA0-43264417C94D}" dt="2020-12-28T06:50:32.202" v="225" actId="1076"/>
          <ac:graphicFrameMkLst>
            <pc:docMk/>
            <pc:sldMk cId="1704004096" sldId="422"/>
            <ac:graphicFrameMk id="12" creationId="{CE676D09-8E85-48AE-9D62-DFD3B59AAC59}"/>
          </ac:graphicFrameMkLst>
        </pc:graphicFrameChg>
        <pc:graphicFrameChg chg="add mod">
          <ac:chgData name="khoi ho" userId="c93cb340-cf97-4d7c-9739-bad0ee582323" providerId="ADAL" clId="{115D3D2B-CADC-4033-9EA0-43264417C94D}" dt="2020-12-28T06:51:41.843" v="232"/>
          <ac:graphicFrameMkLst>
            <pc:docMk/>
            <pc:sldMk cId="1704004096" sldId="422"/>
            <ac:graphicFrameMk id="20" creationId="{7E9D11D7-AA0E-4633-980F-9F0F3AF97FEF}"/>
          </ac:graphicFrameMkLst>
        </pc:graphicFrameChg>
      </pc:sldChg>
      <pc:sldChg chg="addSp delSp modSp add mod">
        <pc:chgData name="khoi ho" userId="c93cb340-cf97-4d7c-9739-bad0ee582323" providerId="ADAL" clId="{115D3D2B-CADC-4033-9EA0-43264417C94D}" dt="2021-01-04T01:43:52.287" v="377" actId="1076"/>
        <pc:sldMkLst>
          <pc:docMk/>
          <pc:sldMk cId="3819202865" sldId="423"/>
        </pc:sldMkLst>
        <pc:spChg chg="del mod">
          <ac:chgData name="khoi ho" userId="c93cb340-cf97-4d7c-9739-bad0ee582323" providerId="ADAL" clId="{115D3D2B-CADC-4033-9EA0-43264417C94D}" dt="2021-01-04T01:36:03.586" v="312"/>
          <ac:spMkLst>
            <pc:docMk/>
            <pc:sldMk cId="3819202865" sldId="423"/>
            <ac:spMk id="8" creationId="{3E57020E-FAAA-486F-AE20-10D8EC7A5DAB}"/>
          </ac:spMkLst>
        </pc:spChg>
        <pc:spChg chg="del mod">
          <ac:chgData name="khoi ho" userId="c93cb340-cf97-4d7c-9739-bad0ee582323" providerId="ADAL" clId="{115D3D2B-CADC-4033-9EA0-43264417C94D}" dt="2021-01-04T01:36:03.586" v="312"/>
          <ac:spMkLst>
            <pc:docMk/>
            <pc:sldMk cId="3819202865" sldId="423"/>
            <ac:spMk id="9" creationId="{003F99DD-B867-4DBB-B171-9422699B4B3A}"/>
          </ac:spMkLst>
        </pc:spChg>
        <pc:spChg chg="del mod">
          <ac:chgData name="khoi ho" userId="c93cb340-cf97-4d7c-9739-bad0ee582323" providerId="ADAL" clId="{115D3D2B-CADC-4033-9EA0-43264417C94D}" dt="2021-01-04T01:36:03.586" v="312"/>
          <ac:spMkLst>
            <pc:docMk/>
            <pc:sldMk cId="3819202865" sldId="423"/>
            <ac:spMk id="10" creationId="{ED93B4C8-E18B-4914-9FA9-DF1A0870E68D}"/>
          </ac:spMkLst>
        </pc:spChg>
        <pc:spChg chg="mod">
          <ac:chgData name="khoi ho" userId="c93cb340-cf97-4d7c-9739-bad0ee582323" providerId="ADAL" clId="{115D3D2B-CADC-4033-9EA0-43264417C94D}" dt="2021-01-04T01:32:19.148" v="297" actId="20577"/>
          <ac:spMkLst>
            <pc:docMk/>
            <pc:sldMk cId="3819202865" sldId="423"/>
            <ac:spMk id="13" creationId="{54BD93B3-4B19-4239-AE5E-DB087DDB95F6}"/>
          </ac:spMkLst>
        </pc:spChg>
        <pc:spChg chg="add del mod">
          <ac:chgData name="khoi ho" userId="c93cb340-cf97-4d7c-9739-bad0ee582323" providerId="ADAL" clId="{115D3D2B-CADC-4033-9EA0-43264417C94D}" dt="2021-01-04T01:41:25.696" v="337"/>
          <ac:spMkLst>
            <pc:docMk/>
            <pc:sldMk cId="3819202865" sldId="423"/>
            <ac:spMk id="15" creationId="{A04641D2-8535-4DD5-A1E9-58E2E21AE27F}"/>
          </ac:spMkLst>
        </pc:spChg>
        <pc:spChg chg="add del mod">
          <ac:chgData name="khoi ho" userId="c93cb340-cf97-4d7c-9739-bad0ee582323" providerId="ADAL" clId="{115D3D2B-CADC-4033-9EA0-43264417C94D}" dt="2021-01-04T01:41:25.696" v="337"/>
          <ac:spMkLst>
            <pc:docMk/>
            <pc:sldMk cId="3819202865" sldId="423"/>
            <ac:spMk id="18" creationId="{7C58C4E9-52FC-48D5-89C9-B81BFD1A4413}"/>
          </ac:spMkLst>
        </pc:spChg>
        <pc:spChg chg="add del mod">
          <ac:chgData name="khoi ho" userId="c93cb340-cf97-4d7c-9739-bad0ee582323" providerId="ADAL" clId="{115D3D2B-CADC-4033-9EA0-43264417C94D}" dt="2021-01-04T01:41:25.696" v="337"/>
          <ac:spMkLst>
            <pc:docMk/>
            <pc:sldMk cId="3819202865" sldId="423"/>
            <ac:spMk id="19" creationId="{210AB810-AB95-4B3C-990A-AE0E7EE24D18}"/>
          </ac:spMkLst>
        </pc:spChg>
        <pc:spChg chg="add del mod">
          <ac:chgData name="khoi ho" userId="c93cb340-cf97-4d7c-9739-bad0ee582323" providerId="ADAL" clId="{115D3D2B-CADC-4033-9EA0-43264417C94D}" dt="2021-01-04T01:41:25.696" v="337"/>
          <ac:spMkLst>
            <pc:docMk/>
            <pc:sldMk cId="3819202865" sldId="423"/>
            <ac:spMk id="20" creationId="{C1CB5B8A-D006-4D69-A38E-9C03195F5B86}"/>
          </ac:spMkLst>
        </pc:spChg>
        <pc:spChg chg="add del mod">
          <ac:chgData name="khoi ho" userId="c93cb340-cf97-4d7c-9739-bad0ee582323" providerId="ADAL" clId="{115D3D2B-CADC-4033-9EA0-43264417C94D}" dt="2021-01-04T01:42:12.523" v="345"/>
          <ac:spMkLst>
            <pc:docMk/>
            <pc:sldMk cId="3819202865" sldId="423"/>
            <ac:spMk id="22" creationId="{FBCA3481-8743-46DA-8FC8-A2F53AB5F45A}"/>
          </ac:spMkLst>
        </pc:spChg>
        <pc:spChg chg="add del mod">
          <ac:chgData name="khoi ho" userId="c93cb340-cf97-4d7c-9739-bad0ee582323" providerId="ADAL" clId="{115D3D2B-CADC-4033-9EA0-43264417C94D}" dt="2021-01-04T01:42:12.523" v="345"/>
          <ac:spMkLst>
            <pc:docMk/>
            <pc:sldMk cId="3819202865" sldId="423"/>
            <ac:spMk id="23" creationId="{71C7186C-DF91-4646-914D-D8DE523DA4BF}"/>
          </ac:spMkLst>
        </pc:spChg>
        <pc:spChg chg="add del mod">
          <ac:chgData name="khoi ho" userId="c93cb340-cf97-4d7c-9739-bad0ee582323" providerId="ADAL" clId="{115D3D2B-CADC-4033-9EA0-43264417C94D}" dt="2021-01-04T01:42:12.523" v="345"/>
          <ac:spMkLst>
            <pc:docMk/>
            <pc:sldMk cId="3819202865" sldId="423"/>
            <ac:spMk id="24" creationId="{A28C0FBE-7AA4-452F-BD7C-EEEAD324B074}"/>
          </ac:spMkLst>
        </pc:spChg>
        <pc:spChg chg="add del mod">
          <ac:chgData name="khoi ho" userId="c93cb340-cf97-4d7c-9739-bad0ee582323" providerId="ADAL" clId="{115D3D2B-CADC-4033-9EA0-43264417C94D}" dt="2021-01-04T01:42:12.523" v="345"/>
          <ac:spMkLst>
            <pc:docMk/>
            <pc:sldMk cId="3819202865" sldId="423"/>
            <ac:spMk id="25" creationId="{C99B928D-4C64-42F6-B858-20D1088BEDD0}"/>
          </ac:spMkLst>
        </pc:spChg>
        <pc:spChg chg="add mod">
          <ac:chgData name="khoi ho" userId="c93cb340-cf97-4d7c-9739-bad0ee582323" providerId="ADAL" clId="{115D3D2B-CADC-4033-9EA0-43264417C94D}" dt="2021-01-04T01:43:42.119" v="376" actId="1076"/>
          <ac:spMkLst>
            <pc:docMk/>
            <pc:sldMk cId="3819202865" sldId="423"/>
            <ac:spMk id="27" creationId="{9C96371A-BC89-4060-810B-3ED21D117093}"/>
          </ac:spMkLst>
        </pc:spChg>
        <pc:spChg chg="add mod">
          <ac:chgData name="khoi ho" userId="c93cb340-cf97-4d7c-9739-bad0ee582323" providerId="ADAL" clId="{115D3D2B-CADC-4033-9EA0-43264417C94D}" dt="2021-01-04T01:43:42.119" v="376" actId="1076"/>
          <ac:spMkLst>
            <pc:docMk/>
            <pc:sldMk cId="3819202865" sldId="423"/>
            <ac:spMk id="28" creationId="{A3A491D2-3375-4DE2-A5F9-662B87077DF4}"/>
          </ac:spMkLst>
        </pc:spChg>
        <pc:spChg chg="add mod">
          <ac:chgData name="khoi ho" userId="c93cb340-cf97-4d7c-9739-bad0ee582323" providerId="ADAL" clId="{115D3D2B-CADC-4033-9EA0-43264417C94D}" dt="2021-01-04T01:43:42.119" v="376" actId="1076"/>
          <ac:spMkLst>
            <pc:docMk/>
            <pc:sldMk cId="3819202865" sldId="423"/>
            <ac:spMk id="29" creationId="{DB7D28CA-BD86-4139-91FB-F0E46281E1BC}"/>
          </ac:spMkLst>
        </pc:spChg>
        <pc:spChg chg="add mod">
          <ac:chgData name="khoi ho" userId="c93cb340-cf97-4d7c-9739-bad0ee582323" providerId="ADAL" clId="{115D3D2B-CADC-4033-9EA0-43264417C94D}" dt="2021-01-04T01:43:42.119" v="376" actId="1076"/>
          <ac:spMkLst>
            <pc:docMk/>
            <pc:sldMk cId="3819202865" sldId="423"/>
            <ac:spMk id="30" creationId="{252C9DFB-91B1-47A1-BA35-F66DC1ADC222}"/>
          </ac:spMkLst>
        </pc:spChg>
        <pc:graphicFrameChg chg="del">
          <ac:chgData name="khoi ho" userId="c93cb340-cf97-4d7c-9739-bad0ee582323" providerId="ADAL" clId="{115D3D2B-CADC-4033-9EA0-43264417C94D}" dt="2021-01-04T01:32:25.110" v="299" actId="478"/>
          <ac:graphicFrameMkLst>
            <pc:docMk/>
            <pc:sldMk cId="3819202865" sldId="423"/>
            <ac:graphicFrameMk id="6" creationId="{E497D4CC-95F7-4818-BC82-6E2DAC20414D}"/>
          </ac:graphicFrameMkLst>
        </pc:graphicFrameChg>
        <pc:graphicFrameChg chg="del">
          <ac:chgData name="khoi ho" userId="c93cb340-cf97-4d7c-9739-bad0ee582323" providerId="ADAL" clId="{115D3D2B-CADC-4033-9EA0-43264417C94D}" dt="2021-01-04T01:32:23.450" v="298" actId="478"/>
          <ac:graphicFrameMkLst>
            <pc:docMk/>
            <pc:sldMk cId="3819202865" sldId="423"/>
            <ac:graphicFrameMk id="11" creationId="{CBD1D145-2DAD-4212-9CA7-9159ADB77AC0}"/>
          </ac:graphicFrameMkLst>
        </pc:graphicFrameChg>
        <pc:graphicFrameChg chg="add del mod">
          <ac:chgData name="khoi ho" userId="c93cb340-cf97-4d7c-9739-bad0ee582323" providerId="ADAL" clId="{115D3D2B-CADC-4033-9EA0-43264417C94D}" dt="2021-01-04T01:40:48.916" v="330" actId="478"/>
          <ac:graphicFrameMkLst>
            <pc:docMk/>
            <pc:sldMk cId="3819202865" sldId="423"/>
            <ac:graphicFrameMk id="12" creationId="{4CA2742B-D1BE-43D3-BE0C-2AAB06383B4C}"/>
          </ac:graphicFrameMkLst>
        </pc:graphicFrameChg>
        <pc:graphicFrameChg chg="add del mod">
          <ac:chgData name="khoi ho" userId="c93cb340-cf97-4d7c-9739-bad0ee582323" providerId="ADAL" clId="{115D3D2B-CADC-4033-9EA0-43264417C94D}" dt="2021-01-04T01:41:20.071" v="335" actId="478"/>
          <ac:graphicFrameMkLst>
            <pc:docMk/>
            <pc:sldMk cId="3819202865" sldId="423"/>
            <ac:graphicFrameMk id="14" creationId="{DEB8BDA9-980E-4560-B8CD-41FE06FDFE5E}"/>
          </ac:graphicFrameMkLst>
        </pc:graphicFrameChg>
        <pc:graphicFrameChg chg="add mod">
          <ac:chgData name="khoi ho" userId="c93cb340-cf97-4d7c-9739-bad0ee582323" providerId="ADAL" clId="{115D3D2B-CADC-4033-9EA0-43264417C94D}" dt="2021-01-04T01:43:52.287" v="377" actId="1076"/>
          <ac:graphicFrameMkLst>
            <pc:docMk/>
            <pc:sldMk cId="3819202865" sldId="423"/>
            <ac:graphicFrameMk id="21" creationId="{4CA2742B-D1BE-43D3-BE0C-2AAB06383B4C}"/>
          </ac:graphicFrameMkLst>
        </pc:graphicFrameChg>
        <pc:graphicFrameChg chg="add mod">
          <ac:chgData name="khoi ho" userId="c93cb340-cf97-4d7c-9739-bad0ee582323" providerId="ADAL" clId="{115D3D2B-CADC-4033-9EA0-43264417C94D}" dt="2021-01-04T01:43:42.119" v="376" actId="1076"/>
          <ac:graphicFrameMkLst>
            <pc:docMk/>
            <pc:sldMk cId="3819202865" sldId="423"/>
            <ac:graphicFrameMk id="26" creationId="{DEB8BDA9-980E-4560-B8CD-41FE06FDFE5E}"/>
          </ac:graphicFrameMkLst>
        </pc:graphicFrameChg>
      </pc:sldChg>
    </pc:docChg>
  </pc:docChgLst>
  <pc:docChgLst>
    <pc:chgData name="khoi ho" userId="c93cb340-cf97-4d7c-9739-bad0ee582323" providerId="ADAL" clId="{940724E5-968E-4500-B1F2-80343A1338E5}"/>
    <pc:docChg chg="delSld">
      <pc:chgData name="khoi ho" userId="c93cb340-cf97-4d7c-9739-bad0ee582323" providerId="ADAL" clId="{940724E5-968E-4500-B1F2-80343A1338E5}" dt="2021-01-04T07:57:22.770" v="1" actId="2696"/>
      <pc:docMkLst>
        <pc:docMk/>
      </pc:docMkLst>
      <pc:sldChg chg="del">
        <pc:chgData name="khoi ho" userId="c93cb340-cf97-4d7c-9739-bad0ee582323" providerId="ADAL" clId="{940724E5-968E-4500-B1F2-80343A1338E5}" dt="2021-01-04T07:57:22.733" v="0" actId="2696"/>
        <pc:sldMkLst>
          <pc:docMk/>
          <pc:sldMk cId="3377966589" sldId="401"/>
        </pc:sldMkLst>
      </pc:sldChg>
      <pc:sldChg chg="del">
        <pc:chgData name="khoi ho" userId="c93cb340-cf97-4d7c-9739-bad0ee582323" providerId="ADAL" clId="{940724E5-968E-4500-B1F2-80343A1338E5}" dt="2021-01-04T07:57:22.770" v="1" actId="2696"/>
        <pc:sldMkLst>
          <pc:docMk/>
          <pc:sldMk cId="2296911850" sldId="424"/>
        </pc:sldMkLst>
      </pc:sldChg>
    </pc:docChg>
  </pc:docChgLst>
  <pc:docChgLst>
    <pc:chgData name="khoi ho" userId="c93cb340-cf97-4d7c-9739-bad0ee582323" providerId="ADAL" clId="{BB4B82C4-0319-4F0B-A380-48D8471EDD56}"/>
    <pc:docChg chg="addSld delSld modSld">
      <pc:chgData name="khoi ho" userId="c93cb340-cf97-4d7c-9739-bad0ee582323" providerId="ADAL" clId="{BB4B82C4-0319-4F0B-A380-48D8471EDD56}" dt="2021-03-24T07:39:43.181" v="1" actId="47"/>
      <pc:docMkLst>
        <pc:docMk/>
      </pc:docMkLst>
      <pc:sldChg chg="del">
        <pc:chgData name="khoi ho" userId="c93cb340-cf97-4d7c-9739-bad0ee582323" providerId="ADAL" clId="{BB4B82C4-0319-4F0B-A380-48D8471EDD56}" dt="2021-03-24T07:39:43.181" v="1" actId="47"/>
        <pc:sldMkLst>
          <pc:docMk/>
          <pc:sldMk cId="2126262705" sldId="425"/>
        </pc:sldMkLst>
      </pc:sldChg>
      <pc:sldChg chg="add">
        <pc:chgData name="khoi ho" userId="c93cb340-cf97-4d7c-9739-bad0ee582323" providerId="ADAL" clId="{BB4B82C4-0319-4F0B-A380-48D8471EDD56}" dt="2021-03-24T07:39:34.998" v="0"/>
        <pc:sldMkLst>
          <pc:docMk/>
          <pc:sldMk cId="492678732" sldId="426"/>
        </pc:sldMkLst>
      </pc:sldChg>
    </pc:docChg>
  </pc:docChgLst>
  <pc:docChgLst>
    <pc:chgData name="khoi ho" userId="c93cb340-cf97-4d7c-9739-bad0ee582323" providerId="ADAL" clId="{A0D29F26-53B9-45CA-9615-1C3502F4732D}"/>
    <pc:docChg chg="custSel addSld delSld modSld">
      <pc:chgData name="khoi ho" userId="c93cb340-cf97-4d7c-9739-bad0ee582323" providerId="ADAL" clId="{A0D29F26-53B9-45CA-9615-1C3502F4732D}" dt="2021-01-04T07:55:57.445" v="79" actId="478"/>
      <pc:docMkLst>
        <pc:docMk/>
      </pc:docMkLst>
      <pc:sldChg chg="del">
        <pc:chgData name="khoi ho" userId="c93cb340-cf97-4d7c-9739-bad0ee582323" providerId="ADAL" clId="{A0D29F26-53B9-45CA-9615-1C3502F4732D}" dt="2021-01-04T07:26:58.316" v="1" actId="2696"/>
        <pc:sldMkLst>
          <pc:docMk/>
          <pc:sldMk cId="3007145726" sldId="395"/>
        </pc:sldMkLst>
      </pc:sldChg>
      <pc:sldChg chg="add">
        <pc:chgData name="khoi ho" userId="c93cb340-cf97-4d7c-9739-bad0ee582323" providerId="ADAL" clId="{A0D29F26-53B9-45CA-9615-1C3502F4732D}" dt="2021-01-04T07:26:53.857" v="0"/>
        <pc:sldMkLst>
          <pc:docMk/>
          <pc:sldMk cId="3377966589" sldId="401"/>
        </pc:sldMkLst>
      </pc:sldChg>
      <pc:sldChg chg="del">
        <pc:chgData name="khoi ho" userId="c93cb340-cf97-4d7c-9739-bad0ee582323" providerId="ADAL" clId="{A0D29F26-53B9-45CA-9615-1C3502F4732D}" dt="2021-01-04T07:41:06.310" v="55" actId="2696"/>
        <pc:sldMkLst>
          <pc:docMk/>
          <pc:sldMk cId="1764524680" sldId="402"/>
        </pc:sldMkLst>
      </pc:sldChg>
      <pc:sldChg chg="del">
        <pc:chgData name="khoi ho" userId="c93cb340-cf97-4d7c-9739-bad0ee582323" providerId="ADAL" clId="{A0D29F26-53B9-45CA-9615-1C3502F4732D}" dt="2021-01-04T07:41:06.357" v="56" actId="2696"/>
        <pc:sldMkLst>
          <pc:docMk/>
          <pc:sldMk cId="3112093971" sldId="420"/>
        </pc:sldMkLst>
      </pc:sldChg>
      <pc:sldChg chg="del">
        <pc:chgData name="khoi ho" userId="c93cb340-cf97-4d7c-9739-bad0ee582323" providerId="ADAL" clId="{A0D29F26-53B9-45CA-9615-1C3502F4732D}" dt="2021-01-04T07:41:06.426" v="58" actId="2696"/>
        <pc:sldMkLst>
          <pc:docMk/>
          <pc:sldMk cId="2214468248" sldId="421"/>
        </pc:sldMkLst>
      </pc:sldChg>
      <pc:sldChg chg="del">
        <pc:chgData name="khoi ho" userId="c93cb340-cf97-4d7c-9739-bad0ee582323" providerId="ADAL" clId="{A0D29F26-53B9-45CA-9615-1C3502F4732D}" dt="2021-01-04T07:41:06.389" v="57" actId="2696"/>
        <pc:sldMkLst>
          <pc:docMk/>
          <pc:sldMk cId="1704004096" sldId="422"/>
        </pc:sldMkLst>
      </pc:sldChg>
      <pc:sldChg chg="del">
        <pc:chgData name="khoi ho" userId="c93cb340-cf97-4d7c-9739-bad0ee582323" providerId="ADAL" clId="{A0D29F26-53B9-45CA-9615-1C3502F4732D}" dt="2021-01-04T07:41:06.447" v="59" actId="2696"/>
        <pc:sldMkLst>
          <pc:docMk/>
          <pc:sldMk cId="3819202865" sldId="423"/>
        </pc:sldMkLst>
      </pc:sldChg>
      <pc:sldChg chg="addSp delSp modSp add mod">
        <pc:chgData name="khoi ho" userId="c93cb340-cf97-4d7c-9739-bad0ee582323" providerId="ADAL" clId="{A0D29F26-53B9-45CA-9615-1C3502F4732D}" dt="2021-01-04T07:55:57.445" v="79" actId="478"/>
        <pc:sldMkLst>
          <pc:docMk/>
          <pc:sldMk cId="2296911850" sldId="424"/>
        </pc:sldMkLst>
        <pc:spChg chg="mod">
          <ac:chgData name="khoi ho" userId="c93cb340-cf97-4d7c-9739-bad0ee582323" providerId="ADAL" clId="{A0D29F26-53B9-45CA-9615-1C3502F4732D}" dt="2021-01-04T07:36:07.265" v="17" actId="1076"/>
          <ac:spMkLst>
            <pc:docMk/>
            <pc:sldMk cId="2296911850" sldId="424"/>
            <ac:spMk id="27" creationId="{2BA3AA9C-88F0-4980-8077-083B26B4A490}"/>
          </ac:spMkLst>
        </pc:spChg>
        <pc:spChg chg="mod">
          <ac:chgData name="khoi ho" userId="c93cb340-cf97-4d7c-9739-bad0ee582323" providerId="ADAL" clId="{A0D29F26-53B9-45CA-9615-1C3502F4732D}" dt="2021-01-04T07:36:07.265" v="17" actId="1076"/>
          <ac:spMkLst>
            <pc:docMk/>
            <pc:sldMk cId="2296911850" sldId="424"/>
            <ac:spMk id="28" creationId="{296C9DBE-F180-4CD6-979C-26BC676D8362}"/>
          </ac:spMkLst>
        </pc:spChg>
        <pc:spChg chg="mod">
          <ac:chgData name="khoi ho" userId="c93cb340-cf97-4d7c-9739-bad0ee582323" providerId="ADAL" clId="{A0D29F26-53B9-45CA-9615-1C3502F4732D}" dt="2021-01-04T07:40:19.506" v="48" actId="465"/>
          <ac:spMkLst>
            <pc:docMk/>
            <pc:sldMk cId="2296911850" sldId="424"/>
            <ac:spMk id="33" creationId="{F1720C31-19DF-479D-9B5A-675F3BD35DD1}"/>
          </ac:spMkLst>
        </pc:spChg>
        <pc:spChg chg="mod">
          <ac:chgData name="khoi ho" userId="c93cb340-cf97-4d7c-9739-bad0ee582323" providerId="ADAL" clId="{A0D29F26-53B9-45CA-9615-1C3502F4732D}" dt="2021-01-04T07:40:28.784" v="50" actId="465"/>
          <ac:spMkLst>
            <pc:docMk/>
            <pc:sldMk cId="2296911850" sldId="424"/>
            <ac:spMk id="34" creationId="{49305999-9936-454E-9DB5-DB630FD9EED3}"/>
          </ac:spMkLst>
        </pc:spChg>
        <pc:spChg chg="del">
          <ac:chgData name="khoi ho" userId="c93cb340-cf97-4d7c-9739-bad0ee582323" providerId="ADAL" clId="{A0D29F26-53B9-45CA-9615-1C3502F4732D}" dt="2021-01-04T07:30:19.951" v="3" actId="478"/>
          <ac:spMkLst>
            <pc:docMk/>
            <pc:sldMk cId="2296911850" sldId="424"/>
            <ac:spMk id="36" creationId="{2FABEA10-76B0-4F46-BF0A-9119430B3D3E}"/>
          </ac:spMkLst>
        </pc:spChg>
        <pc:spChg chg="mod">
          <ac:chgData name="khoi ho" userId="c93cb340-cf97-4d7c-9739-bad0ee582323" providerId="ADAL" clId="{A0D29F26-53B9-45CA-9615-1C3502F4732D}" dt="2021-01-04T07:40:45.477" v="52" actId="465"/>
          <ac:spMkLst>
            <pc:docMk/>
            <pc:sldMk cId="2296911850" sldId="424"/>
            <ac:spMk id="37" creationId="{62C7C64A-D3EB-41F0-A05D-0E30EBA6EAC2}"/>
          </ac:spMkLst>
        </pc:spChg>
        <pc:spChg chg="mod">
          <ac:chgData name="khoi ho" userId="c93cb340-cf97-4d7c-9739-bad0ee582323" providerId="ADAL" clId="{A0D29F26-53B9-45CA-9615-1C3502F4732D}" dt="2021-01-04T07:40:37.670" v="51" actId="465"/>
          <ac:spMkLst>
            <pc:docMk/>
            <pc:sldMk cId="2296911850" sldId="424"/>
            <ac:spMk id="38" creationId="{EF10B90E-6CF4-40FD-8070-DEFEC7588DB8}"/>
          </ac:spMkLst>
        </pc:spChg>
        <pc:spChg chg="del">
          <ac:chgData name="khoi ho" userId="c93cb340-cf97-4d7c-9739-bad0ee582323" providerId="ADAL" clId="{A0D29F26-53B9-45CA-9615-1C3502F4732D}" dt="2021-01-04T07:30:27.341" v="9" actId="478"/>
          <ac:spMkLst>
            <pc:docMk/>
            <pc:sldMk cId="2296911850" sldId="424"/>
            <ac:spMk id="39" creationId="{FCA6F854-E038-47A5-92AD-B89EB33223F7}"/>
          </ac:spMkLst>
        </pc:spChg>
        <pc:spChg chg="del">
          <ac:chgData name="khoi ho" userId="c93cb340-cf97-4d7c-9739-bad0ee582323" providerId="ADAL" clId="{A0D29F26-53B9-45CA-9615-1C3502F4732D}" dt="2021-01-04T07:30:18.813" v="2" actId="478"/>
          <ac:spMkLst>
            <pc:docMk/>
            <pc:sldMk cId="2296911850" sldId="424"/>
            <ac:spMk id="40" creationId="{0F3270CF-9E08-44AC-BE73-484A0B137972}"/>
          </ac:spMkLst>
        </pc:spChg>
        <pc:spChg chg="del">
          <ac:chgData name="khoi ho" userId="c93cb340-cf97-4d7c-9739-bad0ee582323" providerId="ADAL" clId="{A0D29F26-53B9-45CA-9615-1C3502F4732D}" dt="2021-01-04T07:30:20.665" v="4" actId="478"/>
          <ac:spMkLst>
            <pc:docMk/>
            <pc:sldMk cId="2296911850" sldId="424"/>
            <ac:spMk id="41" creationId="{B0BE76B9-5DB3-41F0-8D06-0B85F6A1BA3F}"/>
          </ac:spMkLst>
        </pc:spChg>
        <pc:spChg chg="del">
          <ac:chgData name="khoi ho" userId="c93cb340-cf97-4d7c-9739-bad0ee582323" providerId="ADAL" clId="{A0D29F26-53B9-45CA-9615-1C3502F4732D}" dt="2021-01-04T07:30:21.405" v="5" actId="478"/>
          <ac:spMkLst>
            <pc:docMk/>
            <pc:sldMk cId="2296911850" sldId="424"/>
            <ac:spMk id="42" creationId="{30DF5E5C-C95B-4636-9C8A-201538D7DAFC}"/>
          </ac:spMkLst>
        </pc:spChg>
        <pc:spChg chg="del">
          <ac:chgData name="khoi ho" userId="c93cb340-cf97-4d7c-9739-bad0ee582323" providerId="ADAL" clId="{A0D29F26-53B9-45CA-9615-1C3502F4732D}" dt="2021-01-04T07:30:23.947" v="7" actId="478"/>
          <ac:spMkLst>
            <pc:docMk/>
            <pc:sldMk cId="2296911850" sldId="424"/>
            <ac:spMk id="44" creationId="{E725CA44-151A-4340-A4A7-333CF41A0267}"/>
          </ac:spMkLst>
        </pc:spChg>
        <pc:spChg chg="del mod">
          <ac:chgData name="khoi ho" userId="c93cb340-cf97-4d7c-9739-bad0ee582323" providerId="ADAL" clId="{A0D29F26-53B9-45CA-9615-1C3502F4732D}" dt="2021-01-04T07:30:25.823" v="8" actId="478"/>
          <ac:spMkLst>
            <pc:docMk/>
            <pc:sldMk cId="2296911850" sldId="424"/>
            <ac:spMk id="45" creationId="{E91C5176-E120-499D-A10A-053F112722B6}"/>
          </ac:spMkLst>
        </pc:spChg>
        <pc:spChg chg="add del mod">
          <ac:chgData name="khoi ho" userId="c93cb340-cf97-4d7c-9739-bad0ee582323" providerId="ADAL" clId="{A0D29F26-53B9-45CA-9615-1C3502F4732D}" dt="2021-01-04T07:55:57.445" v="79" actId="478"/>
          <ac:spMkLst>
            <pc:docMk/>
            <pc:sldMk cId="2296911850" sldId="424"/>
            <ac:spMk id="46" creationId="{4F772BC8-12FC-43F3-B384-63E021DBB1AA}"/>
          </ac:spMkLst>
        </pc:spChg>
        <pc:spChg chg="add del mod">
          <ac:chgData name="khoi ho" userId="c93cb340-cf97-4d7c-9739-bad0ee582323" providerId="ADAL" clId="{A0D29F26-53B9-45CA-9615-1C3502F4732D}" dt="2021-01-04T07:55:57.445" v="79" actId="478"/>
          <ac:spMkLst>
            <pc:docMk/>
            <pc:sldMk cId="2296911850" sldId="424"/>
            <ac:spMk id="47" creationId="{1843AD5C-97B0-4958-9D34-3994CADBEF33}"/>
          </ac:spMkLst>
        </pc:spChg>
        <pc:spChg chg="add del mod">
          <ac:chgData name="khoi ho" userId="c93cb340-cf97-4d7c-9739-bad0ee582323" providerId="ADAL" clId="{A0D29F26-53B9-45CA-9615-1C3502F4732D}" dt="2021-01-04T07:55:57.445" v="79" actId="478"/>
          <ac:spMkLst>
            <pc:docMk/>
            <pc:sldMk cId="2296911850" sldId="424"/>
            <ac:spMk id="48" creationId="{168CB7A1-CE87-447C-914D-53992EFA0381}"/>
          </ac:spMkLst>
        </pc:spChg>
        <pc:spChg chg="add del mod">
          <ac:chgData name="khoi ho" userId="c93cb340-cf97-4d7c-9739-bad0ee582323" providerId="ADAL" clId="{A0D29F26-53B9-45CA-9615-1C3502F4732D}" dt="2021-01-04T07:55:57.445" v="79" actId="478"/>
          <ac:spMkLst>
            <pc:docMk/>
            <pc:sldMk cId="2296911850" sldId="424"/>
            <ac:spMk id="49" creationId="{EB8E42C7-D68E-4AA3-841B-BE9367D5DBEF}"/>
          </ac:spMkLst>
        </pc:spChg>
        <pc:graphicFrameChg chg="add del mod">
          <ac:chgData name="khoi ho" userId="c93cb340-cf97-4d7c-9739-bad0ee582323" providerId="ADAL" clId="{A0D29F26-53B9-45CA-9615-1C3502F4732D}" dt="2021-01-04T07:55:55.888" v="78" actId="478"/>
          <ac:graphicFrameMkLst>
            <pc:docMk/>
            <pc:sldMk cId="2296911850" sldId="424"/>
            <ac:graphicFrameMk id="35" creationId="{F56B6F4F-6F1F-4B88-98BD-5FFA1340A943}"/>
          </ac:graphicFrameMkLst>
        </pc:graphicFrameChg>
        <pc:picChg chg="add del mod">
          <ac:chgData name="khoi ho" userId="c93cb340-cf97-4d7c-9739-bad0ee582323" providerId="ADAL" clId="{A0D29F26-53B9-45CA-9615-1C3502F4732D}" dt="2021-01-04T07:31:16.008" v="13" actId="478"/>
          <ac:picMkLst>
            <pc:docMk/>
            <pc:sldMk cId="2296911850" sldId="424"/>
            <ac:picMk id="3" creationId="{F7D11A2B-71F6-48C1-8CC5-658692848677}"/>
          </ac:picMkLst>
        </pc:picChg>
        <pc:picChg chg="add mod">
          <ac:chgData name="khoi ho" userId="c93cb340-cf97-4d7c-9739-bad0ee582323" providerId="ADAL" clId="{A0D29F26-53B9-45CA-9615-1C3502F4732D}" dt="2021-01-04T07:40:53.839" v="53" actId="408"/>
          <ac:picMkLst>
            <pc:docMk/>
            <pc:sldMk cId="2296911850" sldId="424"/>
            <ac:picMk id="5" creationId="{4EED56BF-EDFB-4361-AA88-A0D433656310}"/>
          </ac:picMkLst>
        </pc:picChg>
        <pc:picChg chg="add mod">
          <ac:chgData name="khoi ho" userId="c93cb340-cf97-4d7c-9739-bad0ee582323" providerId="ADAL" clId="{A0D29F26-53B9-45CA-9615-1C3502F4732D}" dt="2021-01-04T07:41:00.598" v="54" actId="408"/>
          <ac:picMkLst>
            <pc:docMk/>
            <pc:sldMk cId="2296911850" sldId="424"/>
            <ac:picMk id="7" creationId="{61CB714E-929D-4E9C-8699-50CB9D9C201A}"/>
          </ac:picMkLst>
        </pc:picChg>
        <pc:picChg chg="add mod">
          <ac:chgData name="khoi ho" userId="c93cb340-cf97-4d7c-9739-bad0ee582323" providerId="ADAL" clId="{A0D29F26-53B9-45CA-9615-1C3502F4732D}" dt="2021-01-04T07:40:53.839" v="53" actId="408"/>
          <ac:picMkLst>
            <pc:docMk/>
            <pc:sldMk cId="2296911850" sldId="424"/>
            <ac:picMk id="9" creationId="{3E8F852A-9755-4016-8F00-29050E015C0F}"/>
          </ac:picMkLst>
        </pc:picChg>
        <pc:picChg chg="add mod">
          <ac:chgData name="khoi ho" userId="c93cb340-cf97-4d7c-9739-bad0ee582323" providerId="ADAL" clId="{A0D29F26-53B9-45CA-9615-1C3502F4732D}" dt="2021-01-04T07:41:00.598" v="54" actId="408"/>
          <ac:picMkLst>
            <pc:docMk/>
            <pc:sldMk cId="2296911850" sldId="424"/>
            <ac:picMk id="11" creationId="{BEDD66C0-C46A-402C-B014-8602F7E990BD}"/>
          </ac:picMkLst>
        </pc:picChg>
        <pc:picChg chg="add mod">
          <ac:chgData name="khoi ho" userId="c93cb340-cf97-4d7c-9739-bad0ee582323" providerId="ADAL" clId="{A0D29F26-53B9-45CA-9615-1C3502F4732D}" dt="2021-01-04T07:40:53.839" v="53" actId="408"/>
          <ac:picMkLst>
            <pc:docMk/>
            <pc:sldMk cId="2296911850" sldId="424"/>
            <ac:picMk id="13" creationId="{0D54521C-51AB-41B1-BE09-8C77A4F64638}"/>
          </ac:picMkLst>
        </pc:picChg>
        <pc:picChg chg="add mod">
          <ac:chgData name="khoi ho" userId="c93cb340-cf97-4d7c-9739-bad0ee582323" providerId="ADAL" clId="{A0D29F26-53B9-45CA-9615-1C3502F4732D}" dt="2021-01-04T07:41:00.598" v="54" actId="408"/>
          <ac:picMkLst>
            <pc:docMk/>
            <pc:sldMk cId="2296911850" sldId="424"/>
            <ac:picMk id="15" creationId="{E28FC5F6-F1C5-4D1C-A4BD-B78E7FE153F2}"/>
          </ac:picMkLst>
        </pc:picChg>
        <pc:picChg chg="add mod">
          <ac:chgData name="khoi ho" userId="c93cb340-cf97-4d7c-9739-bad0ee582323" providerId="ADAL" clId="{A0D29F26-53B9-45CA-9615-1C3502F4732D}" dt="2021-01-04T07:40:53.839" v="53" actId="408"/>
          <ac:picMkLst>
            <pc:docMk/>
            <pc:sldMk cId="2296911850" sldId="424"/>
            <ac:picMk id="17" creationId="{38D3DB8D-780E-4C7F-A0B8-EB32EA6EC6DB}"/>
          </ac:picMkLst>
        </pc:picChg>
        <pc:picChg chg="add mod">
          <ac:chgData name="khoi ho" userId="c93cb340-cf97-4d7c-9739-bad0ee582323" providerId="ADAL" clId="{A0D29F26-53B9-45CA-9615-1C3502F4732D}" dt="2021-01-04T07:41:00.598" v="54" actId="408"/>
          <ac:picMkLst>
            <pc:docMk/>
            <pc:sldMk cId="2296911850" sldId="424"/>
            <ac:picMk id="19" creationId="{D8CBF74F-3D4D-47F5-A184-D97E2C79A9CF}"/>
          </ac:picMkLst>
        </pc:picChg>
      </pc:sldChg>
      <pc:sldChg chg="addSp modSp add">
        <pc:chgData name="khoi ho" userId="c93cb340-cf97-4d7c-9739-bad0ee582323" providerId="ADAL" clId="{A0D29F26-53B9-45CA-9615-1C3502F4732D}" dt="2021-01-04T07:54:53.196" v="77" actId="20577"/>
        <pc:sldMkLst>
          <pc:docMk/>
          <pc:sldMk cId="2126262705" sldId="425"/>
        </pc:sldMkLst>
        <pc:spChg chg="add mod">
          <ac:chgData name="khoi ho" userId="c93cb340-cf97-4d7c-9739-bad0ee582323" providerId="ADAL" clId="{A0D29F26-53B9-45CA-9615-1C3502F4732D}" dt="2021-01-04T07:54:53.196" v="77" actId="20577"/>
          <ac:spMkLst>
            <pc:docMk/>
            <pc:sldMk cId="2126262705" sldId="425"/>
            <ac:spMk id="22" creationId="{E27A54E4-56F5-4B9B-BEED-2C75E4670006}"/>
          </ac:spMkLst>
        </pc:spChg>
        <pc:spChg chg="mod">
          <ac:chgData name="khoi ho" userId="c93cb340-cf97-4d7c-9739-bad0ee582323" providerId="ADAL" clId="{A0D29F26-53B9-45CA-9615-1C3502F4732D}" dt="2021-01-04T07:54:44.359" v="74" actId="20577"/>
          <ac:spMkLst>
            <pc:docMk/>
            <pc:sldMk cId="2126262705" sldId="425"/>
            <ac:spMk id="43" creationId="{90CBF72A-5A87-4CF6-983D-2A2C1B284A44}"/>
          </ac:spMkLst>
        </pc:sp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oleObject" Target="https://ctueduvn-my.sharepoint.com/personal/htkhoi_ctu_edu_vn/Documents/1%20y%20-%20pHD%20Hokkaido/JournalSubmition/Sep2020/SummaryDataFRBM2020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20735433070866141"/>
          <c:y val="9.5115207373271893E-2"/>
          <c:w val="0.77296303587051618"/>
          <c:h val="0.71117287758385039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B$750:$E$750</c:f>
                <c:numCache>
                  <c:formatCode>General</c:formatCode>
                  <c:ptCount val="4"/>
                  <c:pt idx="0">
                    <c:v>2.5191812725161902</c:v>
                  </c:pt>
                  <c:pt idx="1">
                    <c:v>2.0530368307368687</c:v>
                  </c:pt>
                  <c:pt idx="2">
                    <c:v>2.464624232208124</c:v>
                  </c:pt>
                  <c:pt idx="3">
                    <c:v>3.7790783967073085</c:v>
                  </c:pt>
                </c:numCache>
              </c:numRef>
            </c:plus>
            <c:minus>
              <c:numRef>
                <c:f>Sheet1!$B$750:$E$750</c:f>
                <c:numCache>
                  <c:formatCode>General</c:formatCode>
                  <c:ptCount val="4"/>
                  <c:pt idx="0">
                    <c:v>2.5191812725161902</c:v>
                  </c:pt>
                  <c:pt idx="1">
                    <c:v>2.0530368307368687</c:v>
                  </c:pt>
                  <c:pt idx="2">
                    <c:v>2.464624232208124</c:v>
                  </c:pt>
                  <c:pt idx="3">
                    <c:v>3.779078396707308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B$743:$E$743</c:f>
              <c:strCache>
                <c:ptCount val="4"/>
                <c:pt idx="0">
                  <c:v>Control</c:v>
                </c:pt>
                <c:pt idx="1">
                  <c:v>5μM</c:v>
                </c:pt>
                <c:pt idx="2">
                  <c:v>10μM</c:v>
                </c:pt>
                <c:pt idx="3">
                  <c:v>20μM</c:v>
                </c:pt>
              </c:strCache>
            </c:strRef>
          </c:cat>
          <c:val>
            <c:numRef>
              <c:f>Sheet1!$B$748:$E$748</c:f>
              <c:numCache>
                <c:formatCode>0.000</c:formatCode>
                <c:ptCount val="4"/>
                <c:pt idx="0">
                  <c:v>88.587208272030807</c:v>
                </c:pt>
                <c:pt idx="1">
                  <c:v>85.110271565379918</c:v>
                </c:pt>
                <c:pt idx="2">
                  <c:v>76.814229190657571</c:v>
                </c:pt>
                <c:pt idx="3">
                  <c:v>55.97038815526210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A81-4A37-8758-6050563DB7F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597684472"/>
        <c:axId val="597683688"/>
      </c:barChart>
      <c:catAx>
        <c:axId val="59768447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3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597683688"/>
        <c:crossesAt val="0"/>
        <c:auto val="1"/>
        <c:lblAlgn val="ctr"/>
        <c:lblOffset val="100"/>
        <c:noMultiLvlLbl val="0"/>
      </c:catAx>
      <c:valAx>
        <c:axId val="59768368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13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Cell Viability (%)</a:t>
                </a:r>
              </a:p>
            </c:rich>
          </c:tx>
          <c:layout>
            <c:manualLayout>
              <c:xMode val="edge"/>
              <c:yMode val="edge"/>
              <c:x val="6.1092306967393352E-2"/>
              <c:y val="0.2179551880467672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13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ja-JP"/>
            </a:p>
          </c:txPr>
        </c:title>
        <c:numFmt formatCode="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3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597684472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3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35C1267-380A-4881-80EF-388B9F63C491}" type="datetimeFigureOut">
              <a:rPr lang="zh-CN" altLang="en-US" smtClean="0"/>
              <a:t>2021/8/14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726D851-1A64-443C-8F11-3808BCEBB30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2453005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0B8176C-951C-4A11-A129-CE9F02D470F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857250" y="1496484"/>
            <a:ext cx="5143500" cy="3183467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C1C79575-E7F6-4FFF-83F5-201EC484242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857250" y="4802718"/>
            <a:ext cx="5143500" cy="2207683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77713CC-0723-4149-92BD-CB6BC1C3AA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EFC11A-2106-4022-B148-23D8A06E7F8B}" type="datetimeFigureOut">
              <a:rPr lang="zh-CN" altLang="en-US" smtClean="0"/>
              <a:t>2021/8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AA361E8-F2A3-4890-8476-F738FDEF48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249D2CC-C754-400D-8024-8ACFF10ACA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FD9BFF-D817-4611-9C2D-A6342AFEF17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790977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A0A4F73-82D2-47DC-B834-0EBBCD0EC8C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F12136AE-ECFD-4C52-BAF5-40D6F15FEC7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F7A8590-A7FF-4457-A76A-C58E4FAD31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EFC11A-2106-4022-B148-23D8A06E7F8B}" type="datetimeFigureOut">
              <a:rPr lang="zh-CN" altLang="en-US" smtClean="0"/>
              <a:t>2021/8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9E4F82C-D17A-4EEC-BAF5-0C0F50449A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BFD61BC-7D4F-4667-B70E-BE6D2AF5BB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FD9BFF-D817-4611-9C2D-A6342AFEF17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6899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3E7B2588-45FB-43A5-9379-4877A9AE13A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4907756" y="486833"/>
            <a:ext cx="1478756" cy="774911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498D3A96-E395-4E80-9946-8711B1063FF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471487" y="486833"/>
            <a:ext cx="4350544" cy="774911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EC8125C-4EC4-4B48-B99E-2D49BE1976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EFC11A-2106-4022-B148-23D8A06E7F8B}" type="datetimeFigureOut">
              <a:rPr lang="zh-CN" altLang="en-US" smtClean="0"/>
              <a:t>2021/8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A96136F-6C7E-46C2-BF56-E2BF051712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697FA55-423D-414A-AE44-DB8D6FAEB3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FD9BFF-D817-4611-9C2D-A6342AFEF17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804908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4A1C41C-DFD9-48F7-A50D-742BD2C8C0C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C39D83E-92ED-4A8B-A6AD-16439C1D688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5F372E7-6928-49BD-9B53-80588199EF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EFC11A-2106-4022-B148-23D8A06E7F8B}" type="datetimeFigureOut">
              <a:rPr lang="zh-CN" altLang="en-US" smtClean="0"/>
              <a:t>2021/8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F4CFD9C-63FB-4AE0-B725-0D64B3DFD6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6D4B457-B1F7-44C8-BAB2-CBF76BAACD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FD9BFF-D817-4611-9C2D-A6342AFEF17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741770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0AB5543-0075-49BD-88BA-CCC5ABC6333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67917" y="2279651"/>
            <a:ext cx="5915025" cy="3803649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681966E7-1EC3-4BA7-AA41-F499D1757D3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67917" y="6119285"/>
            <a:ext cx="5915025" cy="2000249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2EF9F94-A505-4CAF-8B51-E753993625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EFC11A-2106-4022-B148-23D8A06E7F8B}" type="datetimeFigureOut">
              <a:rPr lang="zh-CN" altLang="en-US" smtClean="0"/>
              <a:t>2021/8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E9F352A-DF19-4C41-9242-A38F7970F0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9A9262C-E97D-4F34-9BB4-7A2BCBB889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FD9BFF-D817-4611-9C2D-A6342AFEF17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781823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02E2F01-FF7E-4E57-87E6-3E74BD14C26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D2274DE4-B30A-4603-A391-CD635067D81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AB12ECDB-17BE-4C6E-88BE-0A0F6327BBF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E5D351C-521D-4EC8-9A97-1F891A8210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EFC11A-2106-4022-B148-23D8A06E7F8B}" type="datetimeFigureOut">
              <a:rPr lang="zh-CN" altLang="en-US" smtClean="0"/>
              <a:t>2021/8/1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7B2A002-954B-4AB8-8AD1-8BF77F86A1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C09E81B-E803-419B-903F-90CF4C36FA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FD9BFF-D817-4611-9C2D-A6342AFEF17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795618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57985BD-97DD-4968-B641-F09977E2B1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2" y="486834"/>
            <a:ext cx="5915025" cy="1767417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A758BD9-32D2-46B3-A01A-2EB981D4BB1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7017DEA1-C07E-4C69-8354-187FB134F7B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72381" y="3340101"/>
            <a:ext cx="2901255" cy="4912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35F8665E-2FA5-4761-8A57-13CDD15D45A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3471864" y="2241551"/>
            <a:ext cx="2915543" cy="1098549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1D92377B-F634-45C5-984C-56BF52F0D6C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3471864" y="3340101"/>
            <a:ext cx="2915543" cy="4912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0C13071A-890B-4BF3-849F-FC90462F21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EFC11A-2106-4022-B148-23D8A06E7F8B}" type="datetimeFigureOut">
              <a:rPr lang="zh-CN" altLang="en-US" smtClean="0"/>
              <a:t>2021/8/14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2B800072-9334-4E8F-A731-DF45C9CA11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F325FB93-F32D-4538-93B1-B4CF638505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FD9BFF-D817-4611-9C2D-A6342AFEF17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321561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CB5078D-61CD-4E97-8B6F-37E79232CE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8DE92998-5BBC-4EF1-B890-8E7983C4F6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EFC11A-2106-4022-B148-23D8A06E7F8B}" type="datetimeFigureOut">
              <a:rPr lang="zh-CN" altLang="en-US" smtClean="0"/>
              <a:t>2021/8/14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00920223-56F5-4D1E-9DE4-34D9829CA7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2F5F649C-F54F-4CCB-A1B3-B04447A163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FD9BFF-D817-4611-9C2D-A6342AFEF17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363126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DC620B95-9400-404E-89FD-2F39DAC93B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EFC11A-2106-4022-B148-23D8A06E7F8B}" type="datetimeFigureOut">
              <a:rPr lang="zh-CN" altLang="en-US" smtClean="0"/>
              <a:t>2021/8/14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3158BCB4-FA89-4FF7-A018-1ABA5D8E23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1A4C5BC6-9C20-4447-B42B-46ED89155C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FD9BFF-D817-4611-9C2D-A6342AFEF17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808547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BEFBE00-D188-4F3E-960D-B6418AB6A42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2" y="609600"/>
            <a:ext cx="2211883" cy="21336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E317372-DBB2-4B78-930E-62A275BB972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915544" y="1316567"/>
            <a:ext cx="3471863" cy="649816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2864C382-6BE1-4E65-A7A7-EF340D7410F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2" y="2743200"/>
            <a:ext cx="2211883" cy="5082117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37738018-89CC-4235-B04F-12B470748B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EFC11A-2106-4022-B148-23D8A06E7F8B}" type="datetimeFigureOut">
              <a:rPr lang="zh-CN" altLang="en-US" smtClean="0"/>
              <a:t>2021/8/1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83356C7C-6503-45FF-BABA-86E91879CF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6457229-1824-42F9-B41F-D4937B9CC0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FD9BFF-D817-4611-9C2D-A6342AFEF17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674697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E69027E-BC34-462E-891E-D236D227D2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2" y="609600"/>
            <a:ext cx="2211883" cy="21336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37748B91-346C-4E59-AC39-3F79005C9BA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2915544" y="1316567"/>
            <a:ext cx="3471863" cy="6498167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5617A583-A98D-4A54-AAA6-9C88E73DB6D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2" y="2743200"/>
            <a:ext cx="2211883" cy="5082117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7AEDBB8-E2BC-42B3-B52B-3B47CAC064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EFC11A-2106-4022-B148-23D8A06E7F8B}" type="datetimeFigureOut">
              <a:rPr lang="zh-CN" altLang="en-US" smtClean="0"/>
              <a:t>2021/8/1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DE6F55B-1512-41EC-8F65-7B48949916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E3822A63-6A04-49E8-8FD7-C479BD89B7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FD9BFF-D817-4611-9C2D-A6342AFEF17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157501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6DD976EA-B3AB-4BE2-AA10-C9472EA6322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9" y="486834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FD416F2-698F-4778-804B-31BEC2CF8C5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1489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736A316-0252-4F97-B303-4C7B5B5D319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471488" y="8475135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EFC11A-2106-4022-B148-23D8A06E7F8B}" type="datetimeFigureOut">
              <a:rPr lang="zh-CN" altLang="en-US" smtClean="0"/>
              <a:t>2021/8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DBD4C0F-FF29-4A61-925F-CD22FB4BD73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271714" y="8475135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5A576EF-E78B-4650-8443-8CE13E6AA5B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843463" y="8475135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FD9BFF-D817-4611-9C2D-A6342AFEF17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302206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1.wdp"/><Relationship Id="rId3" Type="http://schemas.openxmlformats.org/officeDocument/2006/relationships/image" Target="../media/image1.jpg"/><Relationship Id="rId7" Type="http://schemas.openxmlformats.org/officeDocument/2006/relationships/image" Target="../media/image5.pn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jpg"/><Relationship Id="rId11" Type="http://schemas.openxmlformats.org/officeDocument/2006/relationships/image" Target="../media/image8.jpg"/><Relationship Id="rId5" Type="http://schemas.openxmlformats.org/officeDocument/2006/relationships/image" Target="../media/image3.jpg"/><Relationship Id="rId10" Type="http://schemas.openxmlformats.org/officeDocument/2006/relationships/image" Target="../media/image7.jpg"/><Relationship Id="rId4" Type="http://schemas.openxmlformats.org/officeDocument/2006/relationships/image" Target="../media/image2.jpg"/><Relationship Id="rId9" Type="http://schemas.openxmlformats.org/officeDocument/2006/relationships/image" Target="../media/image6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7">
            <a:extLst>
              <a:ext uri="{FF2B5EF4-FFF2-40B4-BE49-F238E27FC236}">
                <a16:creationId xmlns:a16="http://schemas.microsoft.com/office/drawing/2014/main" id="{C7416097-C747-4D5A-95A2-5A5A94F46CDF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85360"/>
            <a:ext cx="6628544" cy="5847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ea typeface="ＭＳ Ｐゴシック" pitchFamily="34" charset="-128"/>
                <a:cs typeface="Arial" panose="020B0604020202020204" pitchFamily="34" charset="0"/>
              </a:rPr>
              <a:t>Supplementary Fig. S1: Effect of PES on the viability of  bovine cumulus-granulosa cells</a:t>
            </a:r>
            <a:r>
              <a:rPr lang="ja-JP" altLang="en-US" sz="1600" dirty="0">
                <a:latin typeface="Arial" panose="020B0604020202020204" pitchFamily="34" charset="0"/>
                <a:ea typeface="ＭＳ Ｐゴシック" pitchFamily="34" charset="-128"/>
                <a:cs typeface="Arial" panose="020B0604020202020204" pitchFamily="34" charset="0"/>
              </a:rPr>
              <a:t> </a:t>
            </a:r>
            <a:endParaRPr lang="en-US" altLang="ja-JP" sz="1600" i="1" dirty="0">
              <a:latin typeface="Arial" panose="020B0604020202020204" pitchFamily="34" charset="0"/>
              <a:ea typeface="ＭＳ Ｐゴシック" pitchFamily="34" charset="-128"/>
              <a:cs typeface="Arial" panose="020B0604020202020204" pitchFamily="34" charset="0"/>
            </a:endParaRPr>
          </a:p>
        </p:txBody>
      </p:sp>
      <p:sp>
        <p:nvSpPr>
          <p:cNvPr id="4" name="文本框 40">
            <a:extLst>
              <a:ext uri="{FF2B5EF4-FFF2-40B4-BE49-F238E27FC236}">
                <a16:creationId xmlns:a16="http://schemas.microsoft.com/office/drawing/2014/main" id="{199906F1-9B84-4B1B-8C44-3634D1FC78EC}"/>
              </a:ext>
            </a:extLst>
          </p:cNvPr>
          <p:cNvSpPr txBox="1"/>
          <p:nvPr/>
        </p:nvSpPr>
        <p:spPr>
          <a:xfrm>
            <a:off x="146194" y="976902"/>
            <a:ext cx="471086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3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2">
            <a:extLst>
              <a:ext uri="{FF2B5EF4-FFF2-40B4-BE49-F238E27FC236}">
                <a16:creationId xmlns:a16="http://schemas.microsoft.com/office/drawing/2014/main" id="{7D4B0B69-0241-4A02-B2F9-D97FFFFBB74C}"/>
              </a:ext>
            </a:extLst>
          </p:cNvPr>
          <p:cNvSpPr txBox="1"/>
          <p:nvPr/>
        </p:nvSpPr>
        <p:spPr>
          <a:xfrm rot="16200000">
            <a:off x="-261891" y="2789558"/>
            <a:ext cx="858644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00" dirty="0">
                <a:solidFill>
                  <a:srgbClr val="FF0000"/>
                </a:solidFill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PI</a:t>
            </a:r>
            <a:endParaRPr lang="zh-CN" altLang="en-US" sz="1300" dirty="0">
              <a:solidFill>
                <a:srgbClr val="FF0000"/>
              </a:solidFill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</p:txBody>
      </p:sp>
      <p:sp>
        <p:nvSpPr>
          <p:cNvPr id="6" name="TextBox 2">
            <a:extLst>
              <a:ext uri="{FF2B5EF4-FFF2-40B4-BE49-F238E27FC236}">
                <a16:creationId xmlns:a16="http://schemas.microsoft.com/office/drawing/2014/main" id="{84FF75EE-0CB9-4F2E-B94E-F7F161620553}"/>
              </a:ext>
            </a:extLst>
          </p:cNvPr>
          <p:cNvSpPr txBox="1"/>
          <p:nvPr/>
        </p:nvSpPr>
        <p:spPr>
          <a:xfrm rot="16200000">
            <a:off x="-492499" y="1906591"/>
            <a:ext cx="1346201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300" dirty="0">
                <a:solidFill>
                  <a:schemeClr val="accent6"/>
                </a:solidFill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FITC</a:t>
            </a:r>
            <a:endParaRPr lang="zh-CN" altLang="en-US" sz="1300" dirty="0">
              <a:solidFill>
                <a:srgbClr val="0070C0"/>
              </a:solidFill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</p:txBody>
      </p:sp>
      <p:sp>
        <p:nvSpPr>
          <p:cNvPr id="7" name="TextBox 1">
            <a:extLst>
              <a:ext uri="{FF2B5EF4-FFF2-40B4-BE49-F238E27FC236}">
                <a16:creationId xmlns:a16="http://schemas.microsoft.com/office/drawing/2014/main" id="{9747FBBD-3198-4A56-B4E8-7A65A616BCAB}"/>
              </a:ext>
            </a:extLst>
          </p:cNvPr>
          <p:cNvSpPr txBox="1"/>
          <p:nvPr/>
        </p:nvSpPr>
        <p:spPr>
          <a:xfrm>
            <a:off x="653310" y="1186375"/>
            <a:ext cx="798434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8" name="TextBox 1">
            <a:extLst>
              <a:ext uri="{FF2B5EF4-FFF2-40B4-BE49-F238E27FC236}">
                <a16:creationId xmlns:a16="http://schemas.microsoft.com/office/drawing/2014/main" id="{9A0FECC3-B79E-4775-B737-FA9DA7B33FB3}"/>
              </a:ext>
            </a:extLst>
          </p:cNvPr>
          <p:cNvSpPr txBox="1"/>
          <p:nvPr/>
        </p:nvSpPr>
        <p:spPr>
          <a:xfrm>
            <a:off x="1989958" y="1205187"/>
            <a:ext cx="12549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 </a:t>
            </a:r>
            <a:r>
              <a:rPr lang="el-GR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</a:p>
        </p:txBody>
      </p:sp>
      <p:sp>
        <p:nvSpPr>
          <p:cNvPr id="9" name="TextBox 1">
            <a:extLst>
              <a:ext uri="{FF2B5EF4-FFF2-40B4-BE49-F238E27FC236}">
                <a16:creationId xmlns:a16="http://schemas.microsoft.com/office/drawing/2014/main" id="{D17E5D2C-7E59-4B86-A37B-3B7D312ADBE0}"/>
              </a:ext>
            </a:extLst>
          </p:cNvPr>
          <p:cNvSpPr txBox="1"/>
          <p:nvPr/>
        </p:nvSpPr>
        <p:spPr>
          <a:xfrm>
            <a:off x="4996801" y="1233381"/>
            <a:ext cx="15254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20 </a:t>
            </a:r>
            <a:r>
              <a:rPr lang="el-GR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</a:p>
        </p:txBody>
      </p:sp>
      <p:sp>
        <p:nvSpPr>
          <p:cNvPr id="10" name="TextBox 1">
            <a:extLst>
              <a:ext uri="{FF2B5EF4-FFF2-40B4-BE49-F238E27FC236}">
                <a16:creationId xmlns:a16="http://schemas.microsoft.com/office/drawing/2014/main" id="{D4D08BF6-EE4B-45C0-A827-76E3FB6F3343}"/>
              </a:ext>
            </a:extLst>
          </p:cNvPr>
          <p:cNvSpPr txBox="1"/>
          <p:nvPr/>
        </p:nvSpPr>
        <p:spPr>
          <a:xfrm>
            <a:off x="3451834" y="1211232"/>
            <a:ext cx="15254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0 </a:t>
            </a:r>
            <a:r>
              <a:rPr lang="el-GR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</a:p>
        </p:txBody>
      </p:sp>
      <p:graphicFrame>
        <p:nvGraphicFramePr>
          <p:cNvPr id="11" name="Chart 34">
            <a:extLst>
              <a:ext uri="{FF2B5EF4-FFF2-40B4-BE49-F238E27FC236}">
                <a16:creationId xmlns:a16="http://schemas.microsoft.com/office/drawing/2014/main" id="{827EDDD0-CC50-41E2-A5D7-4362CB08F4D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29324121"/>
              </p:ext>
            </p:extLst>
          </p:nvPr>
        </p:nvGraphicFramePr>
        <p:xfrm>
          <a:off x="1074111" y="4579575"/>
          <a:ext cx="4584096" cy="284147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2" name="TextBox 1">
            <a:extLst>
              <a:ext uri="{FF2B5EF4-FFF2-40B4-BE49-F238E27FC236}">
                <a16:creationId xmlns:a16="http://schemas.microsoft.com/office/drawing/2014/main" id="{00ECC9ED-531C-46C7-941E-E2AEF1AC673C}"/>
              </a:ext>
            </a:extLst>
          </p:cNvPr>
          <p:cNvSpPr txBox="1"/>
          <p:nvPr/>
        </p:nvSpPr>
        <p:spPr>
          <a:xfrm>
            <a:off x="2335277" y="4781438"/>
            <a:ext cx="257175" cy="212845"/>
          </a:xfrm>
          <a:prstGeom prst="rect">
            <a:avLst/>
          </a:prstGeom>
          <a:noFill/>
          <a:ln>
            <a:noFill/>
          </a:ln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3" name="TextBox 1">
            <a:extLst>
              <a:ext uri="{FF2B5EF4-FFF2-40B4-BE49-F238E27FC236}">
                <a16:creationId xmlns:a16="http://schemas.microsoft.com/office/drawing/2014/main" id="{FBE7E718-D56C-4551-93F5-142C53D38F7F}"/>
              </a:ext>
            </a:extLst>
          </p:cNvPr>
          <p:cNvSpPr txBox="1"/>
          <p:nvPr/>
        </p:nvSpPr>
        <p:spPr>
          <a:xfrm>
            <a:off x="3099181" y="4829386"/>
            <a:ext cx="512985" cy="275575"/>
          </a:xfrm>
          <a:prstGeom prst="rect">
            <a:avLst/>
          </a:prstGeom>
          <a:noFill/>
          <a:ln>
            <a:noFill/>
          </a:ln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b</a:t>
            </a:r>
          </a:p>
        </p:txBody>
      </p:sp>
      <p:sp>
        <p:nvSpPr>
          <p:cNvPr id="14" name="TextBox 1">
            <a:extLst>
              <a:ext uri="{FF2B5EF4-FFF2-40B4-BE49-F238E27FC236}">
                <a16:creationId xmlns:a16="http://schemas.microsoft.com/office/drawing/2014/main" id="{714F80F4-3C90-436E-AC11-2BDFE58742AF}"/>
              </a:ext>
            </a:extLst>
          </p:cNvPr>
          <p:cNvSpPr txBox="1"/>
          <p:nvPr/>
        </p:nvSpPr>
        <p:spPr>
          <a:xfrm>
            <a:off x="4105547" y="5013659"/>
            <a:ext cx="257175" cy="212817"/>
          </a:xfrm>
          <a:prstGeom prst="rect">
            <a:avLst/>
          </a:prstGeom>
          <a:noFill/>
          <a:ln>
            <a:noFill/>
          </a:ln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5" name="TextBox 1">
            <a:extLst>
              <a:ext uri="{FF2B5EF4-FFF2-40B4-BE49-F238E27FC236}">
                <a16:creationId xmlns:a16="http://schemas.microsoft.com/office/drawing/2014/main" id="{DCCAAE49-43BC-4C43-9586-76291EB65D0C}"/>
              </a:ext>
            </a:extLst>
          </p:cNvPr>
          <p:cNvSpPr txBox="1"/>
          <p:nvPr/>
        </p:nvSpPr>
        <p:spPr>
          <a:xfrm>
            <a:off x="4954913" y="5407494"/>
            <a:ext cx="339745" cy="194438"/>
          </a:xfrm>
          <a:prstGeom prst="rect">
            <a:avLst/>
          </a:prstGeom>
          <a:noFill/>
          <a:ln>
            <a:noFill/>
          </a:ln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6" name="文本框 40">
            <a:extLst>
              <a:ext uri="{FF2B5EF4-FFF2-40B4-BE49-F238E27FC236}">
                <a16:creationId xmlns:a16="http://schemas.microsoft.com/office/drawing/2014/main" id="{16239B5E-09AD-47A2-827C-A77E3331B993}"/>
              </a:ext>
            </a:extLst>
          </p:cNvPr>
          <p:cNvSpPr txBox="1"/>
          <p:nvPr/>
        </p:nvSpPr>
        <p:spPr>
          <a:xfrm>
            <a:off x="1199793" y="4412765"/>
            <a:ext cx="471086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3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24">
            <a:extLst>
              <a:ext uri="{FF2B5EF4-FFF2-40B4-BE49-F238E27FC236}">
                <a16:creationId xmlns:a16="http://schemas.microsoft.com/office/drawing/2014/main" id="{B85962D4-3D62-4068-95BA-774506E50767}"/>
              </a:ext>
            </a:extLst>
          </p:cNvPr>
          <p:cNvSpPr txBox="1"/>
          <p:nvPr/>
        </p:nvSpPr>
        <p:spPr>
          <a:xfrm>
            <a:off x="114727" y="7577117"/>
            <a:ext cx="6628545" cy="160217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indent="152400" algn="just">
              <a:lnSpc>
                <a:spcPts val="2000"/>
              </a:lnSpc>
            </a:pPr>
            <a:r>
              <a:rPr lang="en-US" sz="1200" dirty="0">
                <a:effectLst/>
                <a:latin typeface="Arial" panose="020B060402020202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Effect of various concentration of PES on cell viability of Bovine CG cells. Bovine CG cells were treated for 12 h with 0, </a:t>
            </a:r>
            <a:r>
              <a:rPr lang="pt-BR" sz="1200" dirty="0">
                <a:effectLst/>
                <a:latin typeface="Arial" panose="020B060402020202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5, 10 and 20 µM PES</a:t>
            </a:r>
            <a:r>
              <a:rPr lang="en-US" sz="1200" dirty="0">
                <a:effectLst/>
                <a:latin typeface="Arial" panose="020B060402020202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 under 5% CO</a:t>
            </a:r>
            <a:r>
              <a:rPr lang="en-US" sz="1200" baseline="-25000" dirty="0">
                <a:effectLst/>
                <a:latin typeface="Arial" panose="020B060402020202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2</a:t>
            </a:r>
            <a:r>
              <a:rPr lang="en-US" sz="1200" dirty="0">
                <a:effectLst/>
                <a:latin typeface="Arial" panose="020B060402020202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 condition at 38.5°C. cell viability was </a:t>
            </a:r>
            <a:r>
              <a:rPr lang="en-US" sz="1200" dirty="0" err="1">
                <a:effectLst/>
                <a:latin typeface="Arial" panose="020B060402020202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analysed</a:t>
            </a:r>
            <a:r>
              <a:rPr lang="en-US" sz="1200" dirty="0">
                <a:effectLst/>
                <a:latin typeface="Arial" panose="020B060402020202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 by Live-Dead Cell Staining Kit (ALX-850-249, Enzo Life Sciences AG, </a:t>
            </a:r>
            <a:r>
              <a:rPr lang="en-US" sz="1200" dirty="0" err="1">
                <a:effectLst/>
                <a:latin typeface="Arial" panose="020B060402020202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Lausen</a:t>
            </a:r>
            <a:r>
              <a:rPr lang="en-US" sz="1200" dirty="0">
                <a:effectLst/>
                <a:latin typeface="Arial" panose="020B060402020202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, TX, USA)   (a) Fluorescence of FITC indicated for live cells (Upper) and PI indicated for dead or damaged cells (Lower).   Bar shows 150 </a:t>
            </a:r>
            <a:r>
              <a:rPr lang="en-US" sz="1200" dirty="0" err="1">
                <a:effectLst/>
                <a:latin typeface="Arial" panose="020B060402020202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μm</a:t>
            </a:r>
            <a:r>
              <a:rPr lang="en-US" sz="1200" dirty="0">
                <a:effectLst/>
                <a:latin typeface="Arial" panose="020B060402020202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. (b) Cell viability (%).   Data are shown as the means </a:t>
            </a:r>
            <a:r>
              <a:rPr lang="pt-BR" sz="1200" dirty="0">
                <a:effectLst/>
                <a:latin typeface="Arial" panose="020B060402020202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± SEM, n=4, a vs b (P&lt;0.05), a vs c (P&lt;0.01)</a:t>
            </a:r>
            <a:endParaRPr lang="en-US" sz="1200" dirty="0">
              <a:effectLst/>
              <a:latin typeface="Arial" panose="020B0604020202020204" pitchFamily="34" charset="0"/>
              <a:ea typeface="Yu Mincho" panose="02020400000000000000" pitchFamily="18" charset="-128"/>
              <a:cs typeface="Arial" panose="020B0604020202020204" pitchFamily="34" charset="0"/>
            </a:endParaRPr>
          </a:p>
        </p:txBody>
      </p:sp>
      <p:pic>
        <p:nvPicPr>
          <p:cNvPr id="18" name="Picture 2" descr="A picture containing light, green, traffic, laser&#10;&#10;Description automatically generated">
            <a:extLst>
              <a:ext uri="{FF2B5EF4-FFF2-40B4-BE49-F238E27FC236}">
                <a16:creationId xmlns:a16="http://schemas.microsoft.com/office/drawing/2014/main" id="{7899E080-EE50-47D3-B4DD-E7E13982E09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9636" y="1537493"/>
            <a:ext cx="1440000" cy="1080000"/>
          </a:xfrm>
          <a:prstGeom prst="rect">
            <a:avLst/>
          </a:prstGeom>
        </p:spPr>
      </p:pic>
      <p:pic>
        <p:nvPicPr>
          <p:cNvPr id="19" name="Picture 5" descr="A picture containing text, star, dark, outdoor object&#10;&#10;Description automatically generated">
            <a:extLst>
              <a:ext uri="{FF2B5EF4-FFF2-40B4-BE49-F238E27FC236}">
                <a16:creationId xmlns:a16="http://schemas.microsoft.com/office/drawing/2014/main" id="{A3898E82-B67C-41CB-A3F0-DEAF5A5C95EE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9636" y="2715725"/>
            <a:ext cx="1440000" cy="1080000"/>
          </a:xfrm>
          <a:prstGeom prst="rect">
            <a:avLst/>
          </a:prstGeom>
        </p:spPr>
      </p:pic>
      <p:pic>
        <p:nvPicPr>
          <p:cNvPr id="20" name="Picture 9" descr="A picture containing green&#10;&#10;Description automatically generated">
            <a:extLst>
              <a:ext uri="{FF2B5EF4-FFF2-40B4-BE49-F238E27FC236}">
                <a16:creationId xmlns:a16="http://schemas.microsoft.com/office/drawing/2014/main" id="{2F2B3085-552B-4084-9450-4A7B576C7E8F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89000" y="1546081"/>
            <a:ext cx="1440000" cy="1080000"/>
          </a:xfrm>
          <a:prstGeom prst="rect">
            <a:avLst/>
          </a:prstGeom>
        </p:spPr>
      </p:pic>
      <p:pic>
        <p:nvPicPr>
          <p:cNvPr id="21" name="Picture 13" descr="A screenshot of a computer&#10;&#10;Description automatically generated with medium confidence">
            <a:extLst>
              <a:ext uri="{FF2B5EF4-FFF2-40B4-BE49-F238E27FC236}">
                <a16:creationId xmlns:a16="http://schemas.microsoft.com/office/drawing/2014/main" id="{D472F5BB-0E3C-4E01-9854-7C326E754A7C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88999" y="2715725"/>
            <a:ext cx="1440000" cy="1080000"/>
          </a:xfrm>
          <a:prstGeom prst="rect">
            <a:avLst/>
          </a:prstGeom>
        </p:spPr>
      </p:pic>
      <p:pic>
        <p:nvPicPr>
          <p:cNvPr id="22" name="Picture 17" descr="A picture containing graphical user interface&#10;&#10;Description automatically generated">
            <a:extLst>
              <a:ext uri="{FF2B5EF4-FFF2-40B4-BE49-F238E27FC236}">
                <a16:creationId xmlns:a16="http://schemas.microsoft.com/office/drawing/2014/main" id="{1143469D-A17E-41A8-82E9-504F6A2DC527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88364" y="1558109"/>
            <a:ext cx="1440000" cy="1080000"/>
          </a:xfrm>
          <a:prstGeom prst="rect">
            <a:avLst/>
          </a:prstGeom>
        </p:spPr>
      </p:pic>
      <p:pic>
        <p:nvPicPr>
          <p:cNvPr id="23" name="Picture 20" descr="A picture containing text, star, outdoor object, dark&#10;&#10;Description automatically generated">
            <a:extLst>
              <a:ext uri="{FF2B5EF4-FFF2-40B4-BE49-F238E27FC236}">
                <a16:creationId xmlns:a16="http://schemas.microsoft.com/office/drawing/2014/main" id="{D45D29D7-61C1-4C7A-A7AE-F3F0039BA5D2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88364" y="2714139"/>
            <a:ext cx="1440000" cy="1080000"/>
          </a:xfrm>
          <a:prstGeom prst="rect">
            <a:avLst/>
          </a:prstGeom>
        </p:spPr>
      </p:pic>
      <p:pic>
        <p:nvPicPr>
          <p:cNvPr id="24" name="Picture 23" descr="A picture containing text, green&#10;&#10;Description automatically generated">
            <a:extLst>
              <a:ext uri="{FF2B5EF4-FFF2-40B4-BE49-F238E27FC236}">
                <a16:creationId xmlns:a16="http://schemas.microsoft.com/office/drawing/2014/main" id="{42384A18-5603-4E22-A382-D2F3E24C9B3A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87729" y="1572549"/>
            <a:ext cx="1440000" cy="1080000"/>
          </a:xfrm>
          <a:prstGeom prst="rect">
            <a:avLst/>
          </a:prstGeom>
        </p:spPr>
      </p:pic>
      <p:pic>
        <p:nvPicPr>
          <p:cNvPr id="25" name="Picture 25" descr="A picture containing text, star, light&#10;&#10;Description automatically generated">
            <a:extLst>
              <a:ext uri="{FF2B5EF4-FFF2-40B4-BE49-F238E27FC236}">
                <a16:creationId xmlns:a16="http://schemas.microsoft.com/office/drawing/2014/main" id="{32A29709-7915-4EE4-8635-5D56302FE9C0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87727" y="2749623"/>
            <a:ext cx="1440000" cy="108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750320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62653</TotalTime>
  <Words>165</Words>
  <Application>Microsoft Office PowerPoint</Application>
  <PresentationFormat>画面に合わせる (4:3)</PresentationFormat>
  <Paragraphs>1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等线</vt:lpstr>
      <vt:lpstr>等线 Light</vt:lpstr>
      <vt:lpstr>Arial</vt:lpstr>
      <vt:lpstr>Office 主题​​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beckr</dc:creator>
  <cp:lastModifiedBy>高橋 昌志</cp:lastModifiedBy>
  <cp:revision>451</cp:revision>
  <dcterms:created xsi:type="dcterms:W3CDTF">2019-07-30T06:06:02Z</dcterms:created>
  <dcterms:modified xsi:type="dcterms:W3CDTF">2021-08-14T06:10:30Z</dcterms:modified>
</cp:coreProperties>
</file>